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2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3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4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5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6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7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theme/themeOverride8.xml" ContentType="application/vnd.openxmlformats-officedocument.themeOverrid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9.xml" ContentType="application/vnd.openxmlformats-officedocument.themeOverrid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theme/themeOverride10.xml" ContentType="application/vnd.openxmlformats-officedocument.themeOverrid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11.xml" ContentType="application/vnd.openxmlformats-officedocument.themeOverr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theme/themeOverride12.xml" ContentType="application/vnd.openxmlformats-officedocument.themeOverrid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theme/themeOverride13.xml" ContentType="application/vnd.openxmlformats-officedocument.themeOverrid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theme/themeOverride14.xml" ContentType="application/vnd.openxmlformats-officedocument.themeOverrid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theme/themeOverride15.xml" ContentType="application/vnd.openxmlformats-officedocument.themeOverrid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theme/themeOverride16.xml" ContentType="application/vnd.openxmlformats-officedocument.themeOverrid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theme/themeOverride17.xml" ContentType="application/vnd.openxmlformats-officedocument.themeOverrid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theme/themeOverride18.xml" ContentType="application/vnd.openxmlformats-officedocument.themeOverrid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theme/themeOverride19.xml" ContentType="application/vnd.openxmlformats-officedocument.themeOverrid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theme/themeOverride20.xml" ContentType="application/vnd.openxmlformats-officedocument.themeOverrid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theme/themeOverride21.xml" ContentType="application/vnd.openxmlformats-officedocument.themeOverrid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theme/themeOverride22.xml" ContentType="application/vnd.openxmlformats-officedocument.themeOverrid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theme/themeOverride23.xml" ContentType="application/vnd.openxmlformats-officedocument.themeOverrid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theme/themeOverride24.xml" ContentType="application/vnd.openxmlformats-officedocument.themeOverrid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theme/themeOverride25.xml" ContentType="application/vnd.openxmlformats-officedocument.themeOverrid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theme/themeOverride26.xml" ContentType="application/vnd.openxmlformats-officedocument.themeOverrid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theme/themeOverride27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4" r:id="rId3"/>
    <p:sldId id="257" r:id="rId4"/>
    <p:sldId id="265" r:id="rId5"/>
    <p:sldId id="260" r:id="rId6"/>
    <p:sldId id="266" r:id="rId7"/>
    <p:sldId id="262" r:id="rId8"/>
    <p:sldId id="26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404" autoAdjust="0"/>
  </p:normalViewPr>
  <p:slideViewPr>
    <p:cSldViewPr snapToGrid="0">
      <p:cViewPr varScale="1">
        <p:scale>
          <a:sx n="74" d="100"/>
          <a:sy n="74" d="100"/>
        </p:scale>
        <p:origin x="37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elle Iskandar" userId="2c0b4211-5e0e-4cf8-b9a9-c3bd005835aa" providerId="ADAL" clId="{82874DC5-C976-4AD2-A060-FB612A2A6449}"/>
    <pc:docChg chg="undo custSel addSld delSld modSld addSection delSection">
      <pc:chgData name="Christelle Iskandar" userId="2c0b4211-5e0e-4cf8-b9a9-c3bd005835aa" providerId="ADAL" clId="{82874DC5-C976-4AD2-A060-FB612A2A6449}" dt="2024-05-07T15:35:07.104" v="100" actId="1035"/>
      <pc:docMkLst>
        <pc:docMk/>
      </pc:docMkLst>
      <pc:sldChg chg="add">
        <pc:chgData name="Christelle Iskandar" userId="2c0b4211-5e0e-4cf8-b9a9-c3bd005835aa" providerId="ADAL" clId="{82874DC5-C976-4AD2-A060-FB612A2A6449}" dt="2024-04-24T15:31:53.605" v="3"/>
        <pc:sldMkLst>
          <pc:docMk/>
          <pc:sldMk cId="1944362713" sldId="258"/>
        </pc:sldMkLst>
      </pc:sldChg>
      <pc:sldChg chg="modSp mod">
        <pc:chgData name="Christelle Iskandar" userId="2c0b4211-5e0e-4cf8-b9a9-c3bd005835aa" providerId="ADAL" clId="{82874DC5-C976-4AD2-A060-FB612A2A6449}" dt="2024-05-07T15:35:07.104" v="100" actId="1035"/>
        <pc:sldMkLst>
          <pc:docMk/>
          <pc:sldMk cId="2198254577" sldId="267"/>
        </pc:sldMkLst>
        <pc:spChg chg="mod">
          <ac:chgData name="Christelle Iskandar" userId="2c0b4211-5e0e-4cf8-b9a9-c3bd005835aa" providerId="ADAL" clId="{82874DC5-C976-4AD2-A060-FB612A2A6449}" dt="2024-05-07T15:26:08.965" v="21" actId="1076"/>
          <ac:spMkLst>
            <pc:docMk/>
            <pc:sldMk cId="2198254577" sldId="267"/>
            <ac:spMk id="11" creationId="{D385DBEA-4B2A-45AF-B97A-5CDA606A5C09}"/>
          </ac:spMkLst>
        </pc:spChg>
        <pc:spChg chg="mod">
          <ac:chgData name="Christelle Iskandar" userId="2c0b4211-5e0e-4cf8-b9a9-c3bd005835aa" providerId="ADAL" clId="{82874DC5-C976-4AD2-A060-FB612A2A6449}" dt="2024-05-07T15:26:03.517" v="20" actId="1076"/>
          <ac:spMkLst>
            <pc:docMk/>
            <pc:sldMk cId="2198254577" sldId="267"/>
            <ac:spMk id="12" creationId="{077BAB4F-5070-4C95-8425-0416EEED1B23}"/>
          </ac:spMkLst>
        </pc:spChg>
        <pc:spChg chg="mod">
          <ac:chgData name="Christelle Iskandar" userId="2c0b4211-5e0e-4cf8-b9a9-c3bd005835aa" providerId="ADAL" clId="{82874DC5-C976-4AD2-A060-FB612A2A6449}" dt="2024-05-07T15:25:54.782" v="18" actId="1076"/>
          <ac:spMkLst>
            <pc:docMk/>
            <pc:sldMk cId="2198254577" sldId="267"/>
            <ac:spMk id="14" creationId="{50CAB37A-01F9-49E7-9074-4F889A18753A}"/>
          </ac:spMkLst>
        </pc:spChg>
        <pc:spChg chg="mod">
          <ac:chgData name="Christelle Iskandar" userId="2c0b4211-5e0e-4cf8-b9a9-c3bd005835aa" providerId="ADAL" clId="{82874DC5-C976-4AD2-A060-FB612A2A6449}" dt="2024-05-07T15:25:46.694" v="17" actId="1076"/>
          <ac:spMkLst>
            <pc:docMk/>
            <pc:sldMk cId="2198254577" sldId="267"/>
            <ac:spMk id="15" creationId="{1A82500B-ACE1-427D-8EE2-489D49475351}"/>
          </ac:spMkLst>
        </pc:spChg>
        <pc:spChg chg="mod">
          <ac:chgData name="Christelle Iskandar" userId="2c0b4211-5e0e-4cf8-b9a9-c3bd005835aa" providerId="ADAL" clId="{82874DC5-C976-4AD2-A060-FB612A2A6449}" dt="2024-05-07T15:25:09.642" v="10" actId="1076"/>
          <ac:spMkLst>
            <pc:docMk/>
            <pc:sldMk cId="2198254577" sldId="267"/>
            <ac:spMk id="16" creationId="{AF990E2F-46B6-4242-8DE2-11F73CB9A7AD}"/>
          </ac:spMkLst>
        </pc:spChg>
        <pc:spChg chg="mod">
          <ac:chgData name="Christelle Iskandar" userId="2c0b4211-5e0e-4cf8-b9a9-c3bd005835aa" providerId="ADAL" clId="{82874DC5-C976-4AD2-A060-FB612A2A6449}" dt="2024-05-07T15:26:42.652" v="29" actId="1037"/>
          <ac:spMkLst>
            <pc:docMk/>
            <pc:sldMk cId="2198254577" sldId="267"/>
            <ac:spMk id="18" creationId="{4F321455-E4C0-4003-9BCB-BC0739781074}"/>
          </ac:spMkLst>
        </pc:spChg>
        <pc:spChg chg="mod">
          <ac:chgData name="Christelle Iskandar" userId="2c0b4211-5e0e-4cf8-b9a9-c3bd005835aa" providerId="ADAL" clId="{82874DC5-C976-4AD2-A060-FB612A2A6449}" dt="2024-05-07T15:26:57.137" v="33" actId="1076"/>
          <ac:spMkLst>
            <pc:docMk/>
            <pc:sldMk cId="2198254577" sldId="267"/>
            <ac:spMk id="20" creationId="{C714ED6F-76DB-4CCC-9649-E8C28AA5EC03}"/>
          </ac:spMkLst>
        </pc:spChg>
        <pc:spChg chg="mod">
          <ac:chgData name="Christelle Iskandar" userId="2c0b4211-5e0e-4cf8-b9a9-c3bd005835aa" providerId="ADAL" clId="{82874DC5-C976-4AD2-A060-FB612A2A6449}" dt="2024-05-07T15:25:36.303" v="15" actId="1036"/>
          <ac:spMkLst>
            <pc:docMk/>
            <pc:sldMk cId="2198254577" sldId="267"/>
            <ac:spMk id="21" creationId="{25C20F74-2B6B-4782-8D98-73DC73964AED}"/>
          </ac:spMkLst>
        </pc:spChg>
        <pc:spChg chg="mod">
          <ac:chgData name="Christelle Iskandar" userId="2c0b4211-5e0e-4cf8-b9a9-c3bd005835aa" providerId="ADAL" clId="{82874DC5-C976-4AD2-A060-FB612A2A6449}" dt="2024-05-07T15:26:49.344" v="31" actId="1036"/>
          <ac:spMkLst>
            <pc:docMk/>
            <pc:sldMk cId="2198254577" sldId="267"/>
            <ac:spMk id="22" creationId="{2B03AE11-F374-4FE9-AD2F-47F8E9A6AAF2}"/>
          </ac:spMkLst>
        </pc:spChg>
        <pc:spChg chg="mod">
          <ac:chgData name="Christelle Iskandar" userId="2c0b4211-5e0e-4cf8-b9a9-c3bd005835aa" providerId="ADAL" clId="{82874DC5-C976-4AD2-A060-FB612A2A6449}" dt="2024-05-07T15:25:22.308" v="12" actId="1076"/>
          <ac:spMkLst>
            <pc:docMk/>
            <pc:sldMk cId="2198254577" sldId="267"/>
            <ac:spMk id="23" creationId="{7EE7F0CE-BAEE-4072-AC75-332069578A5D}"/>
          </ac:spMkLst>
        </pc:spChg>
        <pc:spChg chg="mod">
          <ac:chgData name="Christelle Iskandar" userId="2c0b4211-5e0e-4cf8-b9a9-c3bd005835aa" providerId="ADAL" clId="{82874DC5-C976-4AD2-A060-FB612A2A6449}" dt="2024-05-07T15:26:21.344" v="23" actId="1076"/>
          <ac:spMkLst>
            <pc:docMk/>
            <pc:sldMk cId="2198254577" sldId="267"/>
            <ac:spMk id="24" creationId="{1B07CE6A-51F6-433F-981B-C6F67904DA70}"/>
          </ac:spMkLst>
        </pc:spChg>
        <pc:spChg chg="mod">
          <ac:chgData name="Christelle Iskandar" userId="2c0b4211-5e0e-4cf8-b9a9-c3bd005835aa" providerId="ADAL" clId="{82874DC5-C976-4AD2-A060-FB612A2A6449}" dt="2024-05-07T15:35:07.104" v="100" actId="1035"/>
          <ac:spMkLst>
            <pc:docMk/>
            <pc:sldMk cId="2198254577" sldId="267"/>
            <ac:spMk id="26" creationId="{9D732B6A-9A72-4E49-8D50-E3CD240660C9}"/>
          </ac:spMkLst>
        </pc:spChg>
        <pc:spChg chg="mod">
          <ac:chgData name="Christelle Iskandar" userId="2c0b4211-5e0e-4cf8-b9a9-c3bd005835aa" providerId="ADAL" clId="{82874DC5-C976-4AD2-A060-FB612A2A6449}" dt="2024-05-07T15:26:12.331" v="22" actId="1076"/>
          <ac:spMkLst>
            <pc:docMk/>
            <pc:sldMk cId="2198254577" sldId="267"/>
            <ac:spMk id="27" creationId="{05A0D2BE-382D-44B1-B964-283D6E4D7EC7}"/>
          </ac:spMkLst>
        </pc:spChg>
        <pc:spChg chg="mod">
          <ac:chgData name="Christelle Iskandar" userId="2c0b4211-5e0e-4cf8-b9a9-c3bd005835aa" providerId="ADAL" clId="{82874DC5-C976-4AD2-A060-FB612A2A6449}" dt="2024-05-07T15:26:53.915" v="32" actId="1076"/>
          <ac:spMkLst>
            <pc:docMk/>
            <pc:sldMk cId="2198254577" sldId="267"/>
            <ac:spMk id="29" creationId="{29AC2D30-6D16-4134-8164-C51AD72BD465}"/>
          </ac:spMkLst>
        </pc:spChg>
        <pc:spChg chg="mod">
          <ac:chgData name="Christelle Iskandar" userId="2c0b4211-5e0e-4cf8-b9a9-c3bd005835aa" providerId="ADAL" clId="{82874DC5-C976-4AD2-A060-FB612A2A6449}" dt="2024-05-07T15:26:35.317" v="26" actId="1076"/>
          <ac:spMkLst>
            <pc:docMk/>
            <pc:sldMk cId="2198254577" sldId="267"/>
            <ac:spMk id="34" creationId="{1FE711C3-551E-46BF-A802-304F8E6383A3}"/>
          </ac:spMkLst>
        </pc:spChg>
        <pc:spChg chg="mod">
          <ac:chgData name="Christelle Iskandar" userId="2c0b4211-5e0e-4cf8-b9a9-c3bd005835aa" providerId="ADAL" clId="{82874DC5-C976-4AD2-A060-FB612A2A6449}" dt="2024-05-07T15:26:29.917" v="25" actId="1035"/>
          <ac:spMkLst>
            <pc:docMk/>
            <pc:sldMk cId="2198254577" sldId="267"/>
            <ac:spMk id="35" creationId="{E7736C7E-29C6-47D8-B7E7-1EC38FF54B89}"/>
          </ac:spMkLst>
        </pc:spChg>
        <pc:spChg chg="mod">
          <ac:chgData name="Christelle Iskandar" userId="2c0b4211-5e0e-4cf8-b9a9-c3bd005835aa" providerId="ADAL" clId="{82874DC5-C976-4AD2-A060-FB612A2A6449}" dt="2024-05-07T15:33:53.310" v="60" actId="1038"/>
          <ac:spMkLst>
            <pc:docMk/>
            <pc:sldMk cId="2198254577" sldId="267"/>
            <ac:spMk id="51" creationId="{D592A0C1-496D-4CD0-B271-36EA8587D7FC}"/>
          </ac:spMkLst>
        </pc:spChg>
        <pc:spChg chg="mod">
          <ac:chgData name="Christelle Iskandar" userId="2c0b4211-5e0e-4cf8-b9a9-c3bd005835aa" providerId="ADAL" clId="{82874DC5-C976-4AD2-A060-FB612A2A6449}" dt="2024-05-07T15:33:31.183" v="55" actId="1076"/>
          <ac:spMkLst>
            <pc:docMk/>
            <pc:sldMk cId="2198254577" sldId="267"/>
            <ac:spMk id="52" creationId="{5820F206-BEA7-4DB8-A664-B4ADFEB1AF3E}"/>
          </ac:spMkLst>
        </pc:spChg>
        <pc:spChg chg="mod">
          <ac:chgData name="Christelle Iskandar" userId="2c0b4211-5e0e-4cf8-b9a9-c3bd005835aa" providerId="ADAL" clId="{82874DC5-C976-4AD2-A060-FB612A2A6449}" dt="2024-05-07T15:33:27.971" v="54" actId="1076"/>
          <ac:spMkLst>
            <pc:docMk/>
            <pc:sldMk cId="2198254577" sldId="267"/>
            <ac:spMk id="53" creationId="{D40981CB-1C29-46A3-B769-C5C58B486340}"/>
          </ac:spMkLst>
        </pc:spChg>
        <pc:spChg chg="mod">
          <ac:chgData name="Christelle Iskandar" userId="2c0b4211-5e0e-4cf8-b9a9-c3bd005835aa" providerId="ADAL" clId="{82874DC5-C976-4AD2-A060-FB612A2A6449}" dt="2024-05-07T15:33:41.366" v="57" actId="1076"/>
          <ac:spMkLst>
            <pc:docMk/>
            <pc:sldMk cId="2198254577" sldId="267"/>
            <ac:spMk id="54" creationId="{95C8ABA6-3934-4457-8174-39A32E7BE456}"/>
          </ac:spMkLst>
        </pc:spChg>
        <pc:spChg chg="mod">
          <ac:chgData name="Christelle Iskandar" userId="2c0b4211-5e0e-4cf8-b9a9-c3bd005835aa" providerId="ADAL" clId="{82874DC5-C976-4AD2-A060-FB612A2A6449}" dt="2024-05-07T15:33:46.288" v="58" actId="1076"/>
          <ac:spMkLst>
            <pc:docMk/>
            <pc:sldMk cId="2198254577" sldId="267"/>
            <ac:spMk id="55" creationId="{4E321EBE-A606-4201-9DB5-4AA2AC45B5CE}"/>
          </ac:spMkLst>
        </pc:spChg>
        <pc:spChg chg="mod">
          <ac:chgData name="Christelle Iskandar" userId="2c0b4211-5e0e-4cf8-b9a9-c3bd005835aa" providerId="ADAL" clId="{82874DC5-C976-4AD2-A060-FB612A2A6449}" dt="2024-05-07T15:33:19.485" v="47" actId="1036"/>
          <ac:spMkLst>
            <pc:docMk/>
            <pc:sldMk cId="2198254577" sldId="267"/>
            <ac:spMk id="56" creationId="{BBF4B306-A94C-49F6-A132-6A98C716BA68}"/>
          </ac:spMkLst>
        </pc:spChg>
        <pc:spChg chg="mod">
          <ac:chgData name="Christelle Iskandar" userId="2c0b4211-5e0e-4cf8-b9a9-c3bd005835aa" providerId="ADAL" clId="{82874DC5-C976-4AD2-A060-FB612A2A6449}" dt="2024-05-07T15:33:58.929" v="62" actId="1036"/>
          <ac:spMkLst>
            <pc:docMk/>
            <pc:sldMk cId="2198254577" sldId="267"/>
            <ac:spMk id="57" creationId="{F2C32315-D59B-4354-9218-EF95E8AD2F63}"/>
          </ac:spMkLst>
        </pc:spChg>
        <pc:spChg chg="mod">
          <ac:chgData name="Christelle Iskandar" userId="2c0b4211-5e0e-4cf8-b9a9-c3bd005835aa" providerId="ADAL" clId="{82874DC5-C976-4AD2-A060-FB612A2A6449}" dt="2024-05-07T15:33:38.043" v="56" actId="1076"/>
          <ac:spMkLst>
            <pc:docMk/>
            <pc:sldMk cId="2198254577" sldId="267"/>
            <ac:spMk id="58" creationId="{F83B76F0-AD48-4A93-A9C9-5F50EB0C0D58}"/>
          </ac:spMkLst>
        </pc:spChg>
        <pc:spChg chg="mod">
          <ac:chgData name="Christelle Iskandar" userId="2c0b4211-5e0e-4cf8-b9a9-c3bd005835aa" providerId="ADAL" clId="{82874DC5-C976-4AD2-A060-FB612A2A6449}" dt="2024-05-07T15:32:24.896" v="36" actId="1076"/>
          <ac:spMkLst>
            <pc:docMk/>
            <pc:sldMk cId="2198254577" sldId="267"/>
            <ac:spMk id="69" creationId="{E99F5244-C521-4AAF-ADA9-F97D4B25B70D}"/>
          </ac:spMkLst>
        </pc:spChg>
        <pc:spChg chg="mod">
          <ac:chgData name="Christelle Iskandar" userId="2c0b4211-5e0e-4cf8-b9a9-c3bd005835aa" providerId="ADAL" clId="{82874DC5-C976-4AD2-A060-FB612A2A6449}" dt="2024-05-07T15:33:04.369" v="43" actId="1076"/>
          <ac:spMkLst>
            <pc:docMk/>
            <pc:sldMk cId="2198254577" sldId="267"/>
            <ac:spMk id="70" creationId="{DE9B3436-1164-46F1-B56F-12D04794EC8D}"/>
          </ac:spMkLst>
        </pc:spChg>
        <pc:spChg chg="mod">
          <ac:chgData name="Christelle Iskandar" userId="2c0b4211-5e0e-4cf8-b9a9-c3bd005835aa" providerId="ADAL" clId="{82874DC5-C976-4AD2-A060-FB612A2A6449}" dt="2024-05-07T15:32:29.240" v="37" actId="1076"/>
          <ac:spMkLst>
            <pc:docMk/>
            <pc:sldMk cId="2198254577" sldId="267"/>
            <ac:spMk id="71" creationId="{FE63F4D0-5479-49EC-BACD-B471AEC3091C}"/>
          </ac:spMkLst>
        </pc:spChg>
        <pc:spChg chg="mod">
          <ac:chgData name="Christelle Iskandar" userId="2c0b4211-5e0e-4cf8-b9a9-c3bd005835aa" providerId="ADAL" clId="{82874DC5-C976-4AD2-A060-FB612A2A6449}" dt="2024-05-07T15:32:46.994" v="40" actId="1076"/>
          <ac:spMkLst>
            <pc:docMk/>
            <pc:sldMk cId="2198254577" sldId="267"/>
            <ac:spMk id="72" creationId="{02CF5CB7-A37F-4A4B-A686-3C9AC28B3EA4}"/>
          </ac:spMkLst>
        </pc:spChg>
        <pc:spChg chg="mod">
          <ac:chgData name="Christelle Iskandar" userId="2c0b4211-5e0e-4cf8-b9a9-c3bd005835aa" providerId="ADAL" clId="{82874DC5-C976-4AD2-A060-FB612A2A6449}" dt="2024-05-07T15:32:35.935" v="38" actId="1076"/>
          <ac:spMkLst>
            <pc:docMk/>
            <pc:sldMk cId="2198254577" sldId="267"/>
            <ac:spMk id="73" creationId="{275AF152-8C45-4BCA-B400-7279426CE75B}"/>
          </ac:spMkLst>
        </pc:spChg>
        <pc:spChg chg="mod">
          <ac:chgData name="Christelle Iskandar" userId="2c0b4211-5e0e-4cf8-b9a9-c3bd005835aa" providerId="ADAL" clId="{82874DC5-C976-4AD2-A060-FB612A2A6449}" dt="2024-05-07T15:32:59.804" v="42" actId="1076"/>
          <ac:spMkLst>
            <pc:docMk/>
            <pc:sldMk cId="2198254577" sldId="267"/>
            <ac:spMk id="74" creationId="{3B56F1A7-A005-4623-8FC9-8A47D1A87C44}"/>
          </ac:spMkLst>
        </pc:spChg>
        <pc:spChg chg="mod">
          <ac:chgData name="Christelle Iskandar" userId="2c0b4211-5e0e-4cf8-b9a9-c3bd005835aa" providerId="ADAL" clId="{82874DC5-C976-4AD2-A060-FB612A2A6449}" dt="2024-05-07T15:32:56.048" v="41" actId="1076"/>
          <ac:spMkLst>
            <pc:docMk/>
            <pc:sldMk cId="2198254577" sldId="267"/>
            <ac:spMk id="75" creationId="{B7443BEC-6C66-473F-A8A3-E5C58CB55C1B}"/>
          </ac:spMkLst>
        </pc:spChg>
        <pc:spChg chg="mod">
          <ac:chgData name="Christelle Iskandar" userId="2c0b4211-5e0e-4cf8-b9a9-c3bd005835aa" providerId="ADAL" clId="{82874DC5-C976-4AD2-A060-FB612A2A6449}" dt="2024-05-07T15:33:09.210" v="44" actId="1076"/>
          <ac:spMkLst>
            <pc:docMk/>
            <pc:sldMk cId="2198254577" sldId="267"/>
            <ac:spMk id="76" creationId="{DECEDBAF-E016-40C2-8765-9885A555A9EA}"/>
          </ac:spMkLst>
        </pc:spChg>
        <pc:spChg chg="mod">
          <ac:chgData name="Christelle Iskandar" userId="2c0b4211-5e0e-4cf8-b9a9-c3bd005835aa" providerId="ADAL" clId="{82874DC5-C976-4AD2-A060-FB612A2A6449}" dt="2024-05-07T15:32:42.287" v="39" actId="1076"/>
          <ac:spMkLst>
            <pc:docMk/>
            <pc:sldMk cId="2198254577" sldId="267"/>
            <ac:spMk id="77" creationId="{CE76259A-B2D1-4084-AEE7-ED3655BDAD96}"/>
          </ac:spMkLst>
        </pc:spChg>
        <pc:spChg chg="mod">
          <ac:chgData name="Christelle Iskandar" userId="2c0b4211-5e0e-4cf8-b9a9-c3bd005835aa" providerId="ADAL" clId="{82874DC5-C976-4AD2-A060-FB612A2A6449}" dt="2024-05-07T15:34:41.313" v="86" actId="1076"/>
          <ac:spMkLst>
            <pc:docMk/>
            <pc:sldMk cId="2198254577" sldId="267"/>
            <ac:spMk id="80" creationId="{7449E90C-FC93-42A3-BBE1-385F5D6DC31A}"/>
          </ac:spMkLst>
        </pc:spChg>
        <pc:spChg chg="mod">
          <ac:chgData name="Christelle Iskandar" userId="2c0b4211-5e0e-4cf8-b9a9-c3bd005835aa" providerId="ADAL" clId="{82874DC5-C976-4AD2-A060-FB612A2A6449}" dt="2024-05-07T15:34:46.365" v="92" actId="1035"/>
          <ac:spMkLst>
            <pc:docMk/>
            <pc:sldMk cId="2198254577" sldId="267"/>
            <ac:spMk id="81" creationId="{4758C3D1-B15C-44EB-B010-F71A80137316}"/>
          </ac:spMkLst>
        </pc:spChg>
        <pc:spChg chg="mod">
          <ac:chgData name="Christelle Iskandar" userId="2c0b4211-5e0e-4cf8-b9a9-c3bd005835aa" providerId="ADAL" clId="{82874DC5-C976-4AD2-A060-FB612A2A6449}" dt="2024-05-07T15:34:11.650" v="64" actId="1035"/>
          <ac:spMkLst>
            <pc:docMk/>
            <pc:sldMk cId="2198254577" sldId="267"/>
            <ac:spMk id="82" creationId="{632BEC16-D042-430D-8030-2DE77887B169}"/>
          </ac:spMkLst>
        </pc:spChg>
        <pc:spChg chg="mod">
          <ac:chgData name="Christelle Iskandar" userId="2c0b4211-5e0e-4cf8-b9a9-c3bd005835aa" providerId="ADAL" clId="{82874DC5-C976-4AD2-A060-FB612A2A6449}" dt="2024-05-07T15:34:21.308" v="67" actId="1036"/>
          <ac:spMkLst>
            <pc:docMk/>
            <pc:sldMk cId="2198254577" sldId="267"/>
            <ac:spMk id="85" creationId="{5C368D54-E9B3-4BE9-A347-9573CC30A617}"/>
          </ac:spMkLst>
        </pc:spChg>
        <pc:spChg chg="mod">
          <ac:chgData name="Christelle Iskandar" userId="2c0b4211-5e0e-4cf8-b9a9-c3bd005835aa" providerId="ADAL" clId="{82874DC5-C976-4AD2-A060-FB612A2A6449}" dt="2024-05-07T15:34:25.478" v="70" actId="1036"/>
          <ac:spMkLst>
            <pc:docMk/>
            <pc:sldMk cId="2198254577" sldId="267"/>
            <ac:spMk id="86" creationId="{8288F938-D9DC-4B3B-8069-6843E727C910}"/>
          </ac:spMkLst>
        </pc:spChg>
        <pc:spChg chg="mod">
          <ac:chgData name="Christelle Iskandar" userId="2c0b4211-5e0e-4cf8-b9a9-c3bd005835aa" providerId="ADAL" clId="{82874DC5-C976-4AD2-A060-FB612A2A6449}" dt="2024-05-07T15:34:34.845" v="85" actId="1035"/>
          <ac:spMkLst>
            <pc:docMk/>
            <pc:sldMk cId="2198254577" sldId="267"/>
            <ac:spMk id="87" creationId="{9AADE4D1-685D-4B52-9214-477873248D5D}"/>
          </ac:spMkLst>
        </pc:spChg>
        <pc:spChg chg="mod">
          <ac:chgData name="Christelle Iskandar" userId="2c0b4211-5e0e-4cf8-b9a9-c3bd005835aa" providerId="ADAL" clId="{82874DC5-C976-4AD2-A060-FB612A2A6449}" dt="2024-05-07T15:34:54.989" v="93" actId="1076"/>
          <ac:spMkLst>
            <pc:docMk/>
            <pc:sldMk cId="2198254577" sldId="267"/>
            <ac:spMk id="88" creationId="{D6D10EC6-C71F-785F-CC55-BAB185C93CBF}"/>
          </ac:spMkLst>
        </pc:spChg>
        <pc:graphicFrameChg chg="mod">
          <ac:chgData name="Christelle Iskandar" userId="2c0b4211-5e0e-4cf8-b9a9-c3bd005835aa" providerId="ADAL" clId="{82874DC5-C976-4AD2-A060-FB612A2A6449}" dt="2024-05-07T15:30:25.381" v="34" actId="167"/>
          <ac:graphicFrameMkLst>
            <pc:docMk/>
            <pc:sldMk cId="2198254577" sldId="267"/>
            <ac:graphicFrameMk id="6" creationId="{179AF1DE-1414-48C7-8D8A-44F8AC441D68}"/>
          </ac:graphicFrameMkLst>
        </pc:graphicFrameChg>
        <pc:graphicFrameChg chg="mod">
          <ac:chgData name="Christelle Iskandar" userId="2c0b4211-5e0e-4cf8-b9a9-c3bd005835aa" providerId="ADAL" clId="{82874DC5-C976-4AD2-A060-FB612A2A6449}" dt="2024-05-07T15:32:05.855" v="35" actId="167"/>
          <ac:graphicFrameMkLst>
            <pc:docMk/>
            <pc:sldMk cId="2198254577" sldId="267"/>
            <ac:graphicFrameMk id="7" creationId="{AD2B02BB-62D5-4953-AA2B-CE4235DCBD45}"/>
          </ac:graphicFrameMkLst>
        </pc:graphicFrameChg>
      </pc:sldChg>
      <pc:sldChg chg="new del">
        <pc:chgData name="Christelle Iskandar" userId="2c0b4211-5e0e-4cf8-b9a9-c3bd005835aa" providerId="ADAL" clId="{82874DC5-C976-4AD2-A060-FB612A2A6449}" dt="2024-04-24T15:31:55.179" v="4" actId="47"/>
        <pc:sldMkLst>
          <pc:docMk/>
          <pc:sldMk cId="278293216" sldId="268"/>
        </pc:sldMkLst>
      </pc:sldChg>
      <pc:sldChg chg="add">
        <pc:chgData name="Christelle Iskandar" userId="2c0b4211-5e0e-4cf8-b9a9-c3bd005835aa" providerId="ADAL" clId="{82874DC5-C976-4AD2-A060-FB612A2A6449}" dt="2024-04-24T15:31:53.605" v="3"/>
        <pc:sldMkLst>
          <pc:docMk/>
          <pc:sldMk cId="234582430" sldId="269"/>
        </pc:sldMkLst>
      </pc:sldChg>
      <pc:sldChg chg="add">
        <pc:chgData name="Christelle Iskandar" userId="2c0b4211-5e0e-4cf8-b9a9-c3bd005835aa" providerId="ADAL" clId="{82874DC5-C976-4AD2-A060-FB612A2A6449}" dt="2024-04-24T15:31:53.605" v="3"/>
        <pc:sldMkLst>
          <pc:docMk/>
          <pc:sldMk cId="1503500823" sldId="270"/>
        </pc:sldMkLst>
      </pc:sldChg>
      <pc:sldChg chg="addSp modSp new del mod">
        <pc:chgData name="Christelle Iskandar" userId="2c0b4211-5e0e-4cf8-b9a9-c3bd005835aa" providerId="ADAL" clId="{82874DC5-C976-4AD2-A060-FB612A2A6449}" dt="2024-05-07T15:23:39.386" v="9" actId="47"/>
        <pc:sldMkLst>
          <pc:docMk/>
          <pc:sldMk cId="1667536395" sldId="271"/>
        </pc:sldMkLst>
        <pc:graphicFrameChg chg="add mod">
          <ac:chgData name="Christelle Iskandar" userId="2c0b4211-5e0e-4cf8-b9a9-c3bd005835aa" providerId="ADAL" clId="{82874DC5-C976-4AD2-A060-FB612A2A6449}" dt="2024-04-24T16:39:30.655" v="8" actId="1076"/>
          <ac:graphicFrameMkLst>
            <pc:docMk/>
            <pc:sldMk cId="1667536395" sldId="271"/>
            <ac:graphicFrameMk id="2" creationId="{7C053462-5059-1DF3-0E2B-73BF8758FC6A}"/>
          </ac:graphicFrameMkLst>
        </pc:graphicFrameChg>
      </pc:sldChg>
    </pc:docChg>
  </pc:docChgLst>
  <pc:docChgLst>
    <pc:chgData name="Mariam Choker" userId="2da3c07e-7cda-4855-bfb8-6b456bc434e2" providerId="ADAL" clId="{6CE7FB70-BCAF-4715-8389-474814E0D63B}"/>
    <pc:docChg chg="undo custSel addSld delSld modSld">
      <pc:chgData name="Mariam Choker" userId="2da3c07e-7cda-4855-bfb8-6b456bc434e2" providerId="ADAL" clId="{6CE7FB70-BCAF-4715-8389-474814E0D63B}" dt="2024-04-19T15:34:48.934" v="783"/>
      <pc:docMkLst>
        <pc:docMk/>
      </pc:docMkLst>
      <pc:sldChg chg="delSp modSp del mod">
        <pc:chgData name="Mariam Choker" userId="2da3c07e-7cda-4855-bfb8-6b456bc434e2" providerId="ADAL" clId="{6CE7FB70-BCAF-4715-8389-474814E0D63B}" dt="2024-04-19T12:07:00.749" v="100" actId="2696"/>
        <pc:sldMkLst>
          <pc:docMk/>
          <pc:sldMk cId="691569303" sldId="256"/>
        </pc:sldMkLst>
        <pc:graphicFrameChg chg="del mod">
          <ac:chgData name="Mariam Choker" userId="2da3c07e-7cda-4855-bfb8-6b456bc434e2" providerId="ADAL" clId="{6CE7FB70-BCAF-4715-8389-474814E0D63B}" dt="2024-04-19T12:01:38.821" v="28" actId="21"/>
          <ac:graphicFrameMkLst>
            <pc:docMk/>
            <pc:sldMk cId="691569303" sldId="256"/>
            <ac:graphicFrameMk id="5" creationId="{2976D715-854F-406A-AA60-467B60D0E8CC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1:50.904" v="31" actId="21"/>
          <ac:graphicFrameMkLst>
            <pc:docMk/>
            <pc:sldMk cId="691569303" sldId="256"/>
            <ac:graphicFrameMk id="6" creationId="{92E9F354-0B5A-4493-B1CF-8151DD8AD9E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1:15.274" v="25" actId="21"/>
          <ac:graphicFrameMkLst>
            <pc:docMk/>
            <pc:sldMk cId="691569303" sldId="256"/>
            <ac:graphicFrameMk id="7" creationId="{4FAEC8ED-E9C7-461C-93DE-061F2C4172F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2:15.935" v="36" actId="21"/>
          <ac:graphicFrameMkLst>
            <pc:docMk/>
            <pc:sldMk cId="691569303" sldId="256"/>
            <ac:graphicFrameMk id="8" creationId="{9648C423-B28F-4DC8-9704-ABA69B69493D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5:38.025" v="76" actId="21"/>
          <ac:graphicFrameMkLst>
            <pc:docMk/>
            <pc:sldMk cId="691569303" sldId="256"/>
            <ac:graphicFrameMk id="9" creationId="{CF3478F0-6C19-42C6-9DE0-130DD00AEE7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4:36.938" v="63" actId="21"/>
          <ac:graphicFrameMkLst>
            <pc:docMk/>
            <pc:sldMk cId="691569303" sldId="256"/>
            <ac:graphicFrameMk id="10" creationId="{BFD9C511-177B-47C6-8BB1-74C81F726CE8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4:53.946" v="67" actId="21"/>
          <ac:graphicFrameMkLst>
            <pc:docMk/>
            <pc:sldMk cId="691569303" sldId="256"/>
            <ac:graphicFrameMk id="11" creationId="{CCE1FAF8-1F10-4436-8188-A12A6964AB85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3:25.386" v="49" actId="21"/>
          <ac:graphicFrameMkLst>
            <pc:docMk/>
            <pc:sldMk cId="691569303" sldId="256"/>
            <ac:graphicFrameMk id="12" creationId="{C894232F-42C6-4A99-AF8B-4E389A66F92C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2:03:43.734" v="52" actId="21"/>
          <ac:graphicFrameMkLst>
            <pc:docMk/>
            <pc:sldMk cId="691569303" sldId="256"/>
            <ac:graphicFrameMk id="13" creationId="{7D5C2281-174A-44ED-94CE-5A3C5BDFC991}"/>
          </ac:graphicFrameMkLst>
        </pc:graphicFrameChg>
      </pc:sldChg>
      <pc:sldChg chg="delSp modSp del mod">
        <pc:chgData name="Mariam Choker" userId="2da3c07e-7cda-4855-bfb8-6b456bc434e2" providerId="ADAL" clId="{6CE7FB70-BCAF-4715-8389-474814E0D63B}" dt="2024-04-19T14:17:21.233" v="412" actId="2696"/>
        <pc:sldMkLst>
          <pc:docMk/>
          <pc:sldMk cId="3218188072" sldId="258"/>
        </pc:sldMkLst>
        <pc:graphicFrameChg chg="del mod">
          <ac:chgData name="Mariam Choker" userId="2da3c07e-7cda-4855-bfb8-6b456bc434e2" providerId="ADAL" clId="{6CE7FB70-BCAF-4715-8389-474814E0D63B}" dt="2024-04-19T14:12:06.167" v="335" actId="21"/>
          <ac:graphicFrameMkLst>
            <pc:docMk/>
            <pc:sldMk cId="3218188072" sldId="258"/>
            <ac:graphicFrameMk id="2" creationId="{9E9CFFC3-CC7F-4AFC-8991-C03A40C3413D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2:23.343" v="340" actId="21"/>
          <ac:graphicFrameMkLst>
            <pc:docMk/>
            <pc:sldMk cId="3218188072" sldId="258"/>
            <ac:graphicFrameMk id="3" creationId="{7505BE7A-DD17-488B-AB7A-409AB79BB2E8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1:53.342" v="332" actId="21"/>
          <ac:graphicFrameMkLst>
            <pc:docMk/>
            <pc:sldMk cId="3218188072" sldId="258"/>
            <ac:graphicFrameMk id="4" creationId="{BDD6B1BE-E540-4482-A040-FE98AA3D27FC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3:25.586" v="353" actId="21"/>
          <ac:graphicFrameMkLst>
            <pc:docMk/>
            <pc:sldMk cId="3218188072" sldId="258"/>
            <ac:graphicFrameMk id="5" creationId="{E467E298-C709-43EE-A110-8C8BFE07B44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6:09.020" v="393" actId="21"/>
          <ac:graphicFrameMkLst>
            <pc:docMk/>
            <pc:sldMk cId="3218188072" sldId="258"/>
            <ac:graphicFrameMk id="6" creationId="{B3F2CA10-9ABE-4BD2-B92B-6F03EDDF55D0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4:19.334" v="366" actId="21"/>
          <ac:graphicFrameMkLst>
            <pc:docMk/>
            <pc:sldMk cId="3218188072" sldId="258"/>
            <ac:graphicFrameMk id="7" creationId="{3EB0F768-1843-4D98-AE78-841EA7FCBA16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5:27.823" v="383" actId="21"/>
          <ac:graphicFrameMkLst>
            <pc:docMk/>
            <pc:sldMk cId="3218188072" sldId="258"/>
            <ac:graphicFrameMk id="8" creationId="{9CF06B13-F6E2-4C75-9ABB-0860F6B6BCAB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3:40.838" v="357" actId="21"/>
          <ac:graphicFrameMkLst>
            <pc:docMk/>
            <pc:sldMk cId="3218188072" sldId="258"/>
            <ac:graphicFrameMk id="9" creationId="{50BCFC1E-D84B-4EC1-9A2A-DFB6AD8C482C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4:02.979" v="363" actId="21"/>
          <ac:graphicFrameMkLst>
            <pc:docMk/>
            <pc:sldMk cId="3218188072" sldId="258"/>
            <ac:graphicFrameMk id="10" creationId="{4E5968C4-3972-4881-A6DA-3B08A704D5B7}"/>
          </ac:graphicFrameMkLst>
        </pc:graphicFrameChg>
      </pc:sldChg>
      <pc:sldChg chg="delSp modSp del mod">
        <pc:chgData name="Mariam Choker" userId="2da3c07e-7cda-4855-bfb8-6b456bc434e2" providerId="ADAL" clId="{6CE7FB70-BCAF-4715-8389-474814E0D63B}" dt="2024-04-19T14:25:06.017" v="512" actId="2696"/>
        <pc:sldMkLst>
          <pc:docMk/>
          <pc:sldMk cId="1391474955" sldId="261"/>
        </pc:sldMkLst>
        <pc:graphicFrameChg chg="del mod">
          <ac:chgData name="Mariam Choker" userId="2da3c07e-7cda-4855-bfb8-6b456bc434e2" providerId="ADAL" clId="{6CE7FB70-BCAF-4715-8389-474814E0D63B}" dt="2024-04-19T14:18:52.295" v="424" actId="21"/>
          <ac:graphicFrameMkLst>
            <pc:docMk/>
            <pc:sldMk cId="1391474955" sldId="261"/>
            <ac:graphicFrameMk id="2" creationId="{DFD33DFD-EF4C-4458-B2C6-9F4FB345BCB2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9:12.206" v="428" actId="21"/>
          <ac:graphicFrameMkLst>
            <pc:docMk/>
            <pc:sldMk cId="1391474955" sldId="261"/>
            <ac:graphicFrameMk id="3" creationId="{40D0677F-D6A3-4171-A081-FB09B026DB5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7:56.045" v="413" actId="21"/>
          <ac:graphicFrameMkLst>
            <pc:docMk/>
            <pc:sldMk cId="1391474955" sldId="261"/>
            <ac:graphicFrameMk id="4" creationId="{5E2B3C6F-37A3-44A6-BC76-58EC7E6A41DD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19:45.362" v="434" actId="21"/>
          <ac:graphicFrameMkLst>
            <pc:docMk/>
            <pc:sldMk cId="1391474955" sldId="261"/>
            <ac:graphicFrameMk id="5" creationId="{DA1B5DCE-A3B9-4A34-800D-4C412D3B216A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1:54.128" v="467" actId="21"/>
          <ac:graphicFrameMkLst>
            <pc:docMk/>
            <pc:sldMk cId="1391474955" sldId="261"/>
            <ac:graphicFrameMk id="6" creationId="{CFBD0974-B941-435E-A22D-FE129305DBB3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0:51.860" v="449" actId="21"/>
          <ac:graphicFrameMkLst>
            <pc:docMk/>
            <pc:sldMk cId="1391474955" sldId="261"/>
            <ac:graphicFrameMk id="7" creationId="{058B05D8-0ACF-48A5-8D5D-EF736207838C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1:33.943" v="462" actId="21"/>
          <ac:graphicFrameMkLst>
            <pc:docMk/>
            <pc:sldMk cId="1391474955" sldId="261"/>
            <ac:graphicFrameMk id="8" creationId="{78F88E93-E1F4-4281-9DFF-21337B9D4946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0:06.771" v="440" actId="21"/>
          <ac:graphicFrameMkLst>
            <pc:docMk/>
            <pc:sldMk cId="1391474955" sldId="261"/>
            <ac:graphicFrameMk id="9" creationId="{CC600005-409F-4871-AE77-5C9881768B47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0:28.728" v="444" actId="21"/>
          <ac:graphicFrameMkLst>
            <pc:docMk/>
            <pc:sldMk cId="1391474955" sldId="261"/>
            <ac:graphicFrameMk id="10" creationId="{0FC4F1EA-1802-4D42-A51B-2AE4B78CD383}"/>
          </ac:graphicFrameMkLst>
        </pc:graphicFrameChg>
      </pc:sldChg>
      <pc:sldChg chg="delSp modSp del mod">
        <pc:chgData name="Mariam Choker" userId="2da3c07e-7cda-4855-bfb8-6b456bc434e2" providerId="ADAL" clId="{6CE7FB70-BCAF-4715-8389-474814E0D63B}" dt="2024-04-19T14:30:38.247" v="592" actId="2696"/>
        <pc:sldMkLst>
          <pc:docMk/>
          <pc:sldMk cId="1029492146" sldId="263"/>
        </pc:sldMkLst>
        <pc:graphicFrameChg chg="del mod">
          <ac:chgData name="Mariam Choker" userId="2da3c07e-7cda-4855-bfb8-6b456bc434e2" providerId="ADAL" clId="{6CE7FB70-BCAF-4715-8389-474814E0D63B}" dt="2024-04-19T14:25:53.150" v="520" actId="21"/>
          <ac:graphicFrameMkLst>
            <pc:docMk/>
            <pc:sldMk cId="1029492146" sldId="263"/>
            <ac:graphicFrameMk id="2" creationId="{1D30D0C6-D4E2-4314-AD29-7B2A6FC2F487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6:26.063" v="526" actId="21"/>
          <ac:graphicFrameMkLst>
            <pc:docMk/>
            <pc:sldMk cId="1029492146" sldId="263"/>
            <ac:graphicFrameMk id="3" creationId="{50B26E06-1977-4C1C-AE21-11EF5FF90A28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5:21.071" v="513" actId="21"/>
          <ac:graphicFrameMkLst>
            <pc:docMk/>
            <pc:sldMk cId="1029492146" sldId="263"/>
            <ac:graphicFrameMk id="4" creationId="{324DB2C8-A5D9-49F7-9DF4-FE4C24C87AAB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7:06.660" v="534" actId="21"/>
          <ac:graphicFrameMkLst>
            <pc:docMk/>
            <pc:sldMk cId="1029492146" sldId="263"/>
            <ac:graphicFrameMk id="5" creationId="{FDBC89D3-94FB-407B-A05A-3D2A0C009B0F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9:10.234" v="559" actId="21"/>
          <ac:graphicFrameMkLst>
            <pc:docMk/>
            <pc:sldMk cId="1029492146" sldId="263"/>
            <ac:graphicFrameMk id="6" creationId="{E8AAB7B8-9698-4BF9-833F-34CEDDF400D5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8:18.681" v="546" actId="21"/>
          <ac:graphicFrameMkLst>
            <pc:docMk/>
            <pc:sldMk cId="1029492146" sldId="263"/>
            <ac:graphicFrameMk id="7" creationId="{776B312A-8844-41BE-8E5C-3D526BB216D1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8:38.821" v="551" actId="21"/>
          <ac:graphicFrameMkLst>
            <pc:docMk/>
            <pc:sldMk cId="1029492146" sldId="263"/>
            <ac:graphicFrameMk id="8" creationId="{A4B01B6A-45BA-4F55-B92D-4BFDDF5BC825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7:20.352" v="537" actId="21"/>
          <ac:graphicFrameMkLst>
            <pc:docMk/>
            <pc:sldMk cId="1029492146" sldId="263"/>
            <ac:graphicFrameMk id="9" creationId="{7BA755B4-5ACE-4563-B61D-DC8D5FCC49C4}"/>
          </ac:graphicFrameMkLst>
        </pc:graphicFrameChg>
        <pc:graphicFrameChg chg="del mod">
          <ac:chgData name="Mariam Choker" userId="2da3c07e-7cda-4855-bfb8-6b456bc434e2" providerId="ADAL" clId="{6CE7FB70-BCAF-4715-8389-474814E0D63B}" dt="2024-04-19T14:27:46.710" v="541" actId="21"/>
          <ac:graphicFrameMkLst>
            <pc:docMk/>
            <pc:sldMk cId="1029492146" sldId="263"/>
            <ac:graphicFrameMk id="10" creationId="{3EE1B389-9208-4412-B8CE-D2A3407B30F6}"/>
          </ac:graphicFrameMkLst>
        </pc:graphicFrameChg>
      </pc:sldChg>
      <pc:sldChg chg="addSp delSp modSp new mod">
        <pc:chgData name="Mariam Choker" userId="2da3c07e-7cda-4855-bfb8-6b456bc434e2" providerId="ADAL" clId="{6CE7FB70-BCAF-4715-8389-474814E0D63B}" dt="2024-04-19T15:34:48.934" v="783"/>
        <pc:sldMkLst>
          <pc:docMk/>
          <pc:sldMk cId="1576424241" sldId="264"/>
        </pc:sldMkLst>
        <pc:spChg chg="add mod">
          <ac:chgData name="Mariam Choker" userId="2da3c07e-7cda-4855-bfb8-6b456bc434e2" providerId="ADAL" clId="{6CE7FB70-BCAF-4715-8389-474814E0D63B}" dt="2024-04-19T12:09:02.996" v="105" actId="1076"/>
          <ac:spMkLst>
            <pc:docMk/>
            <pc:sldMk cId="1576424241" sldId="264"/>
            <ac:spMk id="11" creationId="{7C6E9903-F303-4FBB-BDAC-F54ADB226B0E}"/>
          </ac:spMkLst>
        </pc:spChg>
        <pc:spChg chg="add mod">
          <ac:chgData name="Mariam Choker" userId="2da3c07e-7cda-4855-bfb8-6b456bc434e2" providerId="ADAL" clId="{6CE7FB70-BCAF-4715-8389-474814E0D63B}" dt="2024-04-19T13:59:50.139" v="228" actId="1076"/>
          <ac:spMkLst>
            <pc:docMk/>
            <pc:sldMk cId="1576424241" sldId="264"/>
            <ac:spMk id="12" creationId="{A7993EFB-89C2-437B-97F1-E6593154DE90}"/>
          </ac:spMkLst>
        </pc:spChg>
        <pc:spChg chg="add mod">
          <ac:chgData name="Mariam Choker" userId="2da3c07e-7cda-4855-bfb8-6b456bc434e2" providerId="ADAL" clId="{6CE7FB70-BCAF-4715-8389-474814E0D63B}" dt="2024-04-19T13:59:07.608" v="222" actId="1076"/>
          <ac:spMkLst>
            <pc:docMk/>
            <pc:sldMk cId="1576424241" sldId="264"/>
            <ac:spMk id="13" creationId="{5CD944D8-3DE5-499D-B661-0B9B3382E7F8}"/>
          </ac:spMkLst>
        </pc:spChg>
        <pc:spChg chg="add mod">
          <ac:chgData name="Mariam Choker" userId="2da3c07e-7cda-4855-bfb8-6b456bc434e2" providerId="ADAL" clId="{6CE7FB70-BCAF-4715-8389-474814E0D63B}" dt="2024-04-19T13:59:12.052" v="223" actId="1076"/>
          <ac:spMkLst>
            <pc:docMk/>
            <pc:sldMk cId="1576424241" sldId="264"/>
            <ac:spMk id="14" creationId="{C4249E7B-7AC5-4FC0-9192-63A3757E9236}"/>
          </ac:spMkLst>
        </pc:spChg>
        <pc:spChg chg="add mod">
          <ac:chgData name="Mariam Choker" userId="2da3c07e-7cda-4855-bfb8-6b456bc434e2" providerId="ADAL" clId="{6CE7FB70-BCAF-4715-8389-474814E0D63B}" dt="2024-04-19T13:58:27.606" v="217" actId="1076"/>
          <ac:spMkLst>
            <pc:docMk/>
            <pc:sldMk cId="1576424241" sldId="264"/>
            <ac:spMk id="15" creationId="{DAED67C2-FA4B-407E-BE69-E137A95A3EBE}"/>
          </ac:spMkLst>
        </pc:spChg>
        <pc:spChg chg="add mod">
          <ac:chgData name="Mariam Choker" userId="2da3c07e-7cda-4855-bfb8-6b456bc434e2" providerId="ADAL" clId="{6CE7FB70-BCAF-4715-8389-474814E0D63B}" dt="2024-04-19T13:57:40.749" v="213" actId="1076"/>
          <ac:spMkLst>
            <pc:docMk/>
            <pc:sldMk cId="1576424241" sldId="264"/>
            <ac:spMk id="16" creationId="{2FDFDD56-2F35-4247-B21C-2C38C9817352}"/>
          </ac:spMkLst>
        </pc:spChg>
        <pc:spChg chg="add mod">
          <ac:chgData name="Mariam Choker" userId="2da3c07e-7cda-4855-bfb8-6b456bc434e2" providerId="ADAL" clId="{6CE7FB70-BCAF-4715-8389-474814E0D63B}" dt="2024-04-19T13:57:35.441" v="212" actId="1076"/>
          <ac:spMkLst>
            <pc:docMk/>
            <pc:sldMk cId="1576424241" sldId="264"/>
            <ac:spMk id="17" creationId="{624300E8-4F15-4F5F-A387-F517067D7114}"/>
          </ac:spMkLst>
        </pc:spChg>
        <pc:spChg chg="add mod">
          <ac:chgData name="Mariam Choker" userId="2da3c07e-7cda-4855-bfb8-6b456bc434e2" providerId="ADAL" clId="{6CE7FB70-BCAF-4715-8389-474814E0D63B}" dt="2024-04-19T13:57:16.075" v="209" actId="1076"/>
          <ac:spMkLst>
            <pc:docMk/>
            <pc:sldMk cId="1576424241" sldId="264"/>
            <ac:spMk id="18" creationId="{A4369B8C-7CF6-4356-9808-DEC69381D3CA}"/>
          </ac:spMkLst>
        </pc:spChg>
        <pc:spChg chg="add mod">
          <ac:chgData name="Mariam Choker" userId="2da3c07e-7cda-4855-bfb8-6b456bc434e2" providerId="ADAL" clId="{6CE7FB70-BCAF-4715-8389-474814E0D63B}" dt="2024-04-19T14:02:13.431" v="233" actId="1076"/>
          <ac:spMkLst>
            <pc:docMk/>
            <pc:sldMk cId="1576424241" sldId="264"/>
            <ac:spMk id="19" creationId="{E98A314E-3ABE-483B-8364-21BEB54D2EFF}"/>
          </ac:spMkLst>
        </pc:spChg>
        <pc:spChg chg="add mod">
          <ac:chgData name="Mariam Choker" userId="2da3c07e-7cda-4855-bfb8-6b456bc434e2" providerId="ADAL" clId="{6CE7FB70-BCAF-4715-8389-474814E0D63B}" dt="2024-04-19T13:57:29.254" v="211" actId="1076"/>
          <ac:spMkLst>
            <pc:docMk/>
            <pc:sldMk cId="1576424241" sldId="264"/>
            <ac:spMk id="20" creationId="{FC5E314B-934E-47D0-B2E7-EA52471027ED}"/>
          </ac:spMkLst>
        </pc:spChg>
        <pc:spChg chg="add mod">
          <ac:chgData name="Mariam Choker" userId="2da3c07e-7cda-4855-bfb8-6b456bc434e2" providerId="ADAL" clId="{6CE7FB70-BCAF-4715-8389-474814E0D63B}" dt="2024-04-19T13:58:54.120" v="221" actId="1076"/>
          <ac:spMkLst>
            <pc:docMk/>
            <pc:sldMk cId="1576424241" sldId="264"/>
            <ac:spMk id="21" creationId="{5413DAEF-05AE-4AA1-B2FC-BE542CA0AAE4}"/>
          </ac:spMkLst>
        </pc:spChg>
        <pc:spChg chg="add mod">
          <ac:chgData name="Mariam Choker" userId="2da3c07e-7cda-4855-bfb8-6b456bc434e2" providerId="ADAL" clId="{6CE7FB70-BCAF-4715-8389-474814E0D63B}" dt="2024-04-19T13:59:45.621" v="227" actId="1076"/>
          <ac:spMkLst>
            <pc:docMk/>
            <pc:sldMk cId="1576424241" sldId="264"/>
            <ac:spMk id="22" creationId="{F69D0641-FD29-4062-859B-F36225C540DC}"/>
          </ac:spMkLst>
        </pc:spChg>
        <pc:spChg chg="add mod">
          <ac:chgData name="Mariam Choker" userId="2da3c07e-7cda-4855-bfb8-6b456bc434e2" providerId="ADAL" clId="{6CE7FB70-BCAF-4715-8389-474814E0D63B}" dt="2024-04-19T14:03:15.562" v="250" actId="1076"/>
          <ac:spMkLst>
            <pc:docMk/>
            <pc:sldMk cId="1576424241" sldId="264"/>
            <ac:spMk id="23" creationId="{2A0457DC-E23D-497C-BF96-5276CF8FE8C5}"/>
          </ac:spMkLst>
        </pc:spChg>
        <pc:spChg chg="add del mod">
          <ac:chgData name="Mariam Choker" userId="2da3c07e-7cda-4855-bfb8-6b456bc434e2" providerId="ADAL" clId="{6CE7FB70-BCAF-4715-8389-474814E0D63B}" dt="2024-04-19T14:30:53.047" v="594" actId="478"/>
          <ac:spMkLst>
            <pc:docMk/>
            <pc:sldMk cId="1576424241" sldId="264"/>
            <ac:spMk id="24" creationId="{CFE5AE13-0E7D-4515-ABD3-AB039D274B99}"/>
          </ac:spMkLst>
        </pc:spChg>
        <pc:spChg chg="add del mod">
          <ac:chgData name="Mariam Choker" userId="2da3c07e-7cda-4855-bfb8-6b456bc434e2" providerId="ADAL" clId="{6CE7FB70-BCAF-4715-8389-474814E0D63B}" dt="2024-04-19T14:30:50.087" v="593" actId="21"/>
          <ac:spMkLst>
            <pc:docMk/>
            <pc:sldMk cId="1576424241" sldId="264"/>
            <ac:spMk id="25" creationId="{4F5B0695-E6E0-436F-A9AC-82A08D54F633}"/>
          </ac:spMkLst>
        </pc:spChg>
        <pc:spChg chg="add mod">
          <ac:chgData name="Mariam Choker" userId="2da3c07e-7cda-4855-bfb8-6b456bc434e2" providerId="ADAL" clId="{6CE7FB70-BCAF-4715-8389-474814E0D63B}" dt="2024-04-19T14:02:17.905" v="234" actId="1076"/>
          <ac:spMkLst>
            <pc:docMk/>
            <pc:sldMk cId="1576424241" sldId="264"/>
            <ac:spMk id="26" creationId="{6CCAE04C-2915-4DA5-AD88-B32581CBD689}"/>
          </ac:spMkLst>
        </pc:spChg>
        <pc:spChg chg="add mod">
          <ac:chgData name="Mariam Choker" userId="2da3c07e-7cda-4855-bfb8-6b456bc434e2" providerId="ADAL" clId="{6CE7FB70-BCAF-4715-8389-474814E0D63B}" dt="2024-04-19T13:57:11.384" v="208" actId="1076"/>
          <ac:spMkLst>
            <pc:docMk/>
            <pc:sldMk cId="1576424241" sldId="264"/>
            <ac:spMk id="27" creationId="{006517E0-37EC-49DD-98A0-7E3446A23960}"/>
          </ac:spMkLst>
        </pc:spChg>
        <pc:spChg chg="add mod">
          <ac:chgData name="Mariam Choker" userId="2da3c07e-7cda-4855-bfb8-6b456bc434e2" providerId="ADAL" clId="{6CE7FB70-BCAF-4715-8389-474814E0D63B}" dt="2024-04-19T13:58:49.555" v="220" actId="1076"/>
          <ac:spMkLst>
            <pc:docMk/>
            <pc:sldMk cId="1576424241" sldId="264"/>
            <ac:spMk id="28" creationId="{10E26CBD-43AB-4354-A608-DCA481B1A090}"/>
          </ac:spMkLst>
        </pc:spChg>
        <pc:spChg chg="add mod">
          <ac:chgData name="Mariam Choker" userId="2da3c07e-7cda-4855-bfb8-6b456bc434e2" providerId="ADAL" clId="{6CE7FB70-BCAF-4715-8389-474814E0D63B}" dt="2024-04-19T12:43:13.809" v="192" actId="1076"/>
          <ac:spMkLst>
            <pc:docMk/>
            <pc:sldMk cId="1576424241" sldId="264"/>
            <ac:spMk id="29" creationId="{8CE2770D-C876-4FF3-B006-EA8E2DE561AD}"/>
          </ac:spMkLst>
        </pc:spChg>
        <pc:spChg chg="add mod">
          <ac:chgData name="Mariam Choker" userId="2da3c07e-7cda-4855-bfb8-6b456bc434e2" providerId="ADAL" clId="{6CE7FB70-BCAF-4715-8389-474814E0D63B}" dt="2024-04-19T13:58:42.630" v="219" actId="1076"/>
          <ac:spMkLst>
            <pc:docMk/>
            <pc:sldMk cId="1576424241" sldId="264"/>
            <ac:spMk id="30" creationId="{8CD677E3-E33D-416A-A1D4-4BD3C54A952D}"/>
          </ac:spMkLst>
        </pc:spChg>
        <pc:spChg chg="add mod">
          <ac:chgData name="Mariam Choker" userId="2da3c07e-7cda-4855-bfb8-6b456bc434e2" providerId="ADAL" clId="{6CE7FB70-BCAF-4715-8389-474814E0D63B}" dt="2024-04-19T13:59:17.777" v="224" actId="1076"/>
          <ac:spMkLst>
            <pc:docMk/>
            <pc:sldMk cId="1576424241" sldId="264"/>
            <ac:spMk id="31" creationId="{8EAC28D4-50AA-4C30-B072-E4FE7EABD2BD}"/>
          </ac:spMkLst>
        </pc:spChg>
        <pc:spChg chg="add mod">
          <ac:chgData name="Mariam Choker" userId="2da3c07e-7cda-4855-bfb8-6b456bc434e2" providerId="ADAL" clId="{6CE7FB70-BCAF-4715-8389-474814E0D63B}" dt="2024-04-19T13:58:34.890" v="218" actId="1076"/>
          <ac:spMkLst>
            <pc:docMk/>
            <pc:sldMk cId="1576424241" sldId="264"/>
            <ac:spMk id="32" creationId="{A993A0DD-7C23-49F6-ADD4-F88975171C42}"/>
          </ac:spMkLst>
        </pc:spChg>
        <pc:spChg chg="add mod">
          <ac:chgData name="Mariam Choker" userId="2da3c07e-7cda-4855-bfb8-6b456bc434e2" providerId="ADAL" clId="{6CE7FB70-BCAF-4715-8389-474814E0D63B}" dt="2024-04-19T13:59:23.112" v="225" actId="1076"/>
          <ac:spMkLst>
            <pc:docMk/>
            <pc:sldMk cId="1576424241" sldId="264"/>
            <ac:spMk id="33" creationId="{7C92F475-3629-4746-8B39-49C0D58B6867}"/>
          </ac:spMkLst>
        </pc:spChg>
        <pc:spChg chg="add mod">
          <ac:chgData name="Mariam Choker" userId="2da3c07e-7cda-4855-bfb8-6b456bc434e2" providerId="ADAL" clId="{6CE7FB70-BCAF-4715-8389-474814E0D63B}" dt="2024-04-19T14:04:02.780" v="254" actId="1076"/>
          <ac:spMkLst>
            <pc:docMk/>
            <pc:sldMk cId="1576424241" sldId="264"/>
            <ac:spMk id="34" creationId="{97367327-3AC1-475D-B3E3-6B47FEBA5828}"/>
          </ac:spMkLst>
        </pc:spChg>
        <pc:spChg chg="add mod">
          <ac:chgData name="Mariam Choker" userId="2da3c07e-7cda-4855-bfb8-6b456bc434e2" providerId="ADAL" clId="{6CE7FB70-BCAF-4715-8389-474814E0D63B}" dt="2024-04-19T14:00:11.302" v="231" actId="1076"/>
          <ac:spMkLst>
            <pc:docMk/>
            <pc:sldMk cId="1576424241" sldId="264"/>
            <ac:spMk id="35" creationId="{EE41AB95-5545-4156-90E1-52609438B501}"/>
          </ac:spMkLst>
        </pc:spChg>
        <pc:spChg chg="add mod">
          <ac:chgData name="Mariam Choker" userId="2da3c07e-7cda-4855-bfb8-6b456bc434e2" providerId="ADAL" clId="{6CE7FB70-BCAF-4715-8389-474814E0D63B}" dt="2024-04-19T14:00:05.276" v="230" actId="1076"/>
          <ac:spMkLst>
            <pc:docMk/>
            <pc:sldMk cId="1576424241" sldId="264"/>
            <ac:spMk id="36" creationId="{76D50A4B-4593-49DF-A6C6-B00A100B9192}"/>
          </ac:spMkLst>
        </pc:spChg>
        <pc:spChg chg="add mod">
          <ac:chgData name="Mariam Choker" userId="2da3c07e-7cda-4855-bfb8-6b456bc434e2" providerId="ADAL" clId="{6CE7FB70-BCAF-4715-8389-474814E0D63B}" dt="2024-04-19T12:43:08.106" v="191" actId="1076"/>
          <ac:spMkLst>
            <pc:docMk/>
            <pc:sldMk cId="1576424241" sldId="264"/>
            <ac:spMk id="37" creationId="{27EE103F-AE89-4915-8150-0152C3747F83}"/>
          </ac:spMkLst>
        </pc:spChg>
        <pc:spChg chg="add mod">
          <ac:chgData name="Mariam Choker" userId="2da3c07e-7cda-4855-bfb8-6b456bc434e2" providerId="ADAL" clId="{6CE7FB70-BCAF-4715-8389-474814E0D63B}" dt="2024-04-19T12:43:03.926" v="190" actId="1076"/>
          <ac:spMkLst>
            <pc:docMk/>
            <pc:sldMk cId="1576424241" sldId="264"/>
            <ac:spMk id="38" creationId="{D9438360-1CEE-41A7-89C9-165A9E3CE920}"/>
          </ac:spMkLst>
        </pc:spChg>
        <pc:spChg chg="add mod">
          <ac:chgData name="Mariam Choker" userId="2da3c07e-7cda-4855-bfb8-6b456bc434e2" providerId="ADAL" clId="{6CE7FB70-BCAF-4715-8389-474814E0D63B}" dt="2024-04-19T13:56:44.197" v="205" actId="1076"/>
          <ac:spMkLst>
            <pc:docMk/>
            <pc:sldMk cId="1576424241" sldId="264"/>
            <ac:spMk id="39" creationId="{C90A9254-C6C5-4A94-9173-6F0FF6EF737E}"/>
          </ac:spMkLst>
        </pc:spChg>
        <pc:spChg chg="add mod">
          <ac:chgData name="Mariam Choker" userId="2da3c07e-7cda-4855-bfb8-6b456bc434e2" providerId="ADAL" clId="{6CE7FB70-BCAF-4715-8389-474814E0D63B}" dt="2024-04-19T13:57:55.749" v="215" actId="1076"/>
          <ac:spMkLst>
            <pc:docMk/>
            <pc:sldMk cId="1576424241" sldId="264"/>
            <ac:spMk id="40" creationId="{51F44403-469B-4C97-8647-7322239898E7}"/>
          </ac:spMkLst>
        </pc:spChg>
        <pc:spChg chg="add mod">
          <ac:chgData name="Mariam Choker" userId="2da3c07e-7cda-4855-bfb8-6b456bc434e2" providerId="ADAL" clId="{6CE7FB70-BCAF-4715-8389-474814E0D63B}" dt="2024-04-19T13:57:46.471" v="214" actId="1076"/>
          <ac:spMkLst>
            <pc:docMk/>
            <pc:sldMk cId="1576424241" sldId="264"/>
            <ac:spMk id="41" creationId="{A32FAB2F-7FFE-488D-82A3-3FF08053F26F}"/>
          </ac:spMkLst>
        </pc:spChg>
        <pc:spChg chg="add mod">
          <ac:chgData name="Mariam Choker" userId="2da3c07e-7cda-4855-bfb8-6b456bc434e2" providerId="ADAL" clId="{6CE7FB70-BCAF-4715-8389-474814E0D63B}" dt="2024-04-19T13:58:00.942" v="216" actId="1076"/>
          <ac:spMkLst>
            <pc:docMk/>
            <pc:sldMk cId="1576424241" sldId="264"/>
            <ac:spMk id="42" creationId="{40D678F8-6AC2-4D2E-A855-7B149967D6AF}"/>
          </ac:spMkLst>
        </pc:spChg>
        <pc:spChg chg="add mod">
          <ac:chgData name="Mariam Choker" userId="2da3c07e-7cda-4855-bfb8-6b456bc434e2" providerId="ADAL" clId="{6CE7FB70-BCAF-4715-8389-474814E0D63B}" dt="2024-04-19T13:57:21.266" v="210" actId="1076"/>
          <ac:spMkLst>
            <pc:docMk/>
            <pc:sldMk cId="1576424241" sldId="264"/>
            <ac:spMk id="43" creationId="{0CDA4F6C-2D94-4294-9F6F-1977C1AF24B6}"/>
          </ac:spMkLst>
        </pc:spChg>
        <pc:spChg chg="add mod">
          <ac:chgData name="Mariam Choker" userId="2da3c07e-7cda-4855-bfb8-6b456bc434e2" providerId="ADAL" clId="{6CE7FB70-BCAF-4715-8389-474814E0D63B}" dt="2024-04-19T13:56:52.366" v="206" actId="1076"/>
          <ac:spMkLst>
            <pc:docMk/>
            <pc:sldMk cId="1576424241" sldId="264"/>
            <ac:spMk id="44" creationId="{10F031DE-F540-4AC7-BEFA-7EEBC8BC3580}"/>
          </ac:spMkLst>
        </pc:spChg>
        <pc:spChg chg="add mod">
          <ac:chgData name="Mariam Choker" userId="2da3c07e-7cda-4855-bfb8-6b456bc434e2" providerId="ADAL" clId="{6CE7FB70-BCAF-4715-8389-474814E0D63B}" dt="2024-04-19T13:57:05.756" v="207" actId="1076"/>
          <ac:spMkLst>
            <pc:docMk/>
            <pc:sldMk cId="1576424241" sldId="264"/>
            <ac:spMk id="45" creationId="{53E0C20A-CEBD-4035-BE87-5C05AA99B7C7}"/>
          </ac:spMkLst>
        </pc:spChg>
        <pc:spChg chg="add mod">
          <ac:chgData name="Mariam Choker" userId="2da3c07e-7cda-4855-bfb8-6b456bc434e2" providerId="ADAL" clId="{6CE7FB70-BCAF-4715-8389-474814E0D63B}" dt="2024-04-19T13:59:41.674" v="226" actId="1076"/>
          <ac:spMkLst>
            <pc:docMk/>
            <pc:sldMk cId="1576424241" sldId="264"/>
            <ac:spMk id="46" creationId="{5FCAE949-AE60-4574-A8A4-B6535D996D58}"/>
          </ac:spMkLst>
        </pc:spChg>
        <pc:spChg chg="add mod">
          <ac:chgData name="Mariam Choker" userId="2da3c07e-7cda-4855-bfb8-6b456bc434e2" providerId="ADAL" clId="{6CE7FB70-BCAF-4715-8389-474814E0D63B}" dt="2024-04-19T13:56:38.982" v="204" actId="1076"/>
          <ac:spMkLst>
            <pc:docMk/>
            <pc:sldMk cId="1576424241" sldId="264"/>
            <ac:spMk id="47" creationId="{B56BC5CD-87DE-490E-B402-E8B90136D6E3}"/>
          </ac:spMkLst>
        </pc:spChg>
        <pc:spChg chg="add mod">
          <ac:chgData name="Mariam Choker" userId="2da3c07e-7cda-4855-bfb8-6b456bc434e2" providerId="ADAL" clId="{6CE7FB70-BCAF-4715-8389-474814E0D63B}" dt="2024-04-19T12:42:48.148" v="188" actId="1076"/>
          <ac:spMkLst>
            <pc:docMk/>
            <pc:sldMk cId="1576424241" sldId="264"/>
            <ac:spMk id="48" creationId="{774C0575-AF73-41B2-A1F1-007E20A96C6A}"/>
          </ac:spMkLst>
        </pc:spChg>
        <pc:spChg chg="add mod">
          <ac:chgData name="Mariam Choker" userId="2da3c07e-7cda-4855-bfb8-6b456bc434e2" providerId="ADAL" clId="{6CE7FB70-BCAF-4715-8389-474814E0D63B}" dt="2024-04-19T12:42:58.663" v="189" actId="1076"/>
          <ac:spMkLst>
            <pc:docMk/>
            <pc:sldMk cId="1576424241" sldId="264"/>
            <ac:spMk id="49" creationId="{A18D5E67-949E-46A0-BFDC-DCFFFD3A307B}"/>
          </ac:spMkLst>
        </pc:spChg>
        <pc:spChg chg="add mod">
          <ac:chgData name="Mariam Choker" userId="2da3c07e-7cda-4855-bfb8-6b456bc434e2" providerId="ADAL" clId="{6CE7FB70-BCAF-4715-8389-474814E0D63B}" dt="2024-04-19T13:56:28.092" v="202" actId="1076"/>
          <ac:spMkLst>
            <pc:docMk/>
            <pc:sldMk cId="1576424241" sldId="264"/>
            <ac:spMk id="50" creationId="{C91B16F2-A367-468F-A98C-6A104F41011A}"/>
          </ac:spMkLst>
        </pc:spChg>
        <pc:spChg chg="add mod">
          <ac:chgData name="Mariam Choker" userId="2da3c07e-7cda-4855-bfb8-6b456bc434e2" providerId="ADAL" clId="{6CE7FB70-BCAF-4715-8389-474814E0D63B}" dt="2024-04-19T13:56:33.080" v="203" actId="1076"/>
          <ac:spMkLst>
            <pc:docMk/>
            <pc:sldMk cId="1576424241" sldId="264"/>
            <ac:spMk id="51" creationId="{3E3D50EC-08AB-4C8D-BB08-0AECCC935273}"/>
          </ac:spMkLst>
        </pc:spChg>
        <pc:spChg chg="add mod">
          <ac:chgData name="Mariam Choker" userId="2da3c07e-7cda-4855-bfb8-6b456bc434e2" providerId="ADAL" clId="{6CE7FB70-BCAF-4715-8389-474814E0D63B}" dt="2024-04-19T13:56:14.466" v="200" actId="1076"/>
          <ac:spMkLst>
            <pc:docMk/>
            <pc:sldMk cId="1576424241" sldId="264"/>
            <ac:spMk id="52" creationId="{F5CF0EFB-57BB-40B7-B502-1D5C6BD22F65}"/>
          </ac:spMkLst>
        </pc:spChg>
        <pc:spChg chg="add mod">
          <ac:chgData name="Mariam Choker" userId="2da3c07e-7cda-4855-bfb8-6b456bc434e2" providerId="ADAL" clId="{6CE7FB70-BCAF-4715-8389-474814E0D63B}" dt="2024-04-19T13:56:20.455" v="201" actId="1076"/>
          <ac:spMkLst>
            <pc:docMk/>
            <pc:sldMk cId="1576424241" sldId="264"/>
            <ac:spMk id="53" creationId="{E902B292-0DFE-4CED-9835-E41D752B3379}"/>
          </ac:spMkLst>
        </pc:spChg>
        <pc:spChg chg="add mod">
          <ac:chgData name="Mariam Choker" userId="2da3c07e-7cda-4855-bfb8-6b456bc434e2" providerId="ADAL" clId="{6CE7FB70-BCAF-4715-8389-474814E0D63B}" dt="2024-04-19T13:55:55.373" v="199" actId="1076"/>
          <ac:spMkLst>
            <pc:docMk/>
            <pc:sldMk cId="1576424241" sldId="264"/>
            <ac:spMk id="54" creationId="{F7393B63-4ABA-4303-8CFE-EB603D0A1CC1}"/>
          </ac:spMkLst>
        </pc:spChg>
        <pc:spChg chg="add mod">
          <ac:chgData name="Mariam Choker" userId="2da3c07e-7cda-4855-bfb8-6b456bc434e2" providerId="ADAL" clId="{6CE7FB70-BCAF-4715-8389-474814E0D63B}" dt="2024-04-19T14:03:58.810" v="253" actId="1076"/>
          <ac:spMkLst>
            <pc:docMk/>
            <pc:sldMk cId="1576424241" sldId="264"/>
            <ac:spMk id="55" creationId="{40DFC5AA-D3E2-4898-8FCF-99541755C850}"/>
          </ac:spMkLst>
        </pc:spChg>
        <pc:spChg chg="add mod">
          <ac:chgData name="Mariam Choker" userId="2da3c07e-7cda-4855-bfb8-6b456bc434e2" providerId="ADAL" clId="{6CE7FB70-BCAF-4715-8389-474814E0D63B}" dt="2024-04-19T14:03:54.200" v="252" actId="1076"/>
          <ac:spMkLst>
            <pc:docMk/>
            <pc:sldMk cId="1576424241" sldId="264"/>
            <ac:spMk id="56" creationId="{0A7E6EE3-A7A7-43F7-B07B-530A048B3804}"/>
          </ac:spMkLst>
        </pc:spChg>
        <pc:spChg chg="add mod">
          <ac:chgData name="Mariam Choker" userId="2da3c07e-7cda-4855-bfb8-6b456bc434e2" providerId="ADAL" clId="{6CE7FB70-BCAF-4715-8389-474814E0D63B}" dt="2024-04-19T14:02:58.894" v="249" actId="1076"/>
          <ac:spMkLst>
            <pc:docMk/>
            <pc:sldMk cId="1576424241" sldId="264"/>
            <ac:spMk id="57" creationId="{537EA97F-1406-43CE-80BA-CE77BD624C3F}"/>
          </ac:spMkLst>
        </pc:spChg>
        <pc:spChg chg="add mod">
          <ac:chgData name="Mariam Choker" userId="2da3c07e-7cda-4855-bfb8-6b456bc434e2" providerId="ADAL" clId="{6CE7FB70-BCAF-4715-8389-474814E0D63B}" dt="2024-04-19T14:03:49.729" v="251" actId="1076"/>
          <ac:spMkLst>
            <pc:docMk/>
            <pc:sldMk cId="1576424241" sldId="264"/>
            <ac:spMk id="58" creationId="{2CB99408-E97F-441A-AF0A-4C162572E6AB}"/>
          </ac:spMkLst>
        </pc:spChg>
        <pc:spChg chg="add mod">
          <ac:chgData name="Mariam Choker" userId="2da3c07e-7cda-4855-bfb8-6b456bc434e2" providerId="ADAL" clId="{6CE7FB70-BCAF-4715-8389-474814E0D63B}" dt="2024-04-19T14:02:53.222" v="248" actId="1076"/>
          <ac:spMkLst>
            <pc:docMk/>
            <pc:sldMk cId="1576424241" sldId="264"/>
            <ac:spMk id="59" creationId="{40EE31AD-34C3-4A17-BB53-C7B43E8A7EF1}"/>
          </ac:spMkLst>
        </pc:spChg>
        <pc:spChg chg="add mod">
          <ac:chgData name="Mariam Choker" userId="2da3c07e-7cda-4855-bfb8-6b456bc434e2" providerId="ADAL" clId="{6CE7FB70-BCAF-4715-8389-474814E0D63B}" dt="2024-04-19T14:02:49.161" v="247" actId="1076"/>
          <ac:spMkLst>
            <pc:docMk/>
            <pc:sldMk cId="1576424241" sldId="264"/>
            <ac:spMk id="60" creationId="{52CE5836-8ECD-45C5-8F95-0952B37452A4}"/>
          </ac:spMkLst>
        </pc:spChg>
        <pc:spChg chg="add mod">
          <ac:chgData name="Mariam Choker" userId="2da3c07e-7cda-4855-bfb8-6b456bc434e2" providerId="ADAL" clId="{6CE7FB70-BCAF-4715-8389-474814E0D63B}" dt="2024-04-19T14:02:44.958" v="246" actId="1076"/>
          <ac:spMkLst>
            <pc:docMk/>
            <pc:sldMk cId="1576424241" sldId="264"/>
            <ac:spMk id="61" creationId="{5B90260A-0937-423B-8199-18CF87C17640}"/>
          </ac:spMkLst>
        </pc:spChg>
        <pc:spChg chg="add mod">
          <ac:chgData name="Mariam Choker" userId="2da3c07e-7cda-4855-bfb8-6b456bc434e2" providerId="ADAL" clId="{6CE7FB70-BCAF-4715-8389-474814E0D63B}" dt="2024-04-19T14:04:49.868" v="266" actId="1076"/>
          <ac:spMkLst>
            <pc:docMk/>
            <pc:sldMk cId="1576424241" sldId="264"/>
            <ac:spMk id="62" creationId="{F0D64F0D-4695-4A1E-A094-0D9C034DD2CB}"/>
          </ac:spMkLst>
        </pc:spChg>
        <pc:spChg chg="add mod">
          <ac:chgData name="Mariam Choker" userId="2da3c07e-7cda-4855-bfb8-6b456bc434e2" providerId="ADAL" clId="{6CE7FB70-BCAF-4715-8389-474814E0D63B}" dt="2024-04-19T14:04:42.654" v="265" actId="1076"/>
          <ac:spMkLst>
            <pc:docMk/>
            <pc:sldMk cId="1576424241" sldId="264"/>
            <ac:spMk id="63" creationId="{02FB52E1-C051-4191-933B-BA1BFCB095E3}"/>
          </ac:spMkLst>
        </pc:spChg>
        <pc:spChg chg="add mod">
          <ac:chgData name="Mariam Choker" userId="2da3c07e-7cda-4855-bfb8-6b456bc434e2" providerId="ADAL" clId="{6CE7FB70-BCAF-4715-8389-474814E0D63B}" dt="2024-04-19T14:04:34.189" v="264" actId="1076"/>
          <ac:spMkLst>
            <pc:docMk/>
            <pc:sldMk cId="1576424241" sldId="264"/>
            <ac:spMk id="64" creationId="{E2CDB316-F027-456F-A8CB-167C8729C67C}"/>
          </ac:spMkLst>
        </pc:spChg>
        <pc:spChg chg="add mod">
          <ac:chgData name="Mariam Choker" userId="2da3c07e-7cda-4855-bfb8-6b456bc434e2" providerId="ADAL" clId="{6CE7FB70-BCAF-4715-8389-474814E0D63B}" dt="2024-04-19T14:04:30.252" v="263" actId="1076"/>
          <ac:spMkLst>
            <pc:docMk/>
            <pc:sldMk cId="1576424241" sldId="264"/>
            <ac:spMk id="65" creationId="{909B96B3-1AA3-49A3-B170-97BFF8E2FD07}"/>
          </ac:spMkLst>
        </pc:spChg>
        <pc:spChg chg="add mod">
          <ac:chgData name="Mariam Choker" userId="2da3c07e-7cda-4855-bfb8-6b456bc434e2" providerId="ADAL" clId="{6CE7FB70-BCAF-4715-8389-474814E0D63B}" dt="2024-04-19T14:04:25.349" v="262" actId="1076"/>
          <ac:spMkLst>
            <pc:docMk/>
            <pc:sldMk cId="1576424241" sldId="264"/>
            <ac:spMk id="66" creationId="{D5FC1E26-48DF-432C-B8BC-AD592777A110}"/>
          </ac:spMkLst>
        </pc:spChg>
        <pc:spChg chg="add mod">
          <ac:chgData name="Mariam Choker" userId="2da3c07e-7cda-4855-bfb8-6b456bc434e2" providerId="ADAL" clId="{6CE7FB70-BCAF-4715-8389-474814E0D63B}" dt="2024-04-19T14:04:18.486" v="261" actId="1076"/>
          <ac:spMkLst>
            <pc:docMk/>
            <pc:sldMk cId="1576424241" sldId="264"/>
            <ac:spMk id="67" creationId="{E0829D55-3417-4A60-9F20-3E1805F4CB24}"/>
          </ac:spMkLst>
        </pc:spChg>
        <pc:spChg chg="add mod">
          <ac:chgData name="Mariam Choker" userId="2da3c07e-7cda-4855-bfb8-6b456bc434e2" providerId="ADAL" clId="{6CE7FB70-BCAF-4715-8389-474814E0D63B}" dt="2024-04-19T14:05:35.744" v="276" actId="1076"/>
          <ac:spMkLst>
            <pc:docMk/>
            <pc:sldMk cId="1576424241" sldId="264"/>
            <ac:spMk id="68" creationId="{00B5D24D-438B-4DDF-8DBF-EF5DF5484D04}"/>
          </ac:spMkLst>
        </pc:spChg>
        <pc:spChg chg="add mod">
          <ac:chgData name="Mariam Choker" userId="2da3c07e-7cda-4855-bfb8-6b456bc434e2" providerId="ADAL" clId="{6CE7FB70-BCAF-4715-8389-474814E0D63B}" dt="2024-04-19T14:05:31.604" v="275" actId="1076"/>
          <ac:spMkLst>
            <pc:docMk/>
            <pc:sldMk cId="1576424241" sldId="264"/>
            <ac:spMk id="69" creationId="{052EBDF6-CBCA-4A5F-B140-FF0D66EB250B}"/>
          </ac:spMkLst>
        </pc:spChg>
        <pc:spChg chg="add mod">
          <ac:chgData name="Mariam Choker" userId="2da3c07e-7cda-4855-bfb8-6b456bc434e2" providerId="ADAL" clId="{6CE7FB70-BCAF-4715-8389-474814E0D63B}" dt="2024-04-19T14:05:26.021" v="274" actId="1076"/>
          <ac:spMkLst>
            <pc:docMk/>
            <pc:sldMk cId="1576424241" sldId="264"/>
            <ac:spMk id="70" creationId="{16348884-B01C-42AF-96BE-7DC8E322DCB3}"/>
          </ac:spMkLst>
        </pc:spChg>
        <pc:spChg chg="add mod">
          <ac:chgData name="Mariam Choker" userId="2da3c07e-7cda-4855-bfb8-6b456bc434e2" providerId="ADAL" clId="{6CE7FB70-BCAF-4715-8389-474814E0D63B}" dt="2024-04-19T14:05:21.298" v="273" actId="1076"/>
          <ac:spMkLst>
            <pc:docMk/>
            <pc:sldMk cId="1576424241" sldId="264"/>
            <ac:spMk id="71" creationId="{15B03DAD-A685-4703-ADEB-4495CB813C3D}"/>
          </ac:spMkLst>
        </pc:spChg>
        <pc:spChg chg="add mod">
          <ac:chgData name="Mariam Choker" userId="2da3c07e-7cda-4855-bfb8-6b456bc434e2" providerId="ADAL" clId="{6CE7FB70-BCAF-4715-8389-474814E0D63B}" dt="2024-04-19T14:05:05.839" v="272" actId="1076"/>
          <ac:spMkLst>
            <pc:docMk/>
            <pc:sldMk cId="1576424241" sldId="264"/>
            <ac:spMk id="72" creationId="{A2F563C3-D05D-474B-9D61-14FD22FA83EC}"/>
          </ac:spMkLst>
        </pc:spChg>
        <pc:spChg chg="add del mod">
          <ac:chgData name="Mariam Choker" userId="2da3c07e-7cda-4855-bfb8-6b456bc434e2" providerId="ADAL" clId="{6CE7FB70-BCAF-4715-8389-474814E0D63B}" dt="2024-04-19T15:30:48.022" v="778" actId="478"/>
          <ac:spMkLst>
            <pc:docMk/>
            <pc:sldMk cId="1576424241" sldId="264"/>
            <ac:spMk id="73" creationId="{FB63B691-5A8E-4BFC-8000-7F2F44CABB98}"/>
          </ac:spMkLst>
        </pc:spChg>
        <pc:spChg chg="add del mod">
          <ac:chgData name="Mariam Choker" userId="2da3c07e-7cda-4855-bfb8-6b456bc434e2" providerId="ADAL" clId="{6CE7FB70-BCAF-4715-8389-474814E0D63B}" dt="2024-04-19T15:30:48.022" v="778" actId="478"/>
          <ac:spMkLst>
            <pc:docMk/>
            <pc:sldMk cId="1576424241" sldId="264"/>
            <ac:spMk id="74" creationId="{2CAF9014-587A-4218-9121-13BDC61D3F34}"/>
          </ac:spMkLst>
        </pc:spChg>
        <pc:spChg chg="add del mod">
          <ac:chgData name="Mariam Choker" userId="2da3c07e-7cda-4855-bfb8-6b456bc434e2" providerId="ADAL" clId="{6CE7FB70-BCAF-4715-8389-474814E0D63B}" dt="2024-04-19T15:30:48.022" v="778" actId="478"/>
          <ac:spMkLst>
            <pc:docMk/>
            <pc:sldMk cId="1576424241" sldId="264"/>
            <ac:spMk id="75" creationId="{FCB48104-79B9-4D7A-8B0C-97DF6AEED0BB}"/>
          </ac:spMkLst>
        </pc:spChg>
        <pc:spChg chg="add mod">
          <ac:chgData name="Mariam Choker" userId="2da3c07e-7cda-4855-bfb8-6b456bc434e2" providerId="ADAL" clId="{6CE7FB70-BCAF-4715-8389-474814E0D63B}" dt="2024-04-19T15:27:45.234" v="777" actId="1076"/>
          <ac:spMkLst>
            <pc:docMk/>
            <pc:sldMk cId="1576424241" sldId="264"/>
            <ac:spMk id="76" creationId="{D821DAC9-3325-4E1E-94A5-699A73562D98}"/>
          </ac:spMkLst>
        </pc:spChg>
        <pc:spChg chg="add mod">
          <ac:chgData name="Mariam Choker" userId="2da3c07e-7cda-4855-bfb8-6b456bc434e2" providerId="ADAL" clId="{6CE7FB70-BCAF-4715-8389-474814E0D63B}" dt="2024-04-19T15:07:40.536" v="752" actId="1076"/>
          <ac:spMkLst>
            <pc:docMk/>
            <pc:sldMk cId="1576424241" sldId="264"/>
            <ac:spMk id="77" creationId="{F5FE569C-F16C-451E-A8A4-54AC7D2C60FD}"/>
          </ac:spMkLst>
        </pc:spChg>
        <pc:spChg chg="add del mod">
          <ac:chgData name="Mariam Choker" userId="2da3c07e-7cda-4855-bfb8-6b456bc434e2" providerId="ADAL" clId="{6CE7FB70-BCAF-4715-8389-474814E0D63B}" dt="2024-04-19T15:10:24.490" v="760" actId="478"/>
          <ac:spMkLst>
            <pc:docMk/>
            <pc:sldMk cId="1576424241" sldId="264"/>
            <ac:spMk id="78" creationId="{C0A6902B-6799-4345-A80B-039AE5357668}"/>
          </ac:spMkLst>
        </pc:spChg>
        <pc:spChg chg="add mod">
          <ac:chgData name="Mariam Choker" userId="2da3c07e-7cda-4855-bfb8-6b456bc434e2" providerId="ADAL" clId="{6CE7FB70-BCAF-4715-8389-474814E0D63B}" dt="2024-04-19T15:15:16.755" v="764" actId="1076"/>
          <ac:spMkLst>
            <pc:docMk/>
            <pc:sldMk cId="1576424241" sldId="264"/>
            <ac:spMk id="79" creationId="{705A835E-7BA2-4308-9CF8-4F6B898FAA71}"/>
          </ac:spMkLst>
        </pc:spChg>
        <pc:spChg chg="add del mod">
          <ac:chgData name="Mariam Choker" userId="2da3c07e-7cda-4855-bfb8-6b456bc434e2" providerId="ADAL" clId="{6CE7FB70-BCAF-4715-8389-474814E0D63B}" dt="2024-04-19T15:14:27.826" v="763" actId="478"/>
          <ac:spMkLst>
            <pc:docMk/>
            <pc:sldMk cId="1576424241" sldId="264"/>
            <ac:spMk id="80" creationId="{D9C2E425-207C-4E41-A57E-15D19D78C6A7}"/>
          </ac:spMkLst>
        </pc:spChg>
        <pc:spChg chg="add mod">
          <ac:chgData name="Mariam Choker" userId="2da3c07e-7cda-4855-bfb8-6b456bc434e2" providerId="ADAL" clId="{6CE7FB70-BCAF-4715-8389-474814E0D63B}" dt="2024-04-19T15:08:09.505" v="759" actId="1076"/>
          <ac:spMkLst>
            <pc:docMk/>
            <pc:sldMk cId="1576424241" sldId="264"/>
            <ac:spMk id="81" creationId="{28B72C28-D752-4498-8AFF-1A6A68282C99}"/>
          </ac:spMkLst>
        </pc:spChg>
        <pc:spChg chg="add del mod">
          <ac:chgData name="Mariam Choker" userId="2da3c07e-7cda-4855-bfb8-6b456bc434e2" providerId="ADAL" clId="{6CE7FB70-BCAF-4715-8389-474814E0D63B}" dt="2024-04-19T15:10:27.678" v="761" actId="478"/>
          <ac:spMkLst>
            <pc:docMk/>
            <pc:sldMk cId="1576424241" sldId="264"/>
            <ac:spMk id="82" creationId="{D5770D7B-957E-4F1C-BA77-C6F5274929C1}"/>
          </ac:spMkLst>
        </pc:spChg>
        <pc:spChg chg="add mod">
          <ac:chgData name="Mariam Choker" userId="2da3c07e-7cda-4855-bfb8-6b456bc434e2" providerId="ADAL" clId="{6CE7FB70-BCAF-4715-8389-474814E0D63B}" dt="2024-04-19T15:27:11.430" v="776" actId="1076"/>
          <ac:spMkLst>
            <pc:docMk/>
            <pc:sldMk cId="1576424241" sldId="264"/>
            <ac:spMk id="83" creationId="{2AABA839-6C17-439D-B129-E28C289C8AF0}"/>
          </ac:spMkLst>
        </pc:spChg>
        <pc:spChg chg="add mod">
          <ac:chgData name="Mariam Choker" userId="2da3c07e-7cda-4855-bfb8-6b456bc434e2" providerId="ADAL" clId="{6CE7FB70-BCAF-4715-8389-474814E0D63B}" dt="2024-04-19T15:27:06.135" v="775" actId="1076"/>
          <ac:spMkLst>
            <pc:docMk/>
            <pc:sldMk cId="1576424241" sldId="264"/>
            <ac:spMk id="84" creationId="{1ECAACFF-C159-481E-9701-E264ABBE0981}"/>
          </ac:spMkLst>
        </pc:spChg>
        <pc:spChg chg="add mod">
          <ac:chgData name="Mariam Choker" userId="2da3c07e-7cda-4855-bfb8-6b456bc434e2" providerId="ADAL" clId="{6CE7FB70-BCAF-4715-8389-474814E0D63B}" dt="2024-04-19T15:17:47.287" v="772" actId="1076"/>
          <ac:spMkLst>
            <pc:docMk/>
            <pc:sldMk cId="1576424241" sldId="264"/>
            <ac:spMk id="85" creationId="{93E42EF3-B1F0-4BFC-88E9-6A550047BD15}"/>
          </ac:spMkLst>
        </pc:spChg>
        <pc:spChg chg="add del mod">
          <ac:chgData name="Mariam Choker" userId="2da3c07e-7cda-4855-bfb8-6b456bc434e2" providerId="ADAL" clId="{6CE7FB70-BCAF-4715-8389-474814E0D63B}" dt="2024-04-19T15:25:47.834" v="774" actId="478"/>
          <ac:spMkLst>
            <pc:docMk/>
            <pc:sldMk cId="1576424241" sldId="264"/>
            <ac:spMk id="86" creationId="{C05C8D82-9D7A-4AE3-9EEA-A006105A91F9}"/>
          </ac:spMkLst>
        </pc:spChg>
        <pc:spChg chg="add mod">
          <ac:chgData name="Mariam Choker" userId="2da3c07e-7cda-4855-bfb8-6b456bc434e2" providerId="ADAL" clId="{6CE7FB70-BCAF-4715-8389-474814E0D63B}" dt="2024-04-19T15:16:11.926" v="770" actId="1076"/>
          <ac:spMkLst>
            <pc:docMk/>
            <pc:sldMk cId="1576424241" sldId="264"/>
            <ac:spMk id="87" creationId="{93EB621F-719E-41CF-A57C-81ACC3694ADC}"/>
          </ac:spMkLst>
        </pc:spChg>
        <pc:spChg chg="add mod">
          <ac:chgData name="Mariam Choker" userId="2da3c07e-7cda-4855-bfb8-6b456bc434e2" providerId="ADAL" clId="{6CE7FB70-BCAF-4715-8389-474814E0D63B}" dt="2024-04-19T15:16:06.988" v="769" actId="1076"/>
          <ac:spMkLst>
            <pc:docMk/>
            <pc:sldMk cId="1576424241" sldId="264"/>
            <ac:spMk id="88" creationId="{F920A518-CB65-4F4E-A848-E86A06554CB5}"/>
          </ac:spMkLst>
        </pc:spChg>
        <pc:spChg chg="add mod">
          <ac:chgData name="Mariam Choker" userId="2da3c07e-7cda-4855-bfb8-6b456bc434e2" providerId="ADAL" clId="{6CE7FB70-BCAF-4715-8389-474814E0D63B}" dt="2024-04-19T15:33:44.422" v="780" actId="1076"/>
          <ac:spMkLst>
            <pc:docMk/>
            <pc:sldMk cId="1576424241" sldId="264"/>
            <ac:spMk id="89" creationId="{DE2541D6-F95C-4864-BBB3-2BC9C31F6F3D}"/>
          </ac:spMkLst>
        </pc:spChg>
        <pc:graphicFrameChg chg="add mod">
          <ac:chgData name="Mariam Choker" userId="2da3c07e-7cda-4855-bfb8-6b456bc434e2" providerId="ADAL" clId="{6CE7FB70-BCAF-4715-8389-474814E0D63B}" dt="2024-04-19T12:04:27.961" v="62"/>
          <ac:graphicFrameMkLst>
            <pc:docMk/>
            <pc:sldMk cId="1576424241" sldId="264"/>
            <ac:graphicFrameMk id="2" creationId="{B3A03C94-43C2-450C-948A-CE5FAA48D91D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2:04:20.431" v="60"/>
          <ac:graphicFrameMkLst>
            <pc:docMk/>
            <pc:sldMk cId="1576424241" sldId="264"/>
            <ac:graphicFrameMk id="3" creationId="{527B4430-F973-43B3-9886-2799B83C5B23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2:04:23.355" v="61"/>
          <ac:graphicFrameMkLst>
            <pc:docMk/>
            <pc:sldMk cId="1576424241" sldId="264"/>
            <ac:graphicFrameMk id="4" creationId="{7E2E0133-EFC6-4B83-9BE1-290AE3AA953B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5:24:22.071" v="773"/>
          <ac:graphicFrameMkLst>
            <pc:docMk/>
            <pc:sldMk cId="1576424241" sldId="264"/>
            <ac:graphicFrameMk id="5" creationId="{6D7BB03C-B5CE-457F-9C8B-DAC51F3ABBE2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2:04:16.169" v="59"/>
          <ac:graphicFrameMkLst>
            <pc:docMk/>
            <pc:sldMk cId="1576424241" sldId="264"/>
            <ac:graphicFrameMk id="6" creationId="{8D4D887D-3291-40BB-9D49-1A5DFAA30124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2:04:07.224" v="58"/>
          <ac:graphicFrameMkLst>
            <pc:docMk/>
            <pc:sldMk cId="1576424241" sldId="264"/>
            <ac:graphicFrameMk id="7" creationId="{9A36E1B0-EBB5-464C-921D-B7D44C9EDC81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5:34:48.934" v="783"/>
          <ac:graphicFrameMkLst>
            <pc:docMk/>
            <pc:sldMk cId="1576424241" sldId="264"/>
            <ac:graphicFrameMk id="8" creationId="{D9D8FBCA-76DF-478D-8FEC-DA7C09E1C9DB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2:05:31.657" v="75"/>
          <ac:graphicFrameMkLst>
            <pc:docMk/>
            <pc:sldMk cId="1576424241" sldId="264"/>
            <ac:graphicFrameMk id="9" creationId="{BE8DE84C-A427-4B54-AB93-70EE9282EDD7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4:51.020" v="511"/>
          <ac:graphicFrameMkLst>
            <pc:docMk/>
            <pc:sldMk cId="1576424241" sldId="264"/>
            <ac:graphicFrameMk id="10" creationId="{D29714B6-7E53-456E-BFE0-C2C9277479F9}"/>
          </ac:graphicFrameMkLst>
        </pc:graphicFrameChg>
      </pc:sldChg>
      <pc:sldChg chg="addSp modSp new mod">
        <pc:chgData name="Mariam Choker" userId="2da3c07e-7cda-4855-bfb8-6b456bc434e2" providerId="ADAL" clId="{6CE7FB70-BCAF-4715-8389-474814E0D63B}" dt="2024-04-19T14:24:10.699" v="501" actId="14100"/>
        <pc:sldMkLst>
          <pc:docMk/>
          <pc:sldMk cId="906996360" sldId="265"/>
        </pc:sldMkLst>
        <pc:graphicFrameChg chg="add mod">
          <ac:chgData name="Mariam Choker" userId="2da3c07e-7cda-4855-bfb8-6b456bc434e2" providerId="ADAL" clId="{6CE7FB70-BCAF-4715-8389-474814E0D63B}" dt="2024-04-19T14:13:16.352" v="352" actId="14100"/>
          <ac:graphicFrameMkLst>
            <pc:docMk/>
            <pc:sldMk cId="906996360" sldId="265"/>
            <ac:graphicFrameMk id="2" creationId="{F3288497-C490-43E5-AD54-61F58614CE32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2:53.655" v="348"/>
          <ac:graphicFrameMkLst>
            <pc:docMk/>
            <pc:sldMk cId="906996360" sldId="265"/>
            <ac:graphicFrameMk id="3" creationId="{9BD922AC-13D6-4A3F-A40B-7FA9534EF08F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2:48.684" v="347"/>
          <ac:graphicFrameMkLst>
            <pc:docMk/>
            <pc:sldMk cId="906996360" sldId="265"/>
            <ac:graphicFrameMk id="4" creationId="{C63AE950-D659-479D-B7D7-46DC37574E7A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3:36.226" v="356"/>
          <ac:graphicFrameMkLst>
            <pc:docMk/>
            <pc:sldMk cId="906996360" sldId="265"/>
            <ac:graphicFrameMk id="5" creationId="{A27FD5AC-EEEE-45CC-A434-FE30321D8500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3:58.142" v="362" actId="14100"/>
          <ac:graphicFrameMkLst>
            <pc:docMk/>
            <pc:sldMk cId="906996360" sldId="265"/>
            <ac:graphicFrameMk id="6" creationId="{469E52AC-890E-4E9A-9CE7-8C4F8AE858EF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5:17.580" v="381" actId="14100"/>
          <ac:graphicFrameMkLst>
            <pc:docMk/>
            <pc:sldMk cId="906996360" sldId="265"/>
            <ac:graphicFrameMk id="7" creationId="{22C3F4F6-0B2D-4493-96AE-2977F9D974EF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3:49.264" v="495" actId="20577"/>
          <ac:graphicFrameMkLst>
            <pc:docMk/>
            <pc:sldMk cId="906996360" sldId="265"/>
            <ac:graphicFrameMk id="8" creationId="{02799F0B-B972-4E8F-864A-D58F1FF34DB5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6:03.571" v="392"/>
          <ac:graphicFrameMkLst>
            <pc:docMk/>
            <pc:sldMk cId="906996360" sldId="265"/>
            <ac:graphicFrameMk id="9" creationId="{25CBF0C7-15C3-4F36-BC62-CEB79F8B36F0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4:10.699" v="501" actId="14100"/>
          <ac:graphicFrameMkLst>
            <pc:docMk/>
            <pc:sldMk cId="906996360" sldId="265"/>
            <ac:graphicFrameMk id="10" creationId="{76298811-BAAF-4FD2-9D00-7A77070915CF}"/>
          </ac:graphicFrameMkLst>
        </pc:graphicFrameChg>
      </pc:sldChg>
      <pc:sldChg chg="addSp delSp modSp new mod">
        <pc:chgData name="Mariam Choker" userId="2da3c07e-7cda-4855-bfb8-6b456bc434e2" providerId="ADAL" clId="{6CE7FB70-BCAF-4715-8389-474814E0D63B}" dt="2024-04-19T14:40:46.439" v="636" actId="478"/>
        <pc:sldMkLst>
          <pc:docMk/>
          <pc:sldMk cId="4099532361" sldId="266"/>
        </pc:sldMkLst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1" creationId="{AE4F7BA5-3783-448A-AA83-7EC9674FBF91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2" creationId="{196C6B17-586E-46F0-8CB7-BB89A857407D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3" creationId="{7E64A81C-32EA-4EBB-8051-A7454DE6E958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4" creationId="{BD126627-F5E8-4FCA-BFA0-DD843D4565A6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5" creationId="{79AAB943-90A5-4E68-8C17-1E1A5EF8E879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6" creationId="{F73C3E8F-CD37-4931-A998-74AEAD00A62E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7" creationId="{B45106DE-9968-47B3-8BA0-2A728591AC29}"/>
          </ac:spMkLst>
        </pc:spChg>
        <pc:spChg chg="add del mod">
          <ac:chgData name="Mariam Choker" userId="2da3c07e-7cda-4855-bfb8-6b456bc434e2" providerId="ADAL" clId="{6CE7FB70-BCAF-4715-8389-474814E0D63B}" dt="2024-04-19T14:40:46.439" v="636" actId="478"/>
          <ac:spMkLst>
            <pc:docMk/>
            <pc:sldMk cId="4099532361" sldId="266"/>
            <ac:spMk id="18" creationId="{39A2CAFA-3567-4DF1-80EB-201C5FE02A0F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19" creationId="{92634455-57EA-4476-A630-DD0AC626787F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0" creationId="{4D3E52BA-B21F-4268-BD7A-3AA0ABE0B74F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1" creationId="{4128C685-1C3B-46FD-9664-6333C1CCACA8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2" creationId="{5CC46CE7-1EEB-4800-882F-9CBF9C310AA3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3" creationId="{A8D71E17-2796-4F76-90DE-D6ECCD7356A6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4" creationId="{FF191B5B-C9BB-4E04-83EB-E976718AF9EB}"/>
          </ac:spMkLst>
        </pc:spChg>
        <pc:spChg chg="add del mod">
          <ac:chgData name="Mariam Choker" userId="2da3c07e-7cda-4855-bfb8-6b456bc434e2" providerId="ADAL" clId="{6CE7FB70-BCAF-4715-8389-474814E0D63B}" dt="2024-04-19T14:40:44.929" v="635" actId="478"/>
          <ac:spMkLst>
            <pc:docMk/>
            <pc:sldMk cId="4099532361" sldId="266"/>
            <ac:spMk id="25" creationId="{6CE40608-C72C-425E-95CF-ACA432D64CD0}"/>
          </ac:spMkLst>
        </pc:spChg>
        <pc:spChg chg="add mod">
          <ac:chgData name="Mariam Choker" userId="2da3c07e-7cda-4855-bfb8-6b456bc434e2" providerId="ADAL" clId="{6CE7FB70-BCAF-4715-8389-474814E0D63B}" dt="2024-04-19T14:40:35.024" v="634" actId="1076"/>
          <ac:spMkLst>
            <pc:docMk/>
            <pc:sldMk cId="4099532361" sldId="266"/>
            <ac:spMk id="26" creationId="{BD573C38-0F78-4777-9D7D-702A929CBBAA}"/>
          </ac:spMkLst>
        </pc:spChg>
        <pc:spChg chg="add mod">
          <ac:chgData name="Mariam Choker" userId="2da3c07e-7cda-4855-bfb8-6b456bc434e2" providerId="ADAL" clId="{6CE7FB70-BCAF-4715-8389-474814E0D63B}" dt="2024-04-19T14:38:27.480" v="625" actId="1076"/>
          <ac:spMkLst>
            <pc:docMk/>
            <pc:sldMk cId="4099532361" sldId="266"/>
            <ac:spMk id="27" creationId="{933942AE-BDB9-4F8F-94D7-647956578969}"/>
          </ac:spMkLst>
        </pc:spChg>
        <pc:spChg chg="add mod">
          <ac:chgData name="Mariam Choker" userId="2da3c07e-7cda-4855-bfb8-6b456bc434e2" providerId="ADAL" clId="{6CE7FB70-BCAF-4715-8389-474814E0D63B}" dt="2024-04-19T14:40:19.665" v="632" actId="1076"/>
          <ac:spMkLst>
            <pc:docMk/>
            <pc:sldMk cId="4099532361" sldId="266"/>
            <ac:spMk id="28" creationId="{1695BE87-63DA-45B8-A074-1A87032D2DD7}"/>
          </ac:spMkLst>
        </pc:spChg>
        <pc:spChg chg="add mod">
          <ac:chgData name="Mariam Choker" userId="2da3c07e-7cda-4855-bfb8-6b456bc434e2" providerId="ADAL" clId="{6CE7FB70-BCAF-4715-8389-474814E0D63B}" dt="2024-04-19T14:40:27.649" v="633" actId="1076"/>
          <ac:spMkLst>
            <pc:docMk/>
            <pc:sldMk cId="4099532361" sldId="266"/>
            <ac:spMk id="29" creationId="{10E29F7D-B519-47D5-ADE0-BA7AC35649F6}"/>
          </ac:spMkLst>
        </pc:spChg>
        <pc:spChg chg="add mod">
          <ac:chgData name="Mariam Choker" userId="2da3c07e-7cda-4855-bfb8-6b456bc434e2" providerId="ADAL" clId="{6CE7FB70-BCAF-4715-8389-474814E0D63B}" dt="2024-04-19T14:40:14.074" v="631" actId="1076"/>
          <ac:spMkLst>
            <pc:docMk/>
            <pc:sldMk cId="4099532361" sldId="266"/>
            <ac:spMk id="30" creationId="{4957277F-D5AF-4887-A6F3-0A98840AE104}"/>
          </ac:spMkLst>
        </pc:spChg>
        <pc:spChg chg="add mod">
          <ac:chgData name="Mariam Choker" userId="2da3c07e-7cda-4855-bfb8-6b456bc434e2" providerId="ADAL" clId="{6CE7FB70-BCAF-4715-8389-474814E0D63B}" dt="2024-04-19T14:40:05.923" v="630" actId="1076"/>
          <ac:spMkLst>
            <pc:docMk/>
            <pc:sldMk cId="4099532361" sldId="266"/>
            <ac:spMk id="31" creationId="{BC4A4479-BD77-432D-B373-0CABF99D4994}"/>
          </ac:spMkLst>
        </pc:spChg>
        <pc:spChg chg="add mod">
          <ac:chgData name="Mariam Choker" userId="2da3c07e-7cda-4855-bfb8-6b456bc434e2" providerId="ADAL" clId="{6CE7FB70-BCAF-4715-8389-474814E0D63B}" dt="2024-04-19T14:39:01.076" v="629" actId="1076"/>
          <ac:spMkLst>
            <pc:docMk/>
            <pc:sldMk cId="4099532361" sldId="266"/>
            <ac:spMk id="32" creationId="{EBDDC42E-7EB5-439A-9F05-9825ADAE48C4}"/>
          </ac:spMkLst>
        </pc:spChg>
        <pc:spChg chg="add mod">
          <ac:chgData name="Mariam Choker" userId="2da3c07e-7cda-4855-bfb8-6b456bc434e2" providerId="ADAL" clId="{6CE7FB70-BCAF-4715-8389-474814E0D63B}" dt="2024-04-19T14:38:55.704" v="628" actId="1076"/>
          <ac:spMkLst>
            <pc:docMk/>
            <pc:sldMk cId="4099532361" sldId="266"/>
            <ac:spMk id="33" creationId="{1B185476-FBED-4331-8509-58C183440CBA}"/>
          </ac:spMkLst>
        </pc:spChg>
        <pc:spChg chg="add mod">
          <ac:chgData name="Mariam Choker" userId="2da3c07e-7cda-4855-bfb8-6b456bc434e2" providerId="ADAL" clId="{6CE7FB70-BCAF-4715-8389-474814E0D63B}" dt="2024-04-19T14:38:49.029" v="627" actId="1076"/>
          <ac:spMkLst>
            <pc:docMk/>
            <pc:sldMk cId="4099532361" sldId="266"/>
            <ac:spMk id="34" creationId="{D4166BF2-7BA3-49E7-ADCD-8543153A31F2}"/>
          </ac:spMkLst>
        </pc:spChg>
        <pc:spChg chg="add mod">
          <ac:chgData name="Mariam Choker" userId="2da3c07e-7cda-4855-bfb8-6b456bc434e2" providerId="ADAL" clId="{6CE7FB70-BCAF-4715-8389-474814E0D63B}" dt="2024-04-19T14:38:39.401" v="626" actId="1076"/>
          <ac:spMkLst>
            <pc:docMk/>
            <pc:sldMk cId="4099532361" sldId="266"/>
            <ac:spMk id="35" creationId="{3BDD1F2D-DEF9-4B04-B2AE-B571D435F4AD}"/>
          </ac:spMkLst>
        </pc:spChg>
        <pc:graphicFrameChg chg="add mod">
          <ac:chgData name="Mariam Choker" userId="2da3c07e-7cda-4855-bfb8-6b456bc434e2" providerId="ADAL" clId="{6CE7FB70-BCAF-4715-8389-474814E0D63B}" dt="2024-04-19T14:18:44.455" v="423"/>
          <ac:graphicFrameMkLst>
            <pc:docMk/>
            <pc:sldMk cId="4099532361" sldId="266"/>
            <ac:graphicFrameMk id="2" creationId="{7217010A-A89E-40A8-9D8B-9C84324A85A3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9:05.244" v="427"/>
          <ac:graphicFrameMkLst>
            <pc:docMk/>
            <pc:sldMk cId="4099532361" sldId="266"/>
            <ac:graphicFrameMk id="3" creationId="{D7C7B5B5-3425-412A-B729-9854405B9C24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19:35.050" v="433"/>
          <ac:graphicFrameMkLst>
            <pc:docMk/>
            <pc:sldMk cId="4099532361" sldId="266"/>
            <ac:graphicFrameMk id="4" creationId="{0698920E-4D96-4911-B109-FFFEC7881FEA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0:01.076" v="439"/>
          <ac:graphicFrameMkLst>
            <pc:docMk/>
            <pc:sldMk cId="4099532361" sldId="266"/>
            <ac:graphicFrameMk id="5" creationId="{49D4B7B5-A2FB-4980-AE6B-02F2686E70B2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0:19.524" v="443"/>
          <ac:graphicFrameMkLst>
            <pc:docMk/>
            <pc:sldMk cId="4099532361" sldId="266"/>
            <ac:graphicFrameMk id="6" creationId="{A0747146-DE4D-4CE2-9BAD-75CDCBCC292A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0:45.665" v="448"/>
          <ac:graphicFrameMkLst>
            <pc:docMk/>
            <pc:sldMk cId="4099532361" sldId="266"/>
            <ac:graphicFrameMk id="7" creationId="{F1844AEA-0AC7-4287-A4FA-F8F5C7780ECC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3:27.374" v="490"/>
          <ac:graphicFrameMkLst>
            <pc:docMk/>
            <pc:sldMk cId="4099532361" sldId="266"/>
            <ac:graphicFrameMk id="8" creationId="{483C6734-22C6-4C13-8C87-10B53255BF9E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1:47.725" v="466"/>
          <ac:graphicFrameMkLst>
            <pc:docMk/>
            <pc:sldMk cId="4099532361" sldId="266"/>
            <ac:graphicFrameMk id="9" creationId="{7A815256-4B8D-4072-93DE-1B99CE837CA4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2:47.636" v="483" actId="20577"/>
          <ac:graphicFrameMkLst>
            <pc:docMk/>
            <pc:sldMk cId="4099532361" sldId="266"/>
            <ac:graphicFrameMk id="10" creationId="{E2D81414-58A4-4274-814F-CD595E62DA06}"/>
          </ac:graphicFrameMkLst>
        </pc:graphicFrameChg>
      </pc:sldChg>
      <pc:sldChg chg="addSp delSp modSp new mod">
        <pc:chgData name="Mariam Choker" userId="2da3c07e-7cda-4855-bfb8-6b456bc434e2" providerId="ADAL" clId="{6CE7FB70-BCAF-4715-8389-474814E0D63B}" dt="2024-04-19T15:00:28.539" v="743" actId="478"/>
        <pc:sldMkLst>
          <pc:docMk/>
          <pc:sldMk cId="2198254577" sldId="267"/>
        </pc:sldMkLst>
        <pc:spChg chg="add mod">
          <ac:chgData name="Mariam Choker" userId="2da3c07e-7cda-4855-bfb8-6b456bc434e2" providerId="ADAL" clId="{6CE7FB70-BCAF-4715-8389-474814E0D63B}" dt="2024-04-19T14:48:59.686" v="652" actId="1076"/>
          <ac:spMkLst>
            <pc:docMk/>
            <pc:sldMk cId="2198254577" sldId="267"/>
            <ac:spMk id="11" creationId="{D385DBEA-4B2A-45AF-B97A-5CDA606A5C09}"/>
          </ac:spMkLst>
        </pc:spChg>
        <pc:spChg chg="add mod">
          <ac:chgData name="Mariam Choker" userId="2da3c07e-7cda-4855-bfb8-6b456bc434e2" providerId="ADAL" clId="{6CE7FB70-BCAF-4715-8389-474814E0D63B}" dt="2024-04-19T14:48:52.768" v="651" actId="1076"/>
          <ac:spMkLst>
            <pc:docMk/>
            <pc:sldMk cId="2198254577" sldId="267"/>
            <ac:spMk id="12" creationId="{077BAB4F-5070-4C95-8425-0416EEED1B23}"/>
          </ac:spMkLst>
        </pc:spChg>
        <pc:spChg chg="add mod">
          <ac:chgData name="Mariam Choker" userId="2da3c07e-7cda-4855-bfb8-6b456bc434e2" providerId="ADAL" clId="{6CE7FB70-BCAF-4715-8389-474814E0D63B}" dt="2024-04-19T14:47:42.479" v="639" actId="1076"/>
          <ac:spMkLst>
            <pc:docMk/>
            <pc:sldMk cId="2198254577" sldId="267"/>
            <ac:spMk id="13" creationId="{C3853F55-7B87-40A7-82AC-E7109E682550}"/>
          </ac:spMkLst>
        </pc:spChg>
        <pc:spChg chg="add mod">
          <ac:chgData name="Mariam Choker" userId="2da3c07e-7cda-4855-bfb8-6b456bc434e2" providerId="ADAL" clId="{6CE7FB70-BCAF-4715-8389-474814E0D63B}" dt="2024-04-19T14:48:40.323" v="648" actId="1076"/>
          <ac:spMkLst>
            <pc:docMk/>
            <pc:sldMk cId="2198254577" sldId="267"/>
            <ac:spMk id="14" creationId="{50CAB37A-01F9-49E7-9074-4F889A18753A}"/>
          </ac:spMkLst>
        </pc:spChg>
        <pc:spChg chg="add mod">
          <ac:chgData name="Mariam Choker" userId="2da3c07e-7cda-4855-bfb8-6b456bc434e2" providerId="ADAL" clId="{6CE7FB70-BCAF-4715-8389-474814E0D63B}" dt="2024-04-19T14:48:29.146" v="646" actId="1076"/>
          <ac:spMkLst>
            <pc:docMk/>
            <pc:sldMk cId="2198254577" sldId="267"/>
            <ac:spMk id="15" creationId="{1A82500B-ACE1-427D-8EE2-489D49475351}"/>
          </ac:spMkLst>
        </pc:spChg>
        <pc:spChg chg="add mod">
          <ac:chgData name="Mariam Choker" userId="2da3c07e-7cda-4855-bfb8-6b456bc434e2" providerId="ADAL" clId="{6CE7FB70-BCAF-4715-8389-474814E0D63B}" dt="2024-04-19T14:47:51.274" v="640" actId="1076"/>
          <ac:spMkLst>
            <pc:docMk/>
            <pc:sldMk cId="2198254577" sldId="267"/>
            <ac:spMk id="16" creationId="{AF990E2F-46B6-4242-8DE2-11F73CB9A7AD}"/>
          </ac:spMkLst>
        </pc:spChg>
        <pc:spChg chg="add mod">
          <ac:chgData name="Mariam Choker" userId="2da3c07e-7cda-4855-bfb8-6b456bc434e2" providerId="ADAL" clId="{6CE7FB70-BCAF-4715-8389-474814E0D63B}" dt="2024-04-19T14:48:48.104" v="650" actId="1076"/>
          <ac:spMkLst>
            <pc:docMk/>
            <pc:sldMk cId="2198254577" sldId="267"/>
            <ac:spMk id="17" creationId="{0EBAE5CA-222E-4D88-983A-F86ABE39D2B4}"/>
          </ac:spMkLst>
        </pc:spChg>
        <pc:spChg chg="add mod">
          <ac:chgData name="Mariam Choker" userId="2da3c07e-7cda-4855-bfb8-6b456bc434e2" providerId="ADAL" clId="{6CE7FB70-BCAF-4715-8389-474814E0D63B}" dt="2024-04-19T14:48:44.047" v="649" actId="1076"/>
          <ac:spMkLst>
            <pc:docMk/>
            <pc:sldMk cId="2198254577" sldId="267"/>
            <ac:spMk id="18" creationId="{4F321455-E4C0-4003-9BCB-BC0739781074}"/>
          </ac:spMkLst>
        </pc:spChg>
        <pc:spChg chg="add mod">
          <ac:chgData name="Mariam Choker" userId="2da3c07e-7cda-4855-bfb8-6b456bc434e2" providerId="ADAL" clId="{6CE7FB70-BCAF-4715-8389-474814E0D63B}" dt="2024-04-19T14:48:35.224" v="647" actId="1076"/>
          <ac:spMkLst>
            <pc:docMk/>
            <pc:sldMk cId="2198254577" sldId="267"/>
            <ac:spMk id="19" creationId="{5D0DA32D-AE0D-4D0E-8043-EFEC2A65BEA4}"/>
          </ac:spMkLst>
        </pc:spChg>
        <pc:spChg chg="add mod">
          <ac:chgData name="Mariam Choker" userId="2da3c07e-7cda-4855-bfb8-6b456bc434e2" providerId="ADAL" clId="{6CE7FB70-BCAF-4715-8389-474814E0D63B}" dt="2024-04-19T14:48:25.454" v="645" actId="1076"/>
          <ac:spMkLst>
            <pc:docMk/>
            <pc:sldMk cId="2198254577" sldId="267"/>
            <ac:spMk id="20" creationId="{C714ED6F-76DB-4CCC-9649-E8C28AA5EC03}"/>
          </ac:spMkLst>
        </pc:spChg>
        <pc:spChg chg="add mod">
          <ac:chgData name="Mariam Choker" userId="2da3c07e-7cda-4855-bfb8-6b456bc434e2" providerId="ADAL" clId="{6CE7FB70-BCAF-4715-8389-474814E0D63B}" dt="2024-04-19T14:48:21.779" v="644" actId="1076"/>
          <ac:spMkLst>
            <pc:docMk/>
            <pc:sldMk cId="2198254577" sldId="267"/>
            <ac:spMk id="21" creationId="{25C20F74-2B6B-4782-8D98-73DC73964AED}"/>
          </ac:spMkLst>
        </pc:spChg>
        <pc:spChg chg="add mod">
          <ac:chgData name="Mariam Choker" userId="2da3c07e-7cda-4855-bfb8-6b456bc434e2" providerId="ADAL" clId="{6CE7FB70-BCAF-4715-8389-474814E0D63B}" dt="2024-04-19T14:48:10.928" v="642" actId="1076"/>
          <ac:spMkLst>
            <pc:docMk/>
            <pc:sldMk cId="2198254577" sldId="267"/>
            <ac:spMk id="22" creationId="{2B03AE11-F374-4FE9-AD2F-47F8E9A6AAF2}"/>
          </ac:spMkLst>
        </pc:spChg>
        <pc:spChg chg="add mod">
          <ac:chgData name="Mariam Choker" userId="2da3c07e-7cda-4855-bfb8-6b456bc434e2" providerId="ADAL" clId="{6CE7FB70-BCAF-4715-8389-474814E0D63B}" dt="2024-04-19T14:48:01.636" v="641" actId="1076"/>
          <ac:spMkLst>
            <pc:docMk/>
            <pc:sldMk cId="2198254577" sldId="267"/>
            <ac:spMk id="23" creationId="{7EE7F0CE-BAEE-4072-AC75-332069578A5D}"/>
          </ac:spMkLst>
        </pc:spChg>
        <pc:spChg chg="add mod">
          <ac:chgData name="Mariam Choker" userId="2da3c07e-7cda-4855-bfb8-6b456bc434e2" providerId="ADAL" clId="{6CE7FB70-BCAF-4715-8389-474814E0D63B}" dt="2024-04-19T14:49:30.314" v="656" actId="1076"/>
          <ac:spMkLst>
            <pc:docMk/>
            <pc:sldMk cId="2198254577" sldId="267"/>
            <ac:spMk id="24" creationId="{1B07CE6A-51F6-433F-981B-C6F67904DA70}"/>
          </ac:spMkLst>
        </pc:spChg>
        <pc:spChg chg="add mod">
          <ac:chgData name="Mariam Choker" userId="2da3c07e-7cda-4855-bfb8-6b456bc434e2" providerId="ADAL" clId="{6CE7FB70-BCAF-4715-8389-474814E0D63B}" dt="2024-04-19T14:49:34.687" v="657" actId="1076"/>
          <ac:spMkLst>
            <pc:docMk/>
            <pc:sldMk cId="2198254577" sldId="267"/>
            <ac:spMk id="25" creationId="{AEED0624-C42B-4B9D-BED0-F181DCEF669C}"/>
          </ac:spMkLst>
        </pc:spChg>
        <pc:spChg chg="add mod">
          <ac:chgData name="Mariam Choker" userId="2da3c07e-7cda-4855-bfb8-6b456bc434e2" providerId="ADAL" clId="{6CE7FB70-BCAF-4715-8389-474814E0D63B}" dt="2024-04-19T14:49:25.419" v="655" actId="1076"/>
          <ac:spMkLst>
            <pc:docMk/>
            <pc:sldMk cId="2198254577" sldId="267"/>
            <ac:spMk id="26" creationId="{9D732B6A-9A72-4E49-8D50-E3CD240660C9}"/>
          </ac:spMkLst>
        </pc:spChg>
        <pc:spChg chg="add mod">
          <ac:chgData name="Mariam Choker" userId="2da3c07e-7cda-4855-bfb8-6b456bc434e2" providerId="ADAL" clId="{6CE7FB70-BCAF-4715-8389-474814E0D63B}" dt="2024-04-19T14:49:09.769" v="654" actId="1076"/>
          <ac:spMkLst>
            <pc:docMk/>
            <pc:sldMk cId="2198254577" sldId="267"/>
            <ac:spMk id="27" creationId="{05A0D2BE-382D-44B1-B964-283D6E4D7EC7}"/>
          </ac:spMkLst>
        </pc:spChg>
        <pc:spChg chg="add mod">
          <ac:chgData name="Mariam Choker" userId="2da3c07e-7cda-4855-bfb8-6b456bc434e2" providerId="ADAL" clId="{6CE7FB70-BCAF-4715-8389-474814E0D63B}" dt="2024-04-19T14:49:05.687" v="653" actId="1076"/>
          <ac:spMkLst>
            <pc:docMk/>
            <pc:sldMk cId="2198254577" sldId="267"/>
            <ac:spMk id="28" creationId="{AFFB0EF5-3C7A-4FBE-B25A-27153D161EF6}"/>
          </ac:spMkLst>
        </pc:spChg>
        <pc:spChg chg="add mod">
          <ac:chgData name="Mariam Choker" userId="2da3c07e-7cda-4855-bfb8-6b456bc434e2" providerId="ADAL" clId="{6CE7FB70-BCAF-4715-8389-474814E0D63B}" dt="2024-04-19T14:48:17.842" v="643" actId="1076"/>
          <ac:spMkLst>
            <pc:docMk/>
            <pc:sldMk cId="2198254577" sldId="267"/>
            <ac:spMk id="29" creationId="{29AC2D30-6D16-4134-8164-C51AD72BD465}"/>
          </ac:spMkLst>
        </pc:spChg>
        <pc:spChg chg="add mod">
          <ac:chgData name="Mariam Choker" userId="2da3c07e-7cda-4855-bfb8-6b456bc434e2" providerId="ADAL" clId="{6CE7FB70-BCAF-4715-8389-474814E0D63B}" dt="2024-04-19T14:50:28.586" v="666" actId="1076"/>
          <ac:spMkLst>
            <pc:docMk/>
            <pc:sldMk cId="2198254577" sldId="267"/>
            <ac:spMk id="30" creationId="{F3324598-584E-457F-B4C9-4BE98767504F}"/>
          </ac:spMkLst>
        </pc:spChg>
        <pc:spChg chg="add mod">
          <ac:chgData name="Mariam Choker" userId="2da3c07e-7cda-4855-bfb8-6b456bc434e2" providerId="ADAL" clId="{6CE7FB70-BCAF-4715-8389-474814E0D63B}" dt="2024-04-19T14:50:24.770" v="665" actId="1076"/>
          <ac:spMkLst>
            <pc:docMk/>
            <pc:sldMk cId="2198254577" sldId="267"/>
            <ac:spMk id="31" creationId="{EC7E46D8-AC1A-4DEC-A20B-74F720B72618}"/>
          </ac:spMkLst>
        </pc:spChg>
        <pc:spChg chg="add mod">
          <ac:chgData name="Mariam Choker" userId="2da3c07e-7cda-4855-bfb8-6b456bc434e2" providerId="ADAL" clId="{6CE7FB70-BCAF-4715-8389-474814E0D63B}" dt="2024-04-19T14:50:08.745" v="663" actId="1076"/>
          <ac:spMkLst>
            <pc:docMk/>
            <pc:sldMk cId="2198254577" sldId="267"/>
            <ac:spMk id="32" creationId="{96FBA0C8-5201-4FF1-B32D-9BE0115C10A1}"/>
          </ac:spMkLst>
        </pc:spChg>
        <pc:spChg chg="add mod">
          <ac:chgData name="Mariam Choker" userId="2da3c07e-7cda-4855-bfb8-6b456bc434e2" providerId="ADAL" clId="{6CE7FB70-BCAF-4715-8389-474814E0D63B}" dt="2024-04-19T14:49:57.501" v="662" actId="1076"/>
          <ac:spMkLst>
            <pc:docMk/>
            <pc:sldMk cId="2198254577" sldId="267"/>
            <ac:spMk id="33" creationId="{CD470C6B-6ED8-4AF5-A61C-C178D88445DF}"/>
          </ac:spMkLst>
        </pc:spChg>
        <pc:spChg chg="add mod">
          <ac:chgData name="Mariam Choker" userId="2da3c07e-7cda-4855-bfb8-6b456bc434e2" providerId="ADAL" clId="{6CE7FB70-BCAF-4715-8389-474814E0D63B}" dt="2024-04-19T14:49:53.283" v="661" actId="1076"/>
          <ac:spMkLst>
            <pc:docMk/>
            <pc:sldMk cId="2198254577" sldId="267"/>
            <ac:spMk id="34" creationId="{1FE711C3-551E-46BF-A802-304F8E6383A3}"/>
          </ac:spMkLst>
        </pc:spChg>
        <pc:spChg chg="add mod">
          <ac:chgData name="Mariam Choker" userId="2da3c07e-7cda-4855-bfb8-6b456bc434e2" providerId="ADAL" clId="{6CE7FB70-BCAF-4715-8389-474814E0D63B}" dt="2024-04-19T14:49:49.026" v="660" actId="1076"/>
          <ac:spMkLst>
            <pc:docMk/>
            <pc:sldMk cId="2198254577" sldId="267"/>
            <ac:spMk id="35" creationId="{E7736C7E-29C6-47D8-B7E7-1EC38FF54B89}"/>
          </ac:spMkLst>
        </pc:spChg>
        <pc:spChg chg="add mod">
          <ac:chgData name="Mariam Choker" userId="2da3c07e-7cda-4855-bfb8-6b456bc434e2" providerId="ADAL" clId="{6CE7FB70-BCAF-4715-8389-474814E0D63B}" dt="2024-04-19T14:50:33.410" v="667" actId="1076"/>
          <ac:spMkLst>
            <pc:docMk/>
            <pc:sldMk cId="2198254577" sldId="267"/>
            <ac:spMk id="36" creationId="{AEB12276-4151-4410-9557-9AA6E52E49AA}"/>
          </ac:spMkLst>
        </pc:spChg>
        <pc:spChg chg="add mod">
          <ac:chgData name="Mariam Choker" userId="2da3c07e-7cda-4855-bfb8-6b456bc434e2" providerId="ADAL" clId="{6CE7FB70-BCAF-4715-8389-474814E0D63B}" dt="2024-04-19T14:51:04.311" v="672" actId="1076"/>
          <ac:spMkLst>
            <pc:docMk/>
            <pc:sldMk cId="2198254577" sldId="267"/>
            <ac:spMk id="37" creationId="{CA99B97D-F98C-4A52-8767-8EF25ED1850A}"/>
          </ac:spMkLst>
        </pc:spChg>
        <pc:spChg chg="add mod">
          <ac:chgData name="Mariam Choker" userId="2da3c07e-7cda-4855-bfb8-6b456bc434e2" providerId="ADAL" clId="{6CE7FB70-BCAF-4715-8389-474814E0D63B}" dt="2024-04-19T14:51:08.485" v="673" actId="1076"/>
          <ac:spMkLst>
            <pc:docMk/>
            <pc:sldMk cId="2198254577" sldId="267"/>
            <ac:spMk id="38" creationId="{9BD2B2B2-A590-4044-A4E4-78D68EF73857}"/>
          </ac:spMkLst>
        </pc:spChg>
        <pc:spChg chg="add mod">
          <ac:chgData name="Mariam Choker" userId="2da3c07e-7cda-4855-bfb8-6b456bc434e2" providerId="ADAL" clId="{6CE7FB70-BCAF-4715-8389-474814E0D63B}" dt="2024-04-19T14:50:54.113" v="671" actId="1076"/>
          <ac:spMkLst>
            <pc:docMk/>
            <pc:sldMk cId="2198254577" sldId="267"/>
            <ac:spMk id="39" creationId="{35E85171-A85D-4140-81F9-2CA0227B8BBE}"/>
          </ac:spMkLst>
        </pc:spChg>
        <pc:spChg chg="add mod">
          <ac:chgData name="Mariam Choker" userId="2da3c07e-7cda-4855-bfb8-6b456bc434e2" providerId="ADAL" clId="{6CE7FB70-BCAF-4715-8389-474814E0D63B}" dt="2024-04-19T14:50:47.859" v="670" actId="1076"/>
          <ac:spMkLst>
            <pc:docMk/>
            <pc:sldMk cId="2198254577" sldId="267"/>
            <ac:spMk id="40" creationId="{4B19DB64-6847-4EF7-8B56-51B7C3A3C993}"/>
          </ac:spMkLst>
        </pc:spChg>
        <pc:spChg chg="add mod">
          <ac:chgData name="Mariam Choker" userId="2da3c07e-7cda-4855-bfb8-6b456bc434e2" providerId="ADAL" clId="{6CE7FB70-BCAF-4715-8389-474814E0D63B}" dt="2024-04-19T14:50:43.282" v="669" actId="1076"/>
          <ac:spMkLst>
            <pc:docMk/>
            <pc:sldMk cId="2198254577" sldId="267"/>
            <ac:spMk id="41" creationId="{B9504054-9A80-48CB-ABBF-D1D319A15262}"/>
          </ac:spMkLst>
        </pc:spChg>
        <pc:spChg chg="add mod">
          <ac:chgData name="Mariam Choker" userId="2da3c07e-7cda-4855-bfb8-6b456bc434e2" providerId="ADAL" clId="{6CE7FB70-BCAF-4715-8389-474814E0D63B}" dt="2024-04-19T14:50:37.730" v="668" actId="1076"/>
          <ac:spMkLst>
            <pc:docMk/>
            <pc:sldMk cId="2198254577" sldId="267"/>
            <ac:spMk id="42" creationId="{9F032F57-5E23-4C02-9864-9B9DDA5C25A4}"/>
          </ac:spMkLst>
        </pc:spChg>
        <pc:spChg chg="add mod">
          <ac:chgData name="Mariam Choker" userId="2da3c07e-7cda-4855-bfb8-6b456bc434e2" providerId="ADAL" clId="{6CE7FB70-BCAF-4715-8389-474814E0D63B}" dt="2024-04-19T14:51:19.381" v="675" actId="1076"/>
          <ac:spMkLst>
            <pc:docMk/>
            <pc:sldMk cId="2198254577" sldId="267"/>
            <ac:spMk id="43" creationId="{85FBA9C0-E621-4E93-B3B6-F77BE804612E}"/>
          </ac:spMkLst>
        </pc:spChg>
        <pc:spChg chg="add mod">
          <ac:chgData name="Mariam Choker" userId="2da3c07e-7cda-4855-bfb8-6b456bc434e2" providerId="ADAL" clId="{6CE7FB70-BCAF-4715-8389-474814E0D63B}" dt="2024-04-19T14:51:14.364" v="674" actId="1076"/>
          <ac:spMkLst>
            <pc:docMk/>
            <pc:sldMk cId="2198254577" sldId="267"/>
            <ac:spMk id="44" creationId="{FB39FA70-9410-4FB0-9684-05435B814E29}"/>
          </ac:spMkLst>
        </pc:spChg>
        <pc:spChg chg="add mod">
          <ac:chgData name="Mariam Choker" userId="2da3c07e-7cda-4855-bfb8-6b456bc434e2" providerId="ADAL" clId="{6CE7FB70-BCAF-4715-8389-474814E0D63B}" dt="2024-04-19T14:51:26.072" v="676" actId="1076"/>
          <ac:spMkLst>
            <pc:docMk/>
            <pc:sldMk cId="2198254577" sldId="267"/>
            <ac:spMk id="45" creationId="{D9D0125C-2DE2-4016-B2CD-430FCF6F3E92}"/>
          </ac:spMkLst>
        </pc:spChg>
        <pc:spChg chg="add mod">
          <ac:chgData name="Mariam Choker" userId="2da3c07e-7cda-4855-bfb8-6b456bc434e2" providerId="ADAL" clId="{6CE7FB70-BCAF-4715-8389-474814E0D63B}" dt="2024-04-19T14:51:41.140" v="679" actId="1076"/>
          <ac:spMkLst>
            <pc:docMk/>
            <pc:sldMk cId="2198254577" sldId="267"/>
            <ac:spMk id="46" creationId="{2093A8EC-5CB4-4CA2-937C-1DC6CA54EC82}"/>
          </ac:spMkLst>
        </pc:spChg>
        <pc:spChg chg="add mod">
          <ac:chgData name="Mariam Choker" userId="2da3c07e-7cda-4855-bfb8-6b456bc434e2" providerId="ADAL" clId="{6CE7FB70-BCAF-4715-8389-474814E0D63B}" dt="2024-04-19T14:51:36.697" v="678" actId="1076"/>
          <ac:spMkLst>
            <pc:docMk/>
            <pc:sldMk cId="2198254577" sldId="267"/>
            <ac:spMk id="47" creationId="{1DBF0443-D330-4EDA-9216-4033C290443F}"/>
          </ac:spMkLst>
        </pc:spChg>
        <pc:spChg chg="add mod">
          <ac:chgData name="Mariam Choker" userId="2da3c07e-7cda-4855-bfb8-6b456bc434e2" providerId="ADAL" clId="{6CE7FB70-BCAF-4715-8389-474814E0D63B}" dt="2024-04-19T14:51:31.943" v="677" actId="1076"/>
          <ac:spMkLst>
            <pc:docMk/>
            <pc:sldMk cId="2198254577" sldId="267"/>
            <ac:spMk id="48" creationId="{E8661203-A259-4E1A-B368-CFFEE9828B32}"/>
          </ac:spMkLst>
        </pc:spChg>
        <pc:spChg chg="add del mod">
          <ac:chgData name="Mariam Choker" userId="2da3c07e-7cda-4855-bfb8-6b456bc434e2" providerId="ADAL" clId="{6CE7FB70-BCAF-4715-8389-474814E0D63B}" dt="2024-04-19T15:00:28.539" v="743" actId="478"/>
          <ac:spMkLst>
            <pc:docMk/>
            <pc:sldMk cId="2198254577" sldId="267"/>
            <ac:spMk id="49" creationId="{AE654772-7C6D-4931-B172-55C185D3BD77}"/>
          </ac:spMkLst>
        </pc:spChg>
        <pc:spChg chg="add del mod">
          <ac:chgData name="Mariam Choker" userId="2da3c07e-7cda-4855-bfb8-6b456bc434e2" providerId="ADAL" clId="{6CE7FB70-BCAF-4715-8389-474814E0D63B}" dt="2024-04-19T15:00:26.075" v="742" actId="478"/>
          <ac:spMkLst>
            <pc:docMk/>
            <pc:sldMk cId="2198254577" sldId="267"/>
            <ac:spMk id="50" creationId="{4A4DC3FA-21DD-4BB1-885E-7B394461BBFF}"/>
          </ac:spMkLst>
        </pc:spChg>
        <pc:spChg chg="add mod">
          <ac:chgData name="Mariam Choker" userId="2da3c07e-7cda-4855-bfb8-6b456bc434e2" providerId="ADAL" clId="{6CE7FB70-BCAF-4715-8389-474814E0D63B}" dt="2024-04-19T15:00:13.427" v="741" actId="1076"/>
          <ac:spMkLst>
            <pc:docMk/>
            <pc:sldMk cId="2198254577" sldId="267"/>
            <ac:spMk id="51" creationId="{D592A0C1-496D-4CD0-B271-36EA8587D7FC}"/>
          </ac:spMkLst>
        </pc:spChg>
        <pc:spChg chg="add mod">
          <ac:chgData name="Mariam Choker" userId="2da3c07e-7cda-4855-bfb8-6b456bc434e2" providerId="ADAL" clId="{6CE7FB70-BCAF-4715-8389-474814E0D63B}" dt="2024-04-19T15:00:08.727" v="740" actId="1076"/>
          <ac:spMkLst>
            <pc:docMk/>
            <pc:sldMk cId="2198254577" sldId="267"/>
            <ac:spMk id="52" creationId="{5820F206-BEA7-4DB8-A664-B4ADFEB1AF3E}"/>
          </ac:spMkLst>
        </pc:spChg>
        <pc:spChg chg="add mod">
          <ac:chgData name="Mariam Choker" userId="2da3c07e-7cda-4855-bfb8-6b456bc434e2" providerId="ADAL" clId="{6CE7FB70-BCAF-4715-8389-474814E0D63B}" dt="2024-04-19T15:00:03.040" v="739" actId="1076"/>
          <ac:spMkLst>
            <pc:docMk/>
            <pc:sldMk cId="2198254577" sldId="267"/>
            <ac:spMk id="53" creationId="{D40981CB-1C29-46A3-B769-C5C58B486340}"/>
          </ac:spMkLst>
        </pc:spChg>
        <pc:spChg chg="add mod">
          <ac:chgData name="Mariam Choker" userId="2da3c07e-7cda-4855-bfb8-6b456bc434e2" providerId="ADAL" clId="{6CE7FB70-BCAF-4715-8389-474814E0D63B}" dt="2024-04-19T14:59:57.997" v="738" actId="1076"/>
          <ac:spMkLst>
            <pc:docMk/>
            <pc:sldMk cId="2198254577" sldId="267"/>
            <ac:spMk id="54" creationId="{95C8ABA6-3934-4457-8174-39A32E7BE456}"/>
          </ac:spMkLst>
        </pc:spChg>
        <pc:spChg chg="add mod">
          <ac:chgData name="Mariam Choker" userId="2da3c07e-7cda-4855-bfb8-6b456bc434e2" providerId="ADAL" clId="{6CE7FB70-BCAF-4715-8389-474814E0D63B}" dt="2024-04-19T14:59:52.047" v="737" actId="1076"/>
          <ac:spMkLst>
            <pc:docMk/>
            <pc:sldMk cId="2198254577" sldId="267"/>
            <ac:spMk id="55" creationId="{4E321EBE-A606-4201-9DB5-4AA2AC45B5CE}"/>
          </ac:spMkLst>
        </pc:spChg>
        <pc:spChg chg="add mod">
          <ac:chgData name="Mariam Choker" userId="2da3c07e-7cda-4855-bfb8-6b456bc434e2" providerId="ADAL" clId="{6CE7FB70-BCAF-4715-8389-474814E0D63B}" dt="2024-04-19T14:59:47.746" v="736" actId="1076"/>
          <ac:spMkLst>
            <pc:docMk/>
            <pc:sldMk cId="2198254577" sldId="267"/>
            <ac:spMk id="56" creationId="{BBF4B306-A94C-49F6-A132-6A98C716BA68}"/>
          </ac:spMkLst>
        </pc:spChg>
        <pc:spChg chg="add mod">
          <ac:chgData name="Mariam Choker" userId="2da3c07e-7cda-4855-bfb8-6b456bc434e2" providerId="ADAL" clId="{6CE7FB70-BCAF-4715-8389-474814E0D63B}" dt="2024-04-19T14:59:44.120" v="735" actId="1076"/>
          <ac:spMkLst>
            <pc:docMk/>
            <pc:sldMk cId="2198254577" sldId="267"/>
            <ac:spMk id="57" creationId="{F2C32315-D59B-4354-9218-EF95E8AD2F63}"/>
          </ac:spMkLst>
        </pc:spChg>
        <pc:spChg chg="add mod">
          <ac:chgData name="Mariam Choker" userId="2da3c07e-7cda-4855-bfb8-6b456bc434e2" providerId="ADAL" clId="{6CE7FB70-BCAF-4715-8389-474814E0D63B}" dt="2024-04-19T14:59:39.776" v="734" actId="1076"/>
          <ac:spMkLst>
            <pc:docMk/>
            <pc:sldMk cId="2198254577" sldId="267"/>
            <ac:spMk id="58" creationId="{F83B76F0-AD48-4A93-A9C9-5F50EB0C0D58}"/>
          </ac:spMkLst>
        </pc:spChg>
        <pc:spChg chg="add mod">
          <ac:chgData name="Mariam Choker" userId="2da3c07e-7cda-4855-bfb8-6b456bc434e2" providerId="ADAL" clId="{6CE7FB70-BCAF-4715-8389-474814E0D63B}" dt="2024-04-19T14:57:26.247" v="725" actId="1076"/>
          <ac:spMkLst>
            <pc:docMk/>
            <pc:sldMk cId="2198254577" sldId="267"/>
            <ac:spMk id="59" creationId="{16B37316-19CD-478D-9761-92477004ABCE}"/>
          </ac:spMkLst>
        </pc:spChg>
        <pc:spChg chg="add mod">
          <ac:chgData name="Mariam Choker" userId="2da3c07e-7cda-4855-bfb8-6b456bc434e2" providerId="ADAL" clId="{6CE7FB70-BCAF-4715-8389-474814E0D63B}" dt="2024-04-19T14:57:20.513" v="724" actId="1076"/>
          <ac:spMkLst>
            <pc:docMk/>
            <pc:sldMk cId="2198254577" sldId="267"/>
            <ac:spMk id="60" creationId="{A35CF77E-4E53-459C-8202-CE6C1A13F873}"/>
          </ac:spMkLst>
        </pc:spChg>
        <pc:spChg chg="add mod">
          <ac:chgData name="Mariam Choker" userId="2da3c07e-7cda-4855-bfb8-6b456bc434e2" providerId="ADAL" clId="{6CE7FB70-BCAF-4715-8389-474814E0D63B}" dt="2024-04-19T14:57:03.189" v="723" actId="1076"/>
          <ac:spMkLst>
            <pc:docMk/>
            <pc:sldMk cId="2198254577" sldId="267"/>
            <ac:spMk id="61" creationId="{F6BF6B7B-9127-4441-9A0A-827D9B30D43E}"/>
          </ac:spMkLst>
        </pc:spChg>
        <pc:spChg chg="add mod">
          <ac:chgData name="Mariam Choker" userId="2da3c07e-7cda-4855-bfb8-6b456bc434e2" providerId="ADAL" clId="{6CE7FB70-BCAF-4715-8389-474814E0D63B}" dt="2024-04-19T14:56:47.107" v="721" actId="1076"/>
          <ac:spMkLst>
            <pc:docMk/>
            <pc:sldMk cId="2198254577" sldId="267"/>
            <ac:spMk id="62" creationId="{E60058CC-389D-4BE8-BB47-FE708311B349}"/>
          </ac:spMkLst>
        </pc:spChg>
        <pc:spChg chg="add mod">
          <ac:chgData name="Mariam Choker" userId="2da3c07e-7cda-4855-bfb8-6b456bc434e2" providerId="ADAL" clId="{6CE7FB70-BCAF-4715-8389-474814E0D63B}" dt="2024-04-19T14:56:56.334" v="722" actId="1076"/>
          <ac:spMkLst>
            <pc:docMk/>
            <pc:sldMk cId="2198254577" sldId="267"/>
            <ac:spMk id="63" creationId="{9E9A8D11-2E01-401F-BDF9-C121E141B5DA}"/>
          </ac:spMkLst>
        </pc:spChg>
        <pc:spChg chg="add mod">
          <ac:chgData name="Mariam Choker" userId="2da3c07e-7cda-4855-bfb8-6b456bc434e2" providerId="ADAL" clId="{6CE7FB70-BCAF-4715-8389-474814E0D63B}" dt="2024-04-19T14:56:41.472" v="720" actId="1076"/>
          <ac:spMkLst>
            <pc:docMk/>
            <pc:sldMk cId="2198254577" sldId="267"/>
            <ac:spMk id="64" creationId="{B753B676-F8BC-407C-BAC8-DCDD5D498828}"/>
          </ac:spMkLst>
        </pc:spChg>
        <pc:spChg chg="add mod">
          <ac:chgData name="Mariam Choker" userId="2da3c07e-7cda-4855-bfb8-6b456bc434e2" providerId="ADAL" clId="{6CE7FB70-BCAF-4715-8389-474814E0D63B}" dt="2024-04-19T14:56:21.685" v="719" actId="1076"/>
          <ac:spMkLst>
            <pc:docMk/>
            <pc:sldMk cId="2198254577" sldId="267"/>
            <ac:spMk id="65" creationId="{19E2864F-1618-4439-B836-9BFA36D31374}"/>
          </ac:spMkLst>
        </pc:spChg>
        <pc:spChg chg="add mod">
          <ac:chgData name="Mariam Choker" userId="2da3c07e-7cda-4855-bfb8-6b456bc434e2" providerId="ADAL" clId="{6CE7FB70-BCAF-4715-8389-474814E0D63B}" dt="2024-04-19T14:56:17.246" v="718" actId="1076"/>
          <ac:spMkLst>
            <pc:docMk/>
            <pc:sldMk cId="2198254577" sldId="267"/>
            <ac:spMk id="66" creationId="{D054741B-844F-4AEA-97CC-525B9274F92C}"/>
          </ac:spMkLst>
        </pc:spChg>
        <pc:spChg chg="add mod">
          <ac:chgData name="Mariam Choker" userId="2da3c07e-7cda-4855-bfb8-6b456bc434e2" providerId="ADAL" clId="{6CE7FB70-BCAF-4715-8389-474814E0D63B}" dt="2024-04-19T14:50:20.178" v="664" actId="1076"/>
          <ac:spMkLst>
            <pc:docMk/>
            <pc:sldMk cId="2198254577" sldId="267"/>
            <ac:spMk id="67" creationId="{5FE8A49C-52EB-48F7-946B-FF0F1F9C1AFD}"/>
          </ac:spMkLst>
        </pc:spChg>
        <pc:spChg chg="add mod">
          <ac:chgData name="Mariam Choker" userId="2da3c07e-7cda-4855-bfb8-6b456bc434e2" providerId="ADAL" clId="{6CE7FB70-BCAF-4715-8389-474814E0D63B}" dt="2024-04-19T14:54:22.958" v="702" actId="1076"/>
          <ac:spMkLst>
            <pc:docMk/>
            <pc:sldMk cId="2198254577" sldId="267"/>
            <ac:spMk id="68" creationId="{921BC7AD-2D24-4CB5-94F7-606421148209}"/>
          </ac:spMkLst>
        </pc:spChg>
        <pc:spChg chg="add mod">
          <ac:chgData name="Mariam Choker" userId="2da3c07e-7cda-4855-bfb8-6b456bc434e2" providerId="ADAL" clId="{6CE7FB70-BCAF-4715-8389-474814E0D63B}" dt="2024-04-19T14:53:16.361" v="693" actId="1076"/>
          <ac:spMkLst>
            <pc:docMk/>
            <pc:sldMk cId="2198254577" sldId="267"/>
            <ac:spMk id="69" creationId="{E99F5244-C521-4AAF-ADA9-F97D4B25B70D}"/>
          </ac:spMkLst>
        </pc:spChg>
        <pc:spChg chg="add mod">
          <ac:chgData name="Mariam Choker" userId="2da3c07e-7cda-4855-bfb8-6b456bc434e2" providerId="ADAL" clId="{6CE7FB70-BCAF-4715-8389-474814E0D63B}" dt="2024-04-19T14:53:09.189" v="692" actId="1076"/>
          <ac:spMkLst>
            <pc:docMk/>
            <pc:sldMk cId="2198254577" sldId="267"/>
            <ac:spMk id="70" creationId="{DE9B3436-1164-46F1-B56F-12D04794EC8D}"/>
          </ac:spMkLst>
        </pc:spChg>
        <pc:spChg chg="add mod">
          <ac:chgData name="Mariam Choker" userId="2da3c07e-7cda-4855-bfb8-6b456bc434e2" providerId="ADAL" clId="{6CE7FB70-BCAF-4715-8389-474814E0D63B}" dt="2024-04-19T14:53:04.373" v="691" actId="1076"/>
          <ac:spMkLst>
            <pc:docMk/>
            <pc:sldMk cId="2198254577" sldId="267"/>
            <ac:spMk id="71" creationId="{FE63F4D0-5479-49EC-BACD-B471AEC3091C}"/>
          </ac:spMkLst>
        </pc:spChg>
        <pc:spChg chg="add mod">
          <ac:chgData name="Mariam Choker" userId="2da3c07e-7cda-4855-bfb8-6b456bc434e2" providerId="ADAL" clId="{6CE7FB70-BCAF-4715-8389-474814E0D63B}" dt="2024-04-19T14:52:23.286" v="685" actId="1076"/>
          <ac:spMkLst>
            <pc:docMk/>
            <pc:sldMk cId="2198254577" sldId="267"/>
            <ac:spMk id="72" creationId="{02CF5CB7-A37F-4A4B-A686-3C9AC28B3EA4}"/>
          </ac:spMkLst>
        </pc:spChg>
        <pc:spChg chg="add mod">
          <ac:chgData name="Mariam Choker" userId="2da3c07e-7cda-4855-bfb8-6b456bc434e2" providerId="ADAL" clId="{6CE7FB70-BCAF-4715-8389-474814E0D63B}" dt="2024-04-19T14:52:54.546" v="689" actId="1076"/>
          <ac:spMkLst>
            <pc:docMk/>
            <pc:sldMk cId="2198254577" sldId="267"/>
            <ac:spMk id="73" creationId="{275AF152-8C45-4BCA-B400-7279426CE75B}"/>
          </ac:spMkLst>
        </pc:spChg>
        <pc:spChg chg="add mod">
          <ac:chgData name="Mariam Choker" userId="2da3c07e-7cda-4855-bfb8-6b456bc434e2" providerId="ADAL" clId="{6CE7FB70-BCAF-4715-8389-474814E0D63B}" dt="2024-04-19T14:53:00.115" v="690" actId="1076"/>
          <ac:spMkLst>
            <pc:docMk/>
            <pc:sldMk cId="2198254577" sldId="267"/>
            <ac:spMk id="74" creationId="{3B56F1A7-A005-4623-8FC9-8A47D1A87C44}"/>
          </ac:spMkLst>
        </pc:spChg>
        <pc:spChg chg="add mod">
          <ac:chgData name="Mariam Choker" userId="2da3c07e-7cda-4855-bfb8-6b456bc434e2" providerId="ADAL" clId="{6CE7FB70-BCAF-4715-8389-474814E0D63B}" dt="2024-04-19T14:52:49.548" v="688" actId="1076"/>
          <ac:spMkLst>
            <pc:docMk/>
            <pc:sldMk cId="2198254577" sldId="267"/>
            <ac:spMk id="75" creationId="{B7443BEC-6C66-473F-A8A3-E5C58CB55C1B}"/>
          </ac:spMkLst>
        </pc:spChg>
        <pc:spChg chg="add mod">
          <ac:chgData name="Mariam Choker" userId="2da3c07e-7cda-4855-bfb8-6b456bc434e2" providerId="ADAL" clId="{6CE7FB70-BCAF-4715-8389-474814E0D63B}" dt="2024-04-19T14:52:37.631" v="687" actId="1076"/>
          <ac:spMkLst>
            <pc:docMk/>
            <pc:sldMk cId="2198254577" sldId="267"/>
            <ac:spMk id="76" creationId="{DECEDBAF-E016-40C2-8765-9885A555A9EA}"/>
          </ac:spMkLst>
        </pc:spChg>
        <pc:spChg chg="add mod">
          <ac:chgData name="Mariam Choker" userId="2da3c07e-7cda-4855-bfb8-6b456bc434e2" providerId="ADAL" clId="{6CE7FB70-BCAF-4715-8389-474814E0D63B}" dt="2024-04-19T14:52:31.978" v="686" actId="1076"/>
          <ac:spMkLst>
            <pc:docMk/>
            <pc:sldMk cId="2198254577" sldId="267"/>
            <ac:spMk id="77" creationId="{CE76259A-B2D1-4084-AEE7-ED3655BDAD96}"/>
          </ac:spMkLst>
        </pc:spChg>
        <pc:spChg chg="add mod">
          <ac:chgData name="Mariam Choker" userId="2da3c07e-7cda-4855-bfb8-6b456bc434e2" providerId="ADAL" clId="{6CE7FB70-BCAF-4715-8389-474814E0D63B}" dt="2024-04-19T14:56:05.955" v="717" actId="1076"/>
          <ac:spMkLst>
            <pc:docMk/>
            <pc:sldMk cId="2198254577" sldId="267"/>
            <ac:spMk id="78" creationId="{97D77AE7-0894-45C2-9D5C-1F90FEA8DCC9}"/>
          </ac:spMkLst>
        </pc:spChg>
        <pc:spChg chg="add mod">
          <ac:chgData name="Mariam Choker" userId="2da3c07e-7cda-4855-bfb8-6b456bc434e2" providerId="ADAL" clId="{6CE7FB70-BCAF-4715-8389-474814E0D63B}" dt="2024-04-19T14:56:01.013" v="716" actId="1076"/>
          <ac:spMkLst>
            <pc:docMk/>
            <pc:sldMk cId="2198254577" sldId="267"/>
            <ac:spMk id="79" creationId="{9279EA22-8BF5-4B89-80DE-5B30D3ADD84E}"/>
          </ac:spMkLst>
        </pc:spChg>
        <pc:spChg chg="add mod">
          <ac:chgData name="Mariam Choker" userId="2da3c07e-7cda-4855-bfb8-6b456bc434e2" providerId="ADAL" clId="{6CE7FB70-BCAF-4715-8389-474814E0D63B}" dt="2024-04-19T14:55:36.419" v="712" actId="1076"/>
          <ac:spMkLst>
            <pc:docMk/>
            <pc:sldMk cId="2198254577" sldId="267"/>
            <ac:spMk id="80" creationId="{7449E90C-FC93-42A3-BBE1-385F5D6DC31A}"/>
          </ac:spMkLst>
        </pc:spChg>
        <pc:spChg chg="add mod">
          <ac:chgData name="Mariam Choker" userId="2da3c07e-7cda-4855-bfb8-6b456bc434e2" providerId="ADAL" clId="{6CE7FB70-BCAF-4715-8389-474814E0D63B}" dt="2024-04-19T14:55:31.569" v="711" actId="1076"/>
          <ac:spMkLst>
            <pc:docMk/>
            <pc:sldMk cId="2198254577" sldId="267"/>
            <ac:spMk id="81" creationId="{4758C3D1-B15C-44EB-B010-F71A80137316}"/>
          </ac:spMkLst>
        </pc:spChg>
        <pc:spChg chg="add mod">
          <ac:chgData name="Mariam Choker" userId="2da3c07e-7cda-4855-bfb8-6b456bc434e2" providerId="ADAL" clId="{6CE7FB70-BCAF-4715-8389-474814E0D63B}" dt="2024-04-19T14:55:20.840" v="710" actId="1076"/>
          <ac:spMkLst>
            <pc:docMk/>
            <pc:sldMk cId="2198254577" sldId="267"/>
            <ac:spMk id="82" creationId="{632BEC16-D042-430D-8030-2DE77887B169}"/>
          </ac:spMkLst>
        </pc:spChg>
        <pc:spChg chg="add mod">
          <ac:chgData name="Mariam Choker" userId="2da3c07e-7cda-4855-bfb8-6b456bc434e2" providerId="ADAL" clId="{6CE7FB70-BCAF-4715-8389-474814E0D63B}" dt="2024-04-19T14:55:16.209" v="709" actId="1076"/>
          <ac:spMkLst>
            <pc:docMk/>
            <pc:sldMk cId="2198254577" sldId="267"/>
            <ac:spMk id="83" creationId="{C160292D-A4F5-441A-8F21-90F53927939D}"/>
          </ac:spMkLst>
        </pc:spChg>
        <pc:spChg chg="add mod">
          <ac:chgData name="Mariam Choker" userId="2da3c07e-7cda-4855-bfb8-6b456bc434e2" providerId="ADAL" clId="{6CE7FB70-BCAF-4715-8389-474814E0D63B}" dt="2024-04-19T14:55:12.680" v="708" actId="1076"/>
          <ac:spMkLst>
            <pc:docMk/>
            <pc:sldMk cId="2198254577" sldId="267"/>
            <ac:spMk id="84" creationId="{580EC200-A900-48BF-9843-A316065F3681}"/>
          </ac:spMkLst>
        </pc:spChg>
        <pc:spChg chg="add mod">
          <ac:chgData name="Mariam Choker" userId="2da3c07e-7cda-4855-bfb8-6b456bc434e2" providerId="ADAL" clId="{6CE7FB70-BCAF-4715-8389-474814E0D63B}" dt="2024-04-19T14:55:03.241" v="707" actId="1076"/>
          <ac:spMkLst>
            <pc:docMk/>
            <pc:sldMk cId="2198254577" sldId="267"/>
            <ac:spMk id="85" creationId="{5C368D54-E9B3-4BE9-A347-9573CC30A617}"/>
          </ac:spMkLst>
        </pc:spChg>
        <pc:spChg chg="add mod">
          <ac:chgData name="Mariam Choker" userId="2da3c07e-7cda-4855-bfb8-6b456bc434e2" providerId="ADAL" clId="{6CE7FB70-BCAF-4715-8389-474814E0D63B}" dt="2024-04-19T14:54:58.181" v="706" actId="1076"/>
          <ac:spMkLst>
            <pc:docMk/>
            <pc:sldMk cId="2198254577" sldId="267"/>
            <ac:spMk id="86" creationId="{8288F938-D9DC-4B3B-8069-6843E727C910}"/>
          </ac:spMkLst>
        </pc:spChg>
        <pc:spChg chg="add mod">
          <ac:chgData name="Mariam Choker" userId="2da3c07e-7cda-4855-bfb8-6b456bc434e2" providerId="ADAL" clId="{6CE7FB70-BCAF-4715-8389-474814E0D63B}" dt="2024-04-19T14:54:44.106" v="705" actId="1076"/>
          <ac:spMkLst>
            <pc:docMk/>
            <pc:sldMk cId="2198254577" sldId="267"/>
            <ac:spMk id="87" creationId="{9AADE4D1-685D-4B52-9214-477873248D5D}"/>
          </ac:spMkLst>
        </pc:spChg>
        <pc:graphicFrameChg chg="add mod">
          <ac:chgData name="Mariam Choker" userId="2da3c07e-7cda-4855-bfb8-6b456bc434e2" providerId="ADAL" clId="{6CE7FB70-BCAF-4715-8389-474814E0D63B}" dt="2024-04-19T14:25:45.455" v="519"/>
          <ac:graphicFrameMkLst>
            <pc:docMk/>
            <pc:sldMk cId="2198254577" sldId="267"/>
            <ac:graphicFrameMk id="2" creationId="{361DC246-6AF7-46A9-B06D-555F78D84537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6:19.536" v="525"/>
          <ac:graphicFrameMkLst>
            <pc:docMk/>
            <pc:sldMk cId="2198254577" sldId="267"/>
            <ac:graphicFrameMk id="3" creationId="{AAF8FA88-0322-4916-878D-7A76CDBAB571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6:57.141" v="533"/>
          <ac:graphicFrameMkLst>
            <pc:docMk/>
            <pc:sldMk cId="2198254577" sldId="267"/>
            <ac:graphicFrameMk id="4" creationId="{3C21A395-143A-4D92-9AFD-81DA007CE7BC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30:33.644" v="591" actId="14100"/>
          <ac:graphicFrameMkLst>
            <pc:docMk/>
            <pc:sldMk cId="2198254577" sldId="267"/>
            <ac:graphicFrameMk id="5" creationId="{48B52006-269F-4927-8DCA-F0EA234A0E02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8:01.652" v="544"/>
          <ac:graphicFrameMkLst>
            <pc:docMk/>
            <pc:sldMk cId="2198254577" sldId="267"/>
            <ac:graphicFrameMk id="6" creationId="{179AF1DE-1414-48C7-8D8A-44F8AC441D68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28:06.992" v="545"/>
          <ac:graphicFrameMkLst>
            <pc:docMk/>
            <pc:sldMk cId="2198254577" sldId="267"/>
            <ac:graphicFrameMk id="7" creationId="{AD2B02BB-62D5-4953-AA2B-CE4235DCBD45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54:18.958" v="701" actId="14100"/>
          <ac:graphicFrameMkLst>
            <pc:docMk/>
            <pc:sldMk cId="2198254577" sldId="267"/>
            <ac:graphicFrameMk id="8" creationId="{8A339F59-1F8D-42D0-A2D1-A78C48CD2DDD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55:53.927" v="715" actId="14100"/>
          <ac:graphicFrameMkLst>
            <pc:docMk/>
            <pc:sldMk cId="2198254577" sldId="267"/>
            <ac:graphicFrameMk id="9" creationId="{CE1633FC-B9F2-4137-AB81-30CD0D844341}"/>
          </ac:graphicFrameMkLst>
        </pc:graphicFrameChg>
        <pc:graphicFrameChg chg="add mod">
          <ac:chgData name="Mariam Choker" userId="2da3c07e-7cda-4855-bfb8-6b456bc434e2" providerId="ADAL" clId="{6CE7FB70-BCAF-4715-8389-474814E0D63B}" dt="2024-04-19T14:59:25.395" v="732" actId="14100"/>
          <ac:graphicFrameMkLst>
            <pc:docMk/>
            <pc:sldMk cId="2198254577" sldId="267"/>
            <ac:graphicFrameMk id="10" creationId="{66C5983B-F762-4D7F-A469-722B37F62CAB}"/>
          </ac:graphicFrameMkLst>
        </pc:graphicFrameChg>
      </pc:sldChg>
    </pc:docChg>
  </pc:docChgLst>
  <pc:docChgLst>
    <pc:chgData name="Christelle Iskandar" userId="2c0b4211-5e0e-4cf8-b9a9-c3bd005835aa" providerId="ADAL" clId="{D01364B5-F3E6-4FFC-9224-2901D798EFF0}"/>
    <pc:docChg chg="undo redo custSel delSld modSld">
      <pc:chgData name="Christelle Iskandar" userId="2c0b4211-5e0e-4cf8-b9a9-c3bd005835aa" providerId="ADAL" clId="{D01364B5-F3E6-4FFC-9224-2901D798EFF0}" dt="2024-06-18T18:33:08.105" v="128" actId="14100"/>
      <pc:docMkLst>
        <pc:docMk/>
      </pc:docMkLst>
      <pc:sldChg chg="modSp mod">
        <pc:chgData name="Christelle Iskandar" userId="2c0b4211-5e0e-4cf8-b9a9-c3bd005835aa" providerId="ADAL" clId="{D01364B5-F3E6-4FFC-9224-2901D798EFF0}" dt="2024-06-18T18:32:31.351" v="108" actId="20577"/>
        <pc:sldMkLst>
          <pc:docMk/>
          <pc:sldMk cId="2092714152" sldId="257"/>
        </pc:sldMkLst>
        <pc:spChg chg="mod">
          <ac:chgData name="Christelle Iskandar" userId="2c0b4211-5e0e-4cf8-b9a9-c3bd005835aa" providerId="ADAL" clId="{D01364B5-F3E6-4FFC-9224-2901D798EFF0}" dt="2024-06-18T18:32:31.351" v="108" actId="20577"/>
          <ac:spMkLst>
            <pc:docMk/>
            <pc:sldMk cId="2092714152" sldId="257"/>
            <ac:spMk id="2" creationId="{79485D9B-F98B-485E-A199-05FB4F090101}"/>
          </ac:spMkLst>
        </pc:spChg>
      </pc:sldChg>
      <pc:sldChg chg="del">
        <pc:chgData name="Christelle Iskandar" userId="2c0b4211-5e0e-4cf8-b9a9-c3bd005835aa" providerId="ADAL" clId="{D01364B5-F3E6-4FFC-9224-2901D798EFF0}" dt="2024-06-18T18:26:49.708" v="0" actId="47"/>
        <pc:sldMkLst>
          <pc:docMk/>
          <pc:sldMk cId="1944362713" sldId="258"/>
        </pc:sldMkLst>
      </pc:sldChg>
      <pc:sldChg chg="modSp mod">
        <pc:chgData name="Christelle Iskandar" userId="2c0b4211-5e0e-4cf8-b9a9-c3bd005835aa" providerId="ADAL" clId="{D01364B5-F3E6-4FFC-9224-2901D798EFF0}" dt="2024-06-18T18:32:00.509" v="94" actId="20577"/>
        <pc:sldMkLst>
          <pc:docMk/>
          <pc:sldMk cId="1887602752" sldId="259"/>
        </pc:sldMkLst>
        <pc:spChg chg="mod">
          <ac:chgData name="Christelle Iskandar" userId="2c0b4211-5e0e-4cf8-b9a9-c3bd005835aa" providerId="ADAL" clId="{D01364B5-F3E6-4FFC-9224-2901D798EFF0}" dt="2024-06-18T18:32:00.509" v="94" actId="20577"/>
          <ac:spMkLst>
            <pc:docMk/>
            <pc:sldMk cId="1887602752" sldId="259"/>
            <ac:spMk id="2" creationId="{1808386E-9544-4C19-8611-4ECA809D456F}"/>
          </ac:spMkLst>
        </pc:spChg>
      </pc:sldChg>
      <pc:sldChg chg="addSp delSp modSp mod">
        <pc:chgData name="Christelle Iskandar" userId="2c0b4211-5e0e-4cf8-b9a9-c3bd005835aa" providerId="ADAL" clId="{D01364B5-F3E6-4FFC-9224-2901D798EFF0}" dt="2024-06-18T18:32:51.887" v="118" actId="14100"/>
        <pc:sldMkLst>
          <pc:docMk/>
          <pc:sldMk cId="967208098" sldId="260"/>
        </pc:sldMkLst>
        <pc:spChg chg="del">
          <ac:chgData name="Christelle Iskandar" userId="2c0b4211-5e0e-4cf8-b9a9-c3bd005835aa" providerId="ADAL" clId="{D01364B5-F3E6-4FFC-9224-2901D798EFF0}" dt="2024-06-18T18:32:37.901" v="109" actId="478"/>
          <ac:spMkLst>
            <pc:docMk/>
            <pc:sldMk cId="967208098" sldId="260"/>
            <ac:spMk id="2" creationId="{F54E4392-57F1-41B9-B1E6-B85AF91F4664}"/>
          </ac:spMkLst>
        </pc:spChg>
        <pc:spChg chg="add mod">
          <ac:chgData name="Christelle Iskandar" userId="2c0b4211-5e0e-4cf8-b9a9-c3bd005835aa" providerId="ADAL" clId="{D01364B5-F3E6-4FFC-9224-2901D798EFF0}" dt="2024-06-18T18:32:51.887" v="118" actId="14100"/>
          <ac:spMkLst>
            <pc:docMk/>
            <pc:sldMk cId="967208098" sldId="260"/>
            <ac:spMk id="4" creationId="{9308889D-A680-E959-A3D1-DF116440F6A7}"/>
          </ac:spMkLst>
        </pc:spChg>
      </pc:sldChg>
      <pc:sldChg chg="addSp delSp modSp mod">
        <pc:chgData name="Christelle Iskandar" userId="2c0b4211-5e0e-4cf8-b9a9-c3bd005835aa" providerId="ADAL" clId="{D01364B5-F3E6-4FFC-9224-2901D798EFF0}" dt="2024-06-18T18:33:08.105" v="128" actId="14100"/>
        <pc:sldMkLst>
          <pc:docMk/>
          <pc:sldMk cId="3875692791" sldId="262"/>
        </pc:sldMkLst>
        <pc:spChg chg="del">
          <ac:chgData name="Christelle Iskandar" userId="2c0b4211-5e0e-4cf8-b9a9-c3bd005835aa" providerId="ADAL" clId="{D01364B5-F3E6-4FFC-9224-2901D798EFF0}" dt="2024-06-18T18:32:56.478" v="119" actId="478"/>
          <ac:spMkLst>
            <pc:docMk/>
            <pc:sldMk cId="3875692791" sldId="262"/>
            <ac:spMk id="2" creationId="{C564444E-0A85-4794-8CD4-422F2FF79ED2}"/>
          </ac:spMkLst>
        </pc:spChg>
        <pc:spChg chg="add mod">
          <ac:chgData name="Christelle Iskandar" userId="2c0b4211-5e0e-4cf8-b9a9-c3bd005835aa" providerId="ADAL" clId="{D01364B5-F3E6-4FFC-9224-2901D798EFF0}" dt="2024-06-18T18:33:08.105" v="128" actId="14100"/>
          <ac:spMkLst>
            <pc:docMk/>
            <pc:sldMk cId="3875692791" sldId="262"/>
            <ac:spMk id="4" creationId="{6A056A84-7FF7-8B71-C3DA-EF90DC704AA0}"/>
          </ac:spMkLst>
        </pc:spChg>
      </pc:sldChg>
      <pc:sldChg chg="del">
        <pc:chgData name="Christelle Iskandar" userId="2c0b4211-5e0e-4cf8-b9a9-c3bd005835aa" providerId="ADAL" clId="{D01364B5-F3E6-4FFC-9224-2901D798EFF0}" dt="2024-06-18T18:26:49.708" v="0" actId="47"/>
        <pc:sldMkLst>
          <pc:docMk/>
          <pc:sldMk cId="234582430" sldId="269"/>
        </pc:sldMkLst>
      </pc:sldChg>
      <pc:sldChg chg="del">
        <pc:chgData name="Christelle Iskandar" userId="2c0b4211-5e0e-4cf8-b9a9-c3bd005835aa" providerId="ADAL" clId="{D01364B5-F3E6-4FFC-9224-2901D798EFF0}" dt="2024-06-18T18:26:49.708" v="0" actId="47"/>
        <pc:sldMkLst>
          <pc:docMk/>
          <pc:sldMk cId="1503500823" sldId="270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../embeddings/oleObject10.bin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../embeddings/oleObject11.bin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../embeddings/oleObject12.bin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../embeddings/oleObject13.bin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../embeddings/oleObject14.bin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../embeddings/oleObject15.bin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../embeddings/oleObject16.bin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oleObject" Target="../embeddings/oleObject17.bin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../embeddings/oleObject18.bin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oleObject" Target="../embeddings/oleObject19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oleObject" Target="../embeddings/oleObject20.bin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oleObject" Target="../embeddings/oleObject21.bin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oleObject" Target="../embeddings/oleObject22.bin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oleObject" Target="../embeddings/oleObject23.bin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24.xml"/><Relationship Id="rId1" Type="http://schemas.microsoft.com/office/2011/relationships/chartStyle" Target="style24.xml"/><Relationship Id="rId4" Type="http://schemas.openxmlformats.org/officeDocument/2006/relationships/oleObject" Target="../embeddings/oleObject24.bin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oleObject" Target="../embeddings/oleObject25.bin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26.xml"/><Relationship Id="rId1" Type="http://schemas.microsoft.com/office/2011/relationships/chartStyle" Target="style26.xml"/><Relationship Id="rId4" Type="http://schemas.openxmlformats.org/officeDocument/2006/relationships/oleObject" Target="../embeddings/oleObject26.bin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27.xml"/><Relationship Id="rId1" Type="http://schemas.microsoft.com/office/2011/relationships/chartStyle" Target="style27.xml"/><Relationship Id="rId4" Type="http://schemas.openxmlformats.org/officeDocument/2006/relationships/oleObject" Target="../embeddings/oleObject27.bin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9.xml"/><Relationship Id="rId2" Type="http://schemas.microsoft.com/office/2011/relationships/chartColorStyle" Target="colors28.xml"/><Relationship Id="rId1" Type="http://schemas.microsoft.com/office/2011/relationships/chartStyle" Target="style28.xml"/><Relationship Id="rId4" Type="http://schemas.openxmlformats.org/officeDocument/2006/relationships/oleObject" Target="../embeddings/oleObject28.bin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0.xml"/><Relationship Id="rId2" Type="http://schemas.microsoft.com/office/2011/relationships/chartColorStyle" Target="colors29.xml"/><Relationship Id="rId1" Type="http://schemas.microsoft.com/office/2011/relationships/chartStyle" Target="style29.xml"/><Relationship Id="rId4" Type="http://schemas.openxmlformats.org/officeDocument/2006/relationships/oleObject" Target="../embeddings/oleObject29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1.xml"/><Relationship Id="rId2" Type="http://schemas.microsoft.com/office/2011/relationships/chartColorStyle" Target="colors30.xml"/><Relationship Id="rId1" Type="http://schemas.microsoft.com/office/2011/relationships/chartStyle" Target="style30.xml"/><Relationship Id="rId4" Type="http://schemas.openxmlformats.org/officeDocument/2006/relationships/oleObject" Target="../embeddings/oleObject30.bin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2.xml"/><Relationship Id="rId2" Type="http://schemas.microsoft.com/office/2011/relationships/chartColorStyle" Target="colors31.xml"/><Relationship Id="rId1" Type="http://schemas.microsoft.com/office/2011/relationships/chartStyle" Target="style31.xml"/><Relationship Id="rId4" Type="http://schemas.openxmlformats.org/officeDocument/2006/relationships/oleObject" Target="../embeddings/oleObject31.bin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3.xml"/><Relationship Id="rId2" Type="http://schemas.microsoft.com/office/2011/relationships/chartColorStyle" Target="colors32.xml"/><Relationship Id="rId1" Type="http://schemas.microsoft.com/office/2011/relationships/chartStyle" Target="style32.xml"/><Relationship Id="rId4" Type="http://schemas.openxmlformats.org/officeDocument/2006/relationships/oleObject" Target="../embeddings/oleObject32.bin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4.xml"/><Relationship Id="rId2" Type="http://schemas.microsoft.com/office/2011/relationships/chartColorStyle" Target="colors33.xml"/><Relationship Id="rId1" Type="http://schemas.microsoft.com/office/2011/relationships/chartStyle" Target="style33.xml"/><Relationship Id="rId4" Type="http://schemas.openxmlformats.org/officeDocument/2006/relationships/oleObject" Target="../embeddings/oleObject33.bin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5.xml"/><Relationship Id="rId2" Type="http://schemas.microsoft.com/office/2011/relationships/chartColorStyle" Target="colors34.xml"/><Relationship Id="rId1" Type="http://schemas.microsoft.com/office/2011/relationships/chartStyle" Target="style34.xml"/><Relationship Id="rId4" Type="http://schemas.openxmlformats.org/officeDocument/2006/relationships/oleObject" Target="../embeddings/oleObject34.bin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6.xml"/><Relationship Id="rId2" Type="http://schemas.microsoft.com/office/2011/relationships/chartColorStyle" Target="colors35.xml"/><Relationship Id="rId1" Type="http://schemas.microsoft.com/office/2011/relationships/chartStyle" Target="style35.xml"/><Relationship Id="rId4" Type="http://schemas.openxmlformats.org/officeDocument/2006/relationships/oleObject" Target="../embeddings/oleObject35.bin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7.xml"/><Relationship Id="rId2" Type="http://schemas.microsoft.com/office/2011/relationships/chartColorStyle" Target="colors36.xml"/><Relationship Id="rId1" Type="http://schemas.microsoft.com/office/2011/relationships/chartStyle" Target="style36.xml"/><Relationship Id="rId4" Type="http://schemas.openxmlformats.org/officeDocument/2006/relationships/oleObject" Target="../embeddings/oleObject36.bin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1</a:t>
            </a:r>
          </a:p>
        </c:rich>
      </c:tx>
      <c:layout>
        <c:manualLayout>
          <c:xMode val="edge"/>
          <c:yMode val="edge"/>
          <c:x val="0.46867555880492423"/>
          <c:y val="0.177194791648612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105335709183502"/>
          <c:y val="0.21816599529913711"/>
          <c:w val="0.79895333219505138"/>
          <c:h val="0.583894594415107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1'!$A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4:$F$34</c:f>
              <c:numCache>
                <c:formatCode>General</c:formatCode>
                <c:ptCount val="5"/>
                <c:pt idx="0">
                  <c:v>0.125</c:v>
                </c:pt>
                <c:pt idx="1">
                  <c:v>0.61349999999999993</c:v>
                </c:pt>
                <c:pt idx="2">
                  <c:v>0.8085</c:v>
                </c:pt>
                <c:pt idx="3">
                  <c:v>0.94099999999999995</c:v>
                </c:pt>
                <c:pt idx="4">
                  <c:v>1.0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AA0-422D-BD04-18103B5FAB7C}"/>
            </c:ext>
          </c:extLst>
        </c:ser>
        <c:ser>
          <c:idx val="1"/>
          <c:order val="1"/>
          <c:tx>
            <c:strRef>
              <c:f>'[E. coli Vs HM results.xlsx]R1L1'!$A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5:$F$35</c:f>
              <c:numCache>
                <c:formatCode>General</c:formatCode>
                <c:ptCount val="5"/>
                <c:pt idx="0">
                  <c:v>0.1065</c:v>
                </c:pt>
                <c:pt idx="1">
                  <c:v>0.61450000000000005</c:v>
                </c:pt>
                <c:pt idx="2">
                  <c:v>0.8234999999999999</c:v>
                </c:pt>
                <c:pt idx="3">
                  <c:v>0.95350000000000001</c:v>
                </c:pt>
                <c:pt idx="4">
                  <c:v>1.08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AA0-422D-BD04-18103B5FAB7C}"/>
            </c:ext>
          </c:extLst>
        </c:ser>
        <c:ser>
          <c:idx val="2"/>
          <c:order val="2"/>
          <c:tx>
            <c:strRef>
              <c:f>'[E. coli Vs HM results.xlsx]R1L1'!$A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6:$F$36</c:f>
              <c:numCache>
                <c:formatCode>General</c:formatCode>
                <c:ptCount val="5"/>
                <c:pt idx="0">
                  <c:v>0.1065</c:v>
                </c:pt>
                <c:pt idx="1">
                  <c:v>0.57499999999999996</c:v>
                </c:pt>
                <c:pt idx="2">
                  <c:v>0.72249999999999992</c:v>
                </c:pt>
                <c:pt idx="3">
                  <c:v>0.83599999999999997</c:v>
                </c:pt>
                <c:pt idx="4">
                  <c:v>0.9935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AA0-422D-BD04-18103B5FAB7C}"/>
            </c:ext>
          </c:extLst>
        </c:ser>
        <c:ser>
          <c:idx val="3"/>
          <c:order val="3"/>
          <c:tx>
            <c:strRef>
              <c:f>'[E. coli Vs HM results.xlsx]R1L1'!$A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7:$F$37</c:f>
              <c:numCache>
                <c:formatCode>General</c:formatCode>
                <c:ptCount val="5"/>
                <c:pt idx="0">
                  <c:v>0.1075</c:v>
                </c:pt>
                <c:pt idx="1">
                  <c:v>0.59499999999999997</c:v>
                </c:pt>
                <c:pt idx="2">
                  <c:v>0.72249999999999992</c:v>
                </c:pt>
                <c:pt idx="3">
                  <c:v>0.82599999999999996</c:v>
                </c:pt>
                <c:pt idx="4">
                  <c:v>0.988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AA0-422D-BD04-18103B5FAB7C}"/>
            </c:ext>
          </c:extLst>
        </c:ser>
        <c:ser>
          <c:idx val="4"/>
          <c:order val="4"/>
          <c:tx>
            <c:strRef>
              <c:f>'[E. coli Vs HM results.xlsx]R1L1'!$A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8:$F$38</c:f>
              <c:numCache>
                <c:formatCode>General</c:formatCode>
                <c:ptCount val="5"/>
                <c:pt idx="0">
                  <c:v>0.1075</c:v>
                </c:pt>
                <c:pt idx="1">
                  <c:v>0.50700000000000001</c:v>
                </c:pt>
                <c:pt idx="2">
                  <c:v>0.626</c:v>
                </c:pt>
                <c:pt idx="3">
                  <c:v>0.72</c:v>
                </c:pt>
                <c:pt idx="4">
                  <c:v>0.81099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AA0-422D-BD04-18103B5FAB7C}"/>
            </c:ext>
          </c:extLst>
        </c:ser>
        <c:ser>
          <c:idx val="5"/>
          <c:order val="5"/>
          <c:tx>
            <c:strRef>
              <c:f>'[E. coli Vs HM results.xlsx]R1L1'!$A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39:$F$39</c:f>
              <c:numCache>
                <c:formatCode>General</c:formatCode>
                <c:ptCount val="5"/>
                <c:pt idx="0">
                  <c:v>0.10650000000000001</c:v>
                </c:pt>
                <c:pt idx="1">
                  <c:v>0.40500000000000003</c:v>
                </c:pt>
                <c:pt idx="2">
                  <c:v>0.54899999999999993</c:v>
                </c:pt>
                <c:pt idx="3">
                  <c:v>0.63850000000000007</c:v>
                </c:pt>
                <c:pt idx="4">
                  <c:v>0.7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AA0-422D-BD04-18103B5FAB7C}"/>
            </c:ext>
          </c:extLst>
        </c:ser>
        <c:ser>
          <c:idx val="6"/>
          <c:order val="6"/>
          <c:tx>
            <c:strRef>
              <c:f>'[E. coli Vs HM results.xlsx]R1L1'!$A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40:$F$40</c:f>
              <c:numCache>
                <c:formatCode>General</c:formatCode>
                <c:ptCount val="5"/>
                <c:pt idx="0">
                  <c:v>0.10749999999999998</c:v>
                </c:pt>
                <c:pt idx="1">
                  <c:v>0.39750000000000002</c:v>
                </c:pt>
                <c:pt idx="2">
                  <c:v>0.51900000000000002</c:v>
                </c:pt>
                <c:pt idx="3">
                  <c:v>0.504</c:v>
                </c:pt>
                <c:pt idx="4">
                  <c:v>0.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AA0-422D-BD04-18103B5FAB7C}"/>
            </c:ext>
          </c:extLst>
        </c:ser>
        <c:ser>
          <c:idx val="7"/>
          <c:order val="7"/>
          <c:tx>
            <c:strRef>
              <c:f>'[E. coli Vs HM results.xlsx]R1L1'!$A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B$41:$F$41</c:f>
              <c:numCache>
                <c:formatCode>General</c:formatCode>
                <c:ptCount val="5"/>
                <c:pt idx="0">
                  <c:v>0.10650000000000001</c:v>
                </c:pt>
                <c:pt idx="1">
                  <c:v>0.32550000000000001</c:v>
                </c:pt>
                <c:pt idx="2">
                  <c:v>0.26500000000000001</c:v>
                </c:pt>
                <c:pt idx="3">
                  <c:v>0.20700000000000002</c:v>
                </c:pt>
                <c:pt idx="4">
                  <c:v>0.281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AA0-422D-BD04-18103B5FAB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6799"/>
        <c:axId val="1582372943"/>
      </c:scatterChart>
      <c:valAx>
        <c:axId val="142214679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2372943"/>
        <c:crosses val="autoZero"/>
        <c:crossBetween val="midCat"/>
      </c:valAx>
      <c:valAx>
        <c:axId val="15823729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679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037515165601221"/>
          <c:y val="1.9063211549791619E-2"/>
          <c:w val="0.72701215780398831"/>
          <c:h val="0.149047858359082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1</a:t>
            </a:r>
          </a:p>
        </c:rich>
      </c:tx>
      <c:layout>
        <c:manualLayout>
          <c:xMode val="edge"/>
          <c:yMode val="edge"/>
          <c:x val="0.47990706527435806"/>
          <c:y val="0.18410514078907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920981138482869"/>
          <c:y val="0.20211061941097835"/>
          <c:w val="0.82271606554129584"/>
          <c:h val="0.6911743235196908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1'!$O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4:$T$34</c:f>
              <c:numCache>
                <c:formatCode>General</c:formatCode>
                <c:ptCount val="5"/>
                <c:pt idx="0">
                  <c:v>0.125</c:v>
                </c:pt>
                <c:pt idx="1">
                  <c:v>0.61349999999999993</c:v>
                </c:pt>
                <c:pt idx="2">
                  <c:v>0.8085</c:v>
                </c:pt>
                <c:pt idx="3">
                  <c:v>0.94099999999999995</c:v>
                </c:pt>
                <c:pt idx="4">
                  <c:v>1.0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C30-439F-844A-D59104D2C141}"/>
            </c:ext>
          </c:extLst>
        </c:ser>
        <c:ser>
          <c:idx val="1"/>
          <c:order val="1"/>
          <c:tx>
            <c:strRef>
              <c:f>'[E. coli Vs HM results.xlsx]R1L1'!$O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5:$T$35</c:f>
              <c:numCache>
                <c:formatCode>General</c:formatCode>
                <c:ptCount val="5"/>
                <c:pt idx="0">
                  <c:v>0.10299999999999999</c:v>
                </c:pt>
                <c:pt idx="1">
                  <c:v>0.59299999999999997</c:v>
                </c:pt>
                <c:pt idx="2">
                  <c:v>0.79200000000000004</c:v>
                </c:pt>
                <c:pt idx="3">
                  <c:v>0.95499999999999996</c:v>
                </c:pt>
                <c:pt idx="4">
                  <c:v>1.102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C30-439F-844A-D59104D2C141}"/>
            </c:ext>
          </c:extLst>
        </c:ser>
        <c:ser>
          <c:idx val="2"/>
          <c:order val="2"/>
          <c:tx>
            <c:strRef>
              <c:f>'[E. coli Vs HM results.xlsx]R1L1'!$O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6:$T$36</c:f>
              <c:numCache>
                <c:formatCode>General</c:formatCode>
                <c:ptCount val="5"/>
                <c:pt idx="0">
                  <c:v>9.9000000000000005E-2</c:v>
                </c:pt>
                <c:pt idx="1">
                  <c:v>0.60599999999999998</c:v>
                </c:pt>
                <c:pt idx="2">
                  <c:v>0.79200000000000004</c:v>
                </c:pt>
                <c:pt idx="3">
                  <c:v>0.9375</c:v>
                </c:pt>
                <c:pt idx="4">
                  <c:v>1.10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C30-439F-844A-D59104D2C141}"/>
            </c:ext>
          </c:extLst>
        </c:ser>
        <c:ser>
          <c:idx val="3"/>
          <c:order val="3"/>
          <c:tx>
            <c:strRef>
              <c:f>'[E. coli Vs HM results.xlsx]R1L1'!$O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7:$T$37</c:f>
              <c:numCache>
                <c:formatCode>General</c:formatCode>
                <c:ptCount val="5"/>
                <c:pt idx="0">
                  <c:v>0.10050000000000001</c:v>
                </c:pt>
                <c:pt idx="1">
                  <c:v>0.621</c:v>
                </c:pt>
                <c:pt idx="2">
                  <c:v>0.82199999999999995</c:v>
                </c:pt>
                <c:pt idx="3">
                  <c:v>0.9504999999999999</c:v>
                </c:pt>
                <c:pt idx="4">
                  <c:v>1.105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C30-439F-844A-D59104D2C141}"/>
            </c:ext>
          </c:extLst>
        </c:ser>
        <c:ser>
          <c:idx val="4"/>
          <c:order val="4"/>
          <c:tx>
            <c:strRef>
              <c:f>'[E. coli Vs HM results.xlsx]R1L1'!$O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8:$T$38</c:f>
              <c:numCache>
                <c:formatCode>General</c:formatCode>
                <c:ptCount val="5"/>
                <c:pt idx="0">
                  <c:v>0.10100000000000001</c:v>
                </c:pt>
                <c:pt idx="1">
                  <c:v>0.62050000000000005</c:v>
                </c:pt>
                <c:pt idx="2">
                  <c:v>0.8294999999999999</c:v>
                </c:pt>
                <c:pt idx="3">
                  <c:v>0.96649999999999991</c:v>
                </c:pt>
                <c:pt idx="4">
                  <c:v>1.214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C30-439F-844A-D59104D2C141}"/>
            </c:ext>
          </c:extLst>
        </c:ser>
        <c:ser>
          <c:idx val="5"/>
          <c:order val="5"/>
          <c:tx>
            <c:strRef>
              <c:f>'[E. coli Vs HM results.xlsx]R1L1'!$O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39:$T$39</c:f>
              <c:numCache>
                <c:formatCode>General</c:formatCode>
                <c:ptCount val="5"/>
                <c:pt idx="0">
                  <c:v>9.7000000000000003E-2</c:v>
                </c:pt>
                <c:pt idx="1">
                  <c:v>0.60349999999999993</c:v>
                </c:pt>
                <c:pt idx="2">
                  <c:v>0.82499999999999996</c:v>
                </c:pt>
                <c:pt idx="3">
                  <c:v>0.95299999999999996</c:v>
                </c:pt>
                <c:pt idx="4">
                  <c:v>1.214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C30-439F-844A-D59104D2C141}"/>
            </c:ext>
          </c:extLst>
        </c:ser>
        <c:ser>
          <c:idx val="6"/>
          <c:order val="6"/>
          <c:tx>
            <c:strRef>
              <c:f>'[E. coli Vs HM results.xlsx]R1L1'!$O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40:$T$40</c:f>
              <c:numCache>
                <c:formatCode>General</c:formatCode>
                <c:ptCount val="5"/>
                <c:pt idx="0">
                  <c:v>9.6000000000000002E-2</c:v>
                </c:pt>
                <c:pt idx="1">
                  <c:v>0.56400000000000006</c:v>
                </c:pt>
                <c:pt idx="2">
                  <c:v>0.78600000000000003</c:v>
                </c:pt>
                <c:pt idx="3">
                  <c:v>0.95849999999999991</c:v>
                </c:pt>
                <c:pt idx="4">
                  <c:v>1.228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C30-439F-844A-D59104D2C141}"/>
            </c:ext>
          </c:extLst>
        </c:ser>
        <c:ser>
          <c:idx val="7"/>
          <c:order val="7"/>
          <c:tx>
            <c:strRef>
              <c:f>'[E. coli Vs HM results.xlsx]R1L1'!$O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P$41:$T$41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55649999999999999</c:v>
                </c:pt>
                <c:pt idx="2">
                  <c:v>0.78</c:v>
                </c:pt>
                <c:pt idx="3">
                  <c:v>0.9225000000000001</c:v>
                </c:pt>
                <c:pt idx="4">
                  <c:v>1.186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C30-439F-844A-D59104D2C1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2935535"/>
        <c:axId val="1822937935"/>
      </c:scatterChart>
      <c:valAx>
        <c:axId val="1822935535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2937935"/>
        <c:crosses val="autoZero"/>
        <c:crossBetween val="midCat"/>
      </c:valAx>
      <c:valAx>
        <c:axId val="1822937935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293553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201710282170873"/>
          <c:y val="1.5845218708140735E-2"/>
          <c:w val="0.66073765794575012"/>
          <c:h val="0.175112732739075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063559708662302"/>
          <c:y val="0.15841280892207218"/>
          <c:w val="0.79239924213554602"/>
          <c:h val="0.7211020467801159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2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35:$T$35</c:f>
              <c:numCache>
                <c:formatCode>General</c:formatCode>
                <c:ptCount val="5"/>
                <c:pt idx="0">
                  <c:v>0.124</c:v>
                </c:pt>
                <c:pt idx="1">
                  <c:v>0.70199999999999996</c:v>
                </c:pt>
                <c:pt idx="2">
                  <c:v>0.87149999999999994</c:v>
                </c:pt>
                <c:pt idx="3">
                  <c:v>0.97249999999999992</c:v>
                </c:pt>
                <c:pt idx="4">
                  <c:v>1.07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B77-47E6-B2D2-8F9BD512BE81}"/>
            </c:ext>
          </c:extLst>
        </c:ser>
        <c:ser>
          <c:idx val="1"/>
          <c:order val="1"/>
          <c:tx>
            <c:strRef>
              <c:f>'[E. coli Vs HM results.xlsx]R2L2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36:$T$36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73249999999999993</c:v>
                </c:pt>
                <c:pt idx="2">
                  <c:v>0.88800000000000001</c:v>
                </c:pt>
                <c:pt idx="3">
                  <c:v>0.97299999999999998</c:v>
                </c:pt>
                <c:pt idx="4">
                  <c:v>1.053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B77-47E6-B2D2-8F9BD512BE81}"/>
            </c:ext>
          </c:extLst>
        </c:ser>
        <c:ser>
          <c:idx val="2"/>
          <c:order val="2"/>
          <c:tx>
            <c:strRef>
              <c:f>'[E. coli Vs HM results.xlsx]R2L2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37:$T$37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800000000000005</c:v>
                </c:pt>
                <c:pt idx="2">
                  <c:v>0.84650000000000003</c:v>
                </c:pt>
                <c:pt idx="3">
                  <c:v>0.95</c:v>
                </c:pt>
                <c:pt idx="4">
                  <c:v>1.083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B77-47E6-B2D2-8F9BD512BE81}"/>
            </c:ext>
          </c:extLst>
        </c:ser>
        <c:ser>
          <c:idx val="3"/>
          <c:order val="3"/>
          <c:tx>
            <c:strRef>
              <c:f>'[E. coli Vs HM results.xlsx]R2L2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38:$T$38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72399999999999998</c:v>
                </c:pt>
                <c:pt idx="2">
                  <c:v>0.88850000000000007</c:v>
                </c:pt>
                <c:pt idx="3">
                  <c:v>0.97899999999999998</c:v>
                </c:pt>
                <c:pt idx="4">
                  <c:v>1.1284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B77-47E6-B2D2-8F9BD512BE81}"/>
            </c:ext>
          </c:extLst>
        </c:ser>
        <c:ser>
          <c:idx val="4"/>
          <c:order val="4"/>
          <c:tx>
            <c:strRef>
              <c:f>'[E. coli Vs HM results.xlsx]R2L2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39:$T$39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72449999999999992</c:v>
                </c:pt>
                <c:pt idx="2">
                  <c:v>0.88149999999999995</c:v>
                </c:pt>
                <c:pt idx="3">
                  <c:v>0.96899999999999997</c:v>
                </c:pt>
                <c:pt idx="4">
                  <c:v>1.10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B77-47E6-B2D2-8F9BD512BE81}"/>
            </c:ext>
          </c:extLst>
        </c:ser>
        <c:ser>
          <c:idx val="5"/>
          <c:order val="5"/>
          <c:tx>
            <c:strRef>
              <c:f>'[E. coli Vs HM results.xlsx]R2L2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40:$T$40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70950000000000002</c:v>
                </c:pt>
                <c:pt idx="2">
                  <c:v>0.86349999999999993</c:v>
                </c:pt>
                <c:pt idx="3">
                  <c:v>0.9415</c:v>
                </c:pt>
                <c:pt idx="4">
                  <c:v>1.14464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B77-47E6-B2D2-8F9BD512BE81}"/>
            </c:ext>
          </c:extLst>
        </c:ser>
        <c:ser>
          <c:idx val="6"/>
          <c:order val="6"/>
          <c:tx>
            <c:strRef>
              <c:f>'[E. coli Vs HM results.xlsx]R2L2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41:$T$41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62450000000000006</c:v>
                </c:pt>
                <c:pt idx="2">
                  <c:v>0.81100000000000005</c:v>
                </c:pt>
                <c:pt idx="3">
                  <c:v>0.92200000000000004</c:v>
                </c:pt>
                <c:pt idx="4">
                  <c:v>1.06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B77-47E6-B2D2-8F9BD512BE81}"/>
            </c:ext>
          </c:extLst>
        </c:ser>
        <c:ser>
          <c:idx val="7"/>
          <c:order val="7"/>
          <c:tx>
            <c:strRef>
              <c:f>'[E. coli Vs HM results.xlsx]R2L2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P$42:$T$42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60499999999999998</c:v>
                </c:pt>
                <c:pt idx="2">
                  <c:v>0.80500000000000005</c:v>
                </c:pt>
                <c:pt idx="3">
                  <c:v>0.91400000000000003</c:v>
                </c:pt>
                <c:pt idx="4">
                  <c:v>1.0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B77-47E6-B2D2-8F9BD512BE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3</a:t>
            </a:r>
          </a:p>
        </c:rich>
      </c:tx>
      <c:layout>
        <c:manualLayout>
          <c:xMode val="edge"/>
          <c:yMode val="edge"/>
          <c:x val="0.48633421468889243"/>
          <c:y val="6.85102811972731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68501232700201"/>
          <c:y val="0.14559566788531372"/>
          <c:w val="0.80534406366733891"/>
          <c:h val="0.7297248458846645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7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35:$T$35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100000000000004</c:v>
                </c:pt>
                <c:pt idx="2">
                  <c:v>0.83399999999999996</c:v>
                </c:pt>
                <c:pt idx="3">
                  <c:v>0.97350000000000003</c:v>
                </c:pt>
                <c:pt idx="4">
                  <c:v>1.04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B01-4781-81E5-5BF4B87AA93B}"/>
            </c:ext>
          </c:extLst>
        </c:ser>
        <c:ser>
          <c:idx val="1"/>
          <c:order val="1"/>
          <c:tx>
            <c:strRef>
              <c:f>'[E. coli Vs HM results.xlsx]R3L7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36:$T$36</c:f>
              <c:numCache>
                <c:formatCode>General</c:formatCode>
                <c:ptCount val="5"/>
                <c:pt idx="0">
                  <c:v>0.1095</c:v>
                </c:pt>
                <c:pt idx="1">
                  <c:v>0.6725000000000001</c:v>
                </c:pt>
                <c:pt idx="2">
                  <c:v>0.83</c:v>
                </c:pt>
                <c:pt idx="3">
                  <c:v>0.98649999999999993</c:v>
                </c:pt>
                <c:pt idx="4">
                  <c:v>1.03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B01-4781-81E5-5BF4B87AA93B}"/>
            </c:ext>
          </c:extLst>
        </c:ser>
        <c:ser>
          <c:idx val="2"/>
          <c:order val="2"/>
          <c:tx>
            <c:strRef>
              <c:f>'[E. coli Vs HM results.xlsx]R3L7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37:$T$37</c:f>
              <c:numCache>
                <c:formatCode>General</c:formatCode>
                <c:ptCount val="5"/>
                <c:pt idx="0">
                  <c:v>0.1105</c:v>
                </c:pt>
                <c:pt idx="1">
                  <c:v>0.66250000000000009</c:v>
                </c:pt>
                <c:pt idx="2">
                  <c:v>0.85749999999999993</c:v>
                </c:pt>
                <c:pt idx="3">
                  <c:v>1.01</c:v>
                </c:pt>
                <c:pt idx="4">
                  <c:v>1.096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B01-4781-81E5-5BF4B87AA93B}"/>
            </c:ext>
          </c:extLst>
        </c:ser>
        <c:ser>
          <c:idx val="3"/>
          <c:order val="3"/>
          <c:tx>
            <c:strRef>
              <c:f>'[E. coli Vs HM results.xlsx]R3L7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38:$T$38</c:f>
              <c:numCache>
                <c:formatCode>General</c:formatCode>
                <c:ptCount val="5"/>
                <c:pt idx="0">
                  <c:v>0.1095</c:v>
                </c:pt>
                <c:pt idx="1">
                  <c:v>0.68300000000000005</c:v>
                </c:pt>
                <c:pt idx="2">
                  <c:v>0.85749999999999993</c:v>
                </c:pt>
                <c:pt idx="3">
                  <c:v>1.0049999999999999</c:v>
                </c:pt>
                <c:pt idx="4">
                  <c:v>1.1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B01-4781-81E5-5BF4B87AA93B}"/>
            </c:ext>
          </c:extLst>
        </c:ser>
        <c:ser>
          <c:idx val="4"/>
          <c:order val="4"/>
          <c:tx>
            <c:strRef>
              <c:f>'[E. coli Vs HM results.xlsx]R3L7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39:$T$39</c:f>
              <c:numCache>
                <c:formatCode>General</c:formatCode>
                <c:ptCount val="5"/>
                <c:pt idx="0">
                  <c:v>0.1105</c:v>
                </c:pt>
                <c:pt idx="1">
                  <c:v>0.66549999999999998</c:v>
                </c:pt>
                <c:pt idx="2">
                  <c:v>0.84299999999999997</c:v>
                </c:pt>
                <c:pt idx="3">
                  <c:v>0.98649999999999993</c:v>
                </c:pt>
                <c:pt idx="4">
                  <c:v>1.091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B01-4781-81E5-5BF4B87AA93B}"/>
            </c:ext>
          </c:extLst>
        </c:ser>
        <c:ser>
          <c:idx val="5"/>
          <c:order val="5"/>
          <c:tx>
            <c:strRef>
              <c:f>'[E. coli Vs HM results.xlsx]R3L7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40:$T$40</c:f>
              <c:numCache>
                <c:formatCode>General</c:formatCode>
                <c:ptCount val="5"/>
                <c:pt idx="0">
                  <c:v>0.1105</c:v>
                </c:pt>
                <c:pt idx="1">
                  <c:v>0.65850000000000009</c:v>
                </c:pt>
                <c:pt idx="2">
                  <c:v>0.84650000000000003</c:v>
                </c:pt>
                <c:pt idx="3">
                  <c:v>0.98550000000000004</c:v>
                </c:pt>
                <c:pt idx="4">
                  <c:v>1.123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B01-4781-81E5-5BF4B87AA93B}"/>
            </c:ext>
          </c:extLst>
        </c:ser>
        <c:ser>
          <c:idx val="6"/>
          <c:order val="6"/>
          <c:tx>
            <c:strRef>
              <c:f>'[E. coli Vs HM results.xlsx]R3L7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41:$T$41</c:f>
              <c:numCache>
                <c:formatCode>General</c:formatCode>
                <c:ptCount val="5"/>
                <c:pt idx="0">
                  <c:v>0.1105</c:v>
                </c:pt>
                <c:pt idx="1">
                  <c:v>0.63349999999999995</c:v>
                </c:pt>
                <c:pt idx="2">
                  <c:v>0.83250000000000002</c:v>
                </c:pt>
                <c:pt idx="3">
                  <c:v>0.97199999999999998</c:v>
                </c:pt>
                <c:pt idx="4">
                  <c:v>1.08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B01-4781-81E5-5BF4B87AA93B}"/>
            </c:ext>
          </c:extLst>
        </c:ser>
        <c:ser>
          <c:idx val="7"/>
          <c:order val="7"/>
          <c:tx>
            <c:strRef>
              <c:f>'[E. coli Vs HM results.xlsx]R3L7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P$42:$T$42</c:f>
              <c:numCache>
                <c:formatCode>General</c:formatCode>
                <c:ptCount val="5"/>
                <c:pt idx="0">
                  <c:v>0.1105</c:v>
                </c:pt>
                <c:pt idx="1">
                  <c:v>0.61599999999999999</c:v>
                </c:pt>
                <c:pt idx="2">
                  <c:v>0.80249999999999999</c:v>
                </c:pt>
                <c:pt idx="3">
                  <c:v>0.94199999999999995</c:v>
                </c:pt>
                <c:pt idx="4">
                  <c:v>1.059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B01-4781-81E5-5BF4B87AA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985011826677837"/>
          <c:y val="0.11738875708129572"/>
          <c:w val="0.81441419756800915"/>
          <c:h val="0.7399598121338304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2 '!$O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4:$T$34</c:f>
              <c:numCache>
                <c:formatCode>General</c:formatCode>
                <c:ptCount val="5"/>
                <c:pt idx="0">
                  <c:v>0.1055</c:v>
                </c:pt>
                <c:pt idx="1">
                  <c:v>0.64200000000000002</c:v>
                </c:pt>
                <c:pt idx="2">
                  <c:v>0.80700000000000005</c:v>
                </c:pt>
                <c:pt idx="3">
                  <c:v>0.87149999999999994</c:v>
                </c:pt>
                <c:pt idx="4">
                  <c:v>0.945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87F-47B9-9A08-FA442A3BEE7D}"/>
            </c:ext>
          </c:extLst>
        </c:ser>
        <c:ser>
          <c:idx val="1"/>
          <c:order val="1"/>
          <c:tx>
            <c:strRef>
              <c:f>'[E. coli Vs HM results.xlsx]R1L2 '!$O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5:$T$35</c:f>
              <c:numCache>
                <c:formatCode>General</c:formatCode>
                <c:ptCount val="5"/>
                <c:pt idx="0">
                  <c:v>9.9500000000000005E-2</c:v>
                </c:pt>
                <c:pt idx="1">
                  <c:v>0.66349999999999998</c:v>
                </c:pt>
                <c:pt idx="2">
                  <c:v>0.80800000000000005</c:v>
                </c:pt>
                <c:pt idx="3">
                  <c:v>0.87</c:v>
                </c:pt>
                <c:pt idx="4">
                  <c:v>0.952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87F-47B9-9A08-FA442A3BEE7D}"/>
            </c:ext>
          </c:extLst>
        </c:ser>
        <c:ser>
          <c:idx val="2"/>
          <c:order val="2"/>
          <c:tx>
            <c:strRef>
              <c:f>'[E. coli Vs HM results.xlsx]R1L2 '!$O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6:$T$36</c:f>
              <c:numCache>
                <c:formatCode>General</c:formatCode>
                <c:ptCount val="5"/>
                <c:pt idx="0">
                  <c:v>9.9000000000000005E-2</c:v>
                </c:pt>
                <c:pt idx="1">
                  <c:v>0.64900000000000002</c:v>
                </c:pt>
                <c:pt idx="2">
                  <c:v>0.79500000000000004</c:v>
                </c:pt>
                <c:pt idx="3">
                  <c:v>0.86549999999999994</c:v>
                </c:pt>
                <c:pt idx="4">
                  <c:v>0.955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87F-47B9-9A08-FA442A3BEE7D}"/>
            </c:ext>
          </c:extLst>
        </c:ser>
        <c:ser>
          <c:idx val="3"/>
          <c:order val="3"/>
          <c:tx>
            <c:strRef>
              <c:f>'[E. coli Vs HM results.xlsx]R1L2 '!$O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7:$T$37</c:f>
              <c:numCache>
                <c:formatCode>General</c:formatCode>
                <c:ptCount val="5"/>
                <c:pt idx="0">
                  <c:v>9.8500000000000004E-2</c:v>
                </c:pt>
                <c:pt idx="1">
                  <c:v>0.64549999999999996</c:v>
                </c:pt>
                <c:pt idx="2">
                  <c:v>0.7975000000000001</c:v>
                </c:pt>
                <c:pt idx="3">
                  <c:v>0.85949999999999993</c:v>
                </c:pt>
                <c:pt idx="4">
                  <c:v>0.9389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87F-47B9-9A08-FA442A3BEE7D}"/>
            </c:ext>
          </c:extLst>
        </c:ser>
        <c:ser>
          <c:idx val="4"/>
          <c:order val="4"/>
          <c:tx>
            <c:strRef>
              <c:f>'[E. coli Vs HM results.xlsx]R1L2 '!$O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8:$T$38</c:f>
              <c:numCache>
                <c:formatCode>General</c:formatCode>
                <c:ptCount val="5"/>
                <c:pt idx="0">
                  <c:v>9.9500000000000005E-2</c:v>
                </c:pt>
                <c:pt idx="1">
                  <c:v>0.64</c:v>
                </c:pt>
                <c:pt idx="2">
                  <c:v>0.7975000000000001</c:v>
                </c:pt>
                <c:pt idx="3">
                  <c:v>0.86099999999999999</c:v>
                </c:pt>
                <c:pt idx="4">
                  <c:v>0.928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87F-47B9-9A08-FA442A3BEE7D}"/>
            </c:ext>
          </c:extLst>
        </c:ser>
        <c:ser>
          <c:idx val="5"/>
          <c:order val="5"/>
          <c:tx>
            <c:strRef>
              <c:f>'[E. coli Vs HM results.xlsx]R1L2 '!$O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39:$T$39</c:f>
              <c:numCache>
                <c:formatCode>General</c:formatCode>
                <c:ptCount val="5"/>
                <c:pt idx="0">
                  <c:v>9.9000000000000005E-2</c:v>
                </c:pt>
                <c:pt idx="1">
                  <c:v>0.61099999999999999</c:v>
                </c:pt>
                <c:pt idx="2">
                  <c:v>0.8125</c:v>
                </c:pt>
                <c:pt idx="3">
                  <c:v>0.87250000000000005</c:v>
                </c:pt>
                <c:pt idx="4">
                  <c:v>0.968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87F-47B9-9A08-FA442A3BEE7D}"/>
            </c:ext>
          </c:extLst>
        </c:ser>
        <c:ser>
          <c:idx val="6"/>
          <c:order val="6"/>
          <c:tx>
            <c:strRef>
              <c:f>'[E. coli Vs HM results.xlsx]R1L2 '!$O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40:$T$40</c:f>
              <c:numCache>
                <c:formatCode>General</c:formatCode>
                <c:ptCount val="5"/>
                <c:pt idx="0">
                  <c:v>9.5000000000000001E-2</c:v>
                </c:pt>
                <c:pt idx="1">
                  <c:v>0.59650000000000003</c:v>
                </c:pt>
                <c:pt idx="2">
                  <c:v>0.76449999999999996</c:v>
                </c:pt>
                <c:pt idx="3">
                  <c:v>0.7975000000000001</c:v>
                </c:pt>
                <c:pt idx="4">
                  <c:v>0.922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87F-47B9-9A08-FA442A3BEE7D}"/>
            </c:ext>
          </c:extLst>
        </c:ser>
        <c:ser>
          <c:idx val="7"/>
          <c:order val="7"/>
          <c:tx>
            <c:strRef>
              <c:f>'[E. coli Vs HM results.xlsx]R1L2 '!$O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P$41:$T$41</c:f>
              <c:numCache>
                <c:formatCode>General</c:formatCode>
                <c:ptCount val="5"/>
                <c:pt idx="0">
                  <c:v>0.11499999999999999</c:v>
                </c:pt>
                <c:pt idx="1">
                  <c:v>0.58599999999999997</c:v>
                </c:pt>
                <c:pt idx="2">
                  <c:v>0.73849999999999993</c:v>
                </c:pt>
                <c:pt idx="3">
                  <c:v>0.79</c:v>
                </c:pt>
                <c:pt idx="4">
                  <c:v>0.916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87F-47B9-9A08-FA442A3BE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55357823"/>
        <c:axId val="1755358783"/>
      </c:scatterChart>
      <c:valAx>
        <c:axId val="1755357823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5358783"/>
        <c:crosses val="autoZero"/>
        <c:crossBetween val="midCat"/>
      </c:valAx>
      <c:valAx>
        <c:axId val="1755358783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53578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2</a:t>
            </a:r>
          </a:p>
        </c:rich>
      </c:tx>
      <c:layout>
        <c:manualLayout>
          <c:xMode val="edge"/>
          <c:yMode val="edge"/>
          <c:x val="0.46870802492881575"/>
          <c:y val="9.54784489472727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37949147471243"/>
          <c:y val="0.103497218904956"/>
          <c:w val="0.81769280227280372"/>
          <c:h val="0.6677512234222072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3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35:$T$35</c:f>
              <c:numCache>
                <c:formatCode>General</c:formatCode>
                <c:ptCount val="5"/>
                <c:pt idx="0">
                  <c:v>0.1205</c:v>
                </c:pt>
                <c:pt idx="1">
                  <c:v>0.73499999999999999</c:v>
                </c:pt>
                <c:pt idx="2">
                  <c:v>0.90200000000000002</c:v>
                </c:pt>
                <c:pt idx="3">
                  <c:v>0.98750000000000004</c:v>
                </c:pt>
                <c:pt idx="4">
                  <c:v>1.08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43D-4999-9D36-2522DAEAC7E8}"/>
            </c:ext>
          </c:extLst>
        </c:ser>
        <c:ser>
          <c:idx val="1"/>
          <c:order val="1"/>
          <c:tx>
            <c:strRef>
              <c:f>'[E. coli Vs HM results.xlsx]R3L3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36:$T$36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64600000000000002</c:v>
                </c:pt>
                <c:pt idx="2">
                  <c:v>0.85699999999999998</c:v>
                </c:pt>
                <c:pt idx="3">
                  <c:v>0.97449999999999992</c:v>
                </c:pt>
                <c:pt idx="4">
                  <c:v>1.053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43D-4999-9D36-2522DAEAC7E8}"/>
            </c:ext>
          </c:extLst>
        </c:ser>
        <c:ser>
          <c:idx val="2"/>
          <c:order val="2"/>
          <c:tx>
            <c:strRef>
              <c:f>'[E. coli Vs HM results.xlsx]R3L3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37:$T$37</c:f>
              <c:numCache>
                <c:formatCode>General</c:formatCode>
                <c:ptCount val="5"/>
                <c:pt idx="0">
                  <c:v>0.114</c:v>
                </c:pt>
                <c:pt idx="1">
                  <c:v>0.66200000000000003</c:v>
                </c:pt>
                <c:pt idx="2">
                  <c:v>0.86699999999999999</c:v>
                </c:pt>
                <c:pt idx="3">
                  <c:v>0.97550000000000003</c:v>
                </c:pt>
                <c:pt idx="4">
                  <c:v>1.03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43D-4999-9D36-2522DAEAC7E8}"/>
            </c:ext>
          </c:extLst>
        </c:ser>
        <c:ser>
          <c:idx val="3"/>
          <c:order val="3"/>
          <c:tx>
            <c:strRef>
              <c:f>'[E. coli Vs HM results.xlsx]R3L3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38:$T$38</c:f>
              <c:numCache>
                <c:formatCode>General</c:formatCode>
                <c:ptCount val="5"/>
                <c:pt idx="0">
                  <c:v>0.1135</c:v>
                </c:pt>
                <c:pt idx="1">
                  <c:v>0.65900000000000003</c:v>
                </c:pt>
                <c:pt idx="2">
                  <c:v>0.85899999999999999</c:v>
                </c:pt>
                <c:pt idx="3">
                  <c:v>0.96699999999999997</c:v>
                </c:pt>
                <c:pt idx="4">
                  <c:v>1.04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43D-4999-9D36-2522DAEAC7E8}"/>
            </c:ext>
          </c:extLst>
        </c:ser>
        <c:ser>
          <c:idx val="4"/>
          <c:order val="4"/>
          <c:tx>
            <c:strRef>
              <c:f>'[E. coli Vs HM results.xlsx]R3L3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39:$T$39</c:f>
              <c:numCache>
                <c:formatCode>General</c:formatCode>
                <c:ptCount val="5"/>
                <c:pt idx="0">
                  <c:v>0.1135</c:v>
                </c:pt>
                <c:pt idx="1">
                  <c:v>0.67100000000000004</c:v>
                </c:pt>
                <c:pt idx="2">
                  <c:v>0.84050000000000002</c:v>
                </c:pt>
                <c:pt idx="3">
                  <c:v>0.9444999999999999</c:v>
                </c:pt>
                <c:pt idx="4">
                  <c:v>1.029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43D-4999-9D36-2522DAEAC7E8}"/>
            </c:ext>
          </c:extLst>
        </c:ser>
        <c:ser>
          <c:idx val="5"/>
          <c:order val="5"/>
          <c:tx>
            <c:strRef>
              <c:f>'[E. coli Vs HM results.xlsx]R3L3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40:$T$40</c:f>
              <c:numCache>
                <c:formatCode>General</c:formatCode>
                <c:ptCount val="5"/>
                <c:pt idx="0">
                  <c:v>0.1125</c:v>
                </c:pt>
                <c:pt idx="1">
                  <c:v>0.65749999999999997</c:v>
                </c:pt>
                <c:pt idx="2">
                  <c:v>0.83450000000000002</c:v>
                </c:pt>
                <c:pt idx="3">
                  <c:v>0.94350000000000001</c:v>
                </c:pt>
                <c:pt idx="4">
                  <c:v>1.062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43D-4999-9D36-2522DAEAC7E8}"/>
            </c:ext>
          </c:extLst>
        </c:ser>
        <c:ser>
          <c:idx val="6"/>
          <c:order val="6"/>
          <c:tx>
            <c:strRef>
              <c:f>'[E. coli Vs HM results.xlsx]R3L3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41:$T$41</c:f>
              <c:numCache>
                <c:formatCode>General</c:formatCode>
                <c:ptCount val="5"/>
                <c:pt idx="0">
                  <c:v>0.1135</c:v>
                </c:pt>
                <c:pt idx="1">
                  <c:v>0.62749999999999995</c:v>
                </c:pt>
                <c:pt idx="2">
                  <c:v>0.82399999999999995</c:v>
                </c:pt>
                <c:pt idx="3">
                  <c:v>0.92549999999999999</c:v>
                </c:pt>
                <c:pt idx="4">
                  <c:v>1.05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543D-4999-9D36-2522DAEAC7E8}"/>
            </c:ext>
          </c:extLst>
        </c:ser>
        <c:ser>
          <c:idx val="7"/>
          <c:order val="7"/>
          <c:tx>
            <c:strRef>
              <c:f>'[E. coli Vs HM results.xlsx]R3L3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P$42:$T$42</c:f>
              <c:numCache>
                <c:formatCode>General</c:formatCode>
                <c:ptCount val="5"/>
                <c:pt idx="0">
                  <c:v>0.1135</c:v>
                </c:pt>
                <c:pt idx="1">
                  <c:v>0.61149999999999993</c:v>
                </c:pt>
                <c:pt idx="2">
                  <c:v>0.8165</c:v>
                </c:pt>
                <c:pt idx="3">
                  <c:v>0.91500000000000004</c:v>
                </c:pt>
                <c:pt idx="4">
                  <c:v>1.03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543D-4999-9D36-2522DAEAC7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3</a:t>
            </a:r>
          </a:p>
        </c:rich>
      </c:tx>
      <c:layout>
        <c:manualLayout>
          <c:xMode val="edge"/>
          <c:yMode val="edge"/>
          <c:x val="0.48031515177408812"/>
          <c:y val="0.106166493902293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'[E. coli Vs HM results.xlsx]R3L10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35:$T$35</c:f>
              <c:numCache>
                <c:formatCode>General</c:formatCode>
                <c:ptCount val="5"/>
                <c:pt idx="0">
                  <c:v>0.13150000000000001</c:v>
                </c:pt>
                <c:pt idx="1">
                  <c:v>0.69</c:v>
                </c:pt>
                <c:pt idx="2">
                  <c:v>0.84499999999999997</c:v>
                </c:pt>
                <c:pt idx="3">
                  <c:v>0.94699999999999995</c:v>
                </c:pt>
                <c:pt idx="4">
                  <c:v>1.05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CE8-4669-98F8-529F1A1FE449}"/>
            </c:ext>
          </c:extLst>
        </c:ser>
        <c:ser>
          <c:idx val="1"/>
          <c:order val="1"/>
          <c:tx>
            <c:strRef>
              <c:f>'[E. coli Vs HM results.xlsx]R3L10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36:$T$36</c:f>
              <c:numCache>
                <c:formatCode>General</c:formatCode>
                <c:ptCount val="5"/>
                <c:pt idx="0">
                  <c:v>0.124</c:v>
                </c:pt>
                <c:pt idx="1">
                  <c:v>0.69699999999999995</c:v>
                </c:pt>
                <c:pt idx="2">
                  <c:v>0.874</c:v>
                </c:pt>
                <c:pt idx="3">
                  <c:v>0.997</c:v>
                </c:pt>
                <c:pt idx="4">
                  <c:v>1.20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CE8-4669-98F8-529F1A1FE449}"/>
            </c:ext>
          </c:extLst>
        </c:ser>
        <c:ser>
          <c:idx val="2"/>
          <c:order val="2"/>
          <c:tx>
            <c:strRef>
              <c:f>'[E. coli Vs HM results.xlsx]R3L10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37:$T$37</c:f>
              <c:numCache>
                <c:formatCode>General</c:formatCode>
                <c:ptCount val="5"/>
                <c:pt idx="0">
                  <c:v>0.1245</c:v>
                </c:pt>
                <c:pt idx="1">
                  <c:v>0.65549999999999997</c:v>
                </c:pt>
                <c:pt idx="2">
                  <c:v>0.81349999999999989</c:v>
                </c:pt>
                <c:pt idx="3">
                  <c:v>0.9345</c:v>
                </c:pt>
                <c:pt idx="4">
                  <c:v>1.133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CE8-4669-98F8-529F1A1FE449}"/>
            </c:ext>
          </c:extLst>
        </c:ser>
        <c:ser>
          <c:idx val="3"/>
          <c:order val="3"/>
          <c:tx>
            <c:strRef>
              <c:f>'[E. coli Vs HM results.xlsx]R3L10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38:$T$38</c:f>
              <c:numCache>
                <c:formatCode>General</c:formatCode>
                <c:ptCount val="5"/>
                <c:pt idx="0">
                  <c:v>0.1215</c:v>
                </c:pt>
                <c:pt idx="1">
                  <c:v>0.66050000000000009</c:v>
                </c:pt>
                <c:pt idx="2">
                  <c:v>0.8194999999999999</c:v>
                </c:pt>
                <c:pt idx="3">
                  <c:v>0.9365</c:v>
                </c:pt>
                <c:pt idx="4">
                  <c:v>1.119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CE8-4669-98F8-529F1A1FE449}"/>
            </c:ext>
          </c:extLst>
        </c:ser>
        <c:ser>
          <c:idx val="4"/>
          <c:order val="4"/>
          <c:tx>
            <c:strRef>
              <c:f>'[E. coli Vs HM results.xlsx]R3L10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39:$T$39</c:f>
              <c:numCache>
                <c:formatCode>General</c:formatCode>
                <c:ptCount val="5"/>
                <c:pt idx="0">
                  <c:v>0.1225</c:v>
                </c:pt>
                <c:pt idx="1">
                  <c:v>0.7004999999999999</c:v>
                </c:pt>
                <c:pt idx="2">
                  <c:v>0.88349999999999995</c:v>
                </c:pt>
                <c:pt idx="3">
                  <c:v>0.96799999999999997</c:v>
                </c:pt>
                <c:pt idx="4">
                  <c:v>1.15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CE8-4669-98F8-529F1A1FE449}"/>
            </c:ext>
          </c:extLst>
        </c:ser>
        <c:ser>
          <c:idx val="5"/>
          <c:order val="5"/>
          <c:tx>
            <c:strRef>
              <c:f>'[E. coli Vs HM results.xlsx]R3L10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40:$T$40</c:f>
              <c:numCache>
                <c:formatCode>General</c:formatCode>
                <c:ptCount val="5"/>
                <c:pt idx="0">
                  <c:v>0.1225</c:v>
                </c:pt>
                <c:pt idx="1">
                  <c:v>0.65900000000000003</c:v>
                </c:pt>
                <c:pt idx="2">
                  <c:v>0.83749999999999991</c:v>
                </c:pt>
                <c:pt idx="3">
                  <c:v>0.93199999999999994</c:v>
                </c:pt>
                <c:pt idx="4">
                  <c:v>1.0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CE8-4669-98F8-529F1A1FE449}"/>
            </c:ext>
          </c:extLst>
        </c:ser>
        <c:ser>
          <c:idx val="6"/>
          <c:order val="6"/>
          <c:tx>
            <c:strRef>
              <c:f>'[E. coli Vs HM results.xlsx]R3L10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41:$T$41</c:f>
              <c:numCache>
                <c:formatCode>General</c:formatCode>
                <c:ptCount val="5"/>
                <c:pt idx="0">
                  <c:v>0.124</c:v>
                </c:pt>
                <c:pt idx="1">
                  <c:v>0.64800000000000002</c:v>
                </c:pt>
                <c:pt idx="2">
                  <c:v>0.82399999999999995</c:v>
                </c:pt>
                <c:pt idx="3">
                  <c:v>0.90549999999999997</c:v>
                </c:pt>
                <c:pt idx="4">
                  <c:v>1.035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BCE8-4669-98F8-529F1A1FE449}"/>
            </c:ext>
          </c:extLst>
        </c:ser>
        <c:ser>
          <c:idx val="7"/>
          <c:order val="7"/>
          <c:tx>
            <c:strRef>
              <c:f>'[E. coli Vs HM results.xlsx]R3L10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P$42:$T$42</c:f>
              <c:numCache>
                <c:formatCode>General</c:formatCode>
                <c:ptCount val="5"/>
                <c:pt idx="0">
                  <c:v>0.1225</c:v>
                </c:pt>
                <c:pt idx="1">
                  <c:v>0.63450000000000006</c:v>
                </c:pt>
                <c:pt idx="2">
                  <c:v>0.8085</c:v>
                </c:pt>
                <c:pt idx="3">
                  <c:v>0.89450000000000007</c:v>
                </c:pt>
                <c:pt idx="4">
                  <c:v>1.03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BCE8-4669-98F8-529F1A1FE4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498412688510484"/>
          <c:y val="0.13727652653135031"/>
          <c:w val="0.80760119575626022"/>
          <c:h val="0.7367609438550016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3'!$O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4:$T$34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59149999999999991</c:v>
                </c:pt>
                <c:pt idx="2">
                  <c:v>0.76300000000000001</c:v>
                </c:pt>
                <c:pt idx="3">
                  <c:v>0.9335</c:v>
                </c:pt>
                <c:pt idx="4">
                  <c:v>1.016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98A-4FCF-951B-9F98991C1D64}"/>
            </c:ext>
          </c:extLst>
        </c:ser>
        <c:ser>
          <c:idx val="1"/>
          <c:order val="1"/>
          <c:tx>
            <c:strRef>
              <c:f>'[E. coli Vs HM results.xlsx]R1L3'!$O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5:$T$35</c:f>
              <c:numCache>
                <c:formatCode>General</c:formatCode>
                <c:ptCount val="5"/>
                <c:pt idx="0">
                  <c:v>9.1499999999999998E-2</c:v>
                </c:pt>
                <c:pt idx="1">
                  <c:v>0.59199999999999997</c:v>
                </c:pt>
                <c:pt idx="2">
                  <c:v>0.74299999999999999</c:v>
                </c:pt>
                <c:pt idx="3">
                  <c:v>0.88</c:v>
                </c:pt>
                <c:pt idx="4">
                  <c:v>0.984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98A-4FCF-951B-9F98991C1D64}"/>
            </c:ext>
          </c:extLst>
        </c:ser>
        <c:ser>
          <c:idx val="2"/>
          <c:order val="2"/>
          <c:tx>
            <c:strRef>
              <c:f>'[E. coli Vs HM results.xlsx]R1L3'!$O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6:$T$36</c:f>
              <c:numCache>
                <c:formatCode>General</c:formatCode>
                <c:ptCount val="5"/>
                <c:pt idx="0">
                  <c:v>9.2499999999999999E-2</c:v>
                </c:pt>
                <c:pt idx="1">
                  <c:v>0.59099999999999997</c:v>
                </c:pt>
                <c:pt idx="2">
                  <c:v>0.77950000000000008</c:v>
                </c:pt>
                <c:pt idx="3">
                  <c:v>0.90250000000000008</c:v>
                </c:pt>
                <c:pt idx="4">
                  <c:v>1.02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98A-4FCF-951B-9F98991C1D64}"/>
            </c:ext>
          </c:extLst>
        </c:ser>
        <c:ser>
          <c:idx val="3"/>
          <c:order val="3"/>
          <c:tx>
            <c:strRef>
              <c:f>'[E. coli Vs HM results.xlsx]R1L3'!$O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7:$T$37</c:f>
              <c:numCache>
                <c:formatCode>General</c:formatCode>
                <c:ptCount val="5"/>
                <c:pt idx="0">
                  <c:v>9.35E-2</c:v>
                </c:pt>
                <c:pt idx="1">
                  <c:v>0.61949999999999994</c:v>
                </c:pt>
                <c:pt idx="2">
                  <c:v>0.80600000000000005</c:v>
                </c:pt>
                <c:pt idx="3">
                  <c:v>0.92400000000000004</c:v>
                </c:pt>
                <c:pt idx="4">
                  <c:v>1.02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98A-4FCF-951B-9F98991C1D64}"/>
            </c:ext>
          </c:extLst>
        </c:ser>
        <c:ser>
          <c:idx val="4"/>
          <c:order val="4"/>
          <c:tx>
            <c:strRef>
              <c:f>'[E. coli Vs HM results.xlsx]R1L3'!$O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8:$T$38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61050000000000004</c:v>
                </c:pt>
                <c:pt idx="2">
                  <c:v>0.78550000000000009</c:v>
                </c:pt>
                <c:pt idx="3">
                  <c:v>0.90749999999999997</c:v>
                </c:pt>
                <c:pt idx="4">
                  <c:v>1.012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298A-4FCF-951B-9F98991C1D64}"/>
            </c:ext>
          </c:extLst>
        </c:ser>
        <c:ser>
          <c:idx val="5"/>
          <c:order val="5"/>
          <c:tx>
            <c:strRef>
              <c:f>'[E. coli Vs HM results.xlsx]R1L3'!$O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39:$T$39</c:f>
              <c:numCache>
                <c:formatCode>General</c:formatCode>
                <c:ptCount val="5"/>
                <c:pt idx="0">
                  <c:v>9.9000000000000005E-2</c:v>
                </c:pt>
                <c:pt idx="1">
                  <c:v>0.69399999999999995</c:v>
                </c:pt>
                <c:pt idx="2">
                  <c:v>0.87749999999999995</c:v>
                </c:pt>
                <c:pt idx="3">
                  <c:v>0.97199999999999998</c:v>
                </c:pt>
                <c:pt idx="4">
                  <c:v>1.10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298A-4FCF-951B-9F98991C1D64}"/>
            </c:ext>
          </c:extLst>
        </c:ser>
        <c:ser>
          <c:idx val="6"/>
          <c:order val="6"/>
          <c:tx>
            <c:strRef>
              <c:f>'[E. coli Vs HM results.xlsx]R1L3'!$O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40:$T$40</c:f>
              <c:numCache>
                <c:formatCode>General</c:formatCode>
                <c:ptCount val="5"/>
                <c:pt idx="0">
                  <c:v>9.8500000000000004E-2</c:v>
                </c:pt>
                <c:pt idx="1">
                  <c:v>0.62850000000000006</c:v>
                </c:pt>
                <c:pt idx="2">
                  <c:v>0.84199999999999997</c:v>
                </c:pt>
                <c:pt idx="3">
                  <c:v>0.91850000000000009</c:v>
                </c:pt>
                <c:pt idx="4">
                  <c:v>1.076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298A-4FCF-951B-9F98991C1D64}"/>
            </c:ext>
          </c:extLst>
        </c:ser>
        <c:ser>
          <c:idx val="7"/>
          <c:order val="7"/>
          <c:tx>
            <c:strRef>
              <c:f>'[E. coli Vs HM results.xlsx]R1L3'!$O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P$33:$T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P$41:$T$41</c:f>
              <c:numCache>
                <c:formatCode>General</c:formatCode>
                <c:ptCount val="5"/>
                <c:pt idx="0">
                  <c:v>9.5000000000000001E-2</c:v>
                </c:pt>
                <c:pt idx="1">
                  <c:v>0.57199999999999995</c:v>
                </c:pt>
                <c:pt idx="2">
                  <c:v>0.78</c:v>
                </c:pt>
                <c:pt idx="3">
                  <c:v>0.88500000000000001</c:v>
                </c:pt>
                <c:pt idx="4">
                  <c:v>1.0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298A-4FCF-951B-9F98991C1D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05437423"/>
        <c:axId val="2105438863"/>
      </c:scatterChart>
      <c:valAx>
        <c:axId val="2105437423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5438863"/>
        <c:crosses val="autoZero"/>
        <c:crossBetween val="midCat"/>
      </c:valAx>
      <c:valAx>
        <c:axId val="2105438863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54374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2</a:t>
            </a:r>
          </a:p>
        </c:rich>
      </c:tx>
      <c:layout>
        <c:manualLayout>
          <c:xMode val="edge"/>
          <c:yMode val="edge"/>
          <c:x val="0.5351704915569877"/>
          <c:y val="9.05134181810680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765053272666783"/>
          <c:y val="0.13630603750400924"/>
          <c:w val="0.76265336833144493"/>
          <c:h val="0.7112863503866034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1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35:$T$35</c:f>
              <c:numCache>
                <c:formatCode>General</c:formatCode>
                <c:ptCount val="5"/>
                <c:pt idx="0">
                  <c:v>0.124</c:v>
                </c:pt>
                <c:pt idx="1">
                  <c:v>0.60850000000000004</c:v>
                </c:pt>
                <c:pt idx="2">
                  <c:v>0.78600000000000003</c:v>
                </c:pt>
                <c:pt idx="3">
                  <c:v>0.91700000000000004</c:v>
                </c:pt>
                <c:pt idx="4">
                  <c:v>1.0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DA-4709-9C5A-9A8009872A84}"/>
            </c:ext>
          </c:extLst>
        </c:ser>
        <c:ser>
          <c:idx val="1"/>
          <c:order val="1"/>
          <c:tx>
            <c:strRef>
              <c:f>'[E. coli Vs HM results.xlsx]R2L1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36:$T$36</c:f>
              <c:numCache>
                <c:formatCode>General</c:formatCode>
                <c:ptCount val="5"/>
                <c:pt idx="0">
                  <c:v>0.1105</c:v>
                </c:pt>
                <c:pt idx="1">
                  <c:v>0.626</c:v>
                </c:pt>
                <c:pt idx="2">
                  <c:v>0.79200000000000004</c:v>
                </c:pt>
                <c:pt idx="3">
                  <c:v>0.94350000000000001</c:v>
                </c:pt>
                <c:pt idx="4">
                  <c:v>1.0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DA-4709-9C5A-9A8009872A84}"/>
            </c:ext>
          </c:extLst>
        </c:ser>
        <c:ser>
          <c:idx val="2"/>
          <c:order val="2"/>
          <c:tx>
            <c:strRef>
              <c:f>'[E. coli Vs HM results.xlsx]R2L1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37:$T$37</c:f>
              <c:numCache>
                <c:formatCode>General</c:formatCode>
                <c:ptCount val="5"/>
                <c:pt idx="0">
                  <c:v>0.1105</c:v>
                </c:pt>
                <c:pt idx="1">
                  <c:v>0.63100000000000001</c:v>
                </c:pt>
                <c:pt idx="2">
                  <c:v>0.76500000000000001</c:v>
                </c:pt>
                <c:pt idx="3">
                  <c:v>0.92500000000000004</c:v>
                </c:pt>
                <c:pt idx="4">
                  <c:v>1.096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0DA-4709-9C5A-9A8009872A84}"/>
            </c:ext>
          </c:extLst>
        </c:ser>
        <c:ser>
          <c:idx val="3"/>
          <c:order val="3"/>
          <c:tx>
            <c:strRef>
              <c:f>'[E. coli Vs HM results.xlsx]R2L1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38:$T$38</c:f>
              <c:numCache>
                <c:formatCode>General</c:formatCode>
                <c:ptCount val="5"/>
                <c:pt idx="0">
                  <c:v>0.1105</c:v>
                </c:pt>
                <c:pt idx="1">
                  <c:v>0.64900000000000002</c:v>
                </c:pt>
                <c:pt idx="2">
                  <c:v>0.79300000000000004</c:v>
                </c:pt>
                <c:pt idx="3">
                  <c:v>0.91600000000000004</c:v>
                </c:pt>
                <c:pt idx="4">
                  <c:v>1.089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0DA-4709-9C5A-9A8009872A84}"/>
            </c:ext>
          </c:extLst>
        </c:ser>
        <c:ser>
          <c:idx val="4"/>
          <c:order val="4"/>
          <c:tx>
            <c:strRef>
              <c:f>'[E. coli Vs HM results.xlsx]R2L1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39:$T$39</c:f>
              <c:numCache>
                <c:formatCode>General</c:formatCode>
                <c:ptCount val="5"/>
                <c:pt idx="0">
                  <c:v>0.1105</c:v>
                </c:pt>
                <c:pt idx="1">
                  <c:v>0.60349999999999993</c:v>
                </c:pt>
                <c:pt idx="2">
                  <c:v>0.77049999999999996</c:v>
                </c:pt>
                <c:pt idx="3">
                  <c:v>0.90749999999999997</c:v>
                </c:pt>
                <c:pt idx="4">
                  <c:v>1.126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0DA-4709-9C5A-9A8009872A84}"/>
            </c:ext>
          </c:extLst>
        </c:ser>
        <c:ser>
          <c:idx val="5"/>
          <c:order val="5"/>
          <c:tx>
            <c:strRef>
              <c:f>'[E. coli Vs HM results.xlsx]R2L1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40:$T$40</c:f>
              <c:numCache>
                <c:formatCode>General</c:formatCode>
                <c:ptCount val="5"/>
                <c:pt idx="0">
                  <c:v>0.1095</c:v>
                </c:pt>
                <c:pt idx="1">
                  <c:v>0.58499999999999996</c:v>
                </c:pt>
                <c:pt idx="2">
                  <c:v>0.77049999999999996</c:v>
                </c:pt>
                <c:pt idx="3">
                  <c:v>0.91800000000000004</c:v>
                </c:pt>
                <c:pt idx="4">
                  <c:v>1.14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0DA-4709-9C5A-9A8009872A84}"/>
            </c:ext>
          </c:extLst>
        </c:ser>
        <c:ser>
          <c:idx val="6"/>
          <c:order val="6"/>
          <c:tx>
            <c:strRef>
              <c:f>'[E. coli Vs HM results.xlsx]R2L1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41:$T$41</c:f>
              <c:numCache>
                <c:formatCode>General</c:formatCode>
                <c:ptCount val="5"/>
                <c:pt idx="0">
                  <c:v>0.1105</c:v>
                </c:pt>
                <c:pt idx="1">
                  <c:v>0.57850000000000001</c:v>
                </c:pt>
                <c:pt idx="2">
                  <c:v>0.76550000000000007</c:v>
                </c:pt>
                <c:pt idx="3">
                  <c:v>0.89650000000000007</c:v>
                </c:pt>
                <c:pt idx="4">
                  <c:v>1.116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0DA-4709-9C5A-9A8009872A84}"/>
            </c:ext>
          </c:extLst>
        </c:ser>
        <c:ser>
          <c:idx val="7"/>
          <c:order val="7"/>
          <c:tx>
            <c:strRef>
              <c:f>'[E. coli Vs HM results.xlsx]R2L1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P$42:$T$42</c:f>
              <c:numCache>
                <c:formatCode>General</c:formatCode>
                <c:ptCount val="5"/>
                <c:pt idx="0">
                  <c:v>0.1075</c:v>
                </c:pt>
                <c:pt idx="1">
                  <c:v>0.55449999999999999</c:v>
                </c:pt>
                <c:pt idx="2">
                  <c:v>0.72950000000000004</c:v>
                </c:pt>
                <c:pt idx="3">
                  <c:v>0.90749999999999997</c:v>
                </c:pt>
                <c:pt idx="4">
                  <c:v>1.076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0DA-4709-9C5A-9A8009872A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3</a:t>
            </a:r>
          </a:p>
        </c:rich>
      </c:tx>
      <c:layout>
        <c:manualLayout>
          <c:xMode val="edge"/>
          <c:yMode val="edge"/>
          <c:x val="0.50052283405193987"/>
          <c:y val="9.9312964307657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68646878115268"/>
          <c:y val="0.17540561172243016"/>
          <c:w val="0.81693406302768901"/>
          <c:h val="0.61341935243627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5'!$O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35:$T$35</c:f>
              <c:numCache>
                <c:formatCode>General</c:formatCode>
                <c:ptCount val="5"/>
                <c:pt idx="0">
                  <c:v>0.1215</c:v>
                </c:pt>
                <c:pt idx="1">
                  <c:v>0.62749999999999995</c:v>
                </c:pt>
                <c:pt idx="2">
                  <c:v>0.81549999999999989</c:v>
                </c:pt>
                <c:pt idx="3">
                  <c:v>0.89749999999999996</c:v>
                </c:pt>
                <c:pt idx="4">
                  <c:v>0.952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639-442E-968B-E9788DD3AE2A}"/>
            </c:ext>
          </c:extLst>
        </c:ser>
        <c:ser>
          <c:idx val="1"/>
          <c:order val="1"/>
          <c:tx>
            <c:strRef>
              <c:f>'[E. coli Vs HM results.xlsx]R3L5'!$O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36:$T$36</c:f>
              <c:numCache>
                <c:formatCode>General</c:formatCode>
                <c:ptCount val="5"/>
                <c:pt idx="0">
                  <c:v>0.1105</c:v>
                </c:pt>
                <c:pt idx="1">
                  <c:v>0.64</c:v>
                </c:pt>
                <c:pt idx="2">
                  <c:v>0.8254999999999999</c:v>
                </c:pt>
                <c:pt idx="3">
                  <c:v>0.96950000000000003</c:v>
                </c:pt>
                <c:pt idx="4">
                  <c:v>1.04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639-442E-968B-E9788DD3AE2A}"/>
            </c:ext>
          </c:extLst>
        </c:ser>
        <c:ser>
          <c:idx val="2"/>
          <c:order val="2"/>
          <c:tx>
            <c:strRef>
              <c:f>'[E. coli Vs HM results.xlsx]R3L5'!$O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37:$T$37</c:f>
              <c:numCache>
                <c:formatCode>General</c:formatCode>
                <c:ptCount val="5"/>
                <c:pt idx="0">
                  <c:v>0.1115</c:v>
                </c:pt>
                <c:pt idx="1">
                  <c:v>0.64349999999999996</c:v>
                </c:pt>
                <c:pt idx="2">
                  <c:v>0.7995000000000001</c:v>
                </c:pt>
                <c:pt idx="3">
                  <c:v>0.9265000000000001</c:v>
                </c:pt>
                <c:pt idx="4">
                  <c:v>1.007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639-442E-968B-E9788DD3AE2A}"/>
            </c:ext>
          </c:extLst>
        </c:ser>
        <c:ser>
          <c:idx val="3"/>
          <c:order val="3"/>
          <c:tx>
            <c:strRef>
              <c:f>'[E. coli Vs HM results.xlsx]R3L5'!$O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38:$T$38</c:f>
              <c:numCache>
                <c:formatCode>General</c:formatCode>
                <c:ptCount val="5"/>
                <c:pt idx="0">
                  <c:v>0.1115</c:v>
                </c:pt>
                <c:pt idx="1">
                  <c:v>0.6745000000000001</c:v>
                </c:pt>
                <c:pt idx="2">
                  <c:v>0.85050000000000003</c:v>
                </c:pt>
                <c:pt idx="3">
                  <c:v>0.96649999999999991</c:v>
                </c:pt>
                <c:pt idx="4">
                  <c:v>1.04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639-442E-968B-E9788DD3AE2A}"/>
            </c:ext>
          </c:extLst>
        </c:ser>
        <c:ser>
          <c:idx val="4"/>
          <c:order val="4"/>
          <c:tx>
            <c:strRef>
              <c:f>'[E. coli Vs HM results.xlsx]R3L5'!$O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39:$T$39</c:f>
              <c:numCache>
                <c:formatCode>General</c:formatCode>
                <c:ptCount val="5"/>
                <c:pt idx="0">
                  <c:v>0.1115</c:v>
                </c:pt>
                <c:pt idx="1">
                  <c:v>0.64949999999999997</c:v>
                </c:pt>
                <c:pt idx="2">
                  <c:v>0.81749999999999989</c:v>
                </c:pt>
                <c:pt idx="3">
                  <c:v>0.9504999999999999</c:v>
                </c:pt>
                <c:pt idx="4">
                  <c:v>1.02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639-442E-968B-E9788DD3AE2A}"/>
            </c:ext>
          </c:extLst>
        </c:ser>
        <c:ser>
          <c:idx val="5"/>
          <c:order val="5"/>
          <c:tx>
            <c:strRef>
              <c:f>'[E. coli Vs HM results.xlsx]R3L5'!$O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40:$T$40</c:f>
              <c:numCache>
                <c:formatCode>General</c:formatCode>
                <c:ptCount val="5"/>
                <c:pt idx="0">
                  <c:v>0.1115</c:v>
                </c:pt>
                <c:pt idx="1">
                  <c:v>0.63500000000000001</c:v>
                </c:pt>
                <c:pt idx="2">
                  <c:v>0.80649999999999999</c:v>
                </c:pt>
                <c:pt idx="3">
                  <c:v>0.92200000000000004</c:v>
                </c:pt>
                <c:pt idx="4">
                  <c:v>1.00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639-442E-968B-E9788DD3AE2A}"/>
            </c:ext>
          </c:extLst>
        </c:ser>
        <c:ser>
          <c:idx val="6"/>
          <c:order val="6"/>
          <c:tx>
            <c:strRef>
              <c:f>'[E. coli Vs HM results.xlsx]R3L5'!$O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41:$T$41</c:f>
              <c:numCache>
                <c:formatCode>General</c:formatCode>
                <c:ptCount val="5"/>
                <c:pt idx="0">
                  <c:v>0.1105</c:v>
                </c:pt>
                <c:pt idx="1">
                  <c:v>0.61899999999999999</c:v>
                </c:pt>
                <c:pt idx="2">
                  <c:v>0.79600000000000004</c:v>
                </c:pt>
                <c:pt idx="3">
                  <c:v>0.91949999999999998</c:v>
                </c:pt>
                <c:pt idx="4">
                  <c:v>0.99649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639-442E-968B-E9788DD3AE2A}"/>
            </c:ext>
          </c:extLst>
        </c:ser>
        <c:ser>
          <c:idx val="7"/>
          <c:order val="7"/>
          <c:tx>
            <c:strRef>
              <c:f>'[E. coli Vs HM results.xlsx]R3L5'!$O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P$34:$T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P$42:$T$42</c:f>
              <c:numCache>
                <c:formatCode>General</c:formatCode>
                <c:ptCount val="5"/>
                <c:pt idx="0">
                  <c:v>0.1105</c:v>
                </c:pt>
                <c:pt idx="1">
                  <c:v>0.58549999999999991</c:v>
                </c:pt>
                <c:pt idx="2">
                  <c:v>0.76950000000000007</c:v>
                </c:pt>
                <c:pt idx="3">
                  <c:v>0.89349999999999996</c:v>
                </c:pt>
                <c:pt idx="4">
                  <c:v>0.9835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639-442E-968B-E9788DD3AE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37087"/>
        <c:axId val="1586738047"/>
      </c:scatterChart>
      <c:valAx>
        <c:axId val="1586737087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8047"/>
        <c:crosses val="autoZero"/>
        <c:crossBetween val="midCat"/>
      </c:valAx>
      <c:valAx>
        <c:axId val="1586738047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70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1</a:t>
            </a:r>
          </a:p>
        </c:rich>
      </c:tx>
      <c:layout>
        <c:manualLayout>
          <c:xMode val="edge"/>
          <c:yMode val="edge"/>
          <c:x val="0.45115754736262648"/>
          <c:y val="0.208911960880737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1855450595976594E-2"/>
          <c:y val="0.18726451689271872"/>
          <c:w val="0.91791574025165734"/>
          <c:h val="0.6612725565503374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1'!$H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4:$M$34</c:f>
              <c:numCache>
                <c:formatCode>General</c:formatCode>
                <c:ptCount val="5"/>
                <c:pt idx="0">
                  <c:v>0.125</c:v>
                </c:pt>
                <c:pt idx="1">
                  <c:v>0.61349999999999993</c:v>
                </c:pt>
                <c:pt idx="2">
                  <c:v>0.8085</c:v>
                </c:pt>
                <c:pt idx="3">
                  <c:v>0.94099999999999995</c:v>
                </c:pt>
                <c:pt idx="4">
                  <c:v>1.0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ED0-48AD-B09F-E1BAF8250B90}"/>
            </c:ext>
          </c:extLst>
        </c:ser>
        <c:ser>
          <c:idx val="1"/>
          <c:order val="1"/>
          <c:tx>
            <c:strRef>
              <c:f>'[E. coli Vs HM results.xlsx]R1L1'!$H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5:$M$35</c:f>
              <c:numCache>
                <c:formatCode>General</c:formatCode>
                <c:ptCount val="5"/>
                <c:pt idx="0">
                  <c:v>0.10500000000000001</c:v>
                </c:pt>
                <c:pt idx="1">
                  <c:v>0.6</c:v>
                </c:pt>
                <c:pt idx="2">
                  <c:v>0.80900000000000005</c:v>
                </c:pt>
                <c:pt idx="3">
                  <c:v>0.94750000000000001</c:v>
                </c:pt>
                <c:pt idx="4">
                  <c:v>1.1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ED0-48AD-B09F-E1BAF8250B90}"/>
            </c:ext>
          </c:extLst>
        </c:ser>
        <c:ser>
          <c:idx val="2"/>
          <c:order val="2"/>
          <c:tx>
            <c:strRef>
              <c:f>'[E. coli Vs HM results.xlsx]R1L1'!$H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6:$M$36</c:f>
              <c:numCache>
                <c:formatCode>General</c:formatCode>
                <c:ptCount val="5"/>
                <c:pt idx="0">
                  <c:v>0.10450000000000001</c:v>
                </c:pt>
                <c:pt idx="1">
                  <c:v>0.58699999999999997</c:v>
                </c:pt>
                <c:pt idx="2">
                  <c:v>0.81349999999999989</c:v>
                </c:pt>
                <c:pt idx="3">
                  <c:v>0.97599999999999998</c:v>
                </c:pt>
                <c:pt idx="4">
                  <c:v>1.14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ED0-48AD-B09F-E1BAF8250B90}"/>
            </c:ext>
          </c:extLst>
        </c:ser>
        <c:ser>
          <c:idx val="3"/>
          <c:order val="3"/>
          <c:tx>
            <c:strRef>
              <c:f>'[E. coli Vs HM results.xlsx]R1L1'!$H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7:$M$37</c:f>
              <c:numCache>
                <c:formatCode>General</c:formatCode>
                <c:ptCount val="5"/>
                <c:pt idx="0">
                  <c:v>0.10250000000000001</c:v>
                </c:pt>
                <c:pt idx="1">
                  <c:v>0.63450000000000006</c:v>
                </c:pt>
                <c:pt idx="2">
                  <c:v>0.87749999999999995</c:v>
                </c:pt>
                <c:pt idx="3">
                  <c:v>1.0129999999999999</c:v>
                </c:pt>
                <c:pt idx="4">
                  <c:v>1.177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ED0-48AD-B09F-E1BAF8250B90}"/>
            </c:ext>
          </c:extLst>
        </c:ser>
        <c:ser>
          <c:idx val="4"/>
          <c:order val="4"/>
          <c:tx>
            <c:strRef>
              <c:f>'[E. coli Vs HM results.xlsx]R1L1'!$H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8:$M$38</c:f>
              <c:numCache>
                <c:formatCode>General</c:formatCode>
                <c:ptCount val="5"/>
                <c:pt idx="0">
                  <c:v>0.104</c:v>
                </c:pt>
                <c:pt idx="1">
                  <c:v>0.623</c:v>
                </c:pt>
                <c:pt idx="2">
                  <c:v>0.83899999999999997</c:v>
                </c:pt>
                <c:pt idx="3">
                  <c:v>0.95750000000000002</c:v>
                </c:pt>
                <c:pt idx="4">
                  <c:v>1.11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CED0-48AD-B09F-E1BAF8250B90}"/>
            </c:ext>
          </c:extLst>
        </c:ser>
        <c:ser>
          <c:idx val="5"/>
          <c:order val="5"/>
          <c:tx>
            <c:strRef>
              <c:f>'[E. coli Vs HM results.xlsx]R1L1'!$H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39:$M$39</c:f>
              <c:numCache>
                <c:formatCode>General</c:formatCode>
                <c:ptCount val="5"/>
                <c:pt idx="0">
                  <c:v>0.109</c:v>
                </c:pt>
                <c:pt idx="1">
                  <c:v>0.629</c:v>
                </c:pt>
                <c:pt idx="2">
                  <c:v>0.81549999999999989</c:v>
                </c:pt>
                <c:pt idx="3">
                  <c:v>0.90149999999999997</c:v>
                </c:pt>
                <c:pt idx="4">
                  <c:v>0.988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CED0-48AD-B09F-E1BAF8250B90}"/>
            </c:ext>
          </c:extLst>
        </c:ser>
        <c:ser>
          <c:idx val="6"/>
          <c:order val="6"/>
          <c:tx>
            <c:strRef>
              <c:f>'[E. coli Vs HM results.xlsx]R1L1'!$H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40:$M$40</c:f>
              <c:numCache>
                <c:formatCode>General</c:formatCode>
                <c:ptCount val="5"/>
                <c:pt idx="0">
                  <c:v>0.1085</c:v>
                </c:pt>
                <c:pt idx="1">
                  <c:v>0.5794999999999999</c:v>
                </c:pt>
                <c:pt idx="2">
                  <c:v>0.76550000000000007</c:v>
                </c:pt>
                <c:pt idx="3">
                  <c:v>0.86699999999999999</c:v>
                </c:pt>
                <c:pt idx="4">
                  <c:v>0.9469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CED0-48AD-B09F-E1BAF8250B90}"/>
            </c:ext>
          </c:extLst>
        </c:ser>
        <c:ser>
          <c:idx val="7"/>
          <c:order val="7"/>
          <c:tx>
            <c:strRef>
              <c:f>'[E. coli Vs HM results.xlsx]R1L1'!$H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I$41:$M$41</c:f>
              <c:numCache>
                <c:formatCode>General</c:formatCode>
                <c:ptCount val="5"/>
                <c:pt idx="0">
                  <c:v>0.104</c:v>
                </c:pt>
                <c:pt idx="1">
                  <c:v>0.14400000000000002</c:v>
                </c:pt>
                <c:pt idx="2">
                  <c:v>0.59899999999999998</c:v>
                </c:pt>
                <c:pt idx="3">
                  <c:v>0.83299999999999996</c:v>
                </c:pt>
                <c:pt idx="4">
                  <c:v>0.908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CED0-48AD-B09F-E1BAF8250B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9747279"/>
        <c:axId val="1820786303"/>
      </c:scatterChart>
      <c:valAx>
        <c:axId val="158974727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786303"/>
        <c:crosses val="autoZero"/>
        <c:crossBetween val="midCat"/>
      </c:valAx>
      <c:valAx>
        <c:axId val="18207863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974727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7241992405268219"/>
          <c:y val="3.8978573753800781E-2"/>
          <c:w val="0.65515991451475875"/>
          <c:h val="0.177301581254891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t" anchorCtr="0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t" anchorCtr="0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332906770022286"/>
          <c:y val="0.16637293436296363"/>
          <c:w val="0.80979751486349771"/>
          <c:h val="0.5721739704139274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2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35:$F$35</c:f>
              <c:numCache>
                <c:formatCode>General</c:formatCode>
                <c:ptCount val="5"/>
                <c:pt idx="0">
                  <c:v>0.124</c:v>
                </c:pt>
                <c:pt idx="1">
                  <c:v>0.70199999999999996</c:v>
                </c:pt>
                <c:pt idx="2">
                  <c:v>0.87149999999999994</c:v>
                </c:pt>
                <c:pt idx="3">
                  <c:v>0.97249999999999992</c:v>
                </c:pt>
                <c:pt idx="4">
                  <c:v>1.07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8C2-4B93-932A-C152A36A0461}"/>
            </c:ext>
          </c:extLst>
        </c:ser>
        <c:ser>
          <c:idx val="1"/>
          <c:order val="1"/>
          <c:tx>
            <c:strRef>
              <c:f>'[E. coli Vs HM results.xlsx]R2L2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36:$F$36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72950000000000004</c:v>
                </c:pt>
                <c:pt idx="2">
                  <c:v>0.88949999999999996</c:v>
                </c:pt>
                <c:pt idx="3">
                  <c:v>0.96899999999999997</c:v>
                </c:pt>
                <c:pt idx="4">
                  <c:v>1.071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8C2-4B93-932A-C152A36A0461}"/>
            </c:ext>
          </c:extLst>
        </c:ser>
        <c:ser>
          <c:idx val="2"/>
          <c:order val="2"/>
          <c:tx>
            <c:strRef>
              <c:f>'[E. coli Vs HM results.xlsx]R2L2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37:$F$37</c:f>
              <c:numCache>
                <c:formatCode>General</c:formatCode>
                <c:ptCount val="5"/>
                <c:pt idx="0">
                  <c:v>0.1235</c:v>
                </c:pt>
                <c:pt idx="1">
                  <c:v>0.70950000000000002</c:v>
                </c:pt>
                <c:pt idx="2">
                  <c:v>0.81384999999999996</c:v>
                </c:pt>
                <c:pt idx="3">
                  <c:v>0.90949999999999998</c:v>
                </c:pt>
                <c:pt idx="4">
                  <c:v>0.9875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8C2-4B93-932A-C152A36A0461}"/>
            </c:ext>
          </c:extLst>
        </c:ser>
        <c:ser>
          <c:idx val="3"/>
          <c:order val="3"/>
          <c:tx>
            <c:strRef>
              <c:f>'[E. coli Vs HM results.xlsx]R2L2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38:$F$38</c:f>
              <c:numCache>
                <c:formatCode>General</c:formatCode>
                <c:ptCount val="5"/>
                <c:pt idx="0">
                  <c:v>0.128</c:v>
                </c:pt>
                <c:pt idx="1">
                  <c:v>0.75049999999999994</c:v>
                </c:pt>
                <c:pt idx="2">
                  <c:v>0.86050000000000004</c:v>
                </c:pt>
                <c:pt idx="3">
                  <c:v>0.9</c:v>
                </c:pt>
                <c:pt idx="4">
                  <c:v>1.09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8C2-4B93-932A-C152A36A0461}"/>
            </c:ext>
          </c:extLst>
        </c:ser>
        <c:ser>
          <c:idx val="4"/>
          <c:order val="4"/>
          <c:tx>
            <c:strRef>
              <c:f>'[E. coli Vs HM results.xlsx]R2L2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39:$F$39</c:f>
              <c:numCache>
                <c:formatCode>General</c:formatCode>
                <c:ptCount val="5"/>
                <c:pt idx="0">
                  <c:v>0.124</c:v>
                </c:pt>
                <c:pt idx="1">
                  <c:v>0.5724999999999999</c:v>
                </c:pt>
                <c:pt idx="2">
                  <c:v>0.73299999999999998</c:v>
                </c:pt>
                <c:pt idx="3">
                  <c:v>0.79600000000000004</c:v>
                </c:pt>
                <c:pt idx="4">
                  <c:v>0.913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8C2-4B93-932A-C152A36A0461}"/>
            </c:ext>
          </c:extLst>
        </c:ser>
        <c:ser>
          <c:idx val="5"/>
          <c:order val="5"/>
          <c:tx>
            <c:strRef>
              <c:f>'[E. coli Vs HM results.xlsx]R2L2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40:$F$40</c:f>
              <c:numCache>
                <c:formatCode>General</c:formatCode>
                <c:ptCount val="5"/>
                <c:pt idx="0">
                  <c:v>0.121</c:v>
                </c:pt>
                <c:pt idx="1">
                  <c:v>0.53149999999999997</c:v>
                </c:pt>
                <c:pt idx="2">
                  <c:v>0.63300000000000001</c:v>
                </c:pt>
                <c:pt idx="3">
                  <c:v>0.61299999999999999</c:v>
                </c:pt>
                <c:pt idx="4">
                  <c:v>0.802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D8C2-4B93-932A-C152A36A0461}"/>
            </c:ext>
          </c:extLst>
        </c:ser>
        <c:ser>
          <c:idx val="6"/>
          <c:order val="6"/>
          <c:tx>
            <c:strRef>
              <c:f>'[E. coli Vs HM results.xlsx]R2L2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41:$F$41</c:f>
              <c:numCache>
                <c:formatCode>General</c:formatCode>
                <c:ptCount val="5"/>
                <c:pt idx="0">
                  <c:v>0.1245</c:v>
                </c:pt>
                <c:pt idx="1">
                  <c:v>0.436</c:v>
                </c:pt>
                <c:pt idx="2">
                  <c:v>0.3765</c:v>
                </c:pt>
                <c:pt idx="3">
                  <c:v>0.27450000000000002</c:v>
                </c:pt>
                <c:pt idx="4">
                  <c:v>0.354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D8C2-4B93-932A-C152A36A0461}"/>
            </c:ext>
          </c:extLst>
        </c:ser>
        <c:ser>
          <c:idx val="7"/>
          <c:order val="7"/>
          <c:tx>
            <c:strRef>
              <c:f>'[E. coli Vs HM results.xlsx]R2L2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B$42:$F$42</c:f>
              <c:numCache>
                <c:formatCode>General</c:formatCode>
                <c:ptCount val="5"/>
                <c:pt idx="0">
                  <c:v>0.1255</c:v>
                </c:pt>
                <c:pt idx="1">
                  <c:v>0.21000000000000002</c:v>
                </c:pt>
                <c:pt idx="2">
                  <c:v>0.17949999999999999</c:v>
                </c:pt>
                <c:pt idx="3">
                  <c:v>6.7000000000000004E-2</c:v>
                </c:pt>
                <c:pt idx="4">
                  <c:v>0.140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D8C2-4B93-932A-C152A36A04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832855247164729"/>
          <c:y val="0.21074490176241942"/>
          <c:w val="0.80676222026644262"/>
          <c:h val="0.6374531776838986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2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35:$M$35</c:f>
              <c:numCache>
                <c:formatCode>General</c:formatCode>
                <c:ptCount val="5"/>
                <c:pt idx="0">
                  <c:v>0.124</c:v>
                </c:pt>
                <c:pt idx="1">
                  <c:v>0.70199999999999996</c:v>
                </c:pt>
                <c:pt idx="2">
                  <c:v>0.87149999999999994</c:v>
                </c:pt>
                <c:pt idx="3">
                  <c:v>0.97249999999999992</c:v>
                </c:pt>
                <c:pt idx="4">
                  <c:v>1.07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163-41E1-9EF2-8B61B86075DE}"/>
            </c:ext>
          </c:extLst>
        </c:ser>
        <c:ser>
          <c:idx val="1"/>
          <c:order val="1"/>
          <c:tx>
            <c:strRef>
              <c:f>'[E. coli Vs HM results.xlsx]R2L2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36:$M$36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76100000000000001</c:v>
                </c:pt>
                <c:pt idx="2">
                  <c:v>0.9245000000000001</c:v>
                </c:pt>
                <c:pt idx="3">
                  <c:v>1.0129999999999999</c:v>
                </c:pt>
                <c:pt idx="4">
                  <c:v>1.09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163-41E1-9EF2-8B61B86075DE}"/>
            </c:ext>
          </c:extLst>
        </c:ser>
        <c:ser>
          <c:idx val="2"/>
          <c:order val="2"/>
          <c:tx>
            <c:strRef>
              <c:f>'[E. coli Vs HM results.xlsx]R2L2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37:$M$37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71199999999999997</c:v>
                </c:pt>
                <c:pt idx="2">
                  <c:v>0.871</c:v>
                </c:pt>
                <c:pt idx="3">
                  <c:v>1.0099999999999998</c:v>
                </c:pt>
                <c:pt idx="4">
                  <c:v>1.101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163-41E1-9EF2-8B61B86075DE}"/>
            </c:ext>
          </c:extLst>
        </c:ser>
        <c:ser>
          <c:idx val="3"/>
          <c:order val="3"/>
          <c:tx>
            <c:strRef>
              <c:f>'[E. coli Vs HM results.xlsx]R2L2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38:$M$38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81549999999999989</c:v>
                </c:pt>
                <c:pt idx="2">
                  <c:v>0.99749999999999994</c:v>
                </c:pt>
                <c:pt idx="3">
                  <c:v>1.1055000000000001</c:v>
                </c:pt>
                <c:pt idx="4">
                  <c:v>1.193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163-41E1-9EF2-8B61B86075DE}"/>
            </c:ext>
          </c:extLst>
        </c:ser>
        <c:ser>
          <c:idx val="4"/>
          <c:order val="4"/>
          <c:tx>
            <c:strRef>
              <c:f>'[E. coli Vs HM results.xlsx]R2L2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39:$M$39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84149999999999991</c:v>
                </c:pt>
                <c:pt idx="2">
                  <c:v>1.0605</c:v>
                </c:pt>
                <c:pt idx="3">
                  <c:v>1.1539999999999999</c:v>
                </c:pt>
                <c:pt idx="4">
                  <c:v>1.248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C163-41E1-9EF2-8B61B86075DE}"/>
            </c:ext>
          </c:extLst>
        </c:ser>
        <c:ser>
          <c:idx val="5"/>
          <c:order val="5"/>
          <c:tx>
            <c:strRef>
              <c:f>'[E. coli Vs HM results.xlsx]R2L2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40:$M$40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5350000000000006</c:v>
                </c:pt>
                <c:pt idx="2">
                  <c:v>0.94099999999999995</c:v>
                </c:pt>
                <c:pt idx="3">
                  <c:v>1.0230000000000001</c:v>
                </c:pt>
                <c:pt idx="4">
                  <c:v>1.113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C163-41E1-9EF2-8B61B86075DE}"/>
            </c:ext>
          </c:extLst>
        </c:ser>
        <c:ser>
          <c:idx val="6"/>
          <c:order val="6"/>
          <c:tx>
            <c:strRef>
              <c:f>'[E. coli Vs HM results.xlsx]R2L2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41:$M$41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70649999999999991</c:v>
                </c:pt>
                <c:pt idx="2">
                  <c:v>0.88800000000000001</c:v>
                </c:pt>
                <c:pt idx="3">
                  <c:v>0.96</c:v>
                </c:pt>
                <c:pt idx="4">
                  <c:v>1.04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C163-41E1-9EF2-8B61B86075DE}"/>
            </c:ext>
          </c:extLst>
        </c:ser>
        <c:ser>
          <c:idx val="7"/>
          <c:order val="7"/>
          <c:tx>
            <c:strRef>
              <c:f>'[E. coli Vs HM results.xlsx]R2L2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I$42:$M$42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36749999999999999</c:v>
                </c:pt>
                <c:pt idx="2">
                  <c:v>0.78049999999999997</c:v>
                </c:pt>
                <c:pt idx="3">
                  <c:v>0.88349999999999995</c:v>
                </c:pt>
                <c:pt idx="4">
                  <c:v>1.009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C163-41E1-9EF2-8B61B86075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3</a:t>
            </a:r>
          </a:p>
        </c:rich>
      </c:tx>
      <c:layout>
        <c:manualLayout>
          <c:xMode val="edge"/>
          <c:yMode val="edge"/>
          <c:x val="0.47601125640921338"/>
          <c:y val="7.14699122924353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624529748776414"/>
          <c:y val="0.17724278515347849"/>
          <c:w val="0.8211940450937224"/>
          <c:h val="0.6703890759689238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7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35:$M$35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100000000000004</c:v>
                </c:pt>
                <c:pt idx="2">
                  <c:v>0.83399999999999996</c:v>
                </c:pt>
                <c:pt idx="3">
                  <c:v>0.97350000000000003</c:v>
                </c:pt>
                <c:pt idx="4">
                  <c:v>1.04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249-4867-B6BE-0DBF244B42BC}"/>
            </c:ext>
          </c:extLst>
        </c:ser>
        <c:ser>
          <c:idx val="1"/>
          <c:order val="1"/>
          <c:tx>
            <c:strRef>
              <c:f>'[E. coli Vs HM results.xlsx]R3L7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36:$M$36</c:f>
              <c:numCache>
                <c:formatCode>General</c:formatCode>
                <c:ptCount val="5"/>
                <c:pt idx="0">
                  <c:v>0.1105</c:v>
                </c:pt>
                <c:pt idx="1">
                  <c:v>0.68650000000000011</c:v>
                </c:pt>
                <c:pt idx="2">
                  <c:v>0.83749999999999991</c:v>
                </c:pt>
                <c:pt idx="3">
                  <c:v>0.99049999999999994</c:v>
                </c:pt>
                <c:pt idx="4">
                  <c:v>1.077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249-4867-B6BE-0DBF244B42BC}"/>
            </c:ext>
          </c:extLst>
        </c:ser>
        <c:ser>
          <c:idx val="2"/>
          <c:order val="2"/>
          <c:tx>
            <c:strRef>
              <c:f>'[E. coli Vs HM results.xlsx]R3L7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37:$M$37</c:f>
              <c:numCache>
                <c:formatCode>General</c:formatCode>
                <c:ptCount val="5"/>
                <c:pt idx="0">
                  <c:v>0.1095</c:v>
                </c:pt>
                <c:pt idx="1">
                  <c:v>0.70350000000000001</c:v>
                </c:pt>
                <c:pt idx="2">
                  <c:v>0.87549999999999994</c:v>
                </c:pt>
                <c:pt idx="3">
                  <c:v>0.98399999999999999</c:v>
                </c:pt>
                <c:pt idx="4">
                  <c:v>1.059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249-4867-B6BE-0DBF244B42BC}"/>
            </c:ext>
          </c:extLst>
        </c:ser>
        <c:ser>
          <c:idx val="3"/>
          <c:order val="3"/>
          <c:tx>
            <c:strRef>
              <c:f>'[E. coli Vs HM results.xlsx]R3L7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38:$M$38</c:f>
              <c:numCache>
                <c:formatCode>General</c:formatCode>
                <c:ptCount val="5"/>
                <c:pt idx="0">
                  <c:v>0.1105</c:v>
                </c:pt>
                <c:pt idx="1">
                  <c:v>0.77049999999999996</c:v>
                </c:pt>
                <c:pt idx="2">
                  <c:v>0.93600000000000005</c:v>
                </c:pt>
                <c:pt idx="3">
                  <c:v>1.0249999999999999</c:v>
                </c:pt>
                <c:pt idx="4">
                  <c:v>1.105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249-4867-B6BE-0DBF244B42BC}"/>
            </c:ext>
          </c:extLst>
        </c:ser>
        <c:ser>
          <c:idx val="4"/>
          <c:order val="4"/>
          <c:tx>
            <c:strRef>
              <c:f>'[E. coli Vs HM results.xlsx]R3L7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39:$M$39</c:f>
              <c:numCache>
                <c:formatCode>General</c:formatCode>
                <c:ptCount val="5"/>
                <c:pt idx="0">
                  <c:v>0.1095</c:v>
                </c:pt>
                <c:pt idx="1">
                  <c:v>0.77350000000000008</c:v>
                </c:pt>
                <c:pt idx="2">
                  <c:v>0.94550000000000001</c:v>
                </c:pt>
                <c:pt idx="3">
                  <c:v>1.03</c:v>
                </c:pt>
                <c:pt idx="4">
                  <c:v>1.1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249-4867-B6BE-0DBF244B42BC}"/>
            </c:ext>
          </c:extLst>
        </c:ser>
        <c:ser>
          <c:idx val="5"/>
          <c:order val="5"/>
          <c:tx>
            <c:strRef>
              <c:f>'[E. coli Vs HM results.xlsx]R3L7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40:$M$40</c:f>
              <c:numCache>
                <c:formatCode>General</c:formatCode>
                <c:ptCount val="5"/>
                <c:pt idx="0">
                  <c:v>0.1095</c:v>
                </c:pt>
                <c:pt idx="1">
                  <c:v>0.70899999999999996</c:v>
                </c:pt>
                <c:pt idx="2">
                  <c:v>0.91600000000000004</c:v>
                </c:pt>
                <c:pt idx="3">
                  <c:v>0.99750000000000005</c:v>
                </c:pt>
                <c:pt idx="4">
                  <c:v>1.06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249-4867-B6BE-0DBF244B42BC}"/>
            </c:ext>
          </c:extLst>
        </c:ser>
        <c:ser>
          <c:idx val="6"/>
          <c:order val="6"/>
          <c:tx>
            <c:strRef>
              <c:f>'[E. coli Vs HM results.xlsx]R3L7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41:$M$41</c:f>
              <c:numCache>
                <c:formatCode>General</c:formatCode>
                <c:ptCount val="5"/>
                <c:pt idx="0">
                  <c:v>0.1105</c:v>
                </c:pt>
                <c:pt idx="1">
                  <c:v>0.58899999999999997</c:v>
                </c:pt>
                <c:pt idx="2">
                  <c:v>0.86699999999999999</c:v>
                </c:pt>
                <c:pt idx="3">
                  <c:v>0.96049999999999991</c:v>
                </c:pt>
                <c:pt idx="4">
                  <c:v>1.01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249-4867-B6BE-0DBF244B42BC}"/>
            </c:ext>
          </c:extLst>
        </c:ser>
        <c:ser>
          <c:idx val="7"/>
          <c:order val="7"/>
          <c:tx>
            <c:strRef>
              <c:f>'[E. coli Vs HM results.xlsx]R3L7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I$42:$M$42</c:f>
              <c:numCache>
                <c:formatCode>General</c:formatCode>
                <c:ptCount val="5"/>
                <c:pt idx="0">
                  <c:v>0.1095</c:v>
                </c:pt>
                <c:pt idx="1">
                  <c:v>0.17149999999999999</c:v>
                </c:pt>
                <c:pt idx="2">
                  <c:v>0.3805</c:v>
                </c:pt>
                <c:pt idx="3">
                  <c:v>0.62250000000000005</c:v>
                </c:pt>
                <c:pt idx="4">
                  <c:v>0.7315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249-4867-B6BE-0DBF244B42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  <c:max val="1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67789102468873"/>
          <c:y val="0.14854400487760047"/>
          <c:w val="0.80535351387460763"/>
          <c:h val="0.7239022597008435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2 '!$H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4:$M$34</c:f>
              <c:numCache>
                <c:formatCode>General</c:formatCode>
                <c:ptCount val="5"/>
                <c:pt idx="0">
                  <c:v>0.1055</c:v>
                </c:pt>
                <c:pt idx="1">
                  <c:v>0.64200000000000002</c:v>
                </c:pt>
                <c:pt idx="2">
                  <c:v>0.80700000000000005</c:v>
                </c:pt>
                <c:pt idx="3">
                  <c:v>0.87149999999999994</c:v>
                </c:pt>
                <c:pt idx="4">
                  <c:v>0.945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5B9-4C51-8736-4E8866C5D9F8}"/>
            </c:ext>
          </c:extLst>
        </c:ser>
        <c:ser>
          <c:idx val="1"/>
          <c:order val="1"/>
          <c:tx>
            <c:strRef>
              <c:f>'[E. coli Vs HM results.xlsx]R1L2 '!$H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5:$M$35</c:f>
              <c:numCache>
                <c:formatCode>General</c:formatCode>
                <c:ptCount val="5"/>
                <c:pt idx="0">
                  <c:v>0.1065</c:v>
                </c:pt>
                <c:pt idx="1">
                  <c:v>0.65900000000000003</c:v>
                </c:pt>
                <c:pt idx="2">
                  <c:v>0.83699999999999997</c:v>
                </c:pt>
                <c:pt idx="3">
                  <c:v>0.90450000000000008</c:v>
                </c:pt>
                <c:pt idx="4">
                  <c:v>0.984499999999999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5B9-4C51-8736-4E8866C5D9F8}"/>
            </c:ext>
          </c:extLst>
        </c:ser>
        <c:ser>
          <c:idx val="2"/>
          <c:order val="2"/>
          <c:tx>
            <c:strRef>
              <c:f>'[E. coli Vs HM results.xlsx]R1L2 '!$H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6:$M$36</c:f>
              <c:numCache>
                <c:formatCode>General</c:formatCode>
                <c:ptCount val="5"/>
                <c:pt idx="0">
                  <c:v>0.1075</c:v>
                </c:pt>
                <c:pt idx="1">
                  <c:v>0.65400000000000003</c:v>
                </c:pt>
                <c:pt idx="2">
                  <c:v>0.81599999999999995</c:v>
                </c:pt>
                <c:pt idx="3">
                  <c:v>0.88949999999999996</c:v>
                </c:pt>
                <c:pt idx="4">
                  <c:v>0.975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5B9-4C51-8736-4E8866C5D9F8}"/>
            </c:ext>
          </c:extLst>
        </c:ser>
        <c:ser>
          <c:idx val="3"/>
          <c:order val="3"/>
          <c:tx>
            <c:strRef>
              <c:f>'[E. coli Vs HM results.xlsx]R1L2 '!$H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7:$M$37</c:f>
              <c:numCache>
                <c:formatCode>General</c:formatCode>
                <c:ptCount val="5"/>
                <c:pt idx="0">
                  <c:v>0.108</c:v>
                </c:pt>
                <c:pt idx="1">
                  <c:v>0.6765000000000001</c:v>
                </c:pt>
                <c:pt idx="2">
                  <c:v>0.84949999999999992</c:v>
                </c:pt>
                <c:pt idx="3">
                  <c:v>0.91700000000000004</c:v>
                </c:pt>
                <c:pt idx="4">
                  <c:v>0.99049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5B9-4C51-8736-4E8866C5D9F8}"/>
            </c:ext>
          </c:extLst>
        </c:ser>
        <c:ser>
          <c:idx val="4"/>
          <c:order val="4"/>
          <c:tx>
            <c:strRef>
              <c:f>'[E. coli Vs HM results.xlsx]R1L2 '!$H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8:$M$38</c:f>
              <c:numCache>
                <c:formatCode>General</c:formatCode>
                <c:ptCount val="5"/>
                <c:pt idx="0">
                  <c:v>0.1</c:v>
                </c:pt>
                <c:pt idx="1">
                  <c:v>0.66850000000000009</c:v>
                </c:pt>
                <c:pt idx="2">
                  <c:v>0.83399999999999996</c:v>
                </c:pt>
                <c:pt idx="3">
                  <c:v>0.89700000000000002</c:v>
                </c:pt>
                <c:pt idx="4">
                  <c:v>0.9975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05B9-4C51-8736-4E8866C5D9F8}"/>
            </c:ext>
          </c:extLst>
        </c:ser>
        <c:ser>
          <c:idx val="5"/>
          <c:order val="5"/>
          <c:tx>
            <c:strRef>
              <c:f>'[E. coli Vs HM results.xlsx]R1L2 '!$H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39:$M$39</c:f>
              <c:numCache>
                <c:formatCode>General</c:formatCode>
                <c:ptCount val="5"/>
                <c:pt idx="0">
                  <c:v>0.1105</c:v>
                </c:pt>
                <c:pt idx="1">
                  <c:v>0.6725000000000001</c:v>
                </c:pt>
                <c:pt idx="2">
                  <c:v>0.82450000000000001</c:v>
                </c:pt>
                <c:pt idx="3">
                  <c:v>0.88250000000000006</c:v>
                </c:pt>
                <c:pt idx="4">
                  <c:v>0.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05B9-4C51-8736-4E8866C5D9F8}"/>
            </c:ext>
          </c:extLst>
        </c:ser>
        <c:ser>
          <c:idx val="6"/>
          <c:order val="6"/>
          <c:tx>
            <c:strRef>
              <c:f>'[E. coli Vs HM results.xlsx]R1L2 '!$H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40:$M$40</c:f>
              <c:numCache>
                <c:formatCode>General</c:formatCode>
                <c:ptCount val="5"/>
                <c:pt idx="0">
                  <c:v>0.1105</c:v>
                </c:pt>
                <c:pt idx="1">
                  <c:v>0.61749999999999994</c:v>
                </c:pt>
                <c:pt idx="2">
                  <c:v>0.79200000000000004</c:v>
                </c:pt>
                <c:pt idx="3">
                  <c:v>0.83599999999999997</c:v>
                </c:pt>
                <c:pt idx="4">
                  <c:v>0.912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05B9-4C51-8736-4E8866C5D9F8}"/>
            </c:ext>
          </c:extLst>
        </c:ser>
        <c:ser>
          <c:idx val="7"/>
          <c:order val="7"/>
          <c:tx>
            <c:strRef>
              <c:f>'[E. coli Vs HM results.xlsx]R1L2 '!$H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I$41:$M$41</c:f>
              <c:numCache>
                <c:formatCode>General</c:formatCode>
                <c:ptCount val="5"/>
                <c:pt idx="0">
                  <c:v>0.1115</c:v>
                </c:pt>
                <c:pt idx="1">
                  <c:v>0.223</c:v>
                </c:pt>
                <c:pt idx="2">
                  <c:v>0.621</c:v>
                </c:pt>
                <c:pt idx="3">
                  <c:v>0.75950000000000006</c:v>
                </c:pt>
                <c:pt idx="4">
                  <c:v>0.8934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05B9-4C51-8736-4E8866C5D9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3226623"/>
        <c:axId val="2105430703"/>
      </c:scatterChart>
      <c:valAx>
        <c:axId val="2113226623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5430703"/>
        <c:crosses val="autoZero"/>
        <c:crossBetween val="midCat"/>
      </c:valAx>
      <c:valAx>
        <c:axId val="2105430703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32266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588341105464943"/>
          <c:y val="0.1405688633157518"/>
          <c:w val="0.81967815122138687"/>
          <c:h val="0.7375709689300282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3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35:$M$35</c:f>
              <c:numCache>
                <c:formatCode>General</c:formatCode>
                <c:ptCount val="5"/>
                <c:pt idx="0">
                  <c:v>0.1205</c:v>
                </c:pt>
                <c:pt idx="1">
                  <c:v>0.73499999999999999</c:v>
                </c:pt>
                <c:pt idx="2">
                  <c:v>0.90200000000000002</c:v>
                </c:pt>
                <c:pt idx="3">
                  <c:v>0.98750000000000004</c:v>
                </c:pt>
                <c:pt idx="4">
                  <c:v>1.08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301-4B5F-99C4-03A416285410}"/>
            </c:ext>
          </c:extLst>
        </c:ser>
        <c:ser>
          <c:idx val="1"/>
          <c:order val="1"/>
          <c:tx>
            <c:strRef>
              <c:f>'[E. coli Vs HM results.xlsx]R3L3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36:$M$36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6944999999999999</c:v>
                </c:pt>
                <c:pt idx="2">
                  <c:v>0.85949999999999993</c:v>
                </c:pt>
                <c:pt idx="3">
                  <c:v>0.96499999999999997</c:v>
                </c:pt>
                <c:pt idx="4">
                  <c:v>1.032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301-4B5F-99C4-03A416285410}"/>
            </c:ext>
          </c:extLst>
        </c:ser>
        <c:ser>
          <c:idx val="2"/>
          <c:order val="2"/>
          <c:tx>
            <c:strRef>
              <c:f>'[E. coli Vs HM results.xlsx]R3L3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37:$M$37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2849999999999993</c:v>
                </c:pt>
                <c:pt idx="2">
                  <c:v>0.89650000000000007</c:v>
                </c:pt>
                <c:pt idx="3">
                  <c:v>0.99199999999999999</c:v>
                </c:pt>
                <c:pt idx="4">
                  <c:v>1.05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301-4B5F-99C4-03A416285410}"/>
            </c:ext>
          </c:extLst>
        </c:ser>
        <c:ser>
          <c:idx val="3"/>
          <c:order val="3"/>
          <c:tx>
            <c:strRef>
              <c:f>'[E. coli Vs HM results.xlsx]R3L3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38:$M$38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6750000000000007</c:v>
                </c:pt>
                <c:pt idx="2">
                  <c:v>0.9375</c:v>
                </c:pt>
                <c:pt idx="3">
                  <c:v>1.0255000000000001</c:v>
                </c:pt>
                <c:pt idx="4">
                  <c:v>1.07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1301-4B5F-99C4-03A416285410}"/>
            </c:ext>
          </c:extLst>
        </c:ser>
        <c:ser>
          <c:idx val="4"/>
          <c:order val="4"/>
          <c:tx>
            <c:strRef>
              <c:f>'[E. coli Vs HM results.xlsx]R3L3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39:$M$39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7150000000000007</c:v>
                </c:pt>
                <c:pt idx="2">
                  <c:v>0.95550000000000002</c:v>
                </c:pt>
                <c:pt idx="3">
                  <c:v>1.0205</c:v>
                </c:pt>
                <c:pt idx="4">
                  <c:v>1.059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1301-4B5F-99C4-03A416285410}"/>
            </c:ext>
          </c:extLst>
        </c:ser>
        <c:ser>
          <c:idx val="5"/>
          <c:order val="5"/>
          <c:tx>
            <c:strRef>
              <c:f>'[E. coli Vs HM results.xlsx]R3L3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40:$M$40</c:f>
              <c:numCache>
                <c:formatCode>General</c:formatCode>
                <c:ptCount val="5"/>
                <c:pt idx="0">
                  <c:v>0.115</c:v>
                </c:pt>
                <c:pt idx="1">
                  <c:v>0.72199999999999998</c:v>
                </c:pt>
                <c:pt idx="2">
                  <c:v>0.92300000000000004</c:v>
                </c:pt>
                <c:pt idx="3">
                  <c:v>0.98550000000000004</c:v>
                </c:pt>
                <c:pt idx="4">
                  <c:v>0.956499999999999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1301-4B5F-99C4-03A416285410}"/>
            </c:ext>
          </c:extLst>
        </c:ser>
        <c:ser>
          <c:idx val="6"/>
          <c:order val="6"/>
          <c:tx>
            <c:strRef>
              <c:f>'[E. coli Vs HM results.xlsx]R3L3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41:$M$41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67700000000000005</c:v>
                </c:pt>
                <c:pt idx="2">
                  <c:v>0.87149999999999994</c:v>
                </c:pt>
                <c:pt idx="3">
                  <c:v>0.93149999999999999</c:v>
                </c:pt>
                <c:pt idx="4">
                  <c:v>0.9389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1301-4B5F-99C4-03A416285410}"/>
            </c:ext>
          </c:extLst>
        </c:ser>
        <c:ser>
          <c:idx val="7"/>
          <c:order val="7"/>
          <c:tx>
            <c:strRef>
              <c:f>'[E. coli Vs HM results.xlsx]R3L3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I$42:$M$42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4945</c:v>
                </c:pt>
                <c:pt idx="2">
                  <c:v>0.76950000000000007</c:v>
                </c:pt>
                <c:pt idx="3">
                  <c:v>0.84799999999999998</c:v>
                </c:pt>
                <c:pt idx="4">
                  <c:v>0.927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1301-4B5F-99C4-03A416285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67789102468873"/>
          <c:y val="0.13351924266889281"/>
          <c:w val="0.80535351387460763"/>
          <c:h val="0.7382202499295172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10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35:$M$35</c:f>
              <c:numCache>
                <c:formatCode>General</c:formatCode>
                <c:ptCount val="5"/>
                <c:pt idx="0">
                  <c:v>0.13150000000000001</c:v>
                </c:pt>
                <c:pt idx="1">
                  <c:v>0.69</c:v>
                </c:pt>
                <c:pt idx="2">
                  <c:v>0.84499999999999997</c:v>
                </c:pt>
                <c:pt idx="3">
                  <c:v>0.94699999999999995</c:v>
                </c:pt>
                <c:pt idx="4">
                  <c:v>1.05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799-4D32-9BA2-3098AA8C7B41}"/>
            </c:ext>
          </c:extLst>
        </c:ser>
        <c:ser>
          <c:idx val="1"/>
          <c:order val="1"/>
          <c:tx>
            <c:strRef>
              <c:f>'[E. coli Vs HM results.xlsx]R3L10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36:$M$36</c:f>
              <c:numCache>
                <c:formatCode>General</c:formatCode>
                <c:ptCount val="5"/>
                <c:pt idx="0">
                  <c:v>0.1225</c:v>
                </c:pt>
                <c:pt idx="1">
                  <c:v>0.72399999999999998</c:v>
                </c:pt>
                <c:pt idx="2">
                  <c:v>0.90050000000000008</c:v>
                </c:pt>
                <c:pt idx="3">
                  <c:v>1.0325</c:v>
                </c:pt>
                <c:pt idx="4">
                  <c:v>1.21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799-4D32-9BA2-3098AA8C7B41}"/>
            </c:ext>
          </c:extLst>
        </c:ser>
        <c:ser>
          <c:idx val="2"/>
          <c:order val="2"/>
          <c:tx>
            <c:strRef>
              <c:f>'[E. coli Vs HM results.xlsx]R3L10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37:$M$37</c:f>
              <c:numCache>
                <c:formatCode>General</c:formatCode>
                <c:ptCount val="5"/>
                <c:pt idx="0">
                  <c:v>0.1225</c:v>
                </c:pt>
                <c:pt idx="1">
                  <c:v>0.76649999999999996</c:v>
                </c:pt>
                <c:pt idx="2">
                  <c:v>0.9385</c:v>
                </c:pt>
                <c:pt idx="3">
                  <c:v>1.08</c:v>
                </c:pt>
                <c:pt idx="4">
                  <c:v>1.232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799-4D32-9BA2-3098AA8C7B41}"/>
            </c:ext>
          </c:extLst>
        </c:ser>
        <c:ser>
          <c:idx val="3"/>
          <c:order val="3"/>
          <c:tx>
            <c:strRef>
              <c:f>'[E. coli Vs HM results.xlsx]R3L10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38:$M$38</c:f>
              <c:numCache>
                <c:formatCode>General</c:formatCode>
                <c:ptCount val="5"/>
                <c:pt idx="0">
                  <c:v>0.1225</c:v>
                </c:pt>
                <c:pt idx="1">
                  <c:v>0.78649999999999998</c:v>
                </c:pt>
                <c:pt idx="2">
                  <c:v>0.96249999999999991</c:v>
                </c:pt>
                <c:pt idx="3">
                  <c:v>1.1065</c:v>
                </c:pt>
                <c:pt idx="4">
                  <c:v>1.2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799-4D32-9BA2-3098AA8C7B41}"/>
            </c:ext>
          </c:extLst>
        </c:ser>
        <c:ser>
          <c:idx val="4"/>
          <c:order val="4"/>
          <c:tx>
            <c:strRef>
              <c:f>'[E. coli Vs HM results.xlsx]R3L10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39:$M$39</c:f>
              <c:numCache>
                <c:formatCode>General</c:formatCode>
                <c:ptCount val="5"/>
                <c:pt idx="0">
                  <c:v>0.1215</c:v>
                </c:pt>
                <c:pt idx="1">
                  <c:v>0.78649999999999998</c:v>
                </c:pt>
                <c:pt idx="2">
                  <c:v>0.98299999999999998</c:v>
                </c:pt>
                <c:pt idx="3">
                  <c:v>1.0815000000000001</c:v>
                </c:pt>
                <c:pt idx="4">
                  <c:v>1.184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799-4D32-9BA2-3098AA8C7B41}"/>
            </c:ext>
          </c:extLst>
        </c:ser>
        <c:ser>
          <c:idx val="5"/>
          <c:order val="5"/>
          <c:tx>
            <c:strRef>
              <c:f>'[E. coli Vs HM results.xlsx]R3L10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40:$M$40</c:f>
              <c:numCache>
                <c:formatCode>General</c:formatCode>
                <c:ptCount val="5"/>
                <c:pt idx="0">
                  <c:v>0.1215</c:v>
                </c:pt>
                <c:pt idx="1">
                  <c:v>0.752</c:v>
                </c:pt>
                <c:pt idx="2">
                  <c:v>0.94899999999999995</c:v>
                </c:pt>
                <c:pt idx="3">
                  <c:v>1.0389999999999999</c:v>
                </c:pt>
                <c:pt idx="4">
                  <c:v>1.0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799-4D32-9BA2-3098AA8C7B41}"/>
            </c:ext>
          </c:extLst>
        </c:ser>
        <c:ser>
          <c:idx val="6"/>
          <c:order val="6"/>
          <c:tx>
            <c:strRef>
              <c:f>'[E. coli Vs HM results.xlsx]R3L10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41:$M$41</c:f>
              <c:numCache>
                <c:formatCode>General</c:formatCode>
                <c:ptCount val="5"/>
                <c:pt idx="0">
                  <c:v>0.1205</c:v>
                </c:pt>
                <c:pt idx="1">
                  <c:v>0.66700000000000004</c:v>
                </c:pt>
                <c:pt idx="2">
                  <c:v>0.876</c:v>
                </c:pt>
                <c:pt idx="3">
                  <c:v>0.9285000000000001</c:v>
                </c:pt>
                <c:pt idx="4">
                  <c:v>0.955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B799-4D32-9BA2-3098AA8C7B41}"/>
            </c:ext>
          </c:extLst>
        </c:ser>
        <c:ser>
          <c:idx val="7"/>
          <c:order val="7"/>
          <c:tx>
            <c:strRef>
              <c:f>'[E. coli Vs HM results.xlsx]R3L10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I$42:$M$42</c:f>
              <c:numCache>
                <c:formatCode>General</c:formatCode>
                <c:ptCount val="5"/>
                <c:pt idx="0">
                  <c:v>0.1205</c:v>
                </c:pt>
                <c:pt idx="1">
                  <c:v>0.19650000000000001</c:v>
                </c:pt>
                <c:pt idx="2">
                  <c:v>0.63250000000000006</c:v>
                </c:pt>
                <c:pt idx="3">
                  <c:v>0.77849999999999997</c:v>
                </c:pt>
                <c:pt idx="4">
                  <c:v>0.846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B799-4D32-9BA2-3098AA8C7B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588341105464943"/>
          <c:y val="0.13793693072440019"/>
          <c:w val="0.81967815122138687"/>
          <c:h val="0.7224036747049755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3'!$H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4:$M$34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59149999999999991</c:v>
                </c:pt>
                <c:pt idx="2">
                  <c:v>0.76300000000000001</c:v>
                </c:pt>
                <c:pt idx="3">
                  <c:v>0.9335</c:v>
                </c:pt>
                <c:pt idx="4">
                  <c:v>1.016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635-478A-A3F1-544F32178335}"/>
            </c:ext>
          </c:extLst>
        </c:ser>
        <c:ser>
          <c:idx val="1"/>
          <c:order val="1"/>
          <c:tx>
            <c:strRef>
              <c:f>'[E. coli Vs HM results.xlsx]R1L3'!$H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5:$M$35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6</c:v>
                </c:pt>
                <c:pt idx="2">
                  <c:v>0.76200000000000001</c:v>
                </c:pt>
                <c:pt idx="3">
                  <c:v>0.91149999999999998</c:v>
                </c:pt>
                <c:pt idx="4">
                  <c:v>1.0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635-478A-A3F1-544F32178335}"/>
            </c:ext>
          </c:extLst>
        </c:ser>
        <c:ser>
          <c:idx val="2"/>
          <c:order val="2"/>
          <c:tx>
            <c:strRef>
              <c:f>'[E. coli Vs HM results.xlsx]R1L3'!$H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6:$M$36</c:f>
              <c:numCache>
                <c:formatCode>General</c:formatCode>
                <c:ptCount val="5"/>
                <c:pt idx="0">
                  <c:v>9.35E-2</c:v>
                </c:pt>
                <c:pt idx="1">
                  <c:v>0.60599999999999998</c:v>
                </c:pt>
                <c:pt idx="2">
                  <c:v>0.80449999999999999</c:v>
                </c:pt>
                <c:pt idx="3">
                  <c:v>0.94300000000000006</c:v>
                </c:pt>
                <c:pt idx="4">
                  <c:v>1.04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635-478A-A3F1-544F32178335}"/>
            </c:ext>
          </c:extLst>
        </c:ser>
        <c:ser>
          <c:idx val="3"/>
          <c:order val="3"/>
          <c:tx>
            <c:strRef>
              <c:f>'[E. coli Vs HM results.xlsx]R1L3'!$H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7:$M$37</c:f>
              <c:numCache>
                <c:formatCode>General</c:formatCode>
                <c:ptCount val="5"/>
                <c:pt idx="0">
                  <c:v>9.5500000000000002E-2</c:v>
                </c:pt>
                <c:pt idx="1">
                  <c:v>0.60799999999999998</c:v>
                </c:pt>
                <c:pt idx="2">
                  <c:v>0.83199999999999996</c:v>
                </c:pt>
                <c:pt idx="3">
                  <c:v>0.96249999999999991</c:v>
                </c:pt>
                <c:pt idx="4">
                  <c:v>1.0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635-478A-A3F1-544F32178335}"/>
            </c:ext>
          </c:extLst>
        </c:ser>
        <c:ser>
          <c:idx val="4"/>
          <c:order val="4"/>
          <c:tx>
            <c:strRef>
              <c:f>'[E. coli Vs HM results.xlsx]R1L3'!$H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8:$M$38</c:f>
              <c:numCache>
                <c:formatCode>General</c:formatCode>
                <c:ptCount val="5"/>
                <c:pt idx="0">
                  <c:v>9.4500000000000001E-2</c:v>
                </c:pt>
                <c:pt idx="1">
                  <c:v>0.56999999999999995</c:v>
                </c:pt>
                <c:pt idx="2">
                  <c:v>0.751</c:v>
                </c:pt>
                <c:pt idx="3">
                  <c:v>0.88400000000000001</c:v>
                </c:pt>
                <c:pt idx="4">
                  <c:v>0.963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635-478A-A3F1-544F32178335}"/>
            </c:ext>
          </c:extLst>
        </c:ser>
        <c:ser>
          <c:idx val="5"/>
          <c:order val="5"/>
          <c:tx>
            <c:strRef>
              <c:f>'[E. coli Vs HM results.xlsx]R1L3'!$H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39:$M$39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65549999999999997</c:v>
                </c:pt>
                <c:pt idx="2">
                  <c:v>0.8234999999999999</c:v>
                </c:pt>
                <c:pt idx="3">
                  <c:v>0.92300000000000004</c:v>
                </c:pt>
                <c:pt idx="4">
                  <c:v>0.992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635-478A-A3F1-544F32178335}"/>
            </c:ext>
          </c:extLst>
        </c:ser>
        <c:ser>
          <c:idx val="6"/>
          <c:order val="6"/>
          <c:tx>
            <c:strRef>
              <c:f>'[E. coli Vs HM results.xlsx]R1L3'!$H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40:$M$40</c:f>
              <c:numCache>
                <c:formatCode>General</c:formatCode>
                <c:ptCount val="5"/>
                <c:pt idx="0">
                  <c:v>9.5500000000000002E-2</c:v>
                </c:pt>
                <c:pt idx="1">
                  <c:v>0.62749999999999995</c:v>
                </c:pt>
                <c:pt idx="2">
                  <c:v>0.8125</c:v>
                </c:pt>
                <c:pt idx="3">
                  <c:v>0.89250000000000007</c:v>
                </c:pt>
                <c:pt idx="4">
                  <c:v>0.963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635-478A-A3F1-544F32178335}"/>
            </c:ext>
          </c:extLst>
        </c:ser>
        <c:ser>
          <c:idx val="7"/>
          <c:order val="7"/>
          <c:tx>
            <c:strRef>
              <c:f>'[E. coli Vs HM results.xlsx]R1L3'!$H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I$33:$M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I$41:$M$41</c:f>
              <c:numCache>
                <c:formatCode>General</c:formatCode>
                <c:ptCount val="5"/>
                <c:pt idx="0">
                  <c:v>9.4500000000000001E-2</c:v>
                </c:pt>
                <c:pt idx="1">
                  <c:v>0.223</c:v>
                </c:pt>
                <c:pt idx="2">
                  <c:v>0.67749999999999999</c:v>
                </c:pt>
                <c:pt idx="3">
                  <c:v>0.78049999999999997</c:v>
                </c:pt>
                <c:pt idx="4">
                  <c:v>0.8894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635-478A-A3F1-544F321783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19327"/>
        <c:axId val="1586731807"/>
      </c:scatterChart>
      <c:valAx>
        <c:axId val="1586719327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31807"/>
        <c:crosses val="autoZero"/>
        <c:crossBetween val="midCat"/>
      </c:valAx>
      <c:valAx>
        <c:axId val="1586731807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1932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588341105464943"/>
          <c:y val="0.1241999367884498"/>
          <c:w val="0.81967815122138687"/>
          <c:h val="0.7416382550922283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1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35:$M$35</c:f>
              <c:numCache>
                <c:formatCode>General</c:formatCode>
                <c:ptCount val="5"/>
                <c:pt idx="0">
                  <c:v>0.124</c:v>
                </c:pt>
                <c:pt idx="1">
                  <c:v>0.60850000000000004</c:v>
                </c:pt>
                <c:pt idx="2">
                  <c:v>0.78600000000000003</c:v>
                </c:pt>
                <c:pt idx="3">
                  <c:v>0.91700000000000004</c:v>
                </c:pt>
                <c:pt idx="4">
                  <c:v>1.0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F65-4CCF-9457-E6781F021484}"/>
            </c:ext>
          </c:extLst>
        </c:ser>
        <c:ser>
          <c:idx val="1"/>
          <c:order val="1"/>
          <c:tx>
            <c:strRef>
              <c:f>'[E. coli Vs HM results.xlsx]R2L1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36:$M$36</c:f>
              <c:numCache>
                <c:formatCode>General</c:formatCode>
                <c:ptCount val="5"/>
                <c:pt idx="0">
                  <c:v>0.11699999999999999</c:v>
                </c:pt>
                <c:pt idx="1">
                  <c:v>0.68100000000000005</c:v>
                </c:pt>
                <c:pt idx="2">
                  <c:v>0.85650000000000004</c:v>
                </c:pt>
                <c:pt idx="3">
                  <c:v>1.0185</c:v>
                </c:pt>
                <c:pt idx="4">
                  <c:v>1.21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F65-4CCF-9457-E6781F021484}"/>
            </c:ext>
          </c:extLst>
        </c:ser>
        <c:ser>
          <c:idx val="2"/>
          <c:order val="2"/>
          <c:tx>
            <c:strRef>
              <c:f>'[E. coli Vs HM results.xlsx]R2L1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37:$M$37</c:f>
              <c:numCache>
                <c:formatCode>General</c:formatCode>
                <c:ptCount val="5"/>
                <c:pt idx="0">
                  <c:v>0.1145</c:v>
                </c:pt>
                <c:pt idx="1">
                  <c:v>0.68300000000000005</c:v>
                </c:pt>
                <c:pt idx="2">
                  <c:v>0.83399999999999996</c:v>
                </c:pt>
                <c:pt idx="3">
                  <c:v>0.96649999999999991</c:v>
                </c:pt>
                <c:pt idx="4">
                  <c:v>1.11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F65-4CCF-9457-E6781F021484}"/>
            </c:ext>
          </c:extLst>
        </c:ser>
        <c:ser>
          <c:idx val="3"/>
          <c:order val="3"/>
          <c:tx>
            <c:strRef>
              <c:f>'[E. coli Vs HM results.xlsx]R2L1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38:$M$38</c:f>
              <c:numCache>
                <c:formatCode>General</c:formatCode>
                <c:ptCount val="5"/>
                <c:pt idx="0">
                  <c:v>0.1195</c:v>
                </c:pt>
                <c:pt idx="1">
                  <c:v>0.70649999999999991</c:v>
                </c:pt>
                <c:pt idx="2">
                  <c:v>0.874</c:v>
                </c:pt>
                <c:pt idx="3">
                  <c:v>0.99049999999999994</c:v>
                </c:pt>
                <c:pt idx="4">
                  <c:v>1.130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F65-4CCF-9457-E6781F021484}"/>
            </c:ext>
          </c:extLst>
        </c:ser>
        <c:ser>
          <c:idx val="4"/>
          <c:order val="4"/>
          <c:tx>
            <c:strRef>
              <c:f>'[E. coli Vs HM results.xlsx]R2L1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39:$M$39</c:f>
              <c:numCache>
                <c:formatCode>General</c:formatCode>
                <c:ptCount val="5"/>
                <c:pt idx="0">
                  <c:v>0.1125</c:v>
                </c:pt>
                <c:pt idx="1">
                  <c:v>0.66900000000000004</c:v>
                </c:pt>
                <c:pt idx="2">
                  <c:v>0.83949999999999991</c:v>
                </c:pt>
                <c:pt idx="3">
                  <c:v>0.9345</c:v>
                </c:pt>
                <c:pt idx="4">
                  <c:v>1.075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F65-4CCF-9457-E6781F021484}"/>
            </c:ext>
          </c:extLst>
        </c:ser>
        <c:ser>
          <c:idx val="5"/>
          <c:order val="5"/>
          <c:tx>
            <c:strRef>
              <c:f>'[E. coli Vs HM results.xlsx]R2L1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40:$M$40</c:f>
              <c:numCache>
                <c:formatCode>General</c:formatCode>
                <c:ptCount val="5"/>
                <c:pt idx="0">
                  <c:v>0.1145</c:v>
                </c:pt>
                <c:pt idx="1">
                  <c:v>0.60850000000000004</c:v>
                </c:pt>
                <c:pt idx="2">
                  <c:v>0.77900000000000003</c:v>
                </c:pt>
                <c:pt idx="3">
                  <c:v>0.876</c:v>
                </c:pt>
                <c:pt idx="4">
                  <c:v>0.951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F65-4CCF-9457-E6781F021484}"/>
            </c:ext>
          </c:extLst>
        </c:ser>
        <c:ser>
          <c:idx val="6"/>
          <c:order val="6"/>
          <c:tx>
            <c:strRef>
              <c:f>'[E. coli Vs HM results.xlsx]R2L1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41:$M$41</c:f>
              <c:numCache>
                <c:formatCode>General</c:formatCode>
                <c:ptCount val="5"/>
                <c:pt idx="0">
                  <c:v>0.1145</c:v>
                </c:pt>
                <c:pt idx="1">
                  <c:v>0.61499999999999999</c:v>
                </c:pt>
                <c:pt idx="2">
                  <c:v>0.79500000000000004</c:v>
                </c:pt>
                <c:pt idx="3">
                  <c:v>0.873</c:v>
                </c:pt>
                <c:pt idx="4">
                  <c:v>0.921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8F65-4CCF-9457-E6781F021484}"/>
            </c:ext>
          </c:extLst>
        </c:ser>
        <c:ser>
          <c:idx val="7"/>
          <c:order val="7"/>
          <c:tx>
            <c:strRef>
              <c:f>'[E. coli Vs HM results.xlsx]R2L1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I$42:$M$42</c:f>
              <c:numCache>
                <c:formatCode>General</c:formatCode>
                <c:ptCount val="5"/>
                <c:pt idx="0">
                  <c:v>0.1145</c:v>
                </c:pt>
                <c:pt idx="1">
                  <c:v>0.31850000000000001</c:v>
                </c:pt>
                <c:pt idx="2">
                  <c:v>0.67600000000000005</c:v>
                </c:pt>
                <c:pt idx="3">
                  <c:v>0.80400000000000005</c:v>
                </c:pt>
                <c:pt idx="4">
                  <c:v>0.911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8F65-4CCF-9457-E6781F0214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95070284986307"/>
          <c:y val="0.10868929788586601"/>
          <c:w val="0.81486948920963964"/>
          <c:h val="0.746676463705378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5'!$H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35:$M$35</c:f>
              <c:numCache>
                <c:formatCode>General</c:formatCode>
                <c:ptCount val="5"/>
                <c:pt idx="0">
                  <c:v>0.1215</c:v>
                </c:pt>
                <c:pt idx="1">
                  <c:v>0.62749999999999995</c:v>
                </c:pt>
                <c:pt idx="2">
                  <c:v>0.81549999999999989</c:v>
                </c:pt>
                <c:pt idx="3">
                  <c:v>0.89749999999999996</c:v>
                </c:pt>
                <c:pt idx="4">
                  <c:v>0.952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ECF-4AEC-B889-EDDC61A87253}"/>
            </c:ext>
          </c:extLst>
        </c:ser>
        <c:ser>
          <c:idx val="1"/>
          <c:order val="1"/>
          <c:tx>
            <c:strRef>
              <c:f>'[E. coli Vs HM results.xlsx]R3L5'!$H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36:$M$36</c:f>
              <c:numCache>
                <c:formatCode>General</c:formatCode>
                <c:ptCount val="5"/>
                <c:pt idx="0">
                  <c:v>0.1105</c:v>
                </c:pt>
                <c:pt idx="1">
                  <c:v>0.66549999999999998</c:v>
                </c:pt>
                <c:pt idx="2">
                  <c:v>0.86349999999999993</c:v>
                </c:pt>
                <c:pt idx="3">
                  <c:v>0.99150000000000005</c:v>
                </c:pt>
                <c:pt idx="4">
                  <c:v>0.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ECF-4AEC-B889-EDDC61A87253}"/>
            </c:ext>
          </c:extLst>
        </c:ser>
        <c:ser>
          <c:idx val="2"/>
          <c:order val="2"/>
          <c:tx>
            <c:strRef>
              <c:f>'[E. coli Vs HM results.xlsx]R3L5'!$H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37:$M$37</c:f>
              <c:numCache>
                <c:formatCode>General</c:formatCode>
                <c:ptCount val="5"/>
                <c:pt idx="0">
                  <c:v>0.1105</c:v>
                </c:pt>
                <c:pt idx="1">
                  <c:v>0.70950000000000002</c:v>
                </c:pt>
                <c:pt idx="2">
                  <c:v>0.89650000000000007</c:v>
                </c:pt>
                <c:pt idx="3">
                  <c:v>1.0125</c:v>
                </c:pt>
                <c:pt idx="4">
                  <c:v>1.047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ECF-4AEC-B889-EDDC61A87253}"/>
            </c:ext>
          </c:extLst>
        </c:ser>
        <c:ser>
          <c:idx val="3"/>
          <c:order val="3"/>
          <c:tx>
            <c:strRef>
              <c:f>'[E. coli Vs HM results.xlsx]R3L5'!$H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38:$M$38</c:f>
              <c:numCache>
                <c:formatCode>General</c:formatCode>
                <c:ptCount val="5"/>
                <c:pt idx="0">
                  <c:v>0.1105</c:v>
                </c:pt>
                <c:pt idx="1">
                  <c:v>0.6835</c:v>
                </c:pt>
                <c:pt idx="2">
                  <c:v>0.85699999999999998</c:v>
                </c:pt>
                <c:pt idx="3">
                  <c:v>0.99950000000000006</c:v>
                </c:pt>
                <c:pt idx="4">
                  <c:v>1.045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ECF-4AEC-B889-EDDC61A87253}"/>
            </c:ext>
          </c:extLst>
        </c:ser>
        <c:ser>
          <c:idx val="4"/>
          <c:order val="4"/>
          <c:tx>
            <c:strRef>
              <c:f>'[E. coli Vs HM results.xlsx]R3L5'!$H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39:$M$39</c:f>
              <c:numCache>
                <c:formatCode>General</c:formatCode>
                <c:ptCount val="5"/>
                <c:pt idx="0">
                  <c:v>0.1105</c:v>
                </c:pt>
                <c:pt idx="1">
                  <c:v>0.74199999999999999</c:v>
                </c:pt>
                <c:pt idx="2">
                  <c:v>0.91050000000000009</c:v>
                </c:pt>
                <c:pt idx="3">
                  <c:v>0.99449999999999994</c:v>
                </c:pt>
                <c:pt idx="4">
                  <c:v>1.041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ECF-4AEC-B889-EDDC61A87253}"/>
            </c:ext>
          </c:extLst>
        </c:ser>
        <c:ser>
          <c:idx val="5"/>
          <c:order val="5"/>
          <c:tx>
            <c:strRef>
              <c:f>'[E. coli Vs HM results.xlsx]R3L5'!$H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40:$M$40</c:f>
              <c:numCache>
                <c:formatCode>General</c:formatCode>
                <c:ptCount val="5"/>
                <c:pt idx="0">
                  <c:v>0.1105</c:v>
                </c:pt>
                <c:pt idx="1">
                  <c:v>0.67349999999999999</c:v>
                </c:pt>
                <c:pt idx="2">
                  <c:v>0.87349999999999994</c:v>
                </c:pt>
                <c:pt idx="3">
                  <c:v>1.0035000000000001</c:v>
                </c:pt>
                <c:pt idx="4">
                  <c:v>1.04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ECF-4AEC-B889-EDDC61A87253}"/>
            </c:ext>
          </c:extLst>
        </c:ser>
        <c:ser>
          <c:idx val="6"/>
          <c:order val="6"/>
          <c:tx>
            <c:strRef>
              <c:f>'[E. coli Vs HM results.xlsx]R3L5'!$H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41:$M$41</c:f>
              <c:numCache>
                <c:formatCode>General</c:formatCode>
                <c:ptCount val="5"/>
                <c:pt idx="0">
                  <c:v>0.1115</c:v>
                </c:pt>
                <c:pt idx="1">
                  <c:v>0.68300000000000005</c:v>
                </c:pt>
                <c:pt idx="2">
                  <c:v>0.90800000000000003</c:v>
                </c:pt>
                <c:pt idx="3">
                  <c:v>0.99049999999999994</c:v>
                </c:pt>
                <c:pt idx="4">
                  <c:v>1.000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8ECF-4AEC-B889-EDDC61A87253}"/>
            </c:ext>
          </c:extLst>
        </c:ser>
        <c:ser>
          <c:idx val="7"/>
          <c:order val="7"/>
          <c:tx>
            <c:strRef>
              <c:f>'[E. coli Vs HM results.xlsx]R3L5'!$H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I$34:$M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I$42:$M$42</c:f>
              <c:numCache>
                <c:formatCode>General</c:formatCode>
                <c:ptCount val="5"/>
                <c:pt idx="0">
                  <c:v>0.1105</c:v>
                </c:pt>
                <c:pt idx="1">
                  <c:v>0.46700000000000003</c:v>
                </c:pt>
                <c:pt idx="2">
                  <c:v>0.7975000000000001</c:v>
                </c:pt>
                <c:pt idx="3">
                  <c:v>0.87349999999999994</c:v>
                </c:pt>
                <c:pt idx="4">
                  <c:v>0.912500000000000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8ECF-4AEC-B889-EDDC61A872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2145839"/>
        <c:axId val="1422148719"/>
      </c:scatterChart>
      <c:valAx>
        <c:axId val="1422145839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8719"/>
        <c:crosses val="autoZero"/>
        <c:crossBetween val="midCat"/>
      </c:valAx>
      <c:valAx>
        <c:axId val="1422148719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21458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30025866822546"/>
          <c:y val="9.8876176291381776E-2"/>
          <c:w val="0.81023076613599843"/>
          <c:h val="0.671138008128920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10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35:$AA$35</c:f>
              <c:numCache>
                <c:formatCode>General</c:formatCode>
                <c:ptCount val="5"/>
                <c:pt idx="0">
                  <c:v>0.13150000000000001</c:v>
                </c:pt>
                <c:pt idx="1">
                  <c:v>0.69</c:v>
                </c:pt>
                <c:pt idx="2">
                  <c:v>0.84499999999999997</c:v>
                </c:pt>
                <c:pt idx="3">
                  <c:v>0.94699999999999995</c:v>
                </c:pt>
                <c:pt idx="4">
                  <c:v>1.05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BF9-43B6-91A6-9344B21B7D30}"/>
            </c:ext>
          </c:extLst>
        </c:ser>
        <c:ser>
          <c:idx val="1"/>
          <c:order val="1"/>
          <c:tx>
            <c:strRef>
              <c:f>'[E. coli Vs HM results.xlsx]R3L10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36:$AA$36</c:f>
              <c:numCache>
                <c:formatCode>General</c:formatCode>
                <c:ptCount val="5"/>
                <c:pt idx="0">
                  <c:v>0.124</c:v>
                </c:pt>
                <c:pt idx="1">
                  <c:v>0.71199999999999997</c:v>
                </c:pt>
                <c:pt idx="2">
                  <c:v>0.9444999999999999</c:v>
                </c:pt>
                <c:pt idx="3">
                  <c:v>1.0820000000000001</c:v>
                </c:pt>
                <c:pt idx="4">
                  <c:v>1.27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BF9-43B6-91A6-9344B21B7D30}"/>
            </c:ext>
          </c:extLst>
        </c:ser>
        <c:ser>
          <c:idx val="2"/>
          <c:order val="2"/>
          <c:tx>
            <c:strRef>
              <c:f>'[E. coli Vs HM results.xlsx]R3L10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37:$AA$37</c:f>
              <c:numCache>
                <c:formatCode>General</c:formatCode>
                <c:ptCount val="5"/>
                <c:pt idx="0">
                  <c:v>0.1235</c:v>
                </c:pt>
                <c:pt idx="1">
                  <c:v>0.74</c:v>
                </c:pt>
                <c:pt idx="2">
                  <c:v>0.93100000000000005</c:v>
                </c:pt>
                <c:pt idx="3">
                  <c:v>1.083</c:v>
                </c:pt>
                <c:pt idx="4">
                  <c:v>1.25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BF9-43B6-91A6-9344B21B7D30}"/>
            </c:ext>
          </c:extLst>
        </c:ser>
        <c:ser>
          <c:idx val="3"/>
          <c:order val="3"/>
          <c:tx>
            <c:strRef>
              <c:f>'[E. coli Vs HM results.xlsx]R3L10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38:$AA$38</c:f>
              <c:numCache>
                <c:formatCode>General</c:formatCode>
                <c:ptCount val="5"/>
                <c:pt idx="0">
                  <c:v>0.1245</c:v>
                </c:pt>
                <c:pt idx="1">
                  <c:v>0.72699999999999998</c:v>
                </c:pt>
                <c:pt idx="2">
                  <c:v>0.89700000000000002</c:v>
                </c:pt>
                <c:pt idx="3">
                  <c:v>1.0139999999999998</c:v>
                </c:pt>
                <c:pt idx="4">
                  <c:v>1.21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BF9-43B6-91A6-9344B21B7D30}"/>
            </c:ext>
          </c:extLst>
        </c:ser>
        <c:ser>
          <c:idx val="4"/>
          <c:order val="4"/>
          <c:tx>
            <c:strRef>
              <c:f>'[E. coli Vs HM results.xlsx]R3L10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39:$AA$39</c:f>
              <c:numCache>
                <c:formatCode>General</c:formatCode>
                <c:ptCount val="5"/>
                <c:pt idx="0">
                  <c:v>0.1225</c:v>
                </c:pt>
                <c:pt idx="1">
                  <c:v>0.76750000000000007</c:v>
                </c:pt>
                <c:pt idx="2">
                  <c:v>0.96049999999999991</c:v>
                </c:pt>
                <c:pt idx="3">
                  <c:v>1.0935000000000001</c:v>
                </c:pt>
                <c:pt idx="4">
                  <c:v>1.26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3BF9-43B6-91A6-9344B21B7D30}"/>
            </c:ext>
          </c:extLst>
        </c:ser>
        <c:ser>
          <c:idx val="5"/>
          <c:order val="5"/>
          <c:tx>
            <c:strRef>
              <c:f>'[E. coli Vs HM results.xlsx]R3L10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40:$AA$40</c:f>
              <c:numCache>
                <c:formatCode>General</c:formatCode>
                <c:ptCount val="5"/>
                <c:pt idx="0">
                  <c:v>0.126</c:v>
                </c:pt>
                <c:pt idx="1">
                  <c:v>0.46550000000000002</c:v>
                </c:pt>
                <c:pt idx="2">
                  <c:v>0.62549999999999994</c:v>
                </c:pt>
                <c:pt idx="3">
                  <c:v>0.7024999999999999</c:v>
                </c:pt>
                <c:pt idx="4">
                  <c:v>0.8894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3BF9-43B6-91A6-9344B21B7D30}"/>
            </c:ext>
          </c:extLst>
        </c:ser>
        <c:ser>
          <c:idx val="6"/>
          <c:order val="6"/>
          <c:tx>
            <c:strRef>
              <c:f>'[E. coli Vs HM results.xlsx]R3L10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41:$AA$41</c:f>
              <c:numCache>
                <c:formatCode>General</c:formatCode>
                <c:ptCount val="5"/>
                <c:pt idx="0">
                  <c:v>0.1255</c:v>
                </c:pt>
                <c:pt idx="1">
                  <c:v>0.17699999999999999</c:v>
                </c:pt>
                <c:pt idx="2">
                  <c:v>0.20150000000000001</c:v>
                </c:pt>
                <c:pt idx="3">
                  <c:v>0.17749999999999999</c:v>
                </c:pt>
                <c:pt idx="4">
                  <c:v>0.225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3BF9-43B6-91A6-9344B21B7D30}"/>
            </c:ext>
          </c:extLst>
        </c:ser>
        <c:ser>
          <c:idx val="7"/>
          <c:order val="7"/>
          <c:tx>
            <c:strRef>
              <c:f>'[E. coli Vs HM results.xlsx]R3L10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W$42:$AA$42</c:f>
              <c:numCache>
                <c:formatCode>General</c:formatCode>
                <c:ptCount val="5"/>
                <c:pt idx="0">
                  <c:v>0.126</c:v>
                </c:pt>
                <c:pt idx="1">
                  <c:v>0.14149999999999999</c:v>
                </c:pt>
                <c:pt idx="2">
                  <c:v>0.14549999999999999</c:v>
                </c:pt>
                <c:pt idx="3">
                  <c:v>0.122</c:v>
                </c:pt>
                <c:pt idx="4">
                  <c:v>0.163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3BF9-43B6-91A6-9344B21B7D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888966144817552"/>
          <c:y val="9.251193892182287E-2"/>
          <c:w val="0.81568875601379942"/>
          <c:h val="0.6996024905929308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3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35:$AA$35</c:f>
              <c:numCache>
                <c:formatCode>General</c:formatCode>
                <c:ptCount val="5"/>
                <c:pt idx="0">
                  <c:v>0.1205</c:v>
                </c:pt>
                <c:pt idx="1">
                  <c:v>0.73499999999999999</c:v>
                </c:pt>
                <c:pt idx="2">
                  <c:v>0.90200000000000002</c:v>
                </c:pt>
                <c:pt idx="3">
                  <c:v>0.98750000000000004</c:v>
                </c:pt>
                <c:pt idx="4">
                  <c:v>1.08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41C-4A94-BDDE-3ED335656EF8}"/>
            </c:ext>
          </c:extLst>
        </c:ser>
        <c:ser>
          <c:idx val="1"/>
          <c:order val="1"/>
          <c:tx>
            <c:strRef>
              <c:f>'[E. coli Vs HM results.xlsx]R3L3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36:$AA$36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0350000000000001</c:v>
                </c:pt>
                <c:pt idx="2">
                  <c:v>0.879</c:v>
                </c:pt>
                <c:pt idx="3">
                  <c:v>0.97350000000000003</c:v>
                </c:pt>
                <c:pt idx="4">
                  <c:v>1.101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41C-4A94-BDDE-3ED335656EF8}"/>
            </c:ext>
          </c:extLst>
        </c:ser>
        <c:ser>
          <c:idx val="2"/>
          <c:order val="2"/>
          <c:tx>
            <c:strRef>
              <c:f>'[E. coli Vs HM results.xlsx]R3L3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37:$AA$37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69950000000000001</c:v>
                </c:pt>
                <c:pt idx="2">
                  <c:v>0.86650000000000005</c:v>
                </c:pt>
                <c:pt idx="3">
                  <c:v>0.96399999999999997</c:v>
                </c:pt>
                <c:pt idx="4">
                  <c:v>1.039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41C-4A94-BDDE-3ED335656EF8}"/>
            </c:ext>
          </c:extLst>
        </c:ser>
        <c:ser>
          <c:idx val="3"/>
          <c:order val="3"/>
          <c:tx>
            <c:strRef>
              <c:f>'[E. coli Vs HM results.xlsx]R3L3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38:$AA$38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71350000000000002</c:v>
                </c:pt>
                <c:pt idx="2">
                  <c:v>0.89349999999999996</c:v>
                </c:pt>
                <c:pt idx="3">
                  <c:v>0.98299999999999998</c:v>
                </c:pt>
                <c:pt idx="4">
                  <c:v>1.071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41C-4A94-BDDE-3ED335656EF8}"/>
            </c:ext>
          </c:extLst>
        </c:ser>
        <c:ser>
          <c:idx val="4"/>
          <c:order val="4"/>
          <c:tx>
            <c:strRef>
              <c:f>'[E. coli Vs HM results.xlsx]R3L3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39:$AA$39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70849999999999991</c:v>
                </c:pt>
                <c:pt idx="2">
                  <c:v>0.86399999999999999</c:v>
                </c:pt>
                <c:pt idx="3">
                  <c:v>0.94399999999999995</c:v>
                </c:pt>
                <c:pt idx="4">
                  <c:v>1.037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41C-4A94-BDDE-3ED335656EF8}"/>
            </c:ext>
          </c:extLst>
        </c:ser>
        <c:ser>
          <c:idx val="5"/>
          <c:order val="5"/>
          <c:tx>
            <c:strRef>
              <c:f>'[E. coli Vs HM results.xlsx]R3L3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40:$AA$40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25000000000001</c:v>
                </c:pt>
                <c:pt idx="2">
                  <c:v>0.79700000000000004</c:v>
                </c:pt>
                <c:pt idx="3">
                  <c:v>0.80900000000000005</c:v>
                </c:pt>
                <c:pt idx="4">
                  <c:v>0.902500000000000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41C-4A94-BDDE-3ED335656EF8}"/>
            </c:ext>
          </c:extLst>
        </c:ser>
        <c:ser>
          <c:idx val="6"/>
          <c:order val="6"/>
          <c:tx>
            <c:strRef>
              <c:f>'[E. coli Vs HM results.xlsx]R3L3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41:$AA$41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32450000000000001</c:v>
                </c:pt>
                <c:pt idx="2">
                  <c:v>0.47249999999999998</c:v>
                </c:pt>
                <c:pt idx="3">
                  <c:v>0.51849999999999996</c:v>
                </c:pt>
                <c:pt idx="4">
                  <c:v>0.604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41C-4A94-BDDE-3ED335656EF8}"/>
            </c:ext>
          </c:extLst>
        </c:ser>
        <c:ser>
          <c:idx val="7"/>
          <c:order val="7"/>
          <c:tx>
            <c:strRef>
              <c:f>'[E. coli Vs HM results.xlsx]R3L3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W$42:$AA$42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16550000000000001</c:v>
                </c:pt>
                <c:pt idx="2">
                  <c:v>0.17050000000000001</c:v>
                </c:pt>
                <c:pt idx="3">
                  <c:v>0.13750000000000001</c:v>
                </c:pt>
                <c:pt idx="4">
                  <c:v>0.24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41C-4A94-BDDE-3ED335656E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72169439876558"/>
          <c:y val="0.13553943448260589"/>
          <c:w val="0.81723868750306272"/>
          <c:h val="0.7339383535092868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7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35:$F$35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100000000000004</c:v>
                </c:pt>
                <c:pt idx="2">
                  <c:v>0.83399999999999996</c:v>
                </c:pt>
                <c:pt idx="3">
                  <c:v>0.97350000000000003</c:v>
                </c:pt>
                <c:pt idx="4">
                  <c:v>1.04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64E-4789-8207-D3947C25CEE3}"/>
            </c:ext>
          </c:extLst>
        </c:ser>
        <c:ser>
          <c:idx val="1"/>
          <c:order val="1"/>
          <c:tx>
            <c:strRef>
              <c:f>'[E. coli Vs HM results.xlsx]R3L7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36:$F$36</c:f>
              <c:numCache>
                <c:formatCode>General</c:formatCode>
                <c:ptCount val="5"/>
                <c:pt idx="0">
                  <c:v>0.1195</c:v>
                </c:pt>
                <c:pt idx="1">
                  <c:v>0.64450000000000007</c:v>
                </c:pt>
                <c:pt idx="2">
                  <c:v>0.81200000000000006</c:v>
                </c:pt>
                <c:pt idx="3">
                  <c:v>0.96550000000000002</c:v>
                </c:pt>
                <c:pt idx="4">
                  <c:v>1.04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64E-4789-8207-D3947C25CEE3}"/>
            </c:ext>
          </c:extLst>
        </c:ser>
        <c:ser>
          <c:idx val="2"/>
          <c:order val="2"/>
          <c:tx>
            <c:strRef>
              <c:f>'[E. coli Vs HM results.xlsx]R3L7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37:$F$37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65549999999999997</c:v>
                </c:pt>
                <c:pt idx="2">
                  <c:v>0.77049999999999996</c:v>
                </c:pt>
                <c:pt idx="3">
                  <c:v>0.86499999999999999</c:v>
                </c:pt>
                <c:pt idx="4">
                  <c:v>0.951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64E-4789-8207-D3947C25CEE3}"/>
            </c:ext>
          </c:extLst>
        </c:ser>
        <c:ser>
          <c:idx val="3"/>
          <c:order val="3"/>
          <c:tx>
            <c:strRef>
              <c:f>'[E. coli Vs HM results.xlsx]R3L7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38:$F$38</c:f>
              <c:numCache>
                <c:formatCode>General</c:formatCode>
                <c:ptCount val="5"/>
                <c:pt idx="0">
                  <c:v>0.11799999999999999</c:v>
                </c:pt>
                <c:pt idx="1">
                  <c:v>0.66050000000000009</c:v>
                </c:pt>
                <c:pt idx="2">
                  <c:v>0.77900000000000003</c:v>
                </c:pt>
                <c:pt idx="3">
                  <c:v>0.83949999999999991</c:v>
                </c:pt>
                <c:pt idx="4">
                  <c:v>0.916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64E-4789-8207-D3947C25CEE3}"/>
            </c:ext>
          </c:extLst>
        </c:ser>
        <c:ser>
          <c:idx val="4"/>
          <c:order val="4"/>
          <c:tx>
            <c:strRef>
              <c:f>'[E. coli Vs HM results.xlsx]R3L7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39:$F$39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3649999999999995</c:v>
                </c:pt>
                <c:pt idx="2">
                  <c:v>0.74050000000000005</c:v>
                </c:pt>
                <c:pt idx="3">
                  <c:v>0.80899999999999994</c:v>
                </c:pt>
                <c:pt idx="4">
                  <c:v>0.8655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64E-4789-8207-D3947C25CEE3}"/>
            </c:ext>
          </c:extLst>
        </c:ser>
        <c:ser>
          <c:idx val="5"/>
          <c:order val="5"/>
          <c:tx>
            <c:strRef>
              <c:f>'[E. coli Vs HM results.xlsx]R3L7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40:$F$40</c:f>
              <c:numCache>
                <c:formatCode>General</c:formatCode>
                <c:ptCount val="5"/>
                <c:pt idx="0">
                  <c:v>0.11449999999999999</c:v>
                </c:pt>
                <c:pt idx="1">
                  <c:v>0.51449999999999996</c:v>
                </c:pt>
                <c:pt idx="2">
                  <c:v>0.61749999999999994</c:v>
                </c:pt>
                <c:pt idx="3">
                  <c:v>0.69750000000000001</c:v>
                </c:pt>
                <c:pt idx="4">
                  <c:v>0.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64E-4789-8207-D3947C25CEE3}"/>
            </c:ext>
          </c:extLst>
        </c:ser>
        <c:ser>
          <c:idx val="6"/>
          <c:order val="6"/>
          <c:tx>
            <c:strRef>
              <c:f>'[E. coli Vs HM results.xlsx]R3L7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41:$F$41</c:f>
              <c:numCache>
                <c:formatCode>General</c:formatCode>
                <c:ptCount val="5"/>
                <c:pt idx="0">
                  <c:v>0.11649999999999999</c:v>
                </c:pt>
                <c:pt idx="1">
                  <c:v>0.44350000000000001</c:v>
                </c:pt>
                <c:pt idx="2">
                  <c:v>0.44</c:v>
                </c:pt>
                <c:pt idx="3">
                  <c:v>0.3805</c:v>
                </c:pt>
                <c:pt idx="4">
                  <c:v>0.484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64E-4789-8207-D3947C25CEE3}"/>
            </c:ext>
          </c:extLst>
        </c:ser>
        <c:ser>
          <c:idx val="7"/>
          <c:order val="7"/>
          <c:tx>
            <c:strRef>
              <c:f>'[E. coli Vs HM results.xlsx]R3L7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B$42:$F$42</c:f>
              <c:numCache>
                <c:formatCode>General</c:formatCode>
                <c:ptCount val="5"/>
                <c:pt idx="0">
                  <c:v>0.11649999999999999</c:v>
                </c:pt>
                <c:pt idx="1">
                  <c:v>0.2505</c:v>
                </c:pt>
                <c:pt idx="2">
                  <c:v>0.20050000000000001</c:v>
                </c:pt>
                <c:pt idx="3">
                  <c:v>0.151</c:v>
                </c:pt>
                <c:pt idx="4">
                  <c:v>0.204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64E-4789-8207-D3947C25CE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1</a:t>
            </a:r>
          </a:p>
        </c:rich>
      </c:tx>
      <c:layout>
        <c:manualLayout>
          <c:xMode val="edge"/>
          <c:yMode val="edge"/>
          <c:x val="0.46400484417566412"/>
          <c:y val="0.236678866635848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888966144817552"/>
          <c:y val="0.25528566041085232"/>
          <c:w val="0.81568875601379942"/>
          <c:h val="0.6377400350295614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1'!$V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4:$AA$34</c:f>
              <c:numCache>
                <c:formatCode>General</c:formatCode>
                <c:ptCount val="5"/>
                <c:pt idx="0">
                  <c:v>0.125</c:v>
                </c:pt>
                <c:pt idx="1">
                  <c:v>0.61349999999999993</c:v>
                </c:pt>
                <c:pt idx="2">
                  <c:v>0.8085</c:v>
                </c:pt>
                <c:pt idx="3">
                  <c:v>0.94099999999999995</c:v>
                </c:pt>
                <c:pt idx="4">
                  <c:v>1.0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E0D-4CF4-87A7-F5AF44582E3E}"/>
            </c:ext>
          </c:extLst>
        </c:ser>
        <c:ser>
          <c:idx val="1"/>
          <c:order val="1"/>
          <c:tx>
            <c:strRef>
              <c:f>'[E. coli Vs HM results.xlsx]R1L1'!$V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5:$AA$35</c:f>
              <c:numCache>
                <c:formatCode>General</c:formatCode>
                <c:ptCount val="5"/>
                <c:pt idx="0">
                  <c:v>0.105</c:v>
                </c:pt>
                <c:pt idx="1">
                  <c:v>0.63200000000000001</c:v>
                </c:pt>
                <c:pt idx="2">
                  <c:v>0.82399999999999995</c:v>
                </c:pt>
                <c:pt idx="3">
                  <c:v>0.96649999999999991</c:v>
                </c:pt>
                <c:pt idx="4">
                  <c:v>1.12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E0D-4CF4-87A7-F5AF44582E3E}"/>
            </c:ext>
          </c:extLst>
        </c:ser>
        <c:ser>
          <c:idx val="2"/>
          <c:order val="2"/>
          <c:tx>
            <c:strRef>
              <c:f>'[E. coli Vs HM results.xlsx]R1L1'!$V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6:$AA$36</c:f>
              <c:numCache>
                <c:formatCode>General</c:formatCode>
                <c:ptCount val="5"/>
                <c:pt idx="0">
                  <c:v>0.1055</c:v>
                </c:pt>
                <c:pt idx="1">
                  <c:v>0.62149999999999994</c:v>
                </c:pt>
                <c:pt idx="2">
                  <c:v>0.78750000000000009</c:v>
                </c:pt>
                <c:pt idx="3">
                  <c:v>0.94550000000000001</c:v>
                </c:pt>
                <c:pt idx="4">
                  <c:v>1.143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E0D-4CF4-87A7-F5AF44582E3E}"/>
            </c:ext>
          </c:extLst>
        </c:ser>
        <c:ser>
          <c:idx val="3"/>
          <c:order val="3"/>
          <c:tx>
            <c:strRef>
              <c:f>'[E. coli Vs HM results.xlsx]R1L1'!$V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7:$AA$37</c:f>
              <c:numCache>
                <c:formatCode>General</c:formatCode>
                <c:ptCount val="5"/>
                <c:pt idx="0">
                  <c:v>0.107</c:v>
                </c:pt>
                <c:pt idx="1">
                  <c:v>0.60250000000000004</c:v>
                </c:pt>
                <c:pt idx="2">
                  <c:v>0.77449999999999997</c:v>
                </c:pt>
                <c:pt idx="3">
                  <c:v>0.9265000000000001</c:v>
                </c:pt>
                <c:pt idx="4">
                  <c:v>1.13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E0D-4CF4-87A7-F5AF44582E3E}"/>
            </c:ext>
          </c:extLst>
        </c:ser>
        <c:ser>
          <c:idx val="4"/>
          <c:order val="4"/>
          <c:tx>
            <c:strRef>
              <c:f>'[E. coli Vs HM results.xlsx]R1L1'!$V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8:$AA$38</c:f>
              <c:numCache>
                <c:formatCode>General</c:formatCode>
                <c:ptCount val="5"/>
                <c:pt idx="0">
                  <c:v>0.1045</c:v>
                </c:pt>
                <c:pt idx="1">
                  <c:v>0.5794999999999999</c:v>
                </c:pt>
                <c:pt idx="2">
                  <c:v>0.74299999999999999</c:v>
                </c:pt>
                <c:pt idx="3">
                  <c:v>0.86099999999999999</c:v>
                </c:pt>
                <c:pt idx="4">
                  <c:v>1.0154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E0D-4CF4-87A7-F5AF44582E3E}"/>
            </c:ext>
          </c:extLst>
        </c:ser>
        <c:ser>
          <c:idx val="5"/>
          <c:order val="5"/>
          <c:tx>
            <c:strRef>
              <c:f>'[E. coli Vs HM results.xlsx]R1L1'!$V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39:$AA$39</c:f>
              <c:numCache>
                <c:formatCode>General</c:formatCode>
                <c:ptCount val="5"/>
                <c:pt idx="0">
                  <c:v>0.1055</c:v>
                </c:pt>
                <c:pt idx="1">
                  <c:v>0.56749999999999989</c:v>
                </c:pt>
                <c:pt idx="2">
                  <c:v>0.61550000000000005</c:v>
                </c:pt>
                <c:pt idx="3">
                  <c:v>0.82650000000000001</c:v>
                </c:pt>
                <c:pt idx="4">
                  <c:v>0.946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DE0D-4CF4-87A7-F5AF44582E3E}"/>
            </c:ext>
          </c:extLst>
        </c:ser>
        <c:ser>
          <c:idx val="6"/>
          <c:order val="6"/>
          <c:tx>
            <c:strRef>
              <c:f>'[E. coli Vs HM results.xlsx]R1L1'!$V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40:$AA$40</c:f>
              <c:numCache>
                <c:formatCode>General</c:formatCode>
                <c:ptCount val="5"/>
                <c:pt idx="0">
                  <c:v>0.108</c:v>
                </c:pt>
                <c:pt idx="1">
                  <c:v>0.16600000000000001</c:v>
                </c:pt>
                <c:pt idx="2">
                  <c:v>0.252</c:v>
                </c:pt>
                <c:pt idx="3">
                  <c:v>0.29149999999999998</c:v>
                </c:pt>
                <c:pt idx="4">
                  <c:v>0.4030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DE0D-4CF4-87A7-F5AF44582E3E}"/>
            </c:ext>
          </c:extLst>
        </c:ser>
        <c:ser>
          <c:idx val="7"/>
          <c:order val="7"/>
          <c:tx>
            <c:strRef>
              <c:f>'[E. coli Vs HM results.xlsx]R1L1'!$V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1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1'!$W$41:$AA$41</c:f>
              <c:numCache>
                <c:formatCode>General</c:formatCode>
                <c:ptCount val="5"/>
                <c:pt idx="0">
                  <c:v>0.107</c:v>
                </c:pt>
                <c:pt idx="1">
                  <c:v>0.13</c:v>
                </c:pt>
                <c:pt idx="2">
                  <c:v>0.13100000000000001</c:v>
                </c:pt>
                <c:pt idx="3">
                  <c:v>0.104</c:v>
                </c:pt>
                <c:pt idx="4">
                  <c:v>0.147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DE0D-4CF4-87A7-F5AF44582E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56172879"/>
        <c:axId val="1756173839"/>
      </c:scatterChart>
      <c:valAx>
        <c:axId val="1756172879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6173839"/>
        <c:crosses val="autoZero"/>
        <c:crossBetween val="midCat"/>
      </c:valAx>
      <c:valAx>
        <c:axId val="17561738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61728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6958900646033745"/>
          <c:y val="4.6364568494198781E-2"/>
          <c:w val="0.66082198707932505"/>
          <c:h val="0.164495961077908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2</a:t>
            </a:r>
          </a:p>
        </c:rich>
      </c:tx>
      <c:layout>
        <c:manualLayout>
          <c:xMode val="edge"/>
          <c:yMode val="edge"/>
          <c:x val="0.46836392706417179"/>
          <c:y val="9.27572690237019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840142558818502E-2"/>
          <c:y val="0.11266307750093903"/>
          <c:w val="0.87019936614454318"/>
          <c:h val="0.7130294420741397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2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35:$AA$35</c:f>
              <c:numCache>
                <c:formatCode>General</c:formatCode>
                <c:ptCount val="5"/>
                <c:pt idx="0">
                  <c:v>0.124</c:v>
                </c:pt>
                <c:pt idx="1">
                  <c:v>0.70199999999999996</c:v>
                </c:pt>
                <c:pt idx="2">
                  <c:v>0.87149999999999994</c:v>
                </c:pt>
                <c:pt idx="3">
                  <c:v>0.97249999999999992</c:v>
                </c:pt>
                <c:pt idx="4">
                  <c:v>1.07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4C1-4A3D-8CAD-00FDE8AD56AA}"/>
            </c:ext>
          </c:extLst>
        </c:ser>
        <c:ser>
          <c:idx val="1"/>
          <c:order val="1"/>
          <c:tx>
            <c:strRef>
              <c:f>'[E. coli Vs HM results.xlsx]R2L2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36:$AA$36</c:f>
              <c:numCache>
                <c:formatCode>General</c:formatCode>
                <c:ptCount val="5"/>
                <c:pt idx="0">
                  <c:v>0.1195</c:v>
                </c:pt>
                <c:pt idx="1">
                  <c:v>0.76700000000000002</c:v>
                </c:pt>
                <c:pt idx="2">
                  <c:v>0.93400000000000005</c:v>
                </c:pt>
                <c:pt idx="3">
                  <c:v>1.0175000000000001</c:v>
                </c:pt>
                <c:pt idx="4">
                  <c:v>1.10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4C1-4A3D-8CAD-00FDE8AD56AA}"/>
            </c:ext>
          </c:extLst>
        </c:ser>
        <c:ser>
          <c:idx val="2"/>
          <c:order val="2"/>
          <c:tx>
            <c:strRef>
              <c:f>'[E. coli Vs HM results.xlsx]R2L2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37:$AA$37</c:f>
              <c:numCache>
                <c:formatCode>General</c:formatCode>
                <c:ptCount val="5"/>
                <c:pt idx="0">
                  <c:v>0.121</c:v>
                </c:pt>
                <c:pt idx="1">
                  <c:v>0.76300000000000001</c:v>
                </c:pt>
                <c:pt idx="2">
                  <c:v>0.92149999999999999</c:v>
                </c:pt>
                <c:pt idx="3">
                  <c:v>1.0009999999999999</c:v>
                </c:pt>
                <c:pt idx="4">
                  <c:v>1.162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4C1-4A3D-8CAD-00FDE8AD56AA}"/>
            </c:ext>
          </c:extLst>
        </c:ser>
        <c:ser>
          <c:idx val="3"/>
          <c:order val="3"/>
          <c:tx>
            <c:strRef>
              <c:f>'[E. coli Vs HM results.xlsx]R2L2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38:$AA$38</c:f>
              <c:numCache>
                <c:formatCode>General</c:formatCode>
                <c:ptCount val="5"/>
                <c:pt idx="0">
                  <c:v>0.1195</c:v>
                </c:pt>
                <c:pt idx="1">
                  <c:v>0.74350000000000005</c:v>
                </c:pt>
                <c:pt idx="2">
                  <c:v>0.89300000000000002</c:v>
                </c:pt>
                <c:pt idx="3">
                  <c:v>0.98249999999999993</c:v>
                </c:pt>
                <c:pt idx="4">
                  <c:v>1.152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4C1-4A3D-8CAD-00FDE8AD56AA}"/>
            </c:ext>
          </c:extLst>
        </c:ser>
        <c:ser>
          <c:idx val="4"/>
          <c:order val="4"/>
          <c:tx>
            <c:strRef>
              <c:f>'[E. coli Vs HM results.xlsx]R2L2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39:$AA$39</c:f>
              <c:numCache>
                <c:formatCode>General</c:formatCode>
                <c:ptCount val="5"/>
                <c:pt idx="0">
                  <c:v>0.1195</c:v>
                </c:pt>
                <c:pt idx="1">
                  <c:v>0.74750000000000005</c:v>
                </c:pt>
                <c:pt idx="2">
                  <c:v>0.90850000000000009</c:v>
                </c:pt>
                <c:pt idx="3">
                  <c:v>0.98299999999999998</c:v>
                </c:pt>
                <c:pt idx="4">
                  <c:v>1.08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4C1-4A3D-8CAD-00FDE8AD56AA}"/>
            </c:ext>
          </c:extLst>
        </c:ser>
        <c:ser>
          <c:idx val="5"/>
          <c:order val="5"/>
          <c:tx>
            <c:strRef>
              <c:f>'[E. coli Vs HM results.xlsx]R2L2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40:$AA$40</c:f>
              <c:numCache>
                <c:formatCode>General</c:formatCode>
                <c:ptCount val="5"/>
                <c:pt idx="0">
                  <c:v>0.1205</c:v>
                </c:pt>
                <c:pt idx="1">
                  <c:v>0.65600000000000003</c:v>
                </c:pt>
                <c:pt idx="2">
                  <c:v>0.79200000000000004</c:v>
                </c:pt>
                <c:pt idx="3">
                  <c:v>0.8254999999999999</c:v>
                </c:pt>
                <c:pt idx="4">
                  <c:v>0.932500000000000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4C1-4A3D-8CAD-00FDE8AD56AA}"/>
            </c:ext>
          </c:extLst>
        </c:ser>
        <c:ser>
          <c:idx val="6"/>
          <c:order val="6"/>
          <c:tx>
            <c:strRef>
              <c:f>'[E. coli Vs HM results.xlsx]R2L2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41:$AA$41</c:f>
              <c:numCache>
                <c:formatCode>General</c:formatCode>
                <c:ptCount val="5"/>
                <c:pt idx="0">
                  <c:v>0.1205</c:v>
                </c:pt>
                <c:pt idx="1">
                  <c:v>0.2165</c:v>
                </c:pt>
                <c:pt idx="2">
                  <c:v>0.30499999999999999</c:v>
                </c:pt>
                <c:pt idx="3">
                  <c:v>0.52649999999999997</c:v>
                </c:pt>
                <c:pt idx="4">
                  <c:v>0.718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4C1-4A3D-8CAD-00FDE8AD56AA}"/>
            </c:ext>
          </c:extLst>
        </c:ser>
        <c:ser>
          <c:idx val="7"/>
          <c:order val="7"/>
          <c:tx>
            <c:strRef>
              <c:f>'[E. coli Vs HM results.xlsx]R2L2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2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2'!$W$42:$AA$42</c:f>
              <c:numCache>
                <c:formatCode>General</c:formatCode>
                <c:ptCount val="5"/>
                <c:pt idx="0">
                  <c:v>0.1205</c:v>
                </c:pt>
                <c:pt idx="1">
                  <c:v>0.14949999999999999</c:v>
                </c:pt>
                <c:pt idx="2">
                  <c:v>0.152</c:v>
                </c:pt>
                <c:pt idx="3">
                  <c:v>0.13700000000000001</c:v>
                </c:pt>
                <c:pt idx="4">
                  <c:v>0.204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4C1-4A3D-8CAD-00FDE8AD56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3</a:t>
            </a:r>
          </a:p>
        </c:rich>
      </c:tx>
      <c:layout>
        <c:manualLayout>
          <c:xMode val="edge"/>
          <c:yMode val="edge"/>
          <c:x val="0.48223898001866594"/>
          <c:y val="0.122472358607617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888966144817552"/>
          <c:y val="0.16029156433665576"/>
          <c:w val="0.81568875601379942"/>
          <c:h val="0.7223752229303120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7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35:$AA$35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67100000000000004</c:v>
                </c:pt>
                <c:pt idx="2">
                  <c:v>0.83399999999999996</c:v>
                </c:pt>
                <c:pt idx="3">
                  <c:v>0.97350000000000003</c:v>
                </c:pt>
                <c:pt idx="4">
                  <c:v>1.04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36-4E15-8B88-F30E99E1BD9F}"/>
            </c:ext>
          </c:extLst>
        </c:ser>
        <c:ser>
          <c:idx val="1"/>
          <c:order val="1"/>
          <c:tx>
            <c:strRef>
              <c:f>'[E. coli Vs HM results.xlsx]R3L7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36:$AA$36</c:f>
              <c:numCache>
                <c:formatCode>General</c:formatCode>
                <c:ptCount val="5"/>
                <c:pt idx="0">
                  <c:v>0.1105</c:v>
                </c:pt>
                <c:pt idx="1">
                  <c:v>0.79700000000000004</c:v>
                </c:pt>
                <c:pt idx="2">
                  <c:v>0.95350000000000001</c:v>
                </c:pt>
                <c:pt idx="3">
                  <c:v>1.0429999999999999</c:v>
                </c:pt>
                <c:pt idx="4">
                  <c:v>1.1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36-4E15-8B88-F30E99E1BD9F}"/>
            </c:ext>
          </c:extLst>
        </c:ser>
        <c:ser>
          <c:idx val="2"/>
          <c:order val="2"/>
          <c:tx>
            <c:strRef>
              <c:f>'[E. coli Vs HM results.xlsx]R3L7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37:$AA$37</c:f>
              <c:numCache>
                <c:formatCode>General</c:formatCode>
                <c:ptCount val="5"/>
                <c:pt idx="0">
                  <c:v>0.1105</c:v>
                </c:pt>
                <c:pt idx="1">
                  <c:v>0.8165</c:v>
                </c:pt>
                <c:pt idx="2">
                  <c:v>0.96399999999999997</c:v>
                </c:pt>
                <c:pt idx="3">
                  <c:v>1.0535000000000001</c:v>
                </c:pt>
                <c:pt idx="4">
                  <c:v>1.14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036-4E15-8B88-F30E99E1BD9F}"/>
            </c:ext>
          </c:extLst>
        </c:ser>
        <c:ser>
          <c:idx val="3"/>
          <c:order val="3"/>
          <c:tx>
            <c:strRef>
              <c:f>'[E. coli Vs HM results.xlsx]R3L7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38:$AA$38</c:f>
              <c:numCache>
                <c:formatCode>General</c:formatCode>
                <c:ptCount val="5"/>
                <c:pt idx="0">
                  <c:v>0.1115</c:v>
                </c:pt>
                <c:pt idx="1">
                  <c:v>0.8055000000000001</c:v>
                </c:pt>
                <c:pt idx="2">
                  <c:v>0.95849999999999991</c:v>
                </c:pt>
                <c:pt idx="3">
                  <c:v>1.0525</c:v>
                </c:pt>
                <c:pt idx="4">
                  <c:v>1.144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036-4E15-8B88-F30E99E1BD9F}"/>
            </c:ext>
          </c:extLst>
        </c:ser>
        <c:ser>
          <c:idx val="4"/>
          <c:order val="4"/>
          <c:tx>
            <c:strRef>
              <c:f>'[E. coli Vs HM results.xlsx]R3L7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39:$AA$39</c:f>
              <c:numCache>
                <c:formatCode>General</c:formatCode>
                <c:ptCount val="5"/>
                <c:pt idx="0">
                  <c:v>0.1115</c:v>
                </c:pt>
                <c:pt idx="1">
                  <c:v>0.8055000000000001</c:v>
                </c:pt>
                <c:pt idx="2">
                  <c:v>0.95849999999999991</c:v>
                </c:pt>
                <c:pt idx="3">
                  <c:v>1.0310000000000001</c:v>
                </c:pt>
                <c:pt idx="4">
                  <c:v>1.1175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036-4E15-8B88-F30E99E1BD9F}"/>
            </c:ext>
          </c:extLst>
        </c:ser>
        <c:ser>
          <c:idx val="5"/>
          <c:order val="5"/>
          <c:tx>
            <c:strRef>
              <c:f>'[E. coli Vs HM results.xlsx]R3L7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40:$AA$40</c:f>
              <c:numCache>
                <c:formatCode>General</c:formatCode>
                <c:ptCount val="5"/>
                <c:pt idx="0">
                  <c:v>0.1135</c:v>
                </c:pt>
                <c:pt idx="1">
                  <c:v>0.60549999999999993</c:v>
                </c:pt>
                <c:pt idx="2">
                  <c:v>0.77700000000000002</c:v>
                </c:pt>
                <c:pt idx="3">
                  <c:v>0.86099999999999999</c:v>
                </c:pt>
                <c:pt idx="4">
                  <c:v>0.947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036-4E15-8B88-F30E99E1BD9F}"/>
            </c:ext>
          </c:extLst>
        </c:ser>
        <c:ser>
          <c:idx val="6"/>
          <c:order val="6"/>
          <c:tx>
            <c:strRef>
              <c:f>'[E. coli Vs HM results.xlsx]R3L7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41:$AA$41</c:f>
              <c:numCache>
                <c:formatCode>General</c:formatCode>
                <c:ptCount val="5"/>
                <c:pt idx="0">
                  <c:v>0.1145</c:v>
                </c:pt>
                <c:pt idx="1">
                  <c:v>0.19950000000000001</c:v>
                </c:pt>
                <c:pt idx="2">
                  <c:v>0.30599999999999999</c:v>
                </c:pt>
                <c:pt idx="3">
                  <c:v>0.48699999999999999</c:v>
                </c:pt>
                <c:pt idx="4">
                  <c:v>0.743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036-4E15-8B88-F30E99E1BD9F}"/>
            </c:ext>
          </c:extLst>
        </c:ser>
        <c:ser>
          <c:idx val="7"/>
          <c:order val="7"/>
          <c:tx>
            <c:strRef>
              <c:f>'[E. coli Vs HM results.xlsx]R3L7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7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7'!$W$42:$AA$42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14749999999999999</c:v>
                </c:pt>
                <c:pt idx="2">
                  <c:v>0.14949999999999999</c:v>
                </c:pt>
                <c:pt idx="3">
                  <c:v>0.129</c:v>
                </c:pt>
                <c:pt idx="4">
                  <c:v>0.225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036-4E15-8B88-F30E99E1B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0" dirty="0"/>
              <a:t>L1</a:t>
            </a:r>
          </a:p>
        </c:rich>
      </c:tx>
      <c:layout>
        <c:manualLayout>
          <c:xMode val="edge"/>
          <c:yMode val="edge"/>
          <c:x val="0.47869593746433869"/>
          <c:y val="4.82083901549362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452424745520358"/>
          <c:y val="0.12829263400889165"/>
          <c:w val="0.86336513141670124"/>
          <c:h val="0.695386055328009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2 '!$V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4:$AA$34</c:f>
              <c:numCache>
                <c:formatCode>General</c:formatCode>
                <c:ptCount val="5"/>
                <c:pt idx="0">
                  <c:v>0.1055</c:v>
                </c:pt>
                <c:pt idx="1">
                  <c:v>0.64200000000000002</c:v>
                </c:pt>
                <c:pt idx="2">
                  <c:v>0.80700000000000005</c:v>
                </c:pt>
                <c:pt idx="3">
                  <c:v>0.87149999999999994</c:v>
                </c:pt>
                <c:pt idx="4">
                  <c:v>0.945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2DA-4231-9E2B-3C61C31E03EE}"/>
            </c:ext>
          </c:extLst>
        </c:ser>
        <c:ser>
          <c:idx val="1"/>
          <c:order val="1"/>
          <c:tx>
            <c:strRef>
              <c:f>'[E. coli Vs HM results.xlsx]R1L2 '!$V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5:$AA$35</c:f>
              <c:numCache>
                <c:formatCode>General</c:formatCode>
                <c:ptCount val="5"/>
                <c:pt idx="0">
                  <c:v>0.10100000000000001</c:v>
                </c:pt>
                <c:pt idx="1">
                  <c:v>0.68400000000000005</c:v>
                </c:pt>
                <c:pt idx="2">
                  <c:v>0.83199999999999996</c:v>
                </c:pt>
                <c:pt idx="3">
                  <c:v>0.88949999999999996</c:v>
                </c:pt>
                <c:pt idx="4">
                  <c:v>0.980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2DA-4231-9E2B-3C61C31E03EE}"/>
            </c:ext>
          </c:extLst>
        </c:ser>
        <c:ser>
          <c:idx val="2"/>
          <c:order val="2"/>
          <c:tx>
            <c:strRef>
              <c:f>'[E. coli Vs HM results.xlsx]R1L2 '!$V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6:$AA$36</c:f>
              <c:numCache>
                <c:formatCode>General</c:formatCode>
                <c:ptCount val="5"/>
                <c:pt idx="0">
                  <c:v>0.10050000000000001</c:v>
                </c:pt>
                <c:pt idx="1">
                  <c:v>0.67</c:v>
                </c:pt>
                <c:pt idx="2">
                  <c:v>0.8254999999999999</c:v>
                </c:pt>
                <c:pt idx="3">
                  <c:v>0.89800000000000002</c:v>
                </c:pt>
                <c:pt idx="4">
                  <c:v>0.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2DA-4231-9E2B-3C61C31E03EE}"/>
            </c:ext>
          </c:extLst>
        </c:ser>
        <c:ser>
          <c:idx val="3"/>
          <c:order val="3"/>
          <c:tx>
            <c:strRef>
              <c:f>'[E. coli Vs HM results.xlsx]R1L2 '!$V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7:$AA$37</c:f>
              <c:numCache>
                <c:formatCode>General</c:formatCode>
                <c:ptCount val="5"/>
                <c:pt idx="0">
                  <c:v>0.10100000000000001</c:v>
                </c:pt>
                <c:pt idx="1">
                  <c:v>0.69599999999999995</c:v>
                </c:pt>
                <c:pt idx="2">
                  <c:v>0.84949999999999992</c:v>
                </c:pt>
                <c:pt idx="3">
                  <c:v>0.91</c:v>
                </c:pt>
                <c:pt idx="4">
                  <c:v>0.9975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12DA-4231-9E2B-3C61C31E03EE}"/>
            </c:ext>
          </c:extLst>
        </c:ser>
        <c:ser>
          <c:idx val="4"/>
          <c:order val="4"/>
          <c:tx>
            <c:strRef>
              <c:f>'[E. coli Vs HM results.xlsx]R1L2 '!$V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8:$AA$38</c:f>
              <c:numCache>
                <c:formatCode>General</c:formatCode>
                <c:ptCount val="5"/>
                <c:pt idx="0">
                  <c:v>0.10050000000000001</c:v>
                </c:pt>
                <c:pt idx="1">
                  <c:v>0.66450000000000009</c:v>
                </c:pt>
                <c:pt idx="2">
                  <c:v>0.81</c:v>
                </c:pt>
                <c:pt idx="3">
                  <c:v>0.86399999999999999</c:v>
                </c:pt>
                <c:pt idx="4">
                  <c:v>0.951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12DA-4231-9E2B-3C61C31E03EE}"/>
            </c:ext>
          </c:extLst>
        </c:ser>
        <c:ser>
          <c:idx val="5"/>
          <c:order val="5"/>
          <c:tx>
            <c:strRef>
              <c:f>'[E. coli Vs HM results.xlsx]R1L2 '!$V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39:$AA$39</c:f>
              <c:numCache>
                <c:formatCode>General</c:formatCode>
                <c:ptCount val="5"/>
                <c:pt idx="0">
                  <c:v>0.10100000000000001</c:v>
                </c:pt>
                <c:pt idx="1">
                  <c:v>0.63600000000000001</c:v>
                </c:pt>
                <c:pt idx="2">
                  <c:v>0.7995000000000001</c:v>
                </c:pt>
                <c:pt idx="3">
                  <c:v>0.82199999999999995</c:v>
                </c:pt>
                <c:pt idx="4">
                  <c:v>0.8960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12DA-4231-9E2B-3C61C31E03EE}"/>
            </c:ext>
          </c:extLst>
        </c:ser>
        <c:ser>
          <c:idx val="6"/>
          <c:order val="6"/>
          <c:tx>
            <c:strRef>
              <c:f>'[E. coli Vs HM results.xlsx]R1L2 '!$V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40:$AA$40</c:f>
              <c:numCache>
                <c:formatCode>General</c:formatCode>
                <c:ptCount val="5"/>
                <c:pt idx="0">
                  <c:v>0.104</c:v>
                </c:pt>
                <c:pt idx="1">
                  <c:v>0.1845</c:v>
                </c:pt>
                <c:pt idx="2">
                  <c:v>0.2485</c:v>
                </c:pt>
                <c:pt idx="3">
                  <c:v>0.27050000000000002</c:v>
                </c:pt>
                <c:pt idx="4">
                  <c:v>0.3514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12DA-4231-9E2B-3C61C31E03EE}"/>
            </c:ext>
          </c:extLst>
        </c:ser>
        <c:ser>
          <c:idx val="7"/>
          <c:order val="7"/>
          <c:tx>
            <c:strRef>
              <c:f>'[E. coli Vs HM results.xlsx]R1L2 '!$V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W$41:$AA$41</c:f>
              <c:numCache>
                <c:formatCode>General</c:formatCode>
                <c:ptCount val="5"/>
                <c:pt idx="0">
                  <c:v>0.1065</c:v>
                </c:pt>
                <c:pt idx="1">
                  <c:v>0.13650000000000001</c:v>
                </c:pt>
                <c:pt idx="2">
                  <c:v>0.14000000000000001</c:v>
                </c:pt>
                <c:pt idx="3">
                  <c:v>0.1255</c:v>
                </c:pt>
                <c:pt idx="4">
                  <c:v>0.2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12DA-4231-9E2B-3C61C31E03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6726527"/>
        <c:axId val="1586729407"/>
      </c:scatterChart>
      <c:valAx>
        <c:axId val="158672652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29407"/>
        <c:crosses val="autoZero"/>
        <c:crossBetween val="midCat"/>
      </c:valAx>
      <c:valAx>
        <c:axId val="1586729407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layout>
            <c:manualLayout>
              <c:xMode val="edge"/>
              <c:yMode val="edge"/>
              <c:x val="0"/>
              <c:y val="0.430011778192450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672652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4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084630282145658"/>
          <c:y val="0.12428200377121079"/>
          <c:w val="0.8018119111983355"/>
          <c:h val="0.7708077054715238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3'!$V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4:$AA$34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59149999999999991</c:v>
                </c:pt>
                <c:pt idx="2">
                  <c:v>0.76300000000000001</c:v>
                </c:pt>
                <c:pt idx="3">
                  <c:v>0.9335</c:v>
                </c:pt>
                <c:pt idx="4">
                  <c:v>1.016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BAC-4500-B22B-FCE88B1B2F05}"/>
            </c:ext>
          </c:extLst>
        </c:ser>
        <c:ser>
          <c:idx val="1"/>
          <c:order val="1"/>
          <c:tx>
            <c:strRef>
              <c:f>'[E. coli Vs HM results.xlsx]R1L3'!$V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5:$AA$35</c:f>
              <c:numCache>
                <c:formatCode>General</c:formatCode>
                <c:ptCount val="5"/>
                <c:pt idx="0">
                  <c:v>9.4500000000000001E-2</c:v>
                </c:pt>
                <c:pt idx="1">
                  <c:v>0.60050000000000003</c:v>
                </c:pt>
                <c:pt idx="2">
                  <c:v>0.79500000000000004</c:v>
                </c:pt>
                <c:pt idx="3">
                  <c:v>0.9415</c:v>
                </c:pt>
                <c:pt idx="4">
                  <c:v>1.04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BAC-4500-B22B-FCE88B1B2F05}"/>
            </c:ext>
          </c:extLst>
        </c:ser>
        <c:ser>
          <c:idx val="2"/>
          <c:order val="2"/>
          <c:tx>
            <c:strRef>
              <c:f>'[E. coli Vs HM results.xlsx]R1L3'!$V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6:$AA$36</c:f>
              <c:numCache>
                <c:formatCode>General</c:formatCode>
                <c:ptCount val="5"/>
                <c:pt idx="0">
                  <c:v>9.4500000000000001E-2</c:v>
                </c:pt>
                <c:pt idx="1">
                  <c:v>0.61250000000000004</c:v>
                </c:pt>
                <c:pt idx="2">
                  <c:v>0.8015000000000001</c:v>
                </c:pt>
                <c:pt idx="3">
                  <c:v>0.9464999999999999</c:v>
                </c:pt>
                <c:pt idx="4">
                  <c:v>1.06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BAC-4500-B22B-FCE88B1B2F05}"/>
            </c:ext>
          </c:extLst>
        </c:ser>
        <c:ser>
          <c:idx val="3"/>
          <c:order val="3"/>
          <c:tx>
            <c:strRef>
              <c:f>'[E. coli Vs HM results.xlsx]R1L3'!$V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7:$AA$37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60799999999999998</c:v>
                </c:pt>
                <c:pt idx="2">
                  <c:v>0.80900000000000005</c:v>
                </c:pt>
                <c:pt idx="3">
                  <c:v>0.9305000000000001</c:v>
                </c:pt>
                <c:pt idx="4">
                  <c:v>1.027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BAC-4500-B22B-FCE88B1B2F05}"/>
            </c:ext>
          </c:extLst>
        </c:ser>
        <c:ser>
          <c:idx val="4"/>
          <c:order val="4"/>
          <c:tx>
            <c:strRef>
              <c:f>'[E. coli Vs HM results.xlsx]R1L3'!$V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8:$AA$38</c:f>
              <c:numCache>
                <c:formatCode>General</c:formatCode>
                <c:ptCount val="5"/>
                <c:pt idx="0">
                  <c:v>9.4500000000000001E-2</c:v>
                </c:pt>
                <c:pt idx="1">
                  <c:v>0.59499999999999997</c:v>
                </c:pt>
                <c:pt idx="2">
                  <c:v>0.79150000000000009</c:v>
                </c:pt>
                <c:pt idx="3">
                  <c:v>0.89349999999999996</c:v>
                </c:pt>
                <c:pt idx="4">
                  <c:v>1.016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0BAC-4500-B22B-FCE88B1B2F05}"/>
            </c:ext>
          </c:extLst>
        </c:ser>
        <c:ser>
          <c:idx val="5"/>
          <c:order val="5"/>
          <c:tx>
            <c:strRef>
              <c:f>'[E. coli Vs HM results.xlsx]R1L3'!$V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39:$AA$39</c:f>
              <c:numCache>
                <c:formatCode>General</c:formatCode>
                <c:ptCount val="5"/>
                <c:pt idx="0">
                  <c:v>9.5500000000000002E-2</c:v>
                </c:pt>
                <c:pt idx="1">
                  <c:v>0.4385</c:v>
                </c:pt>
                <c:pt idx="2">
                  <c:v>0.61149999999999993</c:v>
                </c:pt>
                <c:pt idx="3">
                  <c:v>0.63650000000000007</c:v>
                </c:pt>
                <c:pt idx="4">
                  <c:v>0.7524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0BAC-4500-B22B-FCE88B1B2F05}"/>
            </c:ext>
          </c:extLst>
        </c:ser>
        <c:ser>
          <c:idx val="6"/>
          <c:order val="6"/>
          <c:tx>
            <c:strRef>
              <c:f>'[E. coli Vs HM results.xlsx]R1L3'!$V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40:$AA$40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13650000000000001</c:v>
                </c:pt>
                <c:pt idx="2">
                  <c:v>0.188</c:v>
                </c:pt>
                <c:pt idx="3">
                  <c:v>0.26500000000000001</c:v>
                </c:pt>
                <c:pt idx="4">
                  <c:v>0.284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0BAC-4500-B22B-FCE88B1B2F05}"/>
            </c:ext>
          </c:extLst>
        </c:ser>
        <c:ser>
          <c:idx val="7"/>
          <c:order val="7"/>
          <c:tx>
            <c:strRef>
              <c:f>'[E. coli Vs HM results.xlsx]R1L3'!$V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W$33:$AA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W$41:$AA$41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113</c:v>
                </c:pt>
                <c:pt idx="2">
                  <c:v>0.123</c:v>
                </c:pt>
                <c:pt idx="3">
                  <c:v>9.8500000000000004E-2</c:v>
                </c:pt>
                <c:pt idx="4">
                  <c:v>0.142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0BAC-4500-B22B-FCE88B1B2F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455551"/>
        <c:axId val="1784452671"/>
      </c:scatterChart>
      <c:valAx>
        <c:axId val="1784455551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4452671"/>
        <c:crosses val="autoZero"/>
        <c:crossBetween val="midCat"/>
      </c:valAx>
      <c:valAx>
        <c:axId val="1784452671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44555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2</a:t>
            </a:r>
          </a:p>
        </c:rich>
      </c:tx>
      <c:layout>
        <c:manualLayout>
          <c:xMode val="edge"/>
          <c:yMode val="edge"/>
          <c:x val="0.48897942105062953"/>
          <c:y val="2.62677824613946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433266506691779"/>
          <c:y val="0.10332077121481913"/>
          <c:w val="0.82173604321367233"/>
          <c:h val="0.7086330068444756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1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35:$AA$35</c:f>
              <c:numCache>
                <c:formatCode>General</c:formatCode>
                <c:ptCount val="5"/>
                <c:pt idx="0">
                  <c:v>0.124</c:v>
                </c:pt>
                <c:pt idx="1">
                  <c:v>0.60850000000000004</c:v>
                </c:pt>
                <c:pt idx="2">
                  <c:v>0.78600000000000003</c:v>
                </c:pt>
                <c:pt idx="3">
                  <c:v>0.91700000000000004</c:v>
                </c:pt>
                <c:pt idx="4">
                  <c:v>1.0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DEE-4CA0-AD0C-F6F3166E7A67}"/>
            </c:ext>
          </c:extLst>
        </c:ser>
        <c:ser>
          <c:idx val="1"/>
          <c:order val="1"/>
          <c:tx>
            <c:strRef>
              <c:f>'[E. coli Vs HM results.xlsx]R2L1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36:$AA$36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6765000000000001</c:v>
                </c:pt>
                <c:pt idx="2">
                  <c:v>0.84349999999999992</c:v>
                </c:pt>
                <c:pt idx="3">
                  <c:v>0.98049999999999993</c:v>
                </c:pt>
                <c:pt idx="4">
                  <c:v>1.180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DEE-4CA0-AD0C-F6F3166E7A67}"/>
            </c:ext>
          </c:extLst>
        </c:ser>
        <c:ser>
          <c:idx val="2"/>
          <c:order val="2"/>
          <c:tx>
            <c:strRef>
              <c:f>'[E. coli Vs HM results.xlsx]R2L1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37:$AA$37</c:f>
              <c:numCache>
                <c:formatCode>General</c:formatCode>
                <c:ptCount val="5"/>
                <c:pt idx="0">
                  <c:v>0.1205</c:v>
                </c:pt>
                <c:pt idx="1">
                  <c:v>0.62250000000000005</c:v>
                </c:pt>
                <c:pt idx="2">
                  <c:v>0.79849999999999999</c:v>
                </c:pt>
                <c:pt idx="3">
                  <c:v>0.96199999999999997</c:v>
                </c:pt>
                <c:pt idx="4">
                  <c:v>1.119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DEE-4CA0-AD0C-F6F3166E7A67}"/>
            </c:ext>
          </c:extLst>
        </c:ser>
        <c:ser>
          <c:idx val="3"/>
          <c:order val="3"/>
          <c:tx>
            <c:strRef>
              <c:f>'[E. coli Vs HM results.xlsx]R2L1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38:$AA$38</c:f>
              <c:numCache>
                <c:formatCode>General</c:formatCode>
                <c:ptCount val="5"/>
                <c:pt idx="0">
                  <c:v>0.11650000000000001</c:v>
                </c:pt>
                <c:pt idx="1">
                  <c:v>0.64650000000000007</c:v>
                </c:pt>
                <c:pt idx="2">
                  <c:v>0.83799999999999997</c:v>
                </c:pt>
                <c:pt idx="3">
                  <c:v>0.97750000000000004</c:v>
                </c:pt>
                <c:pt idx="4">
                  <c:v>1.1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DEE-4CA0-AD0C-F6F3166E7A67}"/>
            </c:ext>
          </c:extLst>
        </c:ser>
        <c:ser>
          <c:idx val="4"/>
          <c:order val="4"/>
          <c:tx>
            <c:strRef>
              <c:f>'[E. coli Vs HM results.xlsx]R2L1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39:$AA$39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64850000000000008</c:v>
                </c:pt>
                <c:pt idx="2">
                  <c:v>0.79350000000000009</c:v>
                </c:pt>
                <c:pt idx="3">
                  <c:v>0.90450000000000008</c:v>
                </c:pt>
                <c:pt idx="4">
                  <c:v>1.04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CDEE-4CA0-AD0C-F6F3166E7A67}"/>
            </c:ext>
          </c:extLst>
        </c:ser>
        <c:ser>
          <c:idx val="5"/>
          <c:order val="5"/>
          <c:tx>
            <c:strRef>
              <c:f>'[E. coli Vs HM results.xlsx]R2L1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40:$AA$40</c:f>
              <c:numCache>
                <c:formatCode>General</c:formatCode>
                <c:ptCount val="5"/>
                <c:pt idx="0">
                  <c:v>0.11600000000000001</c:v>
                </c:pt>
                <c:pt idx="1">
                  <c:v>0.51600000000000001</c:v>
                </c:pt>
                <c:pt idx="2">
                  <c:v>0.627</c:v>
                </c:pt>
                <c:pt idx="3">
                  <c:v>0.65700000000000003</c:v>
                </c:pt>
                <c:pt idx="4">
                  <c:v>0.7524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CDEE-4CA0-AD0C-F6F3166E7A67}"/>
            </c:ext>
          </c:extLst>
        </c:ser>
        <c:ser>
          <c:idx val="6"/>
          <c:order val="6"/>
          <c:tx>
            <c:strRef>
              <c:f>'[E. coli Vs HM results.xlsx]R2L1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41:$AA$41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16700000000000001</c:v>
                </c:pt>
                <c:pt idx="2">
                  <c:v>0.21099999999999999</c:v>
                </c:pt>
                <c:pt idx="3">
                  <c:v>0.40699999999999997</c:v>
                </c:pt>
                <c:pt idx="4">
                  <c:v>0.29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CDEE-4CA0-AD0C-F6F3166E7A67}"/>
            </c:ext>
          </c:extLst>
        </c:ser>
        <c:ser>
          <c:idx val="7"/>
          <c:order val="7"/>
          <c:tx>
            <c:strRef>
              <c:f>'[E. coli Vs HM results.xlsx]R2L1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W$42:$AA$42</c:f>
              <c:numCache>
                <c:formatCode>General</c:formatCode>
                <c:ptCount val="5"/>
                <c:pt idx="0">
                  <c:v>0.1195</c:v>
                </c:pt>
                <c:pt idx="1">
                  <c:v>0.13200000000000001</c:v>
                </c:pt>
                <c:pt idx="2">
                  <c:v>0.13900000000000001</c:v>
                </c:pt>
                <c:pt idx="3">
                  <c:v>0.112</c:v>
                </c:pt>
                <c:pt idx="4">
                  <c:v>0.172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CDEE-4CA0-AD0C-F6F3166E7A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888966144817552"/>
          <c:y val="0.13197882543769238"/>
          <c:w val="0.81568875601379942"/>
          <c:h val="0.7468043332006096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5'!$V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35:$AA$35</c:f>
              <c:numCache>
                <c:formatCode>General</c:formatCode>
                <c:ptCount val="5"/>
                <c:pt idx="0">
                  <c:v>0.1215</c:v>
                </c:pt>
                <c:pt idx="1">
                  <c:v>0.62749999999999995</c:v>
                </c:pt>
                <c:pt idx="2">
                  <c:v>0.81549999999999989</c:v>
                </c:pt>
                <c:pt idx="3">
                  <c:v>0.89749999999999996</c:v>
                </c:pt>
                <c:pt idx="4">
                  <c:v>0.952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789-41C7-B84D-6C8B2BBEBD12}"/>
            </c:ext>
          </c:extLst>
        </c:ser>
        <c:ser>
          <c:idx val="1"/>
          <c:order val="1"/>
          <c:tx>
            <c:strRef>
              <c:f>'[E. coli Vs HM results.xlsx]R3L5'!$V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36:$AA$36</c:f>
              <c:numCache>
                <c:formatCode>General</c:formatCode>
                <c:ptCount val="5"/>
                <c:pt idx="0">
                  <c:v>0.1115</c:v>
                </c:pt>
                <c:pt idx="1">
                  <c:v>0.67349999999999999</c:v>
                </c:pt>
                <c:pt idx="2">
                  <c:v>0.86650000000000005</c:v>
                </c:pt>
                <c:pt idx="3">
                  <c:v>0.94399999999999995</c:v>
                </c:pt>
                <c:pt idx="4">
                  <c:v>0.9915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789-41C7-B84D-6C8B2BBEBD12}"/>
            </c:ext>
          </c:extLst>
        </c:ser>
        <c:ser>
          <c:idx val="2"/>
          <c:order val="2"/>
          <c:tx>
            <c:strRef>
              <c:f>'[E. coli Vs HM results.xlsx]R3L5'!$V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37:$AA$37</c:f>
              <c:numCache>
                <c:formatCode>General</c:formatCode>
                <c:ptCount val="5"/>
                <c:pt idx="0">
                  <c:v>0.1105</c:v>
                </c:pt>
                <c:pt idx="1">
                  <c:v>0.66800000000000004</c:v>
                </c:pt>
                <c:pt idx="2">
                  <c:v>0.83450000000000002</c:v>
                </c:pt>
                <c:pt idx="3">
                  <c:v>0.96849999999999992</c:v>
                </c:pt>
                <c:pt idx="4">
                  <c:v>1.0154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789-41C7-B84D-6C8B2BBEBD12}"/>
            </c:ext>
          </c:extLst>
        </c:ser>
        <c:ser>
          <c:idx val="3"/>
          <c:order val="3"/>
          <c:tx>
            <c:strRef>
              <c:f>'[E. coli Vs HM results.xlsx]R3L5'!$V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38:$AA$38</c:f>
              <c:numCache>
                <c:formatCode>General</c:formatCode>
                <c:ptCount val="5"/>
                <c:pt idx="0">
                  <c:v>0.1115</c:v>
                </c:pt>
                <c:pt idx="1">
                  <c:v>0.72649999999999992</c:v>
                </c:pt>
                <c:pt idx="2">
                  <c:v>0.89949999999999997</c:v>
                </c:pt>
                <c:pt idx="3">
                  <c:v>0.98599999999999999</c:v>
                </c:pt>
                <c:pt idx="4">
                  <c:v>1.039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789-41C7-B84D-6C8B2BBEBD12}"/>
            </c:ext>
          </c:extLst>
        </c:ser>
        <c:ser>
          <c:idx val="4"/>
          <c:order val="4"/>
          <c:tx>
            <c:strRef>
              <c:f>'[E. coli Vs HM results.xlsx]R3L5'!$V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39:$AA$39</c:f>
              <c:numCache>
                <c:formatCode>General</c:formatCode>
                <c:ptCount val="5"/>
                <c:pt idx="0">
                  <c:v>0.1125</c:v>
                </c:pt>
                <c:pt idx="1">
                  <c:v>0.74249999999999994</c:v>
                </c:pt>
                <c:pt idx="2">
                  <c:v>0.90549999999999997</c:v>
                </c:pt>
                <c:pt idx="3">
                  <c:v>0.99750000000000005</c:v>
                </c:pt>
                <c:pt idx="4">
                  <c:v>1.051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789-41C7-B84D-6C8B2BBEBD12}"/>
            </c:ext>
          </c:extLst>
        </c:ser>
        <c:ser>
          <c:idx val="5"/>
          <c:order val="5"/>
          <c:tx>
            <c:strRef>
              <c:f>'[E. coli Vs HM results.xlsx]R3L5'!$V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40:$AA$40</c:f>
              <c:numCache>
                <c:formatCode>General</c:formatCode>
                <c:ptCount val="5"/>
                <c:pt idx="0">
                  <c:v>0.1135</c:v>
                </c:pt>
                <c:pt idx="1">
                  <c:v>0.67749999999999999</c:v>
                </c:pt>
                <c:pt idx="2">
                  <c:v>0.80449999999999999</c:v>
                </c:pt>
                <c:pt idx="3">
                  <c:v>0.81299999999999994</c:v>
                </c:pt>
                <c:pt idx="4">
                  <c:v>0.87549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789-41C7-B84D-6C8B2BBEBD12}"/>
            </c:ext>
          </c:extLst>
        </c:ser>
        <c:ser>
          <c:idx val="6"/>
          <c:order val="6"/>
          <c:tx>
            <c:strRef>
              <c:f>'[E. coli Vs HM results.xlsx]R3L5'!$V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41:$AA$41</c:f>
              <c:numCache>
                <c:formatCode>General</c:formatCode>
                <c:ptCount val="5"/>
                <c:pt idx="0">
                  <c:v>0.1135</c:v>
                </c:pt>
                <c:pt idx="1">
                  <c:v>0.2455</c:v>
                </c:pt>
                <c:pt idx="2">
                  <c:v>0.312</c:v>
                </c:pt>
                <c:pt idx="3">
                  <c:v>0.3135</c:v>
                </c:pt>
                <c:pt idx="4">
                  <c:v>0.4094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789-41C7-B84D-6C8B2BBEBD12}"/>
            </c:ext>
          </c:extLst>
        </c:ser>
        <c:ser>
          <c:idx val="7"/>
          <c:order val="7"/>
          <c:tx>
            <c:strRef>
              <c:f>'[E. coli Vs HM results.xlsx]R3L5'!$V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W$34:$AA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W$42:$AA$42</c:f>
              <c:numCache>
                <c:formatCode>General</c:formatCode>
                <c:ptCount val="5"/>
                <c:pt idx="0">
                  <c:v>0.1135</c:v>
                </c:pt>
                <c:pt idx="1">
                  <c:v>0.14549999999999999</c:v>
                </c:pt>
                <c:pt idx="2">
                  <c:v>0.17549999999999999</c:v>
                </c:pt>
                <c:pt idx="3">
                  <c:v>0.13100000000000001</c:v>
                </c:pt>
                <c:pt idx="4">
                  <c:v>0.15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789-41C7-B84D-6C8B2BBEBD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277375"/>
        <c:axId val="1583275455"/>
      </c:scatterChart>
      <c:valAx>
        <c:axId val="1583277375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5455"/>
        <c:crosses val="autoZero"/>
        <c:crossBetween val="midCat"/>
      </c:valAx>
      <c:valAx>
        <c:axId val="1583275455"/>
        <c:scaling>
          <c:orientation val="minMax"/>
          <c:max val="1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32773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1</a:t>
            </a:r>
          </a:p>
        </c:rich>
      </c:tx>
      <c:layout>
        <c:manualLayout>
          <c:xMode val="edge"/>
          <c:yMode val="edge"/>
          <c:x val="0.51325408985457321"/>
          <c:y val="2.95397955706588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74217186703563"/>
          <c:y val="0.14288728300024578"/>
          <c:w val="0.79895333219505138"/>
          <c:h val="0.6302829662810004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2 '!$A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4:$F$34</c:f>
              <c:numCache>
                <c:formatCode>General</c:formatCode>
                <c:ptCount val="5"/>
                <c:pt idx="0">
                  <c:v>0.1055</c:v>
                </c:pt>
                <c:pt idx="1">
                  <c:v>0.64200000000000002</c:v>
                </c:pt>
                <c:pt idx="2">
                  <c:v>0.80700000000000005</c:v>
                </c:pt>
                <c:pt idx="3">
                  <c:v>0.87149999999999994</c:v>
                </c:pt>
                <c:pt idx="4">
                  <c:v>0.9455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D84-4D57-8D7D-DA6B6574E738}"/>
            </c:ext>
          </c:extLst>
        </c:ser>
        <c:ser>
          <c:idx val="1"/>
          <c:order val="1"/>
          <c:tx>
            <c:strRef>
              <c:f>'[E. coli Vs HM results.xlsx]R1L2 '!$A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5:$F$35</c:f>
              <c:numCache>
                <c:formatCode>General</c:formatCode>
                <c:ptCount val="5"/>
                <c:pt idx="0">
                  <c:v>0.114</c:v>
                </c:pt>
                <c:pt idx="1">
                  <c:v>0.62250000000000005</c:v>
                </c:pt>
                <c:pt idx="2">
                  <c:v>0.77249999999999996</c:v>
                </c:pt>
                <c:pt idx="3">
                  <c:v>0.86099999999999999</c:v>
                </c:pt>
                <c:pt idx="4">
                  <c:v>0.950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D84-4D57-8D7D-DA6B6574E738}"/>
            </c:ext>
          </c:extLst>
        </c:ser>
        <c:ser>
          <c:idx val="2"/>
          <c:order val="2"/>
          <c:tx>
            <c:strRef>
              <c:f>'[E. coli Vs HM results.xlsx]R1L2 '!$A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6:$F$36</c:f>
              <c:numCache>
                <c:formatCode>General</c:formatCode>
                <c:ptCount val="5"/>
                <c:pt idx="0">
                  <c:v>0.1195</c:v>
                </c:pt>
                <c:pt idx="1">
                  <c:v>0.624</c:v>
                </c:pt>
                <c:pt idx="2">
                  <c:v>0.72550000000000003</c:v>
                </c:pt>
                <c:pt idx="3">
                  <c:v>0.78550000000000009</c:v>
                </c:pt>
                <c:pt idx="4">
                  <c:v>0.8605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D84-4D57-8D7D-DA6B6574E738}"/>
            </c:ext>
          </c:extLst>
        </c:ser>
        <c:ser>
          <c:idx val="3"/>
          <c:order val="3"/>
          <c:tx>
            <c:strRef>
              <c:f>'[E. coli Vs HM results.xlsx]R1L2 '!$A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7:$F$37</c:f>
              <c:numCache>
                <c:formatCode>General</c:formatCode>
                <c:ptCount val="5"/>
                <c:pt idx="0">
                  <c:v>0.11550000000000001</c:v>
                </c:pt>
                <c:pt idx="1">
                  <c:v>0.59799999999999998</c:v>
                </c:pt>
                <c:pt idx="2">
                  <c:v>0.68400000000000005</c:v>
                </c:pt>
                <c:pt idx="3">
                  <c:v>0.73150000000000004</c:v>
                </c:pt>
                <c:pt idx="4">
                  <c:v>0.832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D84-4D57-8D7D-DA6B6574E738}"/>
            </c:ext>
          </c:extLst>
        </c:ser>
        <c:ser>
          <c:idx val="4"/>
          <c:order val="4"/>
          <c:tx>
            <c:strRef>
              <c:f>'[E. coli Vs HM results.xlsx]R1L2 '!$A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8:$F$38</c:f>
              <c:numCache>
                <c:formatCode>General</c:formatCode>
                <c:ptCount val="5"/>
                <c:pt idx="0">
                  <c:v>0.1195</c:v>
                </c:pt>
                <c:pt idx="1">
                  <c:v>0.55649999999999988</c:v>
                </c:pt>
                <c:pt idx="2">
                  <c:v>0.63849999999999996</c:v>
                </c:pt>
                <c:pt idx="3">
                  <c:v>0.66649999999999998</c:v>
                </c:pt>
                <c:pt idx="4">
                  <c:v>0.776500000000000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D84-4D57-8D7D-DA6B6574E738}"/>
            </c:ext>
          </c:extLst>
        </c:ser>
        <c:ser>
          <c:idx val="5"/>
          <c:order val="5"/>
          <c:tx>
            <c:strRef>
              <c:f>'[E. coli Vs HM results.xlsx]R1L2 '!$A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39:$F$39</c:f>
              <c:numCache>
                <c:formatCode>General</c:formatCode>
                <c:ptCount val="5"/>
                <c:pt idx="0">
                  <c:v>0.11549999999999999</c:v>
                </c:pt>
                <c:pt idx="1">
                  <c:v>0.50950000000000006</c:v>
                </c:pt>
                <c:pt idx="2">
                  <c:v>0.59949999999999992</c:v>
                </c:pt>
                <c:pt idx="3">
                  <c:v>0.60899999999999999</c:v>
                </c:pt>
                <c:pt idx="4">
                  <c:v>0.730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D84-4D57-8D7D-DA6B6574E738}"/>
            </c:ext>
          </c:extLst>
        </c:ser>
        <c:ser>
          <c:idx val="6"/>
          <c:order val="6"/>
          <c:tx>
            <c:strRef>
              <c:f>'[E. coli Vs HM results.xlsx]R1L2 '!$A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40:$F$40</c:f>
              <c:numCache>
                <c:formatCode>General</c:formatCode>
                <c:ptCount val="5"/>
                <c:pt idx="0">
                  <c:v>0.11799999999999999</c:v>
                </c:pt>
                <c:pt idx="1">
                  <c:v>0.40400000000000003</c:v>
                </c:pt>
                <c:pt idx="2">
                  <c:v>0.45</c:v>
                </c:pt>
                <c:pt idx="3">
                  <c:v>0.38550000000000001</c:v>
                </c:pt>
                <c:pt idx="4">
                  <c:v>0.409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D84-4D57-8D7D-DA6B6574E738}"/>
            </c:ext>
          </c:extLst>
        </c:ser>
        <c:ser>
          <c:idx val="7"/>
          <c:order val="7"/>
          <c:tx>
            <c:strRef>
              <c:f>'[E. coli Vs HM results.xlsx]R1L2 '!$A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2 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2 '!$B$41:$F$41</c:f>
              <c:numCache>
                <c:formatCode>General</c:formatCode>
                <c:ptCount val="5"/>
                <c:pt idx="0">
                  <c:v>0.1235</c:v>
                </c:pt>
                <c:pt idx="1">
                  <c:v>0.22400000000000003</c:v>
                </c:pt>
                <c:pt idx="2">
                  <c:v>0.20700000000000002</c:v>
                </c:pt>
                <c:pt idx="3">
                  <c:v>0.1605</c:v>
                </c:pt>
                <c:pt idx="4">
                  <c:v>0.1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D84-4D57-8D7D-DA6B6574E7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3224703"/>
        <c:axId val="2113240543"/>
      </c:scatterChart>
      <c:valAx>
        <c:axId val="2113224703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3240543"/>
        <c:crosses val="autoZero"/>
        <c:crossBetween val="midCat"/>
      </c:valAx>
      <c:valAx>
        <c:axId val="2113240543"/>
        <c:scaling>
          <c:orientation val="minMax"/>
          <c:max val="1.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3224703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2</a:t>
            </a:r>
          </a:p>
        </c:rich>
      </c:tx>
      <c:layout>
        <c:manualLayout>
          <c:xMode val="edge"/>
          <c:yMode val="edge"/>
          <c:x val="0.49747703021799794"/>
          <c:y val="8.627045127158010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332906770022286"/>
          <c:y val="0.11210083932877675"/>
          <c:w val="0.80979751486349771"/>
          <c:h val="0.6625642582998847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3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35:$F$35</c:f>
              <c:numCache>
                <c:formatCode>General</c:formatCode>
                <c:ptCount val="5"/>
                <c:pt idx="0">
                  <c:v>0.1205</c:v>
                </c:pt>
                <c:pt idx="1">
                  <c:v>0.73499999999999999</c:v>
                </c:pt>
                <c:pt idx="2">
                  <c:v>0.90200000000000002</c:v>
                </c:pt>
                <c:pt idx="3">
                  <c:v>0.98750000000000004</c:v>
                </c:pt>
                <c:pt idx="4">
                  <c:v>1.08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CC6-412C-B2CF-CAA10E7C997D}"/>
            </c:ext>
          </c:extLst>
        </c:ser>
        <c:ser>
          <c:idx val="1"/>
          <c:order val="1"/>
          <c:tx>
            <c:strRef>
              <c:f>'[E. coli Vs HM results.xlsx]R3L3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36:$F$36</c:f>
              <c:numCache>
                <c:formatCode>General</c:formatCode>
                <c:ptCount val="5"/>
                <c:pt idx="0">
                  <c:v>0.121</c:v>
                </c:pt>
                <c:pt idx="1">
                  <c:v>0.66850000000000009</c:v>
                </c:pt>
                <c:pt idx="2">
                  <c:v>0.81349999999999989</c:v>
                </c:pt>
                <c:pt idx="3">
                  <c:v>0.9335</c:v>
                </c:pt>
                <c:pt idx="4">
                  <c:v>1.0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CC6-412C-B2CF-CAA10E7C997D}"/>
            </c:ext>
          </c:extLst>
        </c:ser>
        <c:ser>
          <c:idx val="2"/>
          <c:order val="2"/>
          <c:tx>
            <c:strRef>
              <c:f>'[E. coli Vs HM results.xlsx]R3L3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37:$F$37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61949999999999994</c:v>
                </c:pt>
                <c:pt idx="2">
                  <c:v>0.72899999999999998</c:v>
                </c:pt>
                <c:pt idx="3">
                  <c:v>0.84099999999999997</c:v>
                </c:pt>
                <c:pt idx="4">
                  <c:v>0.874500000000000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CC6-412C-B2CF-CAA10E7C997D}"/>
            </c:ext>
          </c:extLst>
        </c:ser>
        <c:ser>
          <c:idx val="3"/>
          <c:order val="3"/>
          <c:tx>
            <c:strRef>
              <c:f>'[E. coli Vs HM results.xlsx]R3L3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38:$F$38</c:f>
              <c:numCache>
                <c:formatCode>General</c:formatCode>
                <c:ptCount val="5"/>
                <c:pt idx="0">
                  <c:v>0.1215</c:v>
                </c:pt>
                <c:pt idx="1">
                  <c:v>0.63850000000000007</c:v>
                </c:pt>
                <c:pt idx="2">
                  <c:v>0.73</c:v>
                </c:pt>
                <c:pt idx="3">
                  <c:v>0.8</c:v>
                </c:pt>
                <c:pt idx="4">
                  <c:v>0.8445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CC6-412C-B2CF-CAA10E7C997D}"/>
            </c:ext>
          </c:extLst>
        </c:ser>
        <c:ser>
          <c:idx val="4"/>
          <c:order val="4"/>
          <c:tx>
            <c:strRef>
              <c:f>'[E. coli Vs HM results.xlsx]R3L3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39:$F$39</c:f>
              <c:numCache>
                <c:formatCode>General</c:formatCode>
                <c:ptCount val="5"/>
                <c:pt idx="0">
                  <c:v>0.1215</c:v>
                </c:pt>
                <c:pt idx="1">
                  <c:v>0.59150000000000003</c:v>
                </c:pt>
                <c:pt idx="2">
                  <c:v>0.68799999999999994</c:v>
                </c:pt>
                <c:pt idx="3">
                  <c:v>0.81399999999999995</c:v>
                </c:pt>
                <c:pt idx="4">
                  <c:v>0.842499999999999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7CC6-412C-B2CF-CAA10E7C997D}"/>
            </c:ext>
          </c:extLst>
        </c:ser>
        <c:ser>
          <c:idx val="5"/>
          <c:order val="5"/>
          <c:tx>
            <c:strRef>
              <c:f>'[E. coli Vs HM results.xlsx]R3L3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40:$F$40</c:f>
              <c:numCache>
                <c:formatCode>General</c:formatCode>
                <c:ptCount val="5"/>
                <c:pt idx="0">
                  <c:v>0.1195</c:v>
                </c:pt>
                <c:pt idx="1">
                  <c:v>0.48849999999999993</c:v>
                </c:pt>
                <c:pt idx="2">
                  <c:v>0.57099999999999995</c:v>
                </c:pt>
                <c:pt idx="3">
                  <c:v>0.76100000000000001</c:v>
                </c:pt>
                <c:pt idx="4">
                  <c:v>0.854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7CC6-412C-B2CF-CAA10E7C997D}"/>
            </c:ext>
          </c:extLst>
        </c:ser>
        <c:ser>
          <c:idx val="6"/>
          <c:order val="6"/>
          <c:tx>
            <c:strRef>
              <c:f>'[E. coli Vs HM results.xlsx]R3L3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41:$F$41</c:f>
              <c:numCache>
                <c:formatCode>General</c:formatCode>
                <c:ptCount val="5"/>
                <c:pt idx="0">
                  <c:v>0.1225</c:v>
                </c:pt>
                <c:pt idx="1">
                  <c:v>0.35950000000000004</c:v>
                </c:pt>
                <c:pt idx="2">
                  <c:v>0.39750000000000002</c:v>
                </c:pt>
                <c:pt idx="3">
                  <c:v>0.78249999999999986</c:v>
                </c:pt>
                <c:pt idx="4">
                  <c:v>0.827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7CC6-412C-B2CF-CAA10E7C997D}"/>
            </c:ext>
          </c:extLst>
        </c:ser>
        <c:ser>
          <c:idx val="7"/>
          <c:order val="7"/>
          <c:tx>
            <c:strRef>
              <c:f>'[E. coli Vs HM results.xlsx]R3L3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3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3'!$B$42:$F$42</c:f>
              <c:numCache>
                <c:formatCode>General</c:formatCode>
                <c:ptCount val="5"/>
                <c:pt idx="0">
                  <c:v>0.1235</c:v>
                </c:pt>
                <c:pt idx="1">
                  <c:v>0.1905</c:v>
                </c:pt>
                <c:pt idx="2">
                  <c:v>0.32900000000000001</c:v>
                </c:pt>
                <c:pt idx="3">
                  <c:v>0.61849999999999994</c:v>
                </c:pt>
                <c:pt idx="4">
                  <c:v>0.720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7CC6-412C-B2CF-CAA10E7C99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3</a:t>
            </a:r>
          </a:p>
        </c:rich>
      </c:tx>
      <c:layout>
        <c:manualLayout>
          <c:xMode val="edge"/>
          <c:yMode val="edge"/>
          <c:x val="0.53258211782255294"/>
          <c:y val="2.918556723357811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04159310279655"/>
          <c:y val="5.7551843160266049E-2"/>
          <c:w val="0.80619790258077162"/>
          <c:h val="0.7120160409474030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10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35:$F$35</c:f>
              <c:numCache>
                <c:formatCode>General</c:formatCode>
                <c:ptCount val="5"/>
                <c:pt idx="0">
                  <c:v>0.13150000000000001</c:v>
                </c:pt>
                <c:pt idx="1">
                  <c:v>0.69</c:v>
                </c:pt>
                <c:pt idx="2">
                  <c:v>0.84499999999999997</c:v>
                </c:pt>
                <c:pt idx="3">
                  <c:v>0.94699999999999995</c:v>
                </c:pt>
                <c:pt idx="4">
                  <c:v>1.05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5FB-42C5-AAF5-BF7E515D9E3F}"/>
            </c:ext>
          </c:extLst>
        </c:ser>
        <c:ser>
          <c:idx val="1"/>
          <c:order val="1"/>
          <c:tx>
            <c:strRef>
              <c:f>'[E. coli Vs HM results.xlsx]R3L10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36:$F$36</c:f>
              <c:numCache>
                <c:formatCode>General</c:formatCode>
                <c:ptCount val="5"/>
                <c:pt idx="0">
                  <c:v>0.1245</c:v>
                </c:pt>
                <c:pt idx="1">
                  <c:v>0.7044999999999999</c:v>
                </c:pt>
                <c:pt idx="2">
                  <c:v>0.872</c:v>
                </c:pt>
                <c:pt idx="3">
                  <c:v>0.99299999999999999</c:v>
                </c:pt>
                <c:pt idx="4">
                  <c:v>1.119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5FB-42C5-AAF5-BF7E515D9E3F}"/>
            </c:ext>
          </c:extLst>
        </c:ser>
        <c:ser>
          <c:idx val="2"/>
          <c:order val="2"/>
          <c:tx>
            <c:strRef>
              <c:f>'[E. coli Vs HM results.xlsx]R3L10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37:$F$37</c:f>
              <c:numCache>
                <c:formatCode>General</c:formatCode>
                <c:ptCount val="5"/>
                <c:pt idx="0">
                  <c:v>0.1265</c:v>
                </c:pt>
                <c:pt idx="1">
                  <c:v>0.65650000000000008</c:v>
                </c:pt>
                <c:pt idx="2">
                  <c:v>0.8234999999999999</c:v>
                </c:pt>
                <c:pt idx="3">
                  <c:v>0.96799999999999997</c:v>
                </c:pt>
                <c:pt idx="4">
                  <c:v>1.10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5FB-42C5-AAF5-BF7E515D9E3F}"/>
            </c:ext>
          </c:extLst>
        </c:ser>
        <c:ser>
          <c:idx val="3"/>
          <c:order val="3"/>
          <c:tx>
            <c:strRef>
              <c:f>'[E. coli Vs HM results.xlsx]R3L10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38:$F$38</c:f>
              <c:numCache>
                <c:formatCode>General</c:formatCode>
                <c:ptCount val="5"/>
                <c:pt idx="0">
                  <c:v>0.1305</c:v>
                </c:pt>
                <c:pt idx="1">
                  <c:v>0.69599999999999995</c:v>
                </c:pt>
                <c:pt idx="2">
                  <c:v>0.85650000000000004</c:v>
                </c:pt>
                <c:pt idx="3">
                  <c:v>1.0004999999999999</c:v>
                </c:pt>
                <c:pt idx="4">
                  <c:v>1.1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5FB-42C5-AAF5-BF7E515D9E3F}"/>
            </c:ext>
          </c:extLst>
        </c:ser>
        <c:ser>
          <c:idx val="4"/>
          <c:order val="4"/>
          <c:tx>
            <c:strRef>
              <c:f>'[E. coli Vs HM results.xlsx]R3L10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39:$F$39</c:f>
              <c:numCache>
                <c:formatCode>General</c:formatCode>
                <c:ptCount val="5"/>
                <c:pt idx="0">
                  <c:v>0.13</c:v>
                </c:pt>
                <c:pt idx="1">
                  <c:v>0.6715000000000001</c:v>
                </c:pt>
                <c:pt idx="2">
                  <c:v>0.81449999999999989</c:v>
                </c:pt>
                <c:pt idx="3">
                  <c:v>0.95850000000000002</c:v>
                </c:pt>
                <c:pt idx="4">
                  <c:v>1.1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5FB-42C5-AAF5-BF7E515D9E3F}"/>
            </c:ext>
          </c:extLst>
        </c:ser>
        <c:ser>
          <c:idx val="5"/>
          <c:order val="5"/>
          <c:tx>
            <c:strRef>
              <c:f>'[E. coli Vs HM results.xlsx]R3L10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40:$F$40</c:f>
              <c:numCache>
                <c:formatCode>General</c:formatCode>
                <c:ptCount val="5"/>
                <c:pt idx="0">
                  <c:v>0.1255</c:v>
                </c:pt>
                <c:pt idx="1">
                  <c:v>0.64200000000000002</c:v>
                </c:pt>
                <c:pt idx="2">
                  <c:v>0.78749999999999987</c:v>
                </c:pt>
                <c:pt idx="3">
                  <c:v>0.90649999999999997</c:v>
                </c:pt>
                <c:pt idx="4">
                  <c:v>1.029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5FB-42C5-AAF5-BF7E515D9E3F}"/>
            </c:ext>
          </c:extLst>
        </c:ser>
        <c:ser>
          <c:idx val="6"/>
          <c:order val="6"/>
          <c:tx>
            <c:strRef>
              <c:f>'[E. coli Vs HM results.xlsx]R3L10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41:$F$41</c:f>
              <c:numCache>
                <c:formatCode>General</c:formatCode>
                <c:ptCount val="5"/>
                <c:pt idx="0">
                  <c:v>0.1295</c:v>
                </c:pt>
                <c:pt idx="1">
                  <c:v>0.53849999999999987</c:v>
                </c:pt>
                <c:pt idx="2">
                  <c:v>0.65399999999999991</c:v>
                </c:pt>
                <c:pt idx="3">
                  <c:v>0.76849999999999996</c:v>
                </c:pt>
                <c:pt idx="4">
                  <c:v>0.92999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85FB-42C5-AAF5-BF7E515D9E3F}"/>
            </c:ext>
          </c:extLst>
        </c:ser>
        <c:ser>
          <c:idx val="7"/>
          <c:order val="7"/>
          <c:tx>
            <c:strRef>
              <c:f>'[E. coli Vs HM results.xlsx]R3L10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10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10'!$B$42:$F$42</c:f>
              <c:numCache>
                <c:formatCode>General</c:formatCode>
                <c:ptCount val="5"/>
                <c:pt idx="0">
                  <c:v>0.1285</c:v>
                </c:pt>
                <c:pt idx="1">
                  <c:v>0.4335</c:v>
                </c:pt>
                <c:pt idx="2">
                  <c:v>0.45700000000000002</c:v>
                </c:pt>
                <c:pt idx="3">
                  <c:v>0.47000000000000003</c:v>
                </c:pt>
                <c:pt idx="4">
                  <c:v>0.520499999999999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85FB-42C5-AAF5-BF7E515D9E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  <c:max val="1.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30757724079604"/>
          <c:y val="0.12686572563760043"/>
          <c:w val="0.80584493269918278"/>
          <c:h val="0.739903623959792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1L3'!$A$3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4:$F$34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59149999999999991</c:v>
                </c:pt>
                <c:pt idx="2">
                  <c:v>0.76300000000000001</c:v>
                </c:pt>
                <c:pt idx="3">
                  <c:v>0.9335</c:v>
                </c:pt>
                <c:pt idx="4">
                  <c:v>1.016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4FC-4495-8894-BE740716F658}"/>
            </c:ext>
          </c:extLst>
        </c:ser>
        <c:ser>
          <c:idx val="1"/>
          <c:order val="1"/>
          <c:tx>
            <c:strRef>
              <c:f>'[E. coli Vs HM results.xlsx]R1L3'!$A$35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5:$F$35</c:f>
              <c:numCache>
                <c:formatCode>General</c:formatCode>
                <c:ptCount val="5"/>
                <c:pt idx="0">
                  <c:v>9.6500000000000002E-2</c:v>
                </c:pt>
                <c:pt idx="1">
                  <c:v>0.59299999999999997</c:v>
                </c:pt>
                <c:pt idx="2">
                  <c:v>0.72899999999999998</c:v>
                </c:pt>
                <c:pt idx="3">
                  <c:v>0.86149999999999993</c:v>
                </c:pt>
                <c:pt idx="4">
                  <c:v>0.966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4FC-4495-8894-BE740716F658}"/>
            </c:ext>
          </c:extLst>
        </c:ser>
        <c:ser>
          <c:idx val="2"/>
          <c:order val="2"/>
          <c:tx>
            <c:strRef>
              <c:f>'[E. coli Vs HM results.xlsx]R1L3'!$A$36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6:$F$36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5734999999999999</c:v>
                </c:pt>
                <c:pt idx="2">
                  <c:v>0.73649999999999993</c:v>
                </c:pt>
                <c:pt idx="3">
                  <c:v>0.83250000000000002</c:v>
                </c:pt>
                <c:pt idx="4">
                  <c:v>0.92800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4FC-4495-8894-BE740716F658}"/>
            </c:ext>
          </c:extLst>
        </c:ser>
        <c:ser>
          <c:idx val="3"/>
          <c:order val="3"/>
          <c:tx>
            <c:strRef>
              <c:f>'[E. coli Vs HM results.xlsx]R1L3'!$A$37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7:$F$37</c:f>
              <c:numCache>
                <c:formatCode>General</c:formatCode>
                <c:ptCount val="5"/>
                <c:pt idx="0">
                  <c:v>0.10050000000000001</c:v>
                </c:pt>
                <c:pt idx="1">
                  <c:v>0.5535000000000001</c:v>
                </c:pt>
                <c:pt idx="2">
                  <c:v>0.67400000000000004</c:v>
                </c:pt>
                <c:pt idx="3">
                  <c:v>0.73849999999999993</c:v>
                </c:pt>
                <c:pt idx="4">
                  <c:v>0.8179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A4FC-4495-8894-BE740716F658}"/>
            </c:ext>
          </c:extLst>
        </c:ser>
        <c:ser>
          <c:idx val="4"/>
          <c:order val="4"/>
          <c:tx>
            <c:strRef>
              <c:f>'[E. coli Vs HM results.xlsx]R1L3'!$A$38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8:$F$38</c:f>
              <c:numCache>
                <c:formatCode>General</c:formatCode>
                <c:ptCount val="5"/>
                <c:pt idx="0">
                  <c:v>0.10049999999999999</c:v>
                </c:pt>
                <c:pt idx="1">
                  <c:v>0.46199999999999997</c:v>
                </c:pt>
                <c:pt idx="2">
                  <c:v>0.64449999999999996</c:v>
                </c:pt>
                <c:pt idx="3">
                  <c:v>0.70299999999999996</c:v>
                </c:pt>
                <c:pt idx="4">
                  <c:v>0.790500000000000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A4FC-4495-8894-BE740716F658}"/>
            </c:ext>
          </c:extLst>
        </c:ser>
        <c:ser>
          <c:idx val="5"/>
          <c:order val="5"/>
          <c:tx>
            <c:strRef>
              <c:f>'[E. coli Vs HM results.xlsx]R1L3'!$A$39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39:$F$39</c:f>
              <c:numCache>
                <c:formatCode>General</c:formatCode>
                <c:ptCount val="5"/>
                <c:pt idx="0">
                  <c:v>9.7500000000000003E-2</c:v>
                </c:pt>
                <c:pt idx="1">
                  <c:v>0.34650000000000003</c:v>
                </c:pt>
                <c:pt idx="2">
                  <c:v>0.51249999999999996</c:v>
                </c:pt>
                <c:pt idx="3">
                  <c:v>0.57250000000000001</c:v>
                </c:pt>
                <c:pt idx="4">
                  <c:v>0.757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A4FC-4495-8894-BE740716F658}"/>
            </c:ext>
          </c:extLst>
        </c:ser>
        <c:ser>
          <c:idx val="6"/>
          <c:order val="6"/>
          <c:tx>
            <c:strRef>
              <c:f>'[E. coli Vs HM results.xlsx]R1L3'!$A$40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40:$F$40</c:f>
              <c:numCache>
                <c:formatCode>General</c:formatCode>
                <c:ptCount val="5"/>
                <c:pt idx="0">
                  <c:v>9.8500000000000004E-2</c:v>
                </c:pt>
                <c:pt idx="1">
                  <c:v>0.32450000000000001</c:v>
                </c:pt>
                <c:pt idx="2">
                  <c:v>0.34350000000000003</c:v>
                </c:pt>
                <c:pt idx="3">
                  <c:v>0.26050000000000001</c:v>
                </c:pt>
                <c:pt idx="4">
                  <c:v>0.323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A4FC-4495-8894-BE740716F658}"/>
            </c:ext>
          </c:extLst>
        </c:ser>
        <c:ser>
          <c:idx val="7"/>
          <c:order val="7"/>
          <c:tx>
            <c:strRef>
              <c:f>'[E. coli Vs HM results.xlsx]R1L3'!$A$41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1L3'!$B$33:$F$33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1L3'!$B$41:$F$41</c:f>
              <c:numCache>
                <c:formatCode>General</c:formatCode>
                <c:ptCount val="5"/>
                <c:pt idx="0">
                  <c:v>9.9500000000000005E-2</c:v>
                </c:pt>
                <c:pt idx="1">
                  <c:v>0.1885</c:v>
                </c:pt>
                <c:pt idx="2">
                  <c:v>0.1535</c:v>
                </c:pt>
                <c:pt idx="3">
                  <c:v>0.1235</c:v>
                </c:pt>
                <c:pt idx="4">
                  <c:v>0.15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A4FC-4495-8894-BE740716F6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8437183"/>
        <c:axId val="1428442943"/>
      </c:scatterChart>
      <c:valAx>
        <c:axId val="1428437183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8442943"/>
        <c:crosses val="autoZero"/>
        <c:crossBetween val="midCat"/>
      </c:valAx>
      <c:valAx>
        <c:axId val="14284429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843718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315681823920721"/>
          <c:y val="0.10944710299819758"/>
          <c:w val="0.80064007062848319"/>
          <c:h val="0.660120781109471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2L1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35:$F$35</c:f>
              <c:numCache>
                <c:formatCode>General</c:formatCode>
                <c:ptCount val="5"/>
                <c:pt idx="0">
                  <c:v>0.124</c:v>
                </c:pt>
                <c:pt idx="1">
                  <c:v>0.60850000000000004</c:v>
                </c:pt>
                <c:pt idx="2">
                  <c:v>0.78600000000000003</c:v>
                </c:pt>
                <c:pt idx="3">
                  <c:v>0.91700000000000004</c:v>
                </c:pt>
                <c:pt idx="4">
                  <c:v>1.02999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569-4BF2-969D-CB4ABD763012}"/>
            </c:ext>
          </c:extLst>
        </c:ser>
        <c:ser>
          <c:idx val="1"/>
          <c:order val="1"/>
          <c:tx>
            <c:strRef>
              <c:f>'[E. coli Vs HM results.xlsx]R2L1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36:$F$36</c:f>
              <c:numCache>
                <c:formatCode>General</c:formatCode>
                <c:ptCount val="5"/>
                <c:pt idx="0">
                  <c:v>0.11849999999999999</c:v>
                </c:pt>
                <c:pt idx="1">
                  <c:v>0.63549999999999995</c:v>
                </c:pt>
                <c:pt idx="2">
                  <c:v>0.78849999999999998</c:v>
                </c:pt>
                <c:pt idx="3">
                  <c:v>0.94049999999999989</c:v>
                </c:pt>
                <c:pt idx="4">
                  <c:v>1.073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569-4BF2-969D-CB4ABD763012}"/>
            </c:ext>
          </c:extLst>
        </c:ser>
        <c:ser>
          <c:idx val="2"/>
          <c:order val="2"/>
          <c:tx>
            <c:strRef>
              <c:f>'[E. coli Vs HM results.xlsx]R2L1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37:$F$37</c:f>
              <c:numCache>
                <c:formatCode>General</c:formatCode>
                <c:ptCount val="5"/>
                <c:pt idx="0">
                  <c:v>0.14949999999999999</c:v>
                </c:pt>
                <c:pt idx="1">
                  <c:v>0.59799999999999998</c:v>
                </c:pt>
                <c:pt idx="2">
                  <c:v>0.72499999999999998</c:v>
                </c:pt>
                <c:pt idx="3">
                  <c:v>0.84499999999999997</c:v>
                </c:pt>
                <c:pt idx="4">
                  <c:v>0.9989999999999998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569-4BF2-969D-CB4ABD763012}"/>
            </c:ext>
          </c:extLst>
        </c:ser>
        <c:ser>
          <c:idx val="3"/>
          <c:order val="3"/>
          <c:tx>
            <c:strRef>
              <c:f>'[E. coli Vs HM results.xlsx]R2L1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38:$F$38</c:f>
              <c:numCache>
                <c:formatCode>General</c:formatCode>
                <c:ptCount val="5"/>
                <c:pt idx="0">
                  <c:v>0.1205</c:v>
                </c:pt>
                <c:pt idx="1">
                  <c:v>0.59850000000000003</c:v>
                </c:pt>
                <c:pt idx="2">
                  <c:v>0.71550000000000002</c:v>
                </c:pt>
                <c:pt idx="3">
                  <c:v>0.8165</c:v>
                </c:pt>
                <c:pt idx="4">
                  <c:v>1.021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569-4BF2-969D-CB4ABD763012}"/>
            </c:ext>
          </c:extLst>
        </c:ser>
        <c:ser>
          <c:idx val="4"/>
          <c:order val="4"/>
          <c:tx>
            <c:strRef>
              <c:f>'[E. coli Vs HM results.xlsx]R2L1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39:$F$39</c:f>
              <c:numCache>
                <c:formatCode>General</c:formatCode>
                <c:ptCount val="5"/>
                <c:pt idx="0">
                  <c:v>0.11749999999999999</c:v>
                </c:pt>
                <c:pt idx="1">
                  <c:v>0.50349999999999995</c:v>
                </c:pt>
                <c:pt idx="2">
                  <c:v>0.62649999999999995</c:v>
                </c:pt>
                <c:pt idx="3">
                  <c:v>0.74</c:v>
                </c:pt>
                <c:pt idx="4">
                  <c:v>0.8619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569-4BF2-969D-CB4ABD763012}"/>
            </c:ext>
          </c:extLst>
        </c:ser>
        <c:ser>
          <c:idx val="5"/>
          <c:order val="5"/>
          <c:tx>
            <c:strRef>
              <c:f>'[E. coli Vs HM results.xlsx]R2L1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40:$F$40</c:f>
              <c:numCache>
                <c:formatCode>General</c:formatCode>
                <c:ptCount val="5"/>
                <c:pt idx="0">
                  <c:v>0.11649999999999999</c:v>
                </c:pt>
                <c:pt idx="1">
                  <c:v>0.41049999999999998</c:v>
                </c:pt>
                <c:pt idx="2">
                  <c:v>0.53949999999999987</c:v>
                </c:pt>
                <c:pt idx="3">
                  <c:v>0.5754999999999999</c:v>
                </c:pt>
                <c:pt idx="4">
                  <c:v>0.783499999999999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569-4BF2-969D-CB4ABD763012}"/>
            </c:ext>
          </c:extLst>
        </c:ser>
        <c:ser>
          <c:idx val="6"/>
          <c:order val="6"/>
          <c:tx>
            <c:strRef>
              <c:f>'[E. coli Vs HM results.xlsx]R2L1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41:$F$41</c:f>
              <c:numCache>
                <c:formatCode>General</c:formatCode>
                <c:ptCount val="5"/>
                <c:pt idx="0">
                  <c:v>0.1215</c:v>
                </c:pt>
                <c:pt idx="1">
                  <c:v>0.34450000000000003</c:v>
                </c:pt>
                <c:pt idx="2">
                  <c:v>0.35150000000000003</c:v>
                </c:pt>
                <c:pt idx="3">
                  <c:v>0.26400000000000001</c:v>
                </c:pt>
                <c:pt idx="4">
                  <c:v>0.332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5569-4BF2-969D-CB4ABD763012}"/>
            </c:ext>
          </c:extLst>
        </c:ser>
        <c:ser>
          <c:idx val="7"/>
          <c:order val="7"/>
          <c:tx>
            <c:strRef>
              <c:f>'[E. coli Vs HM results.xlsx]R2L1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2L1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2L1'!$B$42:$F$42</c:f>
              <c:numCache>
                <c:formatCode>General</c:formatCode>
                <c:ptCount val="5"/>
                <c:pt idx="0">
                  <c:v>0.1225</c:v>
                </c:pt>
                <c:pt idx="1">
                  <c:v>0.21350000000000002</c:v>
                </c:pt>
                <c:pt idx="2">
                  <c:v>0.16500000000000001</c:v>
                </c:pt>
                <c:pt idx="3">
                  <c:v>0.127</c:v>
                </c:pt>
                <c:pt idx="4">
                  <c:v>0.1475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5569-4BF2-969D-CB4ABD7630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W3</a:t>
            </a:r>
          </a:p>
        </c:rich>
      </c:tx>
      <c:layout>
        <c:manualLayout>
          <c:xMode val="edge"/>
          <c:yMode val="edge"/>
          <c:x val="0.52994440044034985"/>
          <c:y val="8.781049817628548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087843240680212"/>
          <c:y val="0.11281975633579518"/>
          <c:w val="0.81291845646088823"/>
          <c:h val="0.7500810864514195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E. coli Vs HM results.xlsx]R3L5'!$A$35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35:$F$35</c:f>
              <c:numCache>
                <c:formatCode>General</c:formatCode>
                <c:ptCount val="5"/>
                <c:pt idx="0">
                  <c:v>0.1215</c:v>
                </c:pt>
                <c:pt idx="1">
                  <c:v>0.62749999999999995</c:v>
                </c:pt>
                <c:pt idx="2">
                  <c:v>0.81549999999999989</c:v>
                </c:pt>
                <c:pt idx="3">
                  <c:v>0.89749999999999996</c:v>
                </c:pt>
                <c:pt idx="4">
                  <c:v>0.952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BA0-45D9-AE1D-30BC91B514D0}"/>
            </c:ext>
          </c:extLst>
        </c:ser>
        <c:ser>
          <c:idx val="1"/>
          <c:order val="1"/>
          <c:tx>
            <c:strRef>
              <c:f>'[E. coli Vs HM results.xlsx]R3L5'!$A$36</c:f>
              <c:strCache>
                <c:ptCount val="1"/>
                <c:pt idx="0">
                  <c:v>1pp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36:$F$36</c:f>
              <c:numCache>
                <c:formatCode>General</c:formatCode>
                <c:ptCount val="5"/>
                <c:pt idx="0">
                  <c:v>0.13550000000000001</c:v>
                </c:pt>
                <c:pt idx="1">
                  <c:v>0.61650000000000005</c:v>
                </c:pt>
                <c:pt idx="2">
                  <c:v>0.70950000000000002</c:v>
                </c:pt>
                <c:pt idx="3">
                  <c:v>0.80300000000000005</c:v>
                </c:pt>
                <c:pt idx="4">
                  <c:v>0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BA0-45D9-AE1D-30BC91B514D0}"/>
            </c:ext>
          </c:extLst>
        </c:ser>
        <c:ser>
          <c:idx val="2"/>
          <c:order val="2"/>
          <c:tx>
            <c:strRef>
              <c:f>'[E. coli Vs HM results.xlsx]R3L5'!$A$37</c:f>
              <c:strCache>
                <c:ptCount val="1"/>
                <c:pt idx="0">
                  <c:v>5pp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37:$F$37</c:f>
              <c:numCache>
                <c:formatCode>General</c:formatCode>
                <c:ptCount val="5"/>
                <c:pt idx="0">
                  <c:v>0.1215</c:v>
                </c:pt>
                <c:pt idx="1">
                  <c:v>0.59450000000000003</c:v>
                </c:pt>
                <c:pt idx="2">
                  <c:v>0.68100000000000005</c:v>
                </c:pt>
                <c:pt idx="3">
                  <c:v>0.75600000000000001</c:v>
                </c:pt>
                <c:pt idx="4">
                  <c:v>0.8289999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BA0-45D9-AE1D-30BC91B514D0}"/>
            </c:ext>
          </c:extLst>
        </c:ser>
        <c:ser>
          <c:idx val="3"/>
          <c:order val="3"/>
          <c:tx>
            <c:strRef>
              <c:f>'[E. coli Vs HM results.xlsx]R3L5'!$A$38</c:f>
              <c:strCache>
                <c:ptCount val="1"/>
                <c:pt idx="0">
                  <c:v>10pp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38:$F$38</c:f>
              <c:numCache>
                <c:formatCode>General</c:formatCode>
                <c:ptCount val="5"/>
                <c:pt idx="0">
                  <c:v>0.1245</c:v>
                </c:pt>
                <c:pt idx="1">
                  <c:v>0.59349999999999992</c:v>
                </c:pt>
                <c:pt idx="2">
                  <c:v>0.64900000000000002</c:v>
                </c:pt>
                <c:pt idx="3">
                  <c:v>0.70599999999999996</c:v>
                </c:pt>
                <c:pt idx="4">
                  <c:v>0.7804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BA0-45D9-AE1D-30BC91B514D0}"/>
            </c:ext>
          </c:extLst>
        </c:ser>
        <c:ser>
          <c:idx val="4"/>
          <c:order val="4"/>
          <c:tx>
            <c:strRef>
              <c:f>'[E. coli Vs HM results.xlsx]R3L5'!$A$39</c:f>
              <c:strCache>
                <c:ptCount val="1"/>
                <c:pt idx="0">
                  <c:v>20pp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39:$F$39</c:f>
              <c:numCache>
                <c:formatCode>General</c:formatCode>
                <c:ptCount val="5"/>
                <c:pt idx="0">
                  <c:v>0.1225</c:v>
                </c:pt>
                <c:pt idx="1">
                  <c:v>0.48049999999999998</c:v>
                </c:pt>
                <c:pt idx="2">
                  <c:v>0.56499999999999995</c:v>
                </c:pt>
                <c:pt idx="3">
                  <c:v>0.66200000000000003</c:v>
                </c:pt>
                <c:pt idx="4">
                  <c:v>0.764500000000000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BA0-45D9-AE1D-30BC91B514D0}"/>
            </c:ext>
          </c:extLst>
        </c:ser>
        <c:ser>
          <c:idx val="5"/>
          <c:order val="5"/>
          <c:tx>
            <c:strRef>
              <c:f>'[E. coli Vs HM results.xlsx]R3L5'!$A$40</c:f>
              <c:strCache>
                <c:ptCount val="1"/>
                <c:pt idx="0">
                  <c:v>50pp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40:$F$40</c:f>
              <c:numCache>
                <c:formatCode>General</c:formatCode>
                <c:ptCount val="5"/>
                <c:pt idx="0">
                  <c:v>0.1235</c:v>
                </c:pt>
                <c:pt idx="1">
                  <c:v>0.35250000000000004</c:v>
                </c:pt>
                <c:pt idx="2">
                  <c:v>0.44950000000000001</c:v>
                </c:pt>
                <c:pt idx="3">
                  <c:v>0.46150000000000002</c:v>
                </c:pt>
                <c:pt idx="4">
                  <c:v>0.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BA0-45D9-AE1D-30BC91B514D0}"/>
            </c:ext>
          </c:extLst>
        </c:ser>
        <c:ser>
          <c:idx val="6"/>
          <c:order val="6"/>
          <c:tx>
            <c:strRef>
              <c:f>'[E. coli Vs HM results.xlsx]R3L5'!$A$41</c:f>
              <c:strCache>
                <c:ptCount val="1"/>
                <c:pt idx="0">
                  <c:v>70pp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41:$F$41</c:f>
              <c:numCache>
                <c:formatCode>General</c:formatCode>
                <c:ptCount val="5"/>
                <c:pt idx="0">
                  <c:v>0.1255</c:v>
                </c:pt>
                <c:pt idx="1">
                  <c:v>0.29650000000000004</c:v>
                </c:pt>
                <c:pt idx="2">
                  <c:v>0.26750000000000002</c:v>
                </c:pt>
                <c:pt idx="3">
                  <c:v>0.2205</c:v>
                </c:pt>
                <c:pt idx="4">
                  <c:v>0.283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BA0-45D9-AE1D-30BC91B514D0}"/>
            </c:ext>
          </c:extLst>
        </c:ser>
        <c:ser>
          <c:idx val="7"/>
          <c:order val="7"/>
          <c:tx>
            <c:strRef>
              <c:f>'[E. coli Vs HM results.xlsx]R3L5'!$A$42</c:f>
              <c:strCache>
                <c:ptCount val="1"/>
                <c:pt idx="0">
                  <c:v>100pp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[E. coli Vs HM results.xlsx]R3L5'!$B$34:$F$3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4</c:v>
                </c:pt>
              </c:numCache>
            </c:numRef>
          </c:xVal>
          <c:yVal>
            <c:numRef>
              <c:f>'[E. coli Vs HM results.xlsx]R3L5'!$B$42:$F$42</c:f>
              <c:numCache>
                <c:formatCode>General</c:formatCode>
                <c:ptCount val="5"/>
                <c:pt idx="0">
                  <c:v>0.1225</c:v>
                </c:pt>
                <c:pt idx="1">
                  <c:v>0.15450000000000003</c:v>
                </c:pt>
                <c:pt idx="2">
                  <c:v>0.14050000000000001</c:v>
                </c:pt>
                <c:pt idx="3">
                  <c:v>0.11400000000000002</c:v>
                </c:pt>
                <c:pt idx="4">
                  <c:v>0.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BA0-45D9-AE1D-30BC91B514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691887"/>
        <c:axId val="1685689487"/>
      </c:scatterChart>
      <c:valAx>
        <c:axId val="1685691887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89487"/>
        <c:crosses val="autoZero"/>
        <c:crossBetween val="midCat"/>
      </c:valAx>
      <c:valAx>
        <c:axId val="16856894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O.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69188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2CD1CD-0B81-4BFB-989E-BE63FA4CE4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98DEAC-C687-46FD-AF74-F313F575D0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8D4420-7F63-4811-AE4F-21D93C6D1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93AEAC-D638-40A4-B5D3-514A91B68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9B865D-C800-4738-B296-BEED943FC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377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59E19-7928-4AC3-BFBF-3BBCCF23E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52A754-2266-4894-8B58-DE4FDE190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C78039-A9E3-45E1-B7E1-FCA469639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10E0-1529-4FD5-8E54-EA4AC52CD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B6CDD-F4EE-4ECC-A795-EAF4147E3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58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46639C-CD75-4B7E-954D-A9A45762BA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F18A2F-B012-48AD-B088-F40325DDF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77A99E-B702-4047-B6FE-3B961820A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C776CB-A00F-4260-BA8B-A1A516ECD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AA0819-38E5-45FE-A195-8C414AB7E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272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9016-DD56-4B72-A667-07C7BFE87E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254133-3021-4128-87BC-6177643D9E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D1CE54-066E-4802-A4E6-E8C38E10B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904AA8-16C5-4B05-8303-B5871E376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74F00E-4620-4B70-B74C-170400435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116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51D8D-135F-4F2B-ACD2-12603BF199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335F39-1532-4727-986F-CBB88A9A3B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69B76E-400A-43EF-A45E-236AD9DA6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7C4675-7EBB-42CC-9FA4-0CC966DB0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9AE5FF-2A8D-4051-90FB-165A24CE9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038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73315-2DAE-4F2B-8B30-E176D63C1F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10C79F-3BBA-432D-8417-9D1434D19A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E8E5EC-C028-48DA-B3D0-BC8F16940C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5DAEF0-B03B-40D4-89FB-F5B9E82BE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79A56-0304-4594-AAC2-F641A350E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B2EDE6-DB8F-4898-905E-B29AF396D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09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A694B-0DC9-423C-892F-2A9B5579D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6F3630-6980-4FAB-8C4B-0B3DF845B8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A8DD81-E7B3-4A3F-94F3-919F085374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2768D2E-89EC-461D-B190-3B6AB1D43F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403BA8-F90B-4CB3-944D-1C0353B395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AAC7CF-E60C-419C-A93E-DB0E64C57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410BABE-8ED5-42F3-A78D-6B2755B30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1EA635-4DB4-4225-B1CB-BCE87E72C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470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A9A77-60F7-4936-8BE0-6D339ABFB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1143B8-A753-4BD4-B12C-834474177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58ED16-2851-483A-8EDF-63E7DC81A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3F2182-510A-427D-A0FC-8825D95AB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269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CF1024-0069-48D9-A6A9-3E3A0873E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83B2A4-1146-40C9-8FDC-8F2A6FCD1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CC6B82-9574-4AEA-B64D-04FA0A8D7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725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B8FF8-ECC6-44D3-A450-D160D2A520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CBC0E0-6515-4F53-B4D8-FD12D7AFAA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01C0D4-75C6-4657-8E28-5D817F7139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E0FD3A-BAB0-496A-8442-9A12DB752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F3C2AD-D448-4B92-BA19-AE7B88D11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219C6-1648-475C-A1A9-F6A18C8BC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835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6BDEE-A6C4-4F1B-90A6-F2FE9464B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527CC0-3A70-49A8-AD4E-C3EAAB60A4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028EE2-5BE3-4A1C-B2A6-A359BE051E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10E278-3238-425F-8372-3AF00A0CC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AC8C95-A372-4056-83EE-75714EFD8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6C1C7A-7901-4ECD-999C-67F4EF868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799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93FE9D-6A5C-4F69-B06F-A6B43276D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B4C062-C793-42EB-B14D-AE1CAF15AF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261E49-7001-4563-A0ED-7185830592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E4763-B2E5-4EBD-ADC9-B666F29B42D4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A402BB-D98E-4515-96F5-7F254DC0B9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B4BB4-45C5-4017-922A-E2F9D01C1F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F6E72-6468-4B6F-ADE5-AAA7DAB41D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293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10" Type="http://schemas.openxmlformats.org/officeDocument/2006/relationships/chart" Target="../charts/chart18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5.xml"/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10" Type="http://schemas.openxmlformats.org/officeDocument/2006/relationships/chart" Target="../charts/chart27.xml"/><Relationship Id="rId4" Type="http://schemas.openxmlformats.org/officeDocument/2006/relationships/chart" Target="../charts/chart21.xml"/><Relationship Id="rId9" Type="http://schemas.openxmlformats.org/officeDocument/2006/relationships/chart" Target="../charts/chart2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4.xml"/><Relationship Id="rId3" Type="http://schemas.openxmlformats.org/officeDocument/2006/relationships/chart" Target="../charts/chart29.xml"/><Relationship Id="rId7" Type="http://schemas.openxmlformats.org/officeDocument/2006/relationships/chart" Target="../charts/chart33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2.xml"/><Relationship Id="rId5" Type="http://schemas.openxmlformats.org/officeDocument/2006/relationships/chart" Target="../charts/chart31.xml"/><Relationship Id="rId10" Type="http://schemas.openxmlformats.org/officeDocument/2006/relationships/chart" Target="../charts/chart36.xml"/><Relationship Id="rId4" Type="http://schemas.openxmlformats.org/officeDocument/2006/relationships/chart" Target="../charts/chart30.xml"/><Relationship Id="rId9" Type="http://schemas.openxmlformats.org/officeDocument/2006/relationships/chart" Target="../charts/chart3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808386E-9544-4C19-8611-4ECA809D456F}"/>
              </a:ext>
            </a:extLst>
          </p:cNvPr>
          <p:cNvSpPr txBox="1"/>
          <p:nvPr/>
        </p:nvSpPr>
        <p:spPr>
          <a:xfrm>
            <a:off x="2226644" y="2473693"/>
            <a:ext cx="773871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 A: The behavior of the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coli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olated from water (W1, W2., W3), lettuce (L1, L2, L3), and soil (S1, S2, S3), treated with different concentrations of Cu over a period of 24 hours.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1887602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>
            <a:extLst>
              <a:ext uri="{FF2B5EF4-FFF2-40B4-BE49-F238E27FC236}">
                <a16:creationId xmlns:a16="http://schemas.microsoft.com/office/drawing/2014/main" id="{900473AA-CF91-41C7-FD9C-B40D8A493E73}"/>
              </a:ext>
            </a:extLst>
          </p:cNvPr>
          <p:cNvGrpSpPr/>
          <p:nvPr/>
        </p:nvGrpSpPr>
        <p:grpSpPr>
          <a:xfrm>
            <a:off x="-1" y="-407841"/>
            <a:ext cx="12193001" cy="7257399"/>
            <a:chOff x="-1" y="-407841"/>
            <a:chExt cx="12193001" cy="7257399"/>
          </a:xfrm>
        </p:grpSpPr>
        <p:graphicFrame>
          <p:nvGraphicFramePr>
            <p:cNvPr id="2" name="Content Placeholder 5">
              <a:extLst>
                <a:ext uri="{FF2B5EF4-FFF2-40B4-BE49-F238E27FC236}">
                  <a16:creationId xmlns:a16="http://schemas.microsoft.com/office/drawing/2014/main" id="{B3A03C94-43C2-450C-948A-CE5FAA48D91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4400957"/>
                </p:ext>
              </p:extLst>
            </p:nvPr>
          </p:nvGraphicFramePr>
          <p:xfrm>
            <a:off x="0" y="-407841"/>
            <a:ext cx="3988467" cy="28622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527B4430-F973-43B3-9886-2799B83C5B2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23880362"/>
                </p:ext>
              </p:extLst>
            </p:nvPr>
          </p:nvGraphicFramePr>
          <p:xfrm>
            <a:off x="3817018" y="0"/>
            <a:ext cx="4215865" cy="26373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ontent Placeholder 5">
              <a:extLst>
                <a:ext uri="{FF2B5EF4-FFF2-40B4-BE49-F238E27FC236}">
                  <a16:creationId xmlns:a16="http://schemas.microsoft.com/office/drawing/2014/main" id="{7E2E0133-EFC6-4B83-9BE1-290AE3AA953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18859667"/>
                </p:ext>
              </p:extLst>
            </p:nvPr>
          </p:nvGraphicFramePr>
          <p:xfrm>
            <a:off x="7805485" y="0"/>
            <a:ext cx="4387515" cy="22572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ontent Placeholder 6">
              <a:extLst>
                <a:ext uri="{FF2B5EF4-FFF2-40B4-BE49-F238E27FC236}">
                  <a16:creationId xmlns:a16="http://schemas.microsoft.com/office/drawing/2014/main" id="{6D7BB03C-B5CE-457F-9C8B-DAC51F3ABBE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4625041"/>
                </p:ext>
              </p:extLst>
            </p:nvPr>
          </p:nvGraphicFramePr>
          <p:xfrm>
            <a:off x="-1" y="2257225"/>
            <a:ext cx="3988467" cy="25025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Content Placeholder 5">
              <a:extLst>
                <a:ext uri="{FF2B5EF4-FFF2-40B4-BE49-F238E27FC236}">
                  <a16:creationId xmlns:a16="http://schemas.microsoft.com/office/drawing/2014/main" id="{8D4D887D-3291-40BB-9D49-1A5DFAA3012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64731447"/>
                </p:ext>
              </p:extLst>
            </p:nvPr>
          </p:nvGraphicFramePr>
          <p:xfrm>
            <a:off x="3789043" y="2286001"/>
            <a:ext cx="4215865" cy="25025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Content Placeholder 5">
              <a:extLst>
                <a:ext uri="{FF2B5EF4-FFF2-40B4-BE49-F238E27FC236}">
                  <a16:creationId xmlns:a16="http://schemas.microsoft.com/office/drawing/2014/main" id="{9A36E1B0-EBB5-464C-921D-B7D44C9EDC8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9471068"/>
                </p:ext>
              </p:extLst>
            </p:nvPr>
          </p:nvGraphicFramePr>
          <p:xfrm>
            <a:off x="7805484" y="2312582"/>
            <a:ext cx="4137561" cy="24472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Content Placeholder 5">
              <a:extLst>
                <a:ext uri="{FF2B5EF4-FFF2-40B4-BE49-F238E27FC236}">
                  <a16:creationId xmlns:a16="http://schemas.microsoft.com/office/drawing/2014/main" id="{D9D8FBCA-76DF-478D-8FEC-DA7C09E1C9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7158073"/>
                </p:ext>
              </p:extLst>
            </p:nvPr>
          </p:nvGraphicFramePr>
          <p:xfrm>
            <a:off x="0" y="4403558"/>
            <a:ext cx="4130039" cy="22113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Content Placeholder 5">
              <a:extLst>
                <a:ext uri="{FF2B5EF4-FFF2-40B4-BE49-F238E27FC236}">
                  <a16:creationId xmlns:a16="http://schemas.microsoft.com/office/drawing/2014/main" id="{BE8DE84C-A427-4B54-AB93-70EE9282EDD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9503448"/>
                </p:ext>
              </p:extLst>
            </p:nvPr>
          </p:nvGraphicFramePr>
          <p:xfrm>
            <a:off x="3731191" y="4402321"/>
            <a:ext cx="4277028" cy="24472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" name="Content Placeholder 6">
              <a:extLst>
                <a:ext uri="{FF2B5EF4-FFF2-40B4-BE49-F238E27FC236}">
                  <a16:creationId xmlns:a16="http://schemas.microsoft.com/office/drawing/2014/main" id="{D29714B6-7E53-456E-BFE0-C2C9277479F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29765339"/>
                </p:ext>
              </p:extLst>
            </p:nvPr>
          </p:nvGraphicFramePr>
          <p:xfrm>
            <a:off x="7805483" y="4402321"/>
            <a:ext cx="4277028" cy="21489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7C6E9903-F303-4FBB-BDAC-F54ADB226B0E}"/>
                </a:ext>
              </a:extLst>
            </p:cNvPr>
            <p:cNvSpPr/>
            <p:nvPr/>
          </p:nvSpPr>
          <p:spPr>
            <a:xfrm>
              <a:off x="1250803" y="151934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A7993EFB-89C2-437B-97F1-E6593154DE90}"/>
                </a:ext>
              </a:extLst>
            </p:cNvPr>
            <p:cNvSpPr/>
            <p:nvPr/>
          </p:nvSpPr>
          <p:spPr>
            <a:xfrm>
              <a:off x="5738409" y="383298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5CD944D8-3DE5-499D-B661-0B9B3382E7F8}"/>
                </a:ext>
              </a:extLst>
            </p:cNvPr>
            <p:cNvSpPr/>
            <p:nvPr/>
          </p:nvSpPr>
          <p:spPr>
            <a:xfrm>
              <a:off x="11666617" y="353620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C4249E7B-7AC5-4FC0-9192-63A3757E9236}"/>
                </a:ext>
              </a:extLst>
            </p:cNvPr>
            <p:cNvSpPr/>
            <p:nvPr/>
          </p:nvSpPr>
          <p:spPr>
            <a:xfrm>
              <a:off x="10412430" y="362282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DAED67C2-FA4B-407E-BE69-E137A95A3EBE}"/>
                </a:ext>
              </a:extLst>
            </p:cNvPr>
            <p:cNvSpPr/>
            <p:nvPr/>
          </p:nvSpPr>
          <p:spPr>
            <a:xfrm>
              <a:off x="1892867" y="588576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2FDFDD56-2F35-4247-B21C-2C38C9817352}"/>
                </a:ext>
              </a:extLst>
            </p:cNvPr>
            <p:cNvSpPr/>
            <p:nvPr/>
          </p:nvSpPr>
          <p:spPr>
            <a:xfrm>
              <a:off x="7712238" y="590800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624300E8-4F15-4F5F-A387-F517067D7114}"/>
                </a:ext>
              </a:extLst>
            </p:cNvPr>
            <p:cNvSpPr/>
            <p:nvPr/>
          </p:nvSpPr>
          <p:spPr>
            <a:xfrm>
              <a:off x="6454941" y="6163742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Star: 5 Points 17">
              <a:extLst>
                <a:ext uri="{FF2B5EF4-FFF2-40B4-BE49-F238E27FC236}">
                  <a16:creationId xmlns:a16="http://schemas.microsoft.com/office/drawing/2014/main" id="{A4369B8C-7CF6-4356-9808-DEC69381D3CA}"/>
                </a:ext>
              </a:extLst>
            </p:cNvPr>
            <p:cNvSpPr/>
            <p:nvPr/>
          </p:nvSpPr>
          <p:spPr>
            <a:xfrm>
              <a:off x="5756485" y="582138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Star: 5 Points 18">
              <a:extLst>
                <a:ext uri="{FF2B5EF4-FFF2-40B4-BE49-F238E27FC236}">
                  <a16:creationId xmlns:a16="http://schemas.microsoft.com/office/drawing/2014/main" id="{E98A314E-3ABE-483B-8364-21BEB54D2EFF}"/>
                </a:ext>
              </a:extLst>
            </p:cNvPr>
            <p:cNvSpPr/>
            <p:nvPr/>
          </p:nvSpPr>
          <p:spPr>
            <a:xfrm>
              <a:off x="1241659" y="397498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Star: 5 Points 19">
              <a:extLst>
                <a:ext uri="{FF2B5EF4-FFF2-40B4-BE49-F238E27FC236}">
                  <a16:creationId xmlns:a16="http://schemas.microsoft.com/office/drawing/2014/main" id="{FC5E314B-934E-47D0-B2E7-EA52471027ED}"/>
                </a:ext>
              </a:extLst>
            </p:cNvPr>
            <p:cNvSpPr/>
            <p:nvPr/>
          </p:nvSpPr>
          <p:spPr>
            <a:xfrm>
              <a:off x="6450777" y="595132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Star: 5 Points 20">
              <a:extLst>
                <a:ext uri="{FF2B5EF4-FFF2-40B4-BE49-F238E27FC236}">
                  <a16:creationId xmlns:a16="http://schemas.microsoft.com/office/drawing/2014/main" id="{5413DAEF-05AE-4AA1-B2FC-BE542CA0AAE4}"/>
                </a:ext>
              </a:extLst>
            </p:cNvPr>
            <p:cNvSpPr/>
            <p:nvPr/>
          </p:nvSpPr>
          <p:spPr>
            <a:xfrm>
              <a:off x="3829552" y="612042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F69D0641-FD29-4062-859B-F36225C540DC}"/>
                </a:ext>
              </a:extLst>
            </p:cNvPr>
            <p:cNvSpPr/>
            <p:nvPr/>
          </p:nvSpPr>
          <p:spPr>
            <a:xfrm>
              <a:off x="5061761" y="3759902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2A0457DC-E23D-497C-BF96-5276CF8FE8C5}"/>
                </a:ext>
              </a:extLst>
            </p:cNvPr>
            <p:cNvSpPr/>
            <p:nvPr/>
          </p:nvSpPr>
          <p:spPr>
            <a:xfrm>
              <a:off x="5867999" y="360992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6CCAE04C-2915-4DA5-AD88-B32581CBD689}"/>
                </a:ext>
              </a:extLst>
            </p:cNvPr>
            <p:cNvSpPr/>
            <p:nvPr/>
          </p:nvSpPr>
          <p:spPr>
            <a:xfrm>
              <a:off x="1915326" y="399929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006517E0-37EC-49DD-98A0-7E3446A23960}"/>
                </a:ext>
              </a:extLst>
            </p:cNvPr>
            <p:cNvSpPr/>
            <p:nvPr/>
          </p:nvSpPr>
          <p:spPr>
            <a:xfrm>
              <a:off x="5039853" y="5864694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tar: 5 Points 27">
              <a:extLst>
                <a:ext uri="{FF2B5EF4-FFF2-40B4-BE49-F238E27FC236}">
                  <a16:creationId xmlns:a16="http://schemas.microsoft.com/office/drawing/2014/main" id="{10E26CBD-43AB-4354-A608-DCA481B1A090}"/>
                </a:ext>
              </a:extLst>
            </p:cNvPr>
            <p:cNvSpPr/>
            <p:nvPr/>
          </p:nvSpPr>
          <p:spPr>
            <a:xfrm>
              <a:off x="3817018" y="589904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tar: 5 Points 28">
              <a:extLst>
                <a:ext uri="{FF2B5EF4-FFF2-40B4-BE49-F238E27FC236}">
                  <a16:creationId xmlns:a16="http://schemas.microsoft.com/office/drawing/2014/main" id="{8CE2770D-C876-4FF3-B006-EA8E2DE561AD}"/>
                </a:ext>
              </a:extLst>
            </p:cNvPr>
            <p:cNvSpPr/>
            <p:nvPr/>
          </p:nvSpPr>
          <p:spPr>
            <a:xfrm>
              <a:off x="3771028" y="1601353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Star: 5 Points 29">
              <a:extLst>
                <a:ext uri="{FF2B5EF4-FFF2-40B4-BE49-F238E27FC236}">
                  <a16:creationId xmlns:a16="http://schemas.microsoft.com/office/drawing/2014/main" id="{8CD677E3-E33D-416A-A1D4-4BD3C54A952D}"/>
                </a:ext>
              </a:extLst>
            </p:cNvPr>
            <p:cNvSpPr/>
            <p:nvPr/>
          </p:nvSpPr>
          <p:spPr>
            <a:xfrm>
              <a:off x="2585203" y="617989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Star: 5 Points 30">
              <a:extLst>
                <a:ext uri="{FF2B5EF4-FFF2-40B4-BE49-F238E27FC236}">
                  <a16:creationId xmlns:a16="http://schemas.microsoft.com/office/drawing/2014/main" id="{8EAC28D4-50AA-4C30-B072-E4FE7EABD2BD}"/>
                </a:ext>
              </a:extLst>
            </p:cNvPr>
            <p:cNvSpPr/>
            <p:nvPr/>
          </p:nvSpPr>
          <p:spPr>
            <a:xfrm>
              <a:off x="9729031" y="3579513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Star: 5 Points 31">
              <a:extLst>
                <a:ext uri="{FF2B5EF4-FFF2-40B4-BE49-F238E27FC236}">
                  <a16:creationId xmlns:a16="http://schemas.microsoft.com/office/drawing/2014/main" id="{A993A0DD-7C23-49F6-ADD4-F88975171C42}"/>
                </a:ext>
              </a:extLst>
            </p:cNvPr>
            <p:cNvSpPr/>
            <p:nvPr/>
          </p:nvSpPr>
          <p:spPr>
            <a:xfrm>
              <a:off x="2661382" y="599048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Star: 5 Points 32">
              <a:extLst>
                <a:ext uri="{FF2B5EF4-FFF2-40B4-BE49-F238E27FC236}">
                  <a16:creationId xmlns:a16="http://schemas.microsoft.com/office/drawing/2014/main" id="{7C92F475-3629-4746-8B39-49C0D58B6867}"/>
                </a:ext>
              </a:extLst>
            </p:cNvPr>
            <p:cNvSpPr/>
            <p:nvPr/>
          </p:nvSpPr>
          <p:spPr>
            <a:xfrm>
              <a:off x="9045632" y="363538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Star: 5 Points 33">
              <a:extLst>
                <a:ext uri="{FF2B5EF4-FFF2-40B4-BE49-F238E27FC236}">
                  <a16:creationId xmlns:a16="http://schemas.microsoft.com/office/drawing/2014/main" id="{97367327-3AC1-475D-B3E3-6B47FEBA5828}"/>
                </a:ext>
              </a:extLst>
            </p:cNvPr>
            <p:cNvSpPr/>
            <p:nvPr/>
          </p:nvSpPr>
          <p:spPr>
            <a:xfrm>
              <a:off x="5790026" y="180991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Star: 5 Points 34">
              <a:extLst>
                <a:ext uri="{FF2B5EF4-FFF2-40B4-BE49-F238E27FC236}">
                  <a16:creationId xmlns:a16="http://schemas.microsoft.com/office/drawing/2014/main" id="{EE41AB95-5545-4156-90E1-52609438B501}"/>
                </a:ext>
              </a:extLst>
            </p:cNvPr>
            <p:cNvSpPr/>
            <p:nvPr/>
          </p:nvSpPr>
          <p:spPr>
            <a:xfrm>
              <a:off x="7691889" y="330786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Star: 5 Points 35">
              <a:extLst>
                <a:ext uri="{FF2B5EF4-FFF2-40B4-BE49-F238E27FC236}">
                  <a16:creationId xmlns:a16="http://schemas.microsoft.com/office/drawing/2014/main" id="{76D50A4B-4593-49DF-A6C6-B00A100B9192}"/>
                </a:ext>
              </a:extLst>
            </p:cNvPr>
            <p:cNvSpPr/>
            <p:nvPr/>
          </p:nvSpPr>
          <p:spPr>
            <a:xfrm>
              <a:off x="6460103" y="3504084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Star: 5 Points 36">
              <a:extLst>
                <a:ext uri="{FF2B5EF4-FFF2-40B4-BE49-F238E27FC236}">
                  <a16:creationId xmlns:a16="http://schemas.microsoft.com/office/drawing/2014/main" id="{27EE103F-AE89-4915-8150-0152C3747F83}"/>
                </a:ext>
              </a:extLst>
            </p:cNvPr>
            <p:cNvSpPr/>
            <p:nvPr/>
          </p:nvSpPr>
          <p:spPr>
            <a:xfrm>
              <a:off x="3768349" y="115537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Star: 5 Points 37">
              <a:extLst>
                <a:ext uri="{FF2B5EF4-FFF2-40B4-BE49-F238E27FC236}">
                  <a16:creationId xmlns:a16="http://schemas.microsoft.com/office/drawing/2014/main" id="{D9438360-1CEE-41A7-89C9-165A9E3CE920}"/>
                </a:ext>
              </a:extLst>
            </p:cNvPr>
            <p:cNvSpPr/>
            <p:nvPr/>
          </p:nvSpPr>
          <p:spPr>
            <a:xfrm>
              <a:off x="2575467" y="127427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Star: 5 Points 38">
              <a:extLst>
                <a:ext uri="{FF2B5EF4-FFF2-40B4-BE49-F238E27FC236}">
                  <a16:creationId xmlns:a16="http://schemas.microsoft.com/office/drawing/2014/main" id="{C90A9254-C6C5-4A94-9173-6F0FF6EF737E}"/>
                </a:ext>
              </a:extLst>
            </p:cNvPr>
            <p:cNvSpPr/>
            <p:nvPr/>
          </p:nvSpPr>
          <p:spPr>
            <a:xfrm>
              <a:off x="11833960" y="611341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Star: 5 Points 39">
              <a:extLst>
                <a:ext uri="{FF2B5EF4-FFF2-40B4-BE49-F238E27FC236}">
                  <a16:creationId xmlns:a16="http://schemas.microsoft.com/office/drawing/2014/main" id="{51F44403-469B-4C97-8647-7322239898E7}"/>
                </a:ext>
              </a:extLst>
            </p:cNvPr>
            <p:cNvSpPr/>
            <p:nvPr/>
          </p:nvSpPr>
          <p:spPr>
            <a:xfrm>
              <a:off x="1241659" y="614300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Star: 5 Points 40">
              <a:extLst>
                <a:ext uri="{FF2B5EF4-FFF2-40B4-BE49-F238E27FC236}">
                  <a16:creationId xmlns:a16="http://schemas.microsoft.com/office/drawing/2014/main" id="{A32FAB2F-7FFE-488D-82A3-3FF08053F26F}"/>
                </a:ext>
              </a:extLst>
            </p:cNvPr>
            <p:cNvSpPr/>
            <p:nvPr/>
          </p:nvSpPr>
          <p:spPr>
            <a:xfrm>
              <a:off x="7733598" y="614300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Star: 5 Points 41">
              <a:extLst>
                <a:ext uri="{FF2B5EF4-FFF2-40B4-BE49-F238E27FC236}">
                  <a16:creationId xmlns:a16="http://schemas.microsoft.com/office/drawing/2014/main" id="{40D678F8-6AC2-4D2E-A855-7B149967D6AF}"/>
                </a:ext>
              </a:extLst>
            </p:cNvPr>
            <p:cNvSpPr/>
            <p:nvPr/>
          </p:nvSpPr>
          <p:spPr>
            <a:xfrm>
              <a:off x="1905674" y="6163742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Star: 5 Points 42">
              <a:extLst>
                <a:ext uri="{FF2B5EF4-FFF2-40B4-BE49-F238E27FC236}">
                  <a16:creationId xmlns:a16="http://schemas.microsoft.com/office/drawing/2014/main" id="{0CDA4F6C-2D94-4294-9F6F-1977C1AF24B6}"/>
                </a:ext>
              </a:extLst>
            </p:cNvPr>
            <p:cNvSpPr/>
            <p:nvPr/>
          </p:nvSpPr>
          <p:spPr>
            <a:xfrm>
              <a:off x="5725776" y="612042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Star: 5 Points 43">
              <a:extLst>
                <a:ext uri="{FF2B5EF4-FFF2-40B4-BE49-F238E27FC236}">
                  <a16:creationId xmlns:a16="http://schemas.microsoft.com/office/drawing/2014/main" id="{10F031DE-F540-4AC7-BEFA-7EEBC8BC3580}"/>
                </a:ext>
              </a:extLst>
            </p:cNvPr>
            <p:cNvSpPr/>
            <p:nvPr/>
          </p:nvSpPr>
          <p:spPr>
            <a:xfrm>
              <a:off x="11790145" y="590800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Star: 5 Points 44">
              <a:extLst>
                <a:ext uri="{FF2B5EF4-FFF2-40B4-BE49-F238E27FC236}">
                  <a16:creationId xmlns:a16="http://schemas.microsoft.com/office/drawing/2014/main" id="{53E0C20A-CEBD-4035-BE87-5C05AA99B7C7}"/>
                </a:ext>
              </a:extLst>
            </p:cNvPr>
            <p:cNvSpPr/>
            <p:nvPr/>
          </p:nvSpPr>
          <p:spPr>
            <a:xfrm>
              <a:off x="5061761" y="6077115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Star: 5 Points 45">
              <a:extLst>
                <a:ext uri="{FF2B5EF4-FFF2-40B4-BE49-F238E27FC236}">
                  <a16:creationId xmlns:a16="http://schemas.microsoft.com/office/drawing/2014/main" id="{5FCAE949-AE60-4574-A8A4-B6535D996D58}"/>
                </a:ext>
              </a:extLst>
            </p:cNvPr>
            <p:cNvSpPr/>
            <p:nvPr/>
          </p:nvSpPr>
          <p:spPr>
            <a:xfrm>
              <a:off x="5039853" y="403779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Star: 5 Points 46">
              <a:extLst>
                <a:ext uri="{FF2B5EF4-FFF2-40B4-BE49-F238E27FC236}">
                  <a16:creationId xmlns:a16="http://schemas.microsoft.com/office/drawing/2014/main" id="{B56BC5CD-87DE-490E-B402-E8B90136D6E3}"/>
                </a:ext>
              </a:extLst>
            </p:cNvPr>
            <p:cNvSpPr/>
            <p:nvPr/>
          </p:nvSpPr>
          <p:spPr>
            <a:xfrm>
              <a:off x="10531141" y="5976347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Star: 5 Points 47">
              <a:extLst>
                <a:ext uri="{FF2B5EF4-FFF2-40B4-BE49-F238E27FC236}">
                  <a16:creationId xmlns:a16="http://schemas.microsoft.com/office/drawing/2014/main" id="{774C0575-AF73-41B2-A1F1-007E20A96C6A}"/>
                </a:ext>
              </a:extLst>
            </p:cNvPr>
            <p:cNvSpPr/>
            <p:nvPr/>
          </p:nvSpPr>
          <p:spPr>
            <a:xfrm>
              <a:off x="1907124" y="1599235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Star: 5 Points 48">
              <a:extLst>
                <a:ext uri="{FF2B5EF4-FFF2-40B4-BE49-F238E27FC236}">
                  <a16:creationId xmlns:a16="http://schemas.microsoft.com/office/drawing/2014/main" id="{A18D5E67-949E-46A0-BFDC-DCFFFD3A307B}"/>
                </a:ext>
              </a:extLst>
            </p:cNvPr>
            <p:cNvSpPr/>
            <p:nvPr/>
          </p:nvSpPr>
          <p:spPr>
            <a:xfrm>
              <a:off x="2582205" y="169500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Star: 5 Points 49">
              <a:extLst>
                <a:ext uri="{FF2B5EF4-FFF2-40B4-BE49-F238E27FC236}">
                  <a16:creationId xmlns:a16="http://schemas.microsoft.com/office/drawing/2014/main" id="{C91B16F2-A367-468F-A98C-6A104F41011A}"/>
                </a:ext>
              </a:extLst>
            </p:cNvPr>
            <p:cNvSpPr/>
            <p:nvPr/>
          </p:nvSpPr>
          <p:spPr>
            <a:xfrm>
              <a:off x="9778012" y="590800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Star: 5 Points 50">
              <a:extLst>
                <a:ext uri="{FF2B5EF4-FFF2-40B4-BE49-F238E27FC236}">
                  <a16:creationId xmlns:a16="http://schemas.microsoft.com/office/drawing/2014/main" id="{3E3D50EC-08AB-4C8D-BB08-0AECCC935273}"/>
                </a:ext>
              </a:extLst>
            </p:cNvPr>
            <p:cNvSpPr/>
            <p:nvPr/>
          </p:nvSpPr>
          <p:spPr>
            <a:xfrm>
              <a:off x="10531141" y="615459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Star: 5 Points 51">
              <a:extLst>
                <a:ext uri="{FF2B5EF4-FFF2-40B4-BE49-F238E27FC236}">
                  <a16:creationId xmlns:a16="http://schemas.microsoft.com/office/drawing/2014/main" id="{F5CF0EFB-57BB-40B7-B502-1D5C6BD22F65}"/>
                </a:ext>
              </a:extLst>
            </p:cNvPr>
            <p:cNvSpPr/>
            <p:nvPr/>
          </p:nvSpPr>
          <p:spPr>
            <a:xfrm>
              <a:off x="9078028" y="590800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Star: 5 Points 52">
              <a:extLst>
                <a:ext uri="{FF2B5EF4-FFF2-40B4-BE49-F238E27FC236}">
                  <a16:creationId xmlns:a16="http://schemas.microsoft.com/office/drawing/2014/main" id="{E902B292-0DFE-4CED-9835-E41D752B3379}"/>
                </a:ext>
              </a:extLst>
            </p:cNvPr>
            <p:cNvSpPr/>
            <p:nvPr/>
          </p:nvSpPr>
          <p:spPr>
            <a:xfrm>
              <a:off x="9778012" y="612042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Star: 5 Points 53">
              <a:extLst>
                <a:ext uri="{FF2B5EF4-FFF2-40B4-BE49-F238E27FC236}">
                  <a16:creationId xmlns:a16="http://schemas.microsoft.com/office/drawing/2014/main" id="{F7393B63-4ABA-4303-8CFE-EB603D0A1CC1}"/>
                </a:ext>
              </a:extLst>
            </p:cNvPr>
            <p:cNvSpPr/>
            <p:nvPr/>
          </p:nvSpPr>
          <p:spPr>
            <a:xfrm>
              <a:off x="9076023" y="612043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Star: 5 Points 54">
              <a:extLst>
                <a:ext uri="{FF2B5EF4-FFF2-40B4-BE49-F238E27FC236}">
                  <a16:creationId xmlns:a16="http://schemas.microsoft.com/office/drawing/2014/main" id="{40DFC5AA-D3E2-4898-8FCF-99541755C850}"/>
                </a:ext>
              </a:extLst>
            </p:cNvPr>
            <p:cNvSpPr/>
            <p:nvPr/>
          </p:nvSpPr>
          <p:spPr>
            <a:xfrm>
              <a:off x="5799170" y="157487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Star: 5 Points 55">
              <a:extLst>
                <a:ext uri="{FF2B5EF4-FFF2-40B4-BE49-F238E27FC236}">
                  <a16:creationId xmlns:a16="http://schemas.microsoft.com/office/drawing/2014/main" id="{0A7E6EE3-A7A7-43F7-B07B-530A048B3804}"/>
                </a:ext>
              </a:extLst>
            </p:cNvPr>
            <p:cNvSpPr/>
            <p:nvPr/>
          </p:nvSpPr>
          <p:spPr>
            <a:xfrm>
              <a:off x="5080049" y="149498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Star: 5 Points 56">
              <a:extLst>
                <a:ext uri="{FF2B5EF4-FFF2-40B4-BE49-F238E27FC236}">
                  <a16:creationId xmlns:a16="http://schemas.microsoft.com/office/drawing/2014/main" id="{537EA97F-1406-43CE-80BA-CE77BD624C3F}"/>
                </a:ext>
              </a:extLst>
            </p:cNvPr>
            <p:cNvSpPr/>
            <p:nvPr/>
          </p:nvSpPr>
          <p:spPr>
            <a:xfrm>
              <a:off x="3741817" y="400653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Star: 5 Points 57">
              <a:extLst>
                <a:ext uri="{FF2B5EF4-FFF2-40B4-BE49-F238E27FC236}">
                  <a16:creationId xmlns:a16="http://schemas.microsoft.com/office/drawing/2014/main" id="{2CB99408-E97F-441A-AF0A-4C162572E6AB}"/>
                </a:ext>
              </a:extLst>
            </p:cNvPr>
            <p:cNvSpPr/>
            <p:nvPr/>
          </p:nvSpPr>
          <p:spPr>
            <a:xfrm>
              <a:off x="5076429" y="177883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Star: 5 Points 58">
              <a:extLst>
                <a:ext uri="{FF2B5EF4-FFF2-40B4-BE49-F238E27FC236}">
                  <a16:creationId xmlns:a16="http://schemas.microsoft.com/office/drawing/2014/main" id="{40EE31AD-34C3-4A17-BB53-C7B43E8A7EF1}"/>
                </a:ext>
              </a:extLst>
            </p:cNvPr>
            <p:cNvSpPr/>
            <p:nvPr/>
          </p:nvSpPr>
          <p:spPr>
            <a:xfrm>
              <a:off x="3789042" y="375463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Star: 5 Points 59">
              <a:extLst>
                <a:ext uri="{FF2B5EF4-FFF2-40B4-BE49-F238E27FC236}">
                  <a16:creationId xmlns:a16="http://schemas.microsoft.com/office/drawing/2014/main" id="{52CE5836-8ECD-45C5-8F95-0952B37452A4}"/>
                </a:ext>
              </a:extLst>
            </p:cNvPr>
            <p:cNvSpPr/>
            <p:nvPr/>
          </p:nvSpPr>
          <p:spPr>
            <a:xfrm>
              <a:off x="2565130" y="406160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Star: 5 Points 60">
              <a:extLst>
                <a:ext uri="{FF2B5EF4-FFF2-40B4-BE49-F238E27FC236}">
                  <a16:creationId xmlns:a16="http://schemas.microsoft.com/office/drawing/2014/main" id="{5B90260A-0937-423B-8199-18CF87C17640}"/>
                </a:ext>
              </a:extLst>
            </p:cNvPr>
            <p:cNvSpPr/>
            <p:nvPr/>
          </p:nvSpPr>
          <p:spPr>
            <a:xfrm>
              <a:off x="2585203" y="378524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Star: 5 Points 61">
              <a:extLst>
                <a:ext uri="{FF2B5EF4-FFF2-40B4-BE49-F238E27FC236}">
                  <a16:creationId xmlns:a16="http://schemas.microsoft.com/office/drawing/2014/main" id="{F0D64F0D-4695-4A1E-A094-0D9C034DD2CB}"/>
                </a:ext>
              </a:extLst>
            </p:cNvPr>
            <p:cNvSpPr/>
            <p:nvPr/>
          </p:nvSpPr>
          <p:spPr>
            <a:xfrm>
              <a:off x="9855669" y="1787288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Star: 5 Points 62">
              <a:extLst>
                <a:ext uri="{FF2B5EF4-FFF2-40B4-BE49-F238E27FC236}">
                  <a16:creationId xmlns:a16="http://schemas.microsoft.com/office/drawing/2014/main" id="{02FB52E1-C051-4191-933B-BA1BFCB095E3}"/>
                </a:ext>
              </a:extLst>
            </p:cNvPr>
            <p:cNvSpPr/>
            <p:nvPr/>
          </p:nvSpPr>
          <p:spPr>
            <a:xfrm>
              <a:off x="9099659" y="170066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Star: 5 Points 63">
              <a:extLst>
                <a:ext uri="{FF2B5EF4-FFF2-40B4-BE49-F238E27FC236}">
                  <a16:creationId xmlns:a16="http://schemas.microsoft.com/office/drawing/2014/main" id="{E2CDB316-F027-456F-A8CB-167C8729C67C}"/>
                </a:ext>
              </a:extLst>
            </p:cNvPr>
            <p:cNvSpPr/>
            <p:nvPr/>
          </p:nvSpPr>
          <p:spPr>
            <a:xfrm>
              <a:off x="7790827" y="1876195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Star: 5 Points 64">
              <a:extLst>
                <a:ext uri="{FF2B5EF4-FFF2-40B4-BE49-F238E27FC236}">
                  <a16:creationId xmlns:a16="http://schemas.microsoft.com/office/drawing/2014/main" id="{909B96B3-1AA3-49A3-B170-97BFF8E2FD07}"/>
                </a:ext>
              </a:extLst>
            </p:cNvPr>
            <p:cNvSpPr/>
            <p:nvPr/>
          </p:nvSpPr>
          <p:spPr>
            <a:xfrm>
              <a:off x="7785094" y="1579024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Star: 5 Points 65">
              <a:extLst>
                <a:ext uri="{FF2B5EF4-FFF2-40B4-BE49-F238E27FC236}">
                  <a16:creationId xmlns:a16="http://schemas.microsoft.com/office/drawing/2014/main" id="{D5FC1E26-48DF-432C-B8BC-AD592777A110}"/>
                </a:ext>
              </a:extLst>
            </p:cNvPr>
            <p:cNvSpPr/>
            <p:nvPr/>
          </p:nvSpPr>
          <p:spPr>
            <a:xfrm>
              <a:off x="6506664" y="1956503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Star: 5 Points 66">
              <a:extLst>
                <a:ext uri="{FF2B5EF4-FFF2-40B4-BE49-F238E27FC236}">
                  <a16:creationId xmlns:a16="http://schemas.microsoft.com/office/drawing/2014/main" id="{E0829D55-3417-4A60-9F20-3E1805F4CB24}"/>
                </a:ext>
              </a:extLst>
            </p:cNvPr>
            <p:cNvSpPr/>
            <p:nvPr/>
          </p:nvSpPr>
          <p:spPr>
            <a:xfrm>
              <a:off x="6505608" y="1698362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Star: 5 Points 67">
              <a:extLst>
                <a:ext uri="{FF2B5EF4-FFF2-40B4-BE49-F238E27FC236}">
                  <a16:creationId xmlns:a16="http://schemas.microsoft.com/office/drawing/2014/main" id="{00B5D24D-438B-4DDF-8DBF-EF5DF5484D04}"/>
                </a:ext>
              </a:extLst>
            </p:cNvPr>
            <p:cNvSpPr/>
            <p:nvPr/>
          </p:nvSpPr>
          <p:spPr>
            <a:xfrm>
              <a:off x="11901335" y="1768505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Star: 5 Points 68">
              <a:extLst>
                <a:ext uri="{FF2B5EF4-FFF2-40B4-BE49-F238E27FC236}">
                  <a16:creationId xmlns:a16="http://schemas.microsoft.com/office/drawing/2014/main" id="{052EBDF6-CBCA-4A5F-B140-FF0D66EB250B}"/>
                </a:ext>
              </a:extLst>
            </p:cNvPr>
            <p:cNvSpPr/>
            <p:nvPr/>
          </p:nvSpPr>
          <p:spPr>
            <a:xfrm>
              <a:off x="11894919" y="1404914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Star: 5 Points 69">
              <a:extLst>
                <a:ext uri="{FF2B5EF4-FFF2-40B4-BE49-F238E27FC236}">
                  <a16:creationId xmlns:a16="http://schemas.microsoft.com/office/drawing/2014/main" id="{16348884-B01C-42AF-96BE-7DC8E322DCB3}"/>
                </a:ext>
              </a:extLst>
            </p:cNvPr>
            <p:cNvSpPr/>
            <p:nvPr/>
          </p:nvSpPr>
          <p:spPr>
            <a:xfrm>
              <a:off x="10562424" y="149154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Star: 5 Points 70">
              <a:extLst>
                <a:ext uri="{FF2B5EF4-FFF2-40B4-BE49-F238E27FC236}">
                  <a16:creationId xmlns:a16="http://schemas.microsoft.com/office/drawing/2014/main" id="{15B03DAD-A685-4703-ADEB-4495CB813C3D}"/>
                </a:ext>
              </a:extLst>
            </p:cNvPr>
            <p:cNvSpPr/>
            <p:nvPr/>
          </p:nvSpPr>
          <p:spPr>
            <a:xfrm>
              <a:off x="9820579" y="142369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Star: 5 Points 71">
              <a:extLst>
                <a:ext uri="{FF2B5EF4-FFF2-40B4-BE49-F238E27FC236}">
                  <a16:creationId xmlns:a16="http://schemas.microsoft.com/office/drawing/2014/main" id="{A2F563C3-D05D-474B-9D61-14FD22FA83EC}"/>
                </a:ext>
              </a:extLst>
            </p:cNvPr>
            <p:cNvSpPr/>
            <p:nvPr/>
          </p:nvSpPr>
          <p:spPr>
            <a:xfrm>
              <a:off x="10563553" y="181181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Star: 5 Points 75">
              <a:extLst>
                <a:ext uri="{FF2B5EF4-FFF2-40B4-BE49-F238E27FC236}">
                  <a16:creationId xmlns:a16="http://schemas.microsoft.com/office/drawing/2014/main" id="{D821DAC9-3325-4E1E-94A5-699A73562D98}"/>
                </a:ext>
              </a:extLst>
            </p:cNvPr>
            <p:cNvSpPr/>
            <p:nvPr/>
          </p:nvSpPr>
          <p:spPr>
            <a:xfrm>
              <a:off x="11841739" y="549599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Star: 5 Points 76">
              <a:extLst>
                <a:ext uri="{FF2B5EF4-FFF2-40B4-BE49-F238E27FC236}">
                  <a16:creationId xmlns:a16="http://schemas.microsoft.com/office/drawing/2014/main" id="{F5FE569C-F16C-451E-A8A4-54AC7D2C60FD}"/>
                </a:ext>
              </a:extLst>
            </p:cNvPr>
            <p:cNvSpPr/>
            <p:nvPr/>
          </p:nvSpPr>
          <p:spPr>
            <a:xfrm>
              <a:off x="5074905" y="3581314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Star: 5 Points 78">
              <a:extLst>
                <a:ext uri="{FF2B5EF4-FFF2-40B4-BE49-F238E27FC236}">
                  <a16:creationId xmlns:a16="http://schemas.microsoft.com/office/drawing/2014/main" id="{705A835E-7BA2-4308-9CF8-4F6B898FAA71}"/>
                </a:ext>
              </a:extLst>
            </p:cNvPr>
            <p:cNvSpPr/>
            <p:nvPr/>
          </p:nvSpPr>
          <p:spPr>
            <a:xfrm>
              <a:off x="2633329" y="558301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Star: 5 Points 80">
              <a:extLst>
                <a:ext uri="{FF2B5EF4-FFF2-40B4-BE49-F238E27FC236}">
                  <a16:creationId xmlns:a16="http://schemas.microsoft.com/office/drawing/2014/main" id="{28B72C28-D752-4498-8AFF-1A6A68282C99}"/>
                </a:ext>
              </a:extLst>
            </p:cNvPr>
            <p:cNvSpPr/>
            <p:nvPr/>
          </p:nvSpPr>
          <p:spPr>
            <a:xfrm>
              <a:off x="5733447" y="347534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Star: 5 Points 82">
              <a:extLst>
                <a:ext uri="{FF2B5EF4-FFF2-40B4-BE49-F238E27FC236}">
                  <a16:creationId xmlns:a16="http://schemas.microsoft.com/office/drawing/2014/main" id="{2AABA839-6C17-439D-B129-E28C289C8AF0}"/>
                </a:ext>
              </a:extLst>
            </p:cNvPr>
            <p:cNvSpPr/>
            <p:nvPr/>
          </p:nvSpPr>
          <p:spPr>
            <a:xfrm>
              <a:off x="10521997" y="5703249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Star: 5 Points 83">
              <a:extLst>
                <a:ext uri="{FF2B5EF4-FFF2-40B4-BE49-F238E27FC236}">
                  <a16:creationId xmlns:a16="http://schemas.microsoft.com/office/drawing/2014/main" id="{1ECAACFF-C159-481E-9701-E264ABBE0981}"/>
                </a:ext>
              </a:extLst>
            </p:cNvPr>
            <p:cNvSpPr/>
            <p:nvPr/>
          </p:nvSpPr>
          <p:spPr>
            <a:xfrm>
              <a:off x="9797083" y="5715171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Star: 5 Points 84">
              <a:extLst>
                <a:ext uri="{FF2B5EF4-FFF2-40B4-BE49-F238E27FC236}">
                  <a16:creationId xmlns:a16="http://schemas.microsoft.com/office/drawing/2014/main" id="{93E42EF3-B1F0-4BFC-88E9-6A550047BD15}"/>
                </a:ext>
              </a:extLst>
            </p:cNvPr>
            <p:cNvSpPr/>
            <p:nvPr/>
          </p:nvSpPr>
          <p:spPr>
            <a:xfrm>
              <a:off x="7726699" y="529060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Star: 5 Points 86">
              <a:extLst>
                <a:ext uri="{FF2B5EF4-FFF2-40B4-BE49-F238E27FC236}">
                  <a16:creationId xmlns:a16="http://schemas.microsoft.com/office/drawing/2014/main" id="{93EB621F-719E-41CF-A57C-81ACC3694ADC}"/>
                </a:ext>
              </a:extLst>
            </p:cNvPr>
            <p:cNvSpPr/>
            <p:nvPr/>
          </p:nvSpPr>
          <p:spPr>
            <a:xfrm>
              <a:off x="6508229" y="5539702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Star: 5 Points 87">
              <a:extLst>
                <a:ext uri="{FF2B5EF4-FFF2-40B4-BE49-F238E27FC236}">
                  <a16:creationId xmlns:a16="http://schemas.microsoft.com/office/drawing/2014/main" id="{F920A518-CB65-4F4E-A848-E86A06554CB5}"/>
                </a:ext>
              </a:extLst>
            </p:cNvPr>
            <p:cNvSpPr/>
            <p:nvPr/>
          </p:nvSpPr>
          <p:spPr>
            <a:xfrm>
              <a:off x="5733447" y="5583016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Star: 5 Points 88">
              <a:extLst>
                <a:ext uri="{FF2B5EF4-FFF2-40B4-BE49-F238E27FC236}">
                  <a16:creationId xmlns:a16="http://schemas.microsoft.com/office/drawing/2014/main" id="{DE2541D6-F95C-4864-BBB3-2BC9C31F6F3D}"/>
                </a:ext>
              </a:extLst>
            </p:cNvPr>
            <p:cNvSpPr/>
            <p:nvPr/>
          </p:nvSpPr>
          <p:spPr>
            <a:xfrm>
              <a:off x="11937991" y="1147200"/>
              <a:ext cx="96252" cy="86627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76424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9485D9B-F98B-485E-A199-05FB4F090101}"/>
              </a:ext>
            </a:extLst>
          </p:cNvPr>
          <p:cNvSpPr txBox="1"/>
          <p:nvPr/>
        </p:nvSpPr>
        <p:spPr>
          <a:xfrm>
            <a:off x="1285336" y="2011680"/>
            <a:ext cx="80053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 B: The behavior of the </a:t>
            </a:r>
            <a:r>
              <a:rPr kumimoji="0" lang="en-US" sz="18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coli </a:t>
            </a: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olated from water (W1, W2., W3), lettuce (L1, L2, L3), and soil (S1, S2, S3), treated with different concentrations of Mn over a period of 24 hours.</a:t>
            </a:r>
            <a:endParaRPr kumimoji="0" lang="en-US" sz="4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927141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ontent Placeholder 3">
            <a:extLst>
              <a:ext uri="{FF2B5EF4-FFF2-40B4-BE49-F238E27FC236}">
                <a16:creationId xmlns:a16="http://schemas.microsoft.com/office/drawing/2014/main" id="{F3288497-C490-43E5-AD54-61F58614CE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4859624"/>
              </p:ext>
            </p:extLst>
          </p:nvPr>
        </p:nvGraphicFramePr>
        <p:xfrm>
          <a:off x="0" y="-297700"/>
          <a:ext cx="4321743" cy="26607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9BD922AC-13D6-4A3F-A40B-7FA9534EF0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694612"/>
              </p:ext>
            </p:extLst>
          </p:nvPr>
        </p:nvGraphicFramePr>
        <p:xfrm>
          <a:off x="4244741" y="110143"/>
          <a:ext cx="4321743" cy="23057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C63AE950-D659-479D-B7D7-46DC37574E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952564"/>
              </p:ext>
            </p:extLst>
          </p:nvPr>
        </p:nvGraphicFramePr>
        <p:xfrm>
          <a:off x="8072588" y="-1"/>
          <a:ext cx="4119412" cy="23630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ontent Placeholder 3">
            <a:extLst>
              <a:ext uri="{FF2B5EF4-FFF2-40B4-BE49-F238E27FC236}">
                <a16:creationId xmlns:a16="http://schemas.microsoft.com/office/drawing/2014/main" id="{A27FD5AC-EEEE-45CC-A434-FE30321D85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3011140"/>
              </p:ext>
            </p:extLst>
          </p:nvPr>
        </p:nvGraphicFramePr>
        <p:xfrm>
          <a:off x="-75999" y="2363001"/>
          <a:ext cx="4320740" cy="2065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ontent Placeholder 3">
            <a:extLst>
              <a:ext uri="{FF2B5EF4-FFF2-40B4-BE49-F238E27FC236}">
                <a16:creationId xmlns:a16="http://schemas.microsoft.com/office/drawing/2014/main" id="{469E52AC-890E-4E9A-9CE7-8C4F8AE858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11186"/>
              </p:ext>
            </p:extLst>
          </p:nvPr>
        </p:nvGraphicFramePr>
        <p:xfrm>
          <a:off x="4091038" y="2363001"/>
          <a:ext cx="4398444" cy="2363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ontent Placeholder 3">
            <a:extLst>
              <a:ext uri="{FF2B5EF4-FFF2-40B4-BE49-F238E27FC236}">
                <a16:creationId xmlns:a16="http://schemas.microsoft.com/office/drawing/2014/main" id="{22C3F4F6-0B2D-4493-96AE-2977F9D974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9332187"/>
              </p:ext>
            </p:extLst>
          </p:nvPr>
        </p:nvGraphicFramePr>
        <p:xfrm>
          <a:off x="8072588" y="2234942"/>
          <a:ext cx="4119412" cy="2260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ontent Placeholder 3">
            <a:extLst>
              <a:ext uri="{FF2B5EF4-FFF2-40B4-BE49-F238E27FC236}">
                <a16:creationId xmlns:a16="http://schemas.microsoft.com/office/drawing/2014/main" id="{02799F0B-B972-4E8F-864A-D58F1FF34D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8267108"/>
              </p:ext>
            </p:extLst>
          </p:nvPr>
        </p:nvGraphicFramePr>
        <p:xfrm>
          <a:off x="-92944" y="4318159"/>
          <a:ext cx="4167739" cy="236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ontent Placeholder 3">
            <a:extLst>
              <a:ext uri="{FF2B5EF4-FFF2-40B4-BE49-F238E27FC236}">
                <a16:creationId xmlns:a16="http://schemas.microsoft.com/office/drawing/2014/main" id="{25CBF0C7-15C3-4F36-BC62-CEB79F8B36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7398676"/>
              </p:ext>
            </p:extLst>
          </p:nvPr>
        </p:nvGraphicFramePr>
        <p:xfrm>
          <a:off x="3852011" y="4257513"/>
          <a:ext cx="4459605" cy="24724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ontent Placeholder 3">
            <a:extLst>
              <a:ext uri="{FF2B5EF4-FFF2-40B4-BE49-F238E27FC236}">
                <a16:creationId xmlns:a16="http://schemas.microsoft.com/office/drawing/2014/main" id="{76298811-BAAF-4FD2-9D00-7A77070915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4079404"/>
              </p:ext>
            </p:extLst>
          </p:nvPr>
        </p:nvGraphicFramePr>
        <p:xfrm>
          <a:off x="8056345" y="4257513"/>
          <a:ext cx="4083118" cy="2685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9069963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308889D-A680-E959-A3D1-DF116440F6A7}"/>
              </a:ext>
            </a:extLst>
          </p:cNvPr>
          <p:cNvSpPr txBox="1"/>
          <p:nvPr/>
        </p:nvSpPr>
        <p:spPr>
          <a:xfrm>
            <a:off x="595223" y="2967335"/>
            <a:ext cx="1069675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 C: The behavior of the </a:t>
            </a:r>
            <a:r>
              <a:rPr kumimoji="0" lang="en-US" sz="18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coli </a:t>
            </a: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olated from water (W1, W2., W3), lettuce (L1, L2, L3), and soil (S1, S2, S3), treated with different concentrations of </a:t>
            </a:r>
            <a:r>
              <a:rPr lang="en-US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Zn</a:t>
            </a: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 a period of 24 hours.</a:t>
            </a:r>
            <a:endParaRPr kumimoji="0" lang="en-US" sz="4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672080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ontent Placeholder 3">
            <a:extLst>
              <a:ext uri="{FF2B5EF4-FFF2-40B4-BE49-F238E27FC236}">
                <a16:creationId xmlns:a16="http://schemas.microsoft.com/office/drawing/2014/main" id="{7217010A-A89E-40A8-9D8B-9C84324A85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8048108"/>
              </p:ext>
            </p:extLst>
          </p:nvPr>
        </p:nvGraphicFramePr>
        <p:xfrm>
          <a:off x="105877" y="-374902"/>
          <a:ext cx="4212657" cy="2684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D7C7B5B5-3425-412A-B729-9854405B9C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8097127"/>
              </p:ext>
            </p:extLst>
          </p:nvPr>
        </p:nvGraphicFramePr>
        <p:xfrm>
          <a:off x="4129239" y="87541"/>
          <a:ext cx="4119612" cy="2158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0698920E-4D96-4911-B109-FFFEC7881F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5137853"/>
              </p:ext>
            </p:extLst>
          </p:nvPr>
        </p:nvGraphicFramePr>
        <p:xfrm>
          <a:off x="8078806" y="0"/>
          <a:ext cx="4007317" cy="2310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ontent Placeholder 3">
            <a:extLst>
              <a:ext uri="{FF2B5EF4-FFF2-40B4-BE49-F238E27FC236}">
                <a16:creationId xmlns:a16="http://schemas.microsoft.com/office/drawing/2014/main" id="{49D4B7B5-A2FB-4980-AE6B-02F2686E70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4003938"/>
              </p:ext>
            </p:extLst>
          </p:nvPr>
        </p:nvGraphicFramePr>
        <p:xfrm>
          <a:off x="-182879" y="2146434"/>
          <a:ext cx="4296074" cy="2230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ontent Placeholder 3">
            <a:extLst>
              <a:ext uri="{FF2B5EF4-FFF2-40B4-BE49-F238E27FC236}">
                <a16:creationId xmlns:a16="http://schemas.microsoft.com/office/drawing/2014/main" id="{A0747146-DE4D-4CE2-9BAD-75CDCBCC29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7675920"/>
              </p:ext>
            </p:extLst>
          </p:nvPr>
        </p:nvGraphicFramePr>
        <p:xfrm>
          <a:off x="3965609" y="2182478"/>
          <a:ext cx="4446871" cy="2158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ontent Placeholder 3">
            <a:extLst>
              <a:ext uri="{FF2B5EF4-FFF2-40B4-BE49-F238E27FC236}">
                <a16:creationId xmlns:a16="http://schemas.microsoft.com/office/drawing/2014/main" id="{F1844AEA-0AC7-4287-A4FA-F8F5C7780E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2748902"/>
              </p:ext>
            </p:extLst>
          </p:nvPr>
        </p:nvGraphicFramePr>
        <p:xfrm>
          <a:off x="7972927" y="2146432"/>
          <a:ext cx="4119612" cy="2184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ontent Placeholder 3">
            <a:extLst>
              <a:ext uri="{FF2B5EF4-FFF2-40B4-BE49-F238E27FC236}">
                <a16:creationId xmlns:a16="http://schemas.microsoft.com/office/drawing/2014/main" id="{483C6734-22C6-4C13-8C87-10B53255BF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9323580"/>
              </p:ext>
            </p:extLst>
          </p:nvPr>
        </p:nvGraphicFramePr>
        <p:xfrm>
          <a:off x="-147587" y="4239827"/>
          <a:ext cx="4446871" cy="2526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ontent Placeholder 3">
            <a:extLst>
              <a:ext uri="{FF2B5EF4-FFF2-40B4-BE49-F238E27FC236}">
                <a16:creationId xmlns:a16="http://schemas.microsoft.com/office/drawing/2014/main" id="{7A815256-4B8D-4072-93DE-1B99CE837C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8010070"/>
              </p:ext>
            </p:extLst>
          </p:nvPr>
        </p:nvGraphicFramePr>
        <p:xfrm>
          <a:off x="3959191" y="4492540"/>
          <a:ext cx="4446871" cy="2230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ontent Placeholder 3">
            <a:extLst>
              <a:ext uri="{FF2B5EF4-FFF2-40B4-BE49-F238E27FC236}">
                <a16:creationId xmlns:a16="http://schemas.microsoft.com/office/drawing/2014/main" id="{E2D81414-58A4-4274-814F-CD595E62DA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0337573"/>
              </p:ext>
            </p:extLst>
          </p:nvPr>
        </p:nvGraphicFramePr>
        <p:xfrm>
          <a:off x="8069182" y="4446869"/>
          <a:ext cx="4119612" cy="2230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6" name="Star: 5 Points 25">
            <a:extLst>
              <a:ext uri="{FF2B5EF4-FFF2-40B4-BE49-F238E27FC236}">
                <a16:creationId xmlns:a16="http://schemas.microsoft.com/office/drawing/2014/main" id="{BD573C38-0F78-4777-9D7D-702A929CBBAA}"/>
              </a:ext>
            </a:extLst>
          </p:cNvPr>
          <p:cNvSpPr/>
          <p:nvPr/>
        </p:nvSpPr>
        <p:spPr>
          <a:xfrm>
            <a:off x="5269832" y="613354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Star: 5 Points 26">
            <a:extLst>
              <a:ext uri="{FF2B5EF4-FFF2-40B4-BE49-F238E27FC236}">
                <a16:creationId xmlns:a16="http://schemas.microsoft.com/office/drawing/2014/main" id="{933942AE-BDB9-4F8F-94D7-647956578969}"/>
              </a:ext>
            </a:extLst>
          </p:cNvPr>
          <p:cNvSpPr/>
          <p:nvPr/>
        </p:nvSpPr>
        <p:spPr>
          <a:xfrm>
            <a:off x="1124551" y="181676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tar: 5 Points 27">
            <a:extLst>
              <a:ext uri="{FF2B5EF4-FFF2-40B4-BE49-F238E27FC236}">
                <a16:creationId xmlns:a16="http://schemas.microsoft.com/office/drawing/2014/main" id="{1695BE87-63DA-45B8-A074-1A87032D2DD7}"/>
              </a:ext>
            </a:extLst>
          </p:cNvPr>
          <p:cNvSpPr/>
          <p:nvPr/>
        </p:nvSpPr>
        <p:spPr>
          <a:xfrm>
            <a:off x="9225815" y="390149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Star: 5 Points 28">
            <a:extLst>
              <a:ext uri="{FF2B5EF4-FFF2-40B4-BE49-F238E27FC236}">
                <a16:creationId xmlns:a16="http://schemas.microsoft.com/office/drawing/2014/main" id="{10E29F7D-B519-47D5-ADE0-BA7AC35649F6}"/>
              </a:ext>
            </a:extLst>
          </p:cNvPr>
          <p:cNvSpPr/>
          <p:nvPr/>
        </p:nvSpPr>
        <p:spPr>
          <a:xfrm>
            <a:off x="1172677" y="622017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Star: 5 Points 29">
            <a:extLst>
              <a:ext uri="{FF2B5EF4-FFF2-40B4-BE49-F238E27FC236}">
                <a16:creationId xmlns:a16="http://schemas.microsoft.com/office/drawing/2014/main" id="{4957277F-D5AF-4887-A6F3-0A98840AE104}"/>
              </a:ext>
            </a:extLst>
          </p:cNvPr>
          <p:cNvSpPr/>
          <p:nvPr/>
        </p:nvSpPr>
        <p:spPr>
          <a:xfrm>
            <a:off x="5288120" y="359262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Star: 5 Points 30">
            <a:extLst>
              <a:ext uri="{FF2B5EF4-FFF2-40B4-BE49-F238E27FC236}">
                <a16:creationId xmlns:a16="http://schemas.microsoft.com/office/drawing/2014/main" id="{BC4A4479-BD77-432D-B373-0CABF99D4994}"/>
              </a:ext>
            </a:extLst>
          </p:cNvPr>
          <p:cNvSpPr/>
          <p:nvPr/>
        </p:nvSpPr>
        <p:spPr>
          <a:xfrm>
            <a:off x="1115407" y="393903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Star: 5 Points 31">
            <a:extLst>
              <a:ext uri="{FF2B5EF4-FFF2-40B4-BE49-F238E27FC236}">
                <a16:creationId xmlns:a16="http://schemas.microsoft.com/office/drawing/2014/main" id="{EBDDC42E-7EB5-439A-9F05-9825ADAE48C4}"/>
              </a:ext>
            </a:extLst>
          </p:cNvPr>
          <p:cNvSpPr/>
          <p:nvPr/>
        </p:nvSpPr>
        <p:spPr>
          <a:xfrm>
            <a:off x="10586186" y="135796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Star: 5 Points 32">
            <a:extLst>
              <a:ext uri="{FF2B5EF4-FFF2-40B4-BE49-F238E27FC236}">
                <a16:creationId xmlns:a16="http://schemas.microsoft.com/office/drawing/2014/main" id="{1B185476-FBED-4331-8509-58C183440CBA}"/>
              </a:ext>
            </a:extLst>
          </p:cNvPr>
          <p:cNvSpPr/>
          <p:nvPr/>
        </p:nvSpPr>
        <p:spPr>
          <a:xfrm>
            <a:off x="9936481" y="163618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Star: 5 Points 33">
            <a:extLst>
              <a:ext uri="{FF2B5EF4-FFF2-40B4-BE49-F238E27FC236}">
                <a16:creationId xmlns:a16="http://schemas.microsoft.com/office/drawing/2014/main" id="{D4166BF2-7BA3-49E7-ADCD-8543153A31F2}"/>
              </a:ext>
            </a:extLst>
          </p:cNvPr>
          <p:cNvSpPr/>
          <p:nvPr/>
        </p:nvSpPr>
        <p:spPr>
          <a:xfrm>
            <a:off x="9225815" y="183762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Star: 5 Points 34">
            <a:extLst>
              <a:ext uri="{FF2B5EF4-FFF2-40B4-BE49-F238E27FC236}">
                <a16:creationId xmlns:a16="http://schemas.microsoft.com/office/drawing/2014/main" id="{3BDD1F2D-DEF9-4B04-B2AE-B571D435F4AD}"/>
              </a:ext>
            </a:extLst>
          </p:cNvPr>
          <p:cNvSpPr/>
          <p:nvPr/>
        </p:nvSpPr>
        <p:spPr>
          <a:xfrm>
            <a:off x="5325978" y="163618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B71A6BBA-B1A4-594C-5609-19D34E5A21BD}"/>
              </a:ext>
            </a:extLst>
          </p:cNvPr>
          <p:cNvSpPr/>
          <p:nvPr/>
        </p:nvSpPr>
        <p:spPr>
          <a:xfrm>
            <a:off x="9303779" y="587275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5323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A056A84-7FF7-8B71-C3DA-EF90DC704AA0}"/>
              </a:ext>
            </a:extLst>
          </p:cNvPr>
          <p:cNvSpPr txBox="1"/>
          <p:nvPr/>
        </p:nvSpPr>
        <p:spPr>
          <a:xfrm>
            <a:off x="888520" y="2967335"/>
            <a:ext cx="1029993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 D: The behavior of the </a:t>
            </a:r>
            <a:r>
              <a:rPr kumimoji="0" lang="en-US" sz="18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coli </a:t>
            </a: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olated from water (W1, W2., W3), lettuce (L1, L2, L3), and soil (S1, S2, S3), treated with different concentrations of </a:t>
            </a:r>
            <a:r>
              <a:rPr lang="en-US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i</a:t>
            </a:r>
            <a:r>
              <a:rPr kumimoji="0" lang="en-US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 a period of 24 hours.</a:t>
            </a:r>
            <a:endParaRPr kumimoji="0" lang="en-US" sz="4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756927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ontent Placeholder 3">
            <a:extLst>
              <a:ext uri="{FF2B5EF4-FFF2-40B4-BE49-F238E27FC236}">
                <a16:creationId xmlns:a16="http://schemas.microsoft.com/office/drawing/2014/main" id="{AD2B02BB-62D5-4953-AA2B-CE4235DCBD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505597"/>
              </p:ext>
            </p:extLst>
          </p:nvPr>
        </p:nvGraphicFramePr>
        <p:xfrm>
          <a:off x="8057155" y="2552460"/>
          <a:ext cx="4170945" cy="24519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ontent Placeholder 3">
            <a:extLst>
              <a:ext uri="{FF2B5EF4-FFF2-40B4-BE49-F238E27FC236}">
                <a16:creationId xmlns:a16="http://schemas.microsoft.com/office/drawing/2014/main" id="{179AF1DE-1414-48C7-8D8A-44F8AC441D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4269055"/>
              </p:ext>
            </p:extLst>
          </p:nvPr>
        </p:nvGraphicFramePr>
        <p:xfrm>
          <a:off x="4003713" y="2605399"/>
          <a:ext cx="4350619" cy="2346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Content Placeholder 3">
            <a:extLst>
              <a:ext uri="{FF2B5EF4-FFF2-40B4-BE49-F238E27FC236}">
                <a16:creationId xmlns:a16="http://schemas.microsoft.com/office/drawing/2014/main" id="{361DC246-6AF7-46A9-B06D-555F78D845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7297735"/>
              </p:ext>
            </p:extLst>
          </p:nvPr>
        </p:nvGraphicFramePr>
        <p:xfrm>
          <a:off x="30479" y="-476424"/>
          <a:ext cx="4176562" cy="2765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AAF8FA88-0322-4916-878D-7A76CDBAB5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0776936"/>
              </p:ext>
            </p:extLst>
          </p:nvPr>
        </p:nvGraphicFramePr>
        <p:xfrm>
          <a:off x="4176562" y="-39946"/>
          <a:ext cx="4350619" cy="2595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3C21A395-143A-4D92-9AFD-81DA007CE7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7088944"/>
              </p:ext>
            </p:extLst>
          </p:nvPr>
        </p:nvGraphicFramePr>
        <p:xfrm>
          <a:off x="8252059" y="-127054"/>
          <a:ext cx="4020152" cy="2542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" name="Content Placeholder 3">
            <a:extLst>
              <a:ext uri="{FF2B5EF4-FFF2-40B4-BE49-F238E27FC236}">
                <a16:creationId xmlns:a16="http://schemas.microsoft.com/office/drawing/2014/main" id="{48B52006-269F-4927-8DCA-F0EA234A0E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4778615"/>
              </p:ext>
            </p:extLst>
          </p:nvPr>
        </p:nvGraphicFramePr>
        <p:xfrm>
          <a:off x="129945" y="2308198"/>
          <a:ext cx="4176562" cy="2542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ontent Placeholder 3">
            <a:extLst>
              <a:ext uri="{FF2B5EF4-FFF2-40B4-BE49-F238E27FC236}">
                <a16:creationId xmlns:a16="http://schemas.microsoft.com/office/drawing/2014/main" id="{8A339F59-1F8D-42D0-A2D1-A78C48CD2D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4952098"/>
              </p:ext>
            </p:extLst>
          </p:nvPr>
        </p:nvGraphicFramePr>
        <p:xfrm>
          <a:off x="-172849" y="4521419"/>
          <a:ext cx="4356236" cy="2045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ontent Placeholder 3">
            <a:extLst>
              <a:ext uri="{FF2B5EF4-FFF2-40B4-BE49-F238E27FC236}">
                <a16:creationId xmlns:a16="http://schemas.microsoft.com/office/drawing/2014/main" id="{CE1633FC-B9F2-4137-AB81-30CD0D8443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5618532"/>
              </p:ext>
            </p:extLst>
          </p:nvPr>
        </p:nvGraphicFramePr>
        <p:xfrm>
          <a:off x="3886401" y="4612163"/>
          <a:ext cx="4498206" cy="2120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ontent Placeholder 3">
            <a:extLst>
              <a:ext uri="{FF2B5EF4-FFF2-40B4-BE49-F238E27FC236}">
                <a16:creationId xmlns:a16="http://schemas.microsoft.com/office/drawing/2014/main" id="{66C5983B-F762-4D7F-A469-722B37F62C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9254"/>
              </p:ext>
            </p:extLst>
          </p:nvPr>
        </p:nvGraphicFramePr>
        <p:xfrm>
          <a:off x="8086825" y="4566842"/>
          <a:ext cx="4105175" cy="20767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D385DBEA-4B2A-45AF-B97A-5CDA606A5C09}"/>
              </a:ext>
            </a:extLst>
          </p:cNvPr>
          <p:cNvSpPr/>
          <p:nvPr/>
        </p:nvSpPr>
        <p:spPr>
          <a:xfrm>
            <a:off x="6870792" y="195606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077BAB4F-5070-4C95-8425-0416EEED1B23}"/>
              </a:ext>
            </a:extLst>
          </p:cNvPr>
          <p:cNvSpPr/>
          <p:nvPr/>
        </p:nvSpPr>
        <p:spPr>
          <a:xfrm>
            <a:off x="6878247" y="145974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C3853F55-7B87-40A7-82AC-E7109E682550}"/>
              </a:ext>
            </a:extLst>
          </p:cNvPr>
          <p:cNvSpPr/>
          <p:nvPr/>
        </p:nvSpPr>
        <p:spPr>
          <a:xfrm>
            <a:off x="1294598" y="190494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50CAB37A-01F9-49E7-9074-4F889A18753A}"/>
              </a:ext>
            </a:extLst>
          </p:cNvPr>
          <p:cNvSpPr/>
          <p:nvPr/>
        </p:nvSpPr>
        <p:spPr>
          <a:xfrm>
            <a:off x="5284276" y="165963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1A82500B-ACE1-427D-8EE2-489D49475351}"/>
              </a:ext>
            </a:extLst>
          </p:cNvPr>
          <p:cNvSpPr/>
          <p:nvPr/>
        </p:nvSpPr>
        <p:spPr>
          <a:xfrm>
            <a:off x="3943703" y="183902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AF990E2F-46B6-4242-8DE2-11F73CB9A7AD}"/>
              </a:ext>
            </a:extLst>
          </p:cNvPr>
          <p:cNvSpPr/>
          <p:nvPr/>
        </p:nvSpPr>
        <p:spPr>
          <a:xfrm>
            <a:off x="1259879" y="164099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0EBAE5CA-222E-4D88-983A-F86ABE39D2B4}"/>
              </a:ext>
            </a:extLst>
          </p:cNvPr>
          <p:cNvSpPr/>
          <p:nvPr/>
        </p:nvSpPr>
        <p:spPr>
          <a:xfrm>
            <a:off x="6086777" y="193977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4F321455-E4C0-4003-9BCB-BC0739781074}"/>
              </a:ext>
            </a:extLst>
          </p:cNvPr>
          <p:cNvSpPr/>
          <p:nvPr/>
        </p:nvSpPr>
        <p:spPr>
          <a:xfrm>
            <a:off x="6078151" y="173486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5D0DA32D-AE0D-4D0E-8043-EFEC2A65BEA4}"/>
              </a:ext>
            </a:extLst>
          </p:cNvPr>
          <p:cNvSpPr/>
          <p:nvPr/>
        </p:nvSpPr>
        <p:spPr>
          <a:xfrm>
            <a:off x="5284276" y="193977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C714ED6F-76DB-4CCC-9649-E8C28AA5EC03}"/>
              </a:ext>
            </a:extLst>
          </p:cNvPr>
          <p:cNvSpPr/>
          <p:nvPr/>
        </p:nvSpPr>
        <p:spPr>
          <a:xfrm>
            <a:off x="3955587" y="152343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25C20F74-2B6B-4782-8D98-73DC73964AED}"/>
              </a:ext>
            </a:extLst>
          </p:cNvPr>
          <p:cNvSpPr/>
          <p:nvPr/>
        </p:nvSpPr>
        <p:spPr>
          <a:xfrm>
            <a:off x="2681924" y="189096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2B03AE11-F374-4FE9-AD2F-47F8E9A6AAF2}"/>
              </a:ext>
            </a:extLst>
          </p:cNvPr>
          <p:cNvSpPr/>
          <p:nvPr/>
        </p:nvSpPr>
        <p:spPr>
          <a:xfrm>
            <a:off x="1977315" y="170153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7EE7F0CE-BAEE-4072-AC75-332069578A5D}"/>
              </a:ext>
            </a:extLst>
          </p:cNvPr>
          <p:cNvSpPr/>
          <p:nvPr/>
        </p:nvSpPr>
        <p:spPr>
          <a:xfrm>
            <a:off x="1970577" y="185093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tar: 5 Points 23">
            <a:extLst>
              <a:ext uri="{FF2B5EF4-FFF2-40B4-BE49-F238E27FC236}">
                <a16:creationId xmlns:a16="http://schemas.microsoft.com/office/drawing/2014/main" id="{1B07CE6A-51F6-433F-981B-C6F67904DA70}"/>
              </a:ext>
            </a:extLst>
          </p:cNvPr>
          <p:cNvSpPr/>
          <p:nvPr/>
        </p:nvSpPr>
        <p:spPr>
          <a:xfrm>
            <a:off x="9426946" y="170812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Star: 5 Points 24">
            <a:extLst>
              <a:ext uri="{FF2B5EF4-FFF2-40B4-BE49-F238E27FC236}">
                <a16:creationId xmlns:a16="http://schemas.microsoft.com/office/drawing/2014/main" id="{AEED0624-C42B-4B9D-BED0-F181DCEF669C}"/>
              </a:ext>
            </a:extLst>
          </p:cNvPr>
          <p:cNvSpPr/>
          <p:nvPr/>
        </p:nvSpPr>
        <p:spPr>
          <a:xfrm>
            <a:off x="10155853" y="195353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Star: 5 Points 25">
            <a:extLst>
              <a:ext uri="{FF2B5EF4-FFF2-40B4-BE49-F238E27FC236}">
                <a16:creationId xmlns:a16="http://schemas.microsoft.com/office/drawing/2014/main" id="{9D732B6A-9A72-4E49-8D50-E3CD240660C9}"/>
              </a:ext>
            </a:extLst>
          </p:cNvPr>
          <p:cNvSpPr/>
          <p:nvPr/>
        </p:nvSpPr>
        <p:spPr>
          <a:xfrm>
            <a:off x="9426371" y="196691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Star: 5 Points 26">
            <a:extLst>
              <a:ext uri="{FF2B5EF4-FFF2-40B4-BE49-F238E27FC236}">
                <a16:creationId xmlns:a16="http://schemas.microsoft.com/office/drawing/2014/main" id="{05A0D2BE-382D-44B1-B964-283D6E4D7EC7}"/>
              </a:ext>
            </a:extLst>
          </p:cNvPr>
          <p:cNvSpPr/>
          <p:nvPr/>
        </p:nvSpPr>
        <p:spPr>
          <a:xfrm>
            <a:off x="8277334" y="187865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Star: 5 Points 28">
            <a:extLst>
              <a:ext uri="{FF2B5EF4-FFF2-40B4-BE49-F238E27FC236}">
                <a16:creationId xmlns:a16="http://schemas.microsoft.com/office/drawing/2014/main" id="{29AC2D30-6D16-4134-8164-C51AD72BD465}"/>
              </a:ext>
            </a:extLst>
          </p:cNvPr>
          <p:cNvSpPr/>
          <p:nvPr/>
        </p:nvSpPr>
        <p:spPr>
          <a:xfrm>
            <a:off x="2681924" y="165506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Star: 5 Points 29">
            <a:extLst>
              <a:ext uri="{FF2B5EF4-FFF2-40B4-BE49-F238E27FC236}">
                <a16:creationId xmlns:a16="http://schemas.microsoft.com/office/drawing/2014/main" id="{F3324598-584E-457F-B4C9-4BE98767504F}"/>
              </a:ext>
            </a:extLst>
          </p:cNvPr>
          <p:cNvSpPr/>
          <p:nvPr/>
        </p:nvSpPr>
        <p:spPr>
          <a:xfrm>
            <a:off x="1992353" y="426242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Star: 5 Points 30">
            <a:extLst>
              <a:ext uri="{FF2B5EF4-FFF2-40B4-BE49-F238E27FC236}">
                <a16:creationId xmlns:a16="http://schemas.microsoft.com/office/drawing/2014/main" id="{EC7E46D8-AC1A-4DEC-A20B-74F720B72618}"/>
              </a:ext>
            </a:extLst>
          </p:cNvPr>
          <p:cNvSpPr/>
          <p:nvPr/>
        </p:nvSpPr>
        <p:spPr>
          <a:xfrm>
            <a:off x="1263038" y="401838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Star: 5 Points 31">
            <a:extLst>
              <a:ext uri="{FF2B5EF4-FFF2-40B4-BE49-F238E27FC236}">
                <a16:creationId xmlns:a16="http://schemas.microsoft.com/office/drawing/2014/main" id="{96FBA0C8-5201-4FF1-B32D-9BE0115C10A1}"/>
              </a:ext>
            </a:extLst>
          </p:cNvPr>
          <p:cNvSpPr/>
          <p:nvPr/>
        </p:nvSpPr>
        <p:spPr>
          <a:xfrm>
            <a:off x="12013133" y="187193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Star: 5 Points 32">
            <a:extLst>
              <a:ext uri="{FF2B5EF4-FFF2-40B4-BE49-F238E27FC236}">
                <a16:creationId xmlns:a16="http://schemas.microsoft.com/office/drawing/2014/main" id="{CD470C6B-6ED8-4AF5-A61C-C178D88445DF}"/>
              </a:ext>
            </a:extLst>
          </p:cNvPr>
          <p:cNvSpPr/>
          <p:nvPr/>
        </p:nvSpPr>
        <p:spPr>
          <a:xfrm>
            <a:off x="10797938" y="198967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Star: 5 Points 33">
            <a:extLst>
              <a:ext uri="{FF2B5EF4-FFF2-40B4-BE49-F238E27FC236}">
                <a16:creationId xmlns:a16="http://schemas.microsoft.com/office/drawing/2014/main" id="{1FE711C3-551E-46BF-A802-304F8E6383A3}"/>
              </a:ext>
            </a:extLst>
          </p:cNvPr>
          <p:cNvSpPr/>
          <p:nvPr/>
        </p:nvSpPr>
        <p:spPr>
          <a:xfrm>
            <a:off x="10797938" y="152297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Star: 5 Points 34">
            <a:extLst>
              <a:ext uri="{FF2B5EF4-FFF2-40B4-BE49-F238E27FC236}">
                <a16:creationId xmlns:a16="http://schemas.microsoft.com/office/drawing/2014/main" id="{E7736C7E-29C6-47D8-B7E7-1EC38FF54B89}"/>
              </a:ext>
            </a:extLst>
          </p:cNvPr>
          <p:cNvSpPr/>
          <p:nvPr/>
        </p:nvSpPr>
        <p:spPr>
          <a:xfrm>
            <a:off x="10121077" y="176246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Star: 5 Points 35">
            <a:extLst>
              <a:ext uri="{FF2B5EF4-FFF2-40B4-BE49-F238E27FC236}">
                <a16:creationId xmlns:a16="http://schemas.microsoft.com/office/drawing/2014/main" id="{AEB12276-4151-4410-9557-9AA6E52E49AA}"/>
              </a:ext>
            </a:extLst>
          </p:cNvPr>
          <p:cNvSpPr/>
          <p:nvPr/>
        </p:nvSpPr>
        <p:spPr>
          <a:xfrm>
            <a:off x="2025441" y="395241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Star: 5 Points 36">
            <a:extLst>
              <a:ext uri="{FF2B5EF4-FFF2-40B4-BE49-F238E27FC236}">
                <a16:creationId xmlns:a16="http://schemas.microsoft.com/office/drawing/2014/main" id="{CA99B97D-F98C-4A52-8767-8EF25ED1850A}"/>
              </a:ext>
            </a:extLst>
          </p:cNvPr>
          <p:cNvSpPr/>
          <p:nvPr/>
        </p:nvSpPr>
        <p:spPr>
          <a:xfrm>
            <a:off x="5263020" y="432402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Star: 5 Points 37">
            <a:extLst>
              <a:ext uri="{FF2B5EF4-FFF2-40B4-BE49-F238E27FC236}">
                <a16:creationId xmlns:a16="http://schemas.microsoft.com/office/drawing/2014/main" id="{9BD2B2B2-A590-4044-A4E4-78D68EF73857}"/>
              </a:ext>
            </a:extLst>
          </p:cNvPr>
          <p:cNvSpPr/>
          <p:nvPr/>
        </p:nvSpPr>
        <p:spPr>
          <a:xfrm>
            <a:off x="5263020" y="413211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Star: 5 Points 38">
            <a:extLst>
              <a:ext uri="{FF2B5EF4-FFF2-40B4-BE49-F238E27FC236}">
                <a16:creationId xmlns:a16="http://schemas.microsoft.com/office/drawing/2014/main" id="{35E85171-A85D-4140-81F9-2CA0227B8BBE}"/>
              </a:ext>
            </a:extLst>
          </p:cNvPr>
          <p:cNvSpPr/>
          <p:nvPr/>
        </p:nvSpPr>
        <p:spPr>
          <a:xfrm>
            <a:off x="4110789" y="382176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Star: 5 Points 39">
            <a:extLst>
              <a:ext uri="{FF2B5EF4-FFF2-40B4-BE49-F238E27FC236}">
                <a16:creationId xmlns:a16="http://schemas.microsoft.com/office/drawing/2014/main" id="{4B19DB64-6847-4EF7-8B56-51B7C3A3C993}"/>
              </a:ext>
            </a:extLst>
          </p:cNvPr>
          <p:cNvSpPr/>
          <p:nvPr/>
        </p:nvSpPr>
        <p:spPr>
          <a:xfrm>
            <a:off x="4123235" y="415678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Star: 5 Points 40">
            <a:extLst>
              <a:ext uri="{FF2B5EF4-FFF2-40B4-BE49-F238E27FC236}">
                <a16:creationId xmlns:a16="http://schemas.microsoft.com/office/drawing/2014/main" id="{B9504054-9A80-48CB-ABBF-D1D319A15262}"/>
              </a:ext>
            </a:extLst>
          </p:cNvPr>
          <p:cNvSpPr/>
          <p:nvPr/>
        </p:nvSpPr>
        <p:spPr>
          <a:xfrm>
            <a:off x="2730050" y="430003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Star: 5 Points 41">
            <a:extLst>
              <a:ext uri="{FF2B5EF4-FFF2-40B4-BE49-F238E27FC236}">
                <a16:creationId xmlns:a16="http://schemas.microsoft.com/office/drawing/2014/main" id="{9F032F57-5E23-4C02-9864-9B9DDA5C25A4}"/>
              </a:ext>
            </a:extLst>
          </p:cNvPr>
          <p:cNvSpPr/>
          <p:nvPr/>
        </p:nvSpPr>
        <p:spPr>
          <a:xfrm>
            <a:off x="2765545" y="391302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Star: 5 Points 42">
            <a:extLst>
              <a:ext uri="{FF2B5EF4-FFF2-40B4-BE49-F238E27FC236}">
                <a16:creationId xmlns:a16="http://schemas.microsoft.com/office/drawing/2014/main" id="{85FBA9C0-E621-4E93-B3B6-F77BE804612E}"/>
              </a:ext>
            </a:extLst>
          </p:cNvPr>
          <p:cNvSpPr/>
          <p:nvPr/>
        </p:nvSpPr>
        <p:spPr>
          <a:xfrm>
            <a:off x="6037453" y="430621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Star: 5 Points 43">
            <a:extLst>
              <a:ext uri="{FF2B5EF4-FFF2-40B4-BE49-F238E27FC236}">
                <a16:creationId xmlns:a16="http://schemas.microsoft.com/office/drawing/2014/main" id="{FB39FA70-9410-4FB0-9684-05435B814E29}"/>
              </a:ext>
            </a:extLst>
          </p:cNvPr>
          <p:cNvSpPr/>
          <p:nvPr/>
        </p:nvSpPr>
        <p:spPr>
          <a:xfrm>
            <a:off x="6038651" y="395224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Star: 5 Points 44">
            <a:extLst>
              <a:ext uri="{FF2B5EF4-FFF2-40B4-BE49-F238E27FC236}">
                <a16:creationId xmlns:a16="http://schemas.microsoft.com/office/drawing/2014/main" id="{D9D0125C-2DE2-4016-B2CD-430FCF6F3E92}"/>
              </a:ext>
            </a:extLst>
          </p:cNvPr>
          <p:cNvSpPr/>
          <p:nvPr/>
        </p:nvSpPr>
        <p:spPr>
          <a:xfrm>
            <a:off x="6780005" y="390892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Star: 5 Points 45">
            <a:extLst>
              <a:ext uri="{FF2B5EF4-FFF2-40B4-BE49-F238E27FC236}">
                <a16:creationId xmlns:a16="http://schemas.microsoft.com/office/drawing/2014/main" id="{2093A8EC-5CB4-4CA2-937C-1DC6CA54EC82}"/>
              </a:ext>
            </a:extLst>
          </p:cNvPr>
          <p:cNvSpPr/>
          <p:nvPr/>
        </p:nvSpPr>
        <p:spPr>
          <a:xfrm>
            <a:off x="8091639" y="422512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Star: 5 Points 46">
            <a:extLst>
              <a:ext uri="{FF2B5EF4-FFF2-40B4-BE49-F238E27FC236}">
                <a16:creationId xmlns:a16="http://schemas.microsoft.com/office/drawing/2014/main" id="{1DBF0443-D330-4EDA-9216-4033C290443F}"/>
              </a:ext>
            </a:extLst>
          </p:cNvPr>
          <p:cNvSpPr/>
          <p:nvPr/>
        </p:nvSpPr>
        <p:spPr>
          <a:xfrm>
            <a:off x="8070784" y="377845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Star: 5 Points 47">
            <a:extLst>
              <a:ext uri="{FF2B5EF4-FFF2-40B4-BE49-F238E27FC236}">
                <a16:creationId xmlns:a16="http://schemas.microsoft.com/office/drawing/2014/main" id="{E8661203-A259-4E1A-B368-CFFEE9828B32}"/>
              </a:ext>
            </a:extLst>
          </p:cNvPr>
          <p:cNvSpPr/>
          <p:nvPr/>
        </p:nvSpPr>
        <p:spPr>
          <a:xfrm>
            <a:off x="6780005" y="435707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Star: 5 Points 50">
            <a:extLst>
              <a:ext uri="{FF2B5EF4-FFF2-40B4-BE49-F238E27FC236}">
                <a16:creationId xmlns:a16="http://schemas.microsoft.com/office/drawing/2014/main" id="{D592A0C1-496D-4CD0-B271-36EA8587D7FC}"/>
              </a:ext>
            </a:extLst>
          </p:cNvPr>
          <p:cNvSpPr/>
          <p:nvPr/>
        </p:nvSpPr>
        <p:spPr>
          <a:xfrm>
            <a:off x="11951474" y="624831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Star: 5 Points 51">
            <a:extLst>
              <a:ext uri="{FF2B5EF4-FFF2-40B4-BE49-F238E27FC236}">
                <a16:creationId xmlns:a16="http://schemas.microsoft.com/office/drawing/2014/main" id="{5820F206-BEA7-4DB8-A664-B4ADFEB1AF3E}"/>
              </a:ext>
            </a:extLst>
          </p:cNvPr>
          <p:cNvSpPr/>
          <p:nvPr/>
        </p:nvSpPr>
        <p:spPr>
          <a:xfrm>
            <a:off x="11951365" y="597626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Star: 5 Points 52">
            <a:extLst>
              <a:ext uri="{FF2B5EF4-FFF2-40B4-BE49-F238E27FC236}">
                <a16:creationId xmlns:a16="http://schemas.microsoft.com/office/drawing/2014/main" id="{D40981CB-1C29-46A3-B769-C5C58B486340}"/>
              </a:ext>
            </a:extLst>
          </p:cNvPr>
          <p:cNvSpPr/>
          <p:nvPr/>
        </p:nvSpPr>
        <p:spPr>
          <a:xfrm>
            <a:off x="10695909" y="607735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Star: 5 Points 53">
            <a:extLst>
              <a:ext uri="{FF2B5EF4-FFF2-40B4-BE49-F238E27FC236}">
                <a16:creationId xmlns:a16="http://schemas.microsoft.com/office/drawing/2014/main" id="{95C8ABA6-3934-4457-8174-39A32E7BE456}"/>
              </a:ext>
            </a:extLst>
          </p:cNvPr>
          <p:cNvSpPr/>
          <p:nvPr/>
        </p:nvSpPr>
        <p:spPr>
          <a:xfrm>
            <a:off x="10695909" y="628336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Star: 5 Points 54">
            <a:extLst>
              <a:ext uri="{FF2B5EF4-FFF2-40B4-BE49-F238E27FC236}">
                <a16:creationId xmlns:a16="http://schemas.microsoft.com/office/drawing/2014/main" id="{4E321EBE-A606-4201-9DB5-4AA2AC45B5CE}"/>
              </a:ext>
            </a:extLst>
          </p:cNvPr>
          <p:cNvSpPr/>
          <p:nvPr/>
        </p:nvSpPr>
        <p:spPr>
          <a:xfrm>
            <a:off x="9994315" y="623268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Star: 5 Points 55">
            <a:extLst>
              <a:ext uri="{FF2B5EF4-FFF2-40B4-BE49-F238E27FC236}">
                <a16:creationId xmlns:a16="http://schemas.microsoft.com/office/drawing/2014/main" id="{BBF4B306-A94C-49F6-A132-6A98C716BA68}"/>
              </a:ext>
            </a:extLst>
          </p:cNvPr>
          <p:cNvSpPr/>
          <p:nvPr/>
        </p:nvSpPr>
        <p:spPr>
          <a:xfrm>
            <a:off x="9994315" y="6052756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Star: 5 Points 56">
            <a:extLst>
              <a:ext uri="{FF2B5EF4-FFF2-40B4-BE49-F238E27FC236}">
                <a16:creationId xmlns:a16="http://schemas.microsoft.com/office/drawing/2014/main" id="{F2C32315-D59B-4354-9218-EF95E8AD2F63}"/>
              </a:ext>
            </a:extLst>
          </p:cNvPr>
          <p:cNvSpPr/>
          <p:nvPr/>
        </p:nvSpPr>
        <p:spPr>
          <a:xfrm>
            <a:off x="9301250" y="626723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Star: 5 Points 57">
            <a:extLst>
              <a:ext uri="{FF2B5EF4-FFF2-40B4-BE49-F238E27FC236}">
                <a16:creationId xmlns:a16="http://schemas.microsoft.com/office/drawing/2014/main" id="{F83B76F0-AD48-4A93-A9C9-5F50EB0C0D58}"/>
              </a:ext>
            </a:extLst>
          </p:cNvPr>
          <p:cNvSpPr/>
          <p:nvPr/>
        </p:nvSpPr>
        <p:spPr>
          <a:xfrm>
            <a:off x="9291986" y="599164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Star: 5 Points 58">
            <a:extLst>
              <a:ext uri="{FF2B5EF4-FFF2-40B4-BE49-F238E27FC236}">
                <a16:creationId xmlns:a16="http://schemas.microsoft.com/office/drawing/2014/main" id="{16B37316-19CD-478D-9761-92477004ABCE}"/>
              </a:ext>
            </a:extLst>
          </p:cNvPr>
          <p:cNvSpPr/>
          <p:nvPr/>
        </p:nvSpPr>
        <p:spPr>
          <a:xfrm>
            <a:off x="8096053" y="615567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Star: 5 Points 59">
            <a:extLst>
              <a:ext uri="{FF2B5EF4-FFF2-40B4-BE49-F238E27FC236}">
                <a16:creationId xmlns:a16="http://schemas.microsoft.com/office/drawing/2014/main" id="{A35CF77E-4E53-459C-8202-CE6C1A13F873}"/>
              </a:ext>
            </a:extLst>
          </p:cNvPr>
          <p:cNvSpPr/>
          <p:nvPr/>
        </p:nvSpPr>
        <p:spPr>
          <a:xfrm>
            <a:off x="8047927" y="599727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Star: 5 Points 60">
            <a:extLst>
              <a:ext uri="{FF2B5EF4-FFF2-40B4-BE49-F238E27FC236}">
                <a16:creationId xmlns:a16="http://schemas.microsoft.com/office/drawing/2014/main" id="{F6BF6B7B-9127-4441-9A0A-827D9B30D43E}"/>
              </a:ext>
            </a:extLst>
          </p:cNvPr>
          <p:cNvSpPr/>
          <p:nvPr/>
        </p:nvSpPr>
        <p:spPr>
          <a:xfrm>
            <a:off x="8071996" y="557774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Star: 5 Points 61">
            <a:extLst>
              <a:ext uri="{FF2B5EF4-FFF2-40B4-BE49-F238E27FC236}">
                <a16:creationId xmlns:a16="http://schemas.microsoft.com/office/drawing/2014/main" id="{E60058CC-389D-4BE8-BB47-FE708311B349}"/>
              </a:ext>
            </a:extLst>
          </p:cNvPr>
          <p:cNvSpPr/>
          <p:nvPr/>
        </p:nvSpPr>
        <p:spPr>
          <a:xfrm>
            <a:off x="6756136" y="594680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Star: 5 Points 62">
            <a:extLst>
              <a:ext uri="{FF2B5EF4-FFF2-40B4-BE49-F238E27FC236}">
                <a16:creationId xmlns:a16="http://schemas.microsoft.com/office/drawing/2014/main" id="{9E9A8D11-2E01-401F-BDF9-C121E141B5DA}"/>
              </a:ext>
            </a:extLst>
          </p:cNvPr>
          <p:cNvSpPr/>
          <p:nvPr/>
        </p:nvSpPr>
        <p:spPr>
          <a:xfrm>
            <a:off x="6798244" y="621588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Star: 5 Points 63">
            <a:extLst>
              <a:ext uri="{FF2B5EF4-FFF2-40B4-BE49-F238E27FC236}">
                <a16:creationId xmlns:a16="http://schemas.microsoft.com/office/drawing/2014/main" id="{B753B676-F8BC-407C-BAC8-DCDD5D498828}"/>
              </a:ext>
            </a:extLst>
          </p:cNvPr>
          <p:cNvSpPr/>
          <p:nvPr/>
        </p:nvSpPr>
        <p:spPr>
          <a:xfrm>
            <a:off x="6768774" y="567261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Star: 5 Points 64">
            <a:extLst>
              <a:ext uri="{FF2B5EF4-FFF2-40B4-BE49-F238E27FC236}">
                <a16:creationId xmlns:a16="http://schemas.microsoft.com/office/drawing/2014/main" id="{19E2864F-1618-4439-B836-9BFA36D31374}"/>
              </a:ext>
            </a:extLst>
          </p:cNvPr>
          <p:cNvSpPr/>
          <p:nvPr/>
        </p:nvSpPr>
        <p:spPr>
          <a:xfrm>
            <a:off x="6079563" y="603343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Star: 5 Points 65">
            <a:extLst>
              <a:ext uri="{FF2B5EF4-FFF2-40B4-BE49-F238E27FC236}">
                <a16:creationId xmlns:a16="http://schemas.microsoft.com/office/drawing/2014/main" id="{D054741B-844F-4AEA-97CC-525B9274F92C}"/>
              </a:ext>
            </a:extLst>
          </p:cNvPr>
          <p:cNvSpPr/>
          <p:nvPr/>
        </p:nvSpPr>
        <p:spPr>
          <a:xfrm>
            <a:off x="5942406" y="621588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Star: 5 Points 66">
            <a:extLst>
              <a:ext uri="{FF2B5EF4-FFF2-40B4-BE49-F238E27FC236}">
                <a16:creationId xmlns:a16="http://schemas.microsoft.com/office/drawing/2014/main" id="{5FE8A49C-52EB-48F7-946B-FF0F1F9C1AFD}"/>
              </a:ext>
            </a:extLst>
          </p:cNvPr>
          <p:cNvSpPr/>
          <p:nvPr/>
        </p:nvSpPr>
        <p:spPr>
          <a:xfrm>
            <a:off x="1273743" y="426169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Star: 5 Points 67">
            <a:extLst>
              <a:ext uri="{FF2B5EF4-FFF2-40B4-BE49-F238E27FC236}">
                <a16:creationId xmlns:a16="http://schemas.microsoft.com/office/drawing/2014/main" id="{921BC7AD-2D24-4CB5-94F7-606421148209}"/>
              </a:ext>
            </a:extLst>
          </p:cNvPr>
          <p:cNvSpPr/>
          <p:nvPr/>
        </p:nvSpPr>
        <p:spPr>
          <a:xfrm>
            <a:off x="1156636" y="6209154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Star: 5 Points 68">
            <a:extLst>
              <a:ext uri="{FF2B5EF4-FFF2-40B4-BE49-F238E27FC236}">
                <a16:creationId xmlns:a16="http://schemas.microsoft.com/office/drawing/2014/main" id="{E99F5244-C521-4AAF-ADA9-F97D4B25B70D}"/>
              </a:ext>
            </a:extLst>
          </p:cNvPr>
          <p:cNvSpPr/>
          <p:nvPr/>
        </p:nvSpPr>
        <p:spPr>
          <a:xfrm>
            <a:off x="11969821" y="404207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Star: 5 Points 69">
            <a:extLst>
              <a:ext uri="{FF2B5EF4-FFF2-40B4-BE49-F238E27FC236}">
                <a16:creationId xmlns:a16="http://schemas.microsoft.com/office/drawing/2014/main" id="{DE9B3436-1164-46F1-B56F-12D04794EC8D}"/>
              </a:ext>
            </a:extLst>
          </p:cNvPr>
          <p:cNvSpPr/>
          <p:nvPr/>
        </p:nvSpPr>
        <p:spPr>
          <a:xfrm>
            <a:off x="11972212" y="429716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Star: 5 Points 70">
            <a:extLst>
              <a:ext uri="{FF2B5EF4-FFF2-40B4-BE49-F238E27FC236}">
                <a16:creationId xmlns:a16="http://schemas.microsoft.com/office/drawing/2014/main" id="{FE63F4D0-5479-49EC-BACD-B471AEC3091C}"/>
              </a:ext>
            </a:extLst>
          </p:cNvPr>
          <p:cNvSpPr/>
          <p:nvPr/>
        </p:nvSpPr>
        <p:spPr>
          <a:xfrm>
            <a:off x="10695909" y="410501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Star: 5 Points 71">
            <a:extLst>
              <a:ext uri="{FF2B5EF4-FFF2-40B4-BE49-F238E27FC236}">
                <a16:creationId xmlns:a16="http://schemas.microsoft.com/office/drawing/2014/main" id="{02CF5CB7-A37F-4A4B-A686-3C9AC28B3EA4}"/>
              </a:ext>
            </a:extLst>
          </p:cNvPr>
          <p:cNvSpPr/>
          <p:nvPr/>
        </p:nvSpPr>
        <p:spPr>
          <a:xfrm>
            <a:off x="9301629" y="4313762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Star: 5 Points 72">
            <a:extLst>
              <a:ext uri="{FF2B5EF4-FFF2-40B4-BE49-F238E27FC236}">
                <a16:creationId xmlns:a16="http://schemas.microsoft.com/office/drawing/2014/main" id="{275AF152-8C45-4BCA-B400-7279426CE75B}"/>
              </a:ext>
            </a:extLst>
          </p:cNvPr>
          <p:cNvSpPr/>
          <p:nvPr/>
        </p:nvSpPr>
        <p:spPr>
          <a:xfrm>
            <a:off x="10009208" y="407192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Star: 5 Points 73">
            <a:extLst>
              <a:ext uri="{FF2B5EF4-FFF2-40B4-BE49-F238E27FC236}">
                <a16:creationId xmlns:a16="http://schemas.microsoft.com/office/drawing/2014/main" id="{3B56F1A7-A005-4623-8FC9-8A47D1A87C44}"/>
              </a:ext>
            </a:extLst>
          </p:cNvPr>
          <p:cNvSpPr/>
          <p:nvPr/>
        </p:nvSpPr>
        <p:spPr>
          <a:xfrm>
            <a:off x="10703506" y="4333910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Star: 5 Points 74">
            <a:extLst>
              <a:ext uri="{FF2B5EF4-FFF2-40B4-BE49-F238E27FC236}">
                <a16:creationId xmlns:a16="http://schemas.microsoft.com/office/drawing/2014/main" id="{B7443BEC-6C66-473F-A8A3-E5C58CB55C1B}"/>
              </a:ext>
            </a:extLst>
          </p:cNvPr>
          <p:cNvSpPr/>
          <p:nvPr/>
        </p:nvSpPr>
        <p:spPr>
          <a:xfrm>
            <a:off x="10002876" y="430446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Star: 5 Points 75">
            <a:extLst>
              <a:ext uri="{FF2B5EF4-FFF2-40B4-BE49-F238E27FC236}">
                <a16:creationId xmlns:a16="http://schemas.microsoft.com/office/drawing/2014/main" id="{DECEDBAF-E016-40C2-8765-9885A555A9EA}"/>
              </a:ext>
            </a:extLst>
          </p:cNvPr>
          <p:cNvSpPr/>
          <p:nvPr/>
        </p:nvSpPr>
        <p:spPr>
          <a:xfrm>
            <a:off x="9305344" y="390892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Star: 5 Points 76">
            <a:extLst>
              <a:ext uri="{FF2B5EF4-FFF2-40B4-BE49-F238E27FC236}">
                <a16:creationId xmlns:a16="http://schemas.microsoft.com/office/drawing/2014/main" id="{CE76259A-B2D1-4084-AEE7-ED3655BDAD96}"/>
              </a:ext>
            </a:extLst>
          </p:cNvPr>
          <p:cNvSpPr/>
          <p:nvPr/>
        </p:nvSpPr>
        <p:spPr>
          <a:xfrm>
            <a:off x="9301711" y="410501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Star: 5 Points 77">
            <a:extLst>
              <a:ext uri="{FF2B5EF4-FFF2-40B4-BE49-F238E27FC236}">
                <a16:creationId xmlns:a16="http://schemas.microsoft.com/office/drawing/2014/main" id="{97D77AE7-0894-45C2-9D5C-1F90FEA8DCC9}"/>
              </a:ext>
            </a:extLst>
          </p:cNvPr>
          <p:cNvSpPr/>
          <p:nvPr/>
        </p:nvSpPr>
        <p:spPr>
          <a:xfrm>
            <a:off x="5297506" y="606289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Star: 5 Points 78">
            <a:extLst>
              <a:ext uri="{FF2B5EF4-FFF2-40B4-BE49-F238E27FC236}">
                <a16:creationId xmlns:a16="http://schemas.microsoft.com/office/drawing/2014/main" id="{9279EA22-8BF5-4B89-80DE-5B30D3ADD84E}"/>
              </a:ext>
            </a:extLst>
          </p:cNvPr>
          <p:cNvSpPr/>
          <p:nvPr/>
        </p:nvSpPr>
        <p:spPr>
          <a:xfrm>
            <a:off x="5201254" y="625027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Star: 5 Points 79">
            <a:extLst>
              <a:ext uri="{FF2B5EF4-FFF2-40B4-BE49-F238E27FC236}">
                <a16:creationId xmlns:a16="http://schemas.microsoft.com/office/drawing/2014/main" id="{7449E90C-FC93-42A3-BBE1-385F5D6DC31A}"/>
              </a:ext>
            </a:extLst>
          </p:cNvPr>
          <p:cNvSpPr/>
          <p:nvPr/>
        </p:nvSpPr>
        <p:spPr>
          <a:xfrm>
            <a:off x="3927916" y="6041731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Star: 5 Points 80">
            <a:extLst>
              <a:ext uri="{FF2B5EF4-FFF2-40B4-BE49-F238E27FC236}">
                <a16:creationId xmlns:a16="http://schemas.microsoft.com/office/drawing/2014/main" id="{4758C3D1-B15C-44EB-B010-F71A80137316}"/>
              </a:ext>
            </a:extLst>
          </p:cNvPr>
          <p:cNvSpPr/>
          <p:nvPr/>
        </p:nvSpPr>
        <p:spPr>
          <a:xfrm>
            <a:off x="3917070" y="6207258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Star: 5 Points 81">
            <a:extLst>
              <a:ext uri="{FF2B5EF4-FFF2-40B4-BE49-F238E27FC236}">
                <a16:creationId xmlns:a16="http://schemas.microsoft.com/office/drawing/2014/main" id="{632BEC16-D042-430D-8030-2DE77887B169}"/>
              </a:ext>
            </a:extLst>
          </p:cNvPr>
          <p:cNvSpPr/>
          <p:nvPr/>
        </p:nvSpPr>
        <p:spPr>
          <a:xfrm>
            <a:off x="2603479" y="626670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Star: 5 Points 82">
            <a:extLst>
              <a:ext uri="{FF2B5EF4-FFF2-40B4-BE49-F238E27FC236}">
                <a16:creationId xmlns:a16="http://schemas.microsoft.com/office/drawing/2014/main" id="{C160292D-A4F5-441A-8F21-90F53927939D}"/>
              </a:ext>
            </a:extLst>
          </p:cNvPr>
          <p:cNvSpPr/>
          <p:nvPr/>
        </p:nvSpPr>
        <p:spPr>
          <a:xfrm>
            <a:off x="2607248" y="607066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Star: 5 Points 83">
            <a:extLst>
              <a:ext uri="{FF2B5EF4-FFF2-40B4-BE49-F238E27FC236}">
                <a16:creationId xmlns:a16="http://schemas.microsoft.com/office/drawing/2014/main" id="{580EC200-A900-48BF-9843-A316065F3681}"/>
              </a:ext>
            </a:extLst>
          </p:cNvPr>
          <p:cNvSpPr/>
          <p:nvPr/>
        </p:nvSpPr>
        <p:spPr>
          <a:xfrm>
            <a:off x="2597221" y="566551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Star: 5 Points 84">
            <a:extLst>
              <a:ext uri="{FF2B5EF4-FFF2-40B4-BE49-F238E27FC236}">
                <a16:creationId xmlns:a16="http://schemas.microsoft.com/office/drawing/2014/main" id="{5C368D54-E9B3-4BE9-A347-9573CC30A617}"/>
              </a:ext>
            </a:extLst>
          </p:cNvPr>
          <p:cNvSpPr/>
          <p:nvPr/>
        </p:nvSpPr>
        <p:spPr>
          <a:xfrm>
            <a:off x="1877663" y="5979727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Star: 5 Points 85">
            <a:extLst>
              <a:ext uri="{FF2B5EF4-FFF2-40B4-BE49-F238E27FC236}">
                <a16:creationId xmlns:a16="http://schemas.microsoft.com/office/drawing/2014/main" id="{8288F938-D9DC-4B3B-8069-6843E727C910}"/>
              </a:ext>
            </a:extLst>
          </p:cNvPr>
          <p:cNvSpPr/>
          <p:nvPr/>
        </p:nvSpPr>
        <p:spPr>
          <a:xfrm>
            <a:off x="1872421" y="6213985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Star: 5 Points 86">
            <a:extLst>
              <a:ext uri="{FF2B5EF4-FFF2-40B4-BE49-F238E27FC236}">
                <a16:creationId xmlns:a16="http://schemas.microsoft.com/office/drawing/2014/main" id="{9AADE4D1-685D-4B52-9214-477873248D5D}"/>
              </a:ext>
            </a:extLst>
          </p:cNvPr>
          <p:cNvSpPr/>
          <p:nvPr/>
        </p:nvSpPr>
        <p:spPr>
          <a:xfrm>
            <a:off x="1166628" y="6053793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Star: 5 Points 87">
            <a:extLst>
              <a:ext uri="{FF2B5EF4-FFF2-40B4-BE49-F238E27FC236}">
                <a16:creationId xmlns:a16="http://schemas.microsoft.com/office/drawing/2014/main" id="{D6D10EC6-C71F-785F-CC55-BAB185C93CBF}"/>
              </a:ext>
            </a:extLst>
          </p:cNvPr>
          <p:cNvSpPr/>
          <p:nvPr/>
        </p:nvSpPr>
        <p:spPr>
          <a:xfrm>
            <a:off x="3917070" y="5521219"/>
            <a:ext cx="96252" cy="86627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254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93</TotalTime>
  <Words>424</Words>
  <Application>Microsoft Office PowerPoint</Application>
  <PresentationFormat>Widescreen</PresentationFormat>
  <Paragraphs>8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m Choker</dc:creator>
  <cp:lastModifiedBy>Christelle Iskandar</cp:lastModifiedBy>
  <cp:revision>24</cp:revision>
  <dcterms:created xsi:type="dcterms:W3CDTF">2024-03-26T16:55:21Z</dcterms:created>
  <dcterms:modified xsi:type="dcterms:W3CDTF">2024-06-18T18:33:17Z</dcterms:modified>
</cp:coreProperties>
</file>